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91" d="100"/>
          <a:sy n="91" d="100"/>
        </p:scale>
        <p:origin x="-365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D34D2E-A055-4AA2-A35F-91E2C463BE8F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EC92B9-BA5A-4CEE-9DC8-D7F1818543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877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EC92B9-BA5A-4CEE-9DC8-D7F181854353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43809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2358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085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6988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4336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9199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5968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5889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3973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0292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3325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5250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06E4D9-E030-4612-829E-21C5EA263E51}" type="datetimeFigureOut">
              <a:rPr lang="fr-FR" smtClean="0"/>
              <a:t>27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169849-332D-45DD-A3BE-BE1A733427C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8406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538896" y="2771800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Rha</a:t>
            </a:r>
            <a:endParaRPr lang="fr-FR" dirty="0"/>
          </a:p>
        </p:txBody>
      </p:sp>
      <p:sp>
        <p:nvSpPr>
          <p:cNvPr id="3" name="ZoneTexte 2"/>
          <p:cNvSpPr txBox="1"/>
          <p:nvPr/>
        </p:nvSpPr>
        <p:spPr>
          <a:xfrm>
            <a:off x="1446430" y="2308220"/>
            <a:ext cx="8739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GalNAc</a:t>
            </a:r>
            <a:endParaRPr lang="fr-FR" dirty="0"/>
          </a:p>
        </p:txBody>
      </p:sp>
      <p:sp>
        <p:nvSpPr>
          <p:cNvPr id="4" name="ZoneTexte 3"/>
          <p:cNvSpPr txBox="1"/>
          <p:nvPr/>
        </p:nvSpPr>
        <p:spPr>
          <a:xfrm>
            <a:off x="1772816" y="1970420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GlcNAc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2533372" y="2483768"/>
            <a:ext cx="49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Gal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2621146" y="1691680"/>
            <a:ext cx="4812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Glc</a:t>
            </a:r>
            <a:endParaRPr lang="fr-FR" dirty="0"/>
          </a:p>
        </p:txBody>
      </p:sp>
      <p:grpSp>
        <p:nvGrpSpPr>
          <p:cNvPr id="1351" name="Groupe 1350"/>
          <p:cNvGrpSpPr/>
          <p:nvPr/>
        </p:nvGrpSpPr>
        <p:grpSpPr>
          <a:xfrm>
            <a:off x="619187" y="1333746"/>
            <a:ext cx="2840431" cy="2062163"/>
            <a:chOff x="398463" y="450850"/>
            <a:chExt cx="2878137" cy="2062163"/>
          </a:xfrm>
        </p:grpSpPr>
        <p:sp>
          <p:nvSpPr>
            <p:cNvPr id="1113" name="Freeform 122"/>
            <p:cNvSpPr>
              <a:spLocks/>
            </p:cNvSpPr>
            <p:nvPr/>
          </p:nvSpPr>
          <p:spPr bwMode="auto">
            <a:xfrm>
              <a:off x="398463" y="450850"/>
              <a:ext cx="1630363" cy="2062163"/>
            </a:xfrm>
            <a:custGeom>
              <a:avLst/>
              <a:gdLst>
                <a:gd name="T0" fmla="*/ 14 w 1027"/>
                <a:gd name="T1" fmla="*/ 1289 h 1299"/>
                <a:gd name="T2" fmla="*/ 30 w 1027"/>
                <a:gd name="T3" fmla="*/ 1288 h 1299"/>
                <a:gd name="T4" fmla="*/ 46 w 1027"/>
                <a:gd name="T5" fmla="*/ 1287 h 1299"/>
                <a:gd name="T6" fmla="*/ 62 w 1027"/>
                <a:gd name="T7" fmla="*/ 1286 h 1299"/>
                <a:gd name="T8" fmla="*/ 78 w 1027"/>
                <a:gd name="T9" fmla="*/ 1285 h 1299"/>
                <a:gd name="T10" fmla="*/ 94 w 1027"/>
                <a:gd name="T11" fmla="*/ 1284 h 1299"/>
                <a:gd name="T12" fmla="*/ 110 w 1027"/>
                <a:gd name="T13" fmla="*/ 1284 h 1299"/>
                <a:gd name="T14" fmla="*/ 127 w 1027"/>
                <a:gd name="T15" fmla="*/ 1283 h 1299"/>
                <a:gd name="T16" fmla="*/ 143 w 1027"/>
                <a:gd name="T17" fmla="*/ 1282 h 1299"/>
                <a:gd name="T18" fmla="*/ 159 w 1027"/>
                <a:gd name="T19" fmla="*/ 1281 h 1299"/>
                <a:gd name="T20" fmla="*/ 175 w 1027"/>
                <a:gd name="T21" fmla="*/ 1293 h 1299"/>
                <a:gd name="T22" fmla="*/ 191 w 1027"/>
                <a:gd name="T23" fmla="*/ 1267 h 1299"/>
                <a:gd name="T24" fmla="*/ 207 w 1027"/>
                <a:gd name="T25" fmla="*/ 201 h 1299"/>
                <a:gd name="T26" fmla="*/ 223 w 1027"/>
                <a:gd name="T27" fmla="*/ 1234 h 1299"/>
                <a:gd name="T28" fmla="*/ 239 w 1027"/>
                <a:gd name="T29" fmla="*/ 1262 h 1299"/>
                <a:gd name="T30" fmla="*/ 255 w 1027"/>
                <a:gd name="T31" fmla="*/ 1267 h 1299"/>
                <a:gd name="T32" fmla="*/ 272 w 1027"/>
                <a:gd name="T33" fmla="*/ 1268 h 1299"/>
                <a:gd name="T34" fmla="*/ 288 w 1027"/>
                <a:gd name="T35" fmla="*/ 1267 h 1299"/>
                <a:gd name="T36" fmla="*/ 304 w 1027"/>
                <a:gd name="T37" fmla="*/ 1269 h 1299"/>
                <a:gd name="T38" fmla="*/ 320 w 1027"/>
                <a:gd name="T39" fmla="*/ 1269 h 1299"/>
                <a:gd name="T40" fmla="*/ 336 w 1027"/>
                <a:gd name="T41" fmla="*/ 1263 h 1299"/>
                <a:gd name="T42" fmla="*/ 352 w 1027"/>
                <a:gd name="T43" fmla="*/ 1260 h 1299"/>
                <a:gd name="T44" fmla="*/ 368 w 1027"/>
                <a:gd name="T45" fmla="*/ 1264 h 1299"/>
                <a:gd name="T46" fmla="*/ 384 w 1027"/>
                <a:gd name="T47" fmla="*/ 1245 h 1299"/>
                <a:gd name="T48" fmla="*/ 401 w 1027"/>
                <a:gd name="T49" fmla="*/ 1257 h 1299"/>
                <a:gd name="T50" fmla="*/ 417 w 1027"/>
                <a:gd name="T51" fmla="*/ 1264 h 1299"/>
                <a:gd name="T52" fmla="*/ 433 w 1027"/>
                <a:gd name="T53" fmla="*/ 1265 h 1299"/>
                <a:gd name="T54" fmla="*/ 449 w 1027"/>
                <a:gd name="T55" fmla="*/ 1258 h 1299"/>
                <a:gd name="T56" fmla="*/ 465 w 1027"/>
                <a:gd name="T57" fmla="*/ 1236 h 1299"/>
                <a:gd name="T58" fmla="*/ 481 w 1027"/>
                <a:gd name="T59" fmla="*/ 1251 h 1299"/>
                <a:gd name="T60" fmla="*/ 497 w 1027"/>
                <a:gd name="T61" fmla="*/ 1259 h 1299"/>
                <a:gd name="T62" fmla="*/ 513 w 1027"/>
                <a:gd name="T63" fmla="*/ 1260 h 1299"/>
                <a:gd name="T64" fmla="*/ 529 w 1027"/>
                <a:gd name="T65" fmla="*/ 1261 h 1299"/>
                <a:gd name="T66" fmla="*/ 546 w 1027"/>
                <a:gd name="T67" fmla="*/ 1252 h 1299"/>
                <a:gd name="T68" fmla="*/ 562 w 1027"/>
                <a:gd name="T69" fmla="*/ 1255 h 1299"/>
                <a:gd name="T70" fmla="*/ 578 w 1027"/>
                <a:gd name="T71" fmla="*/ 1259 h 1299"/>
                <a:gd name="T72" fmla="*/ 594 w 1027"/>
                <a:gd name="T73" fmla="*/ 1261 h 1299"/>
                <a:gd name="T74" fmla="*/ 610 w 1027"/>
                <a:gd name="T75" fmla="*/ 1261 h 1299"/>
                <a:gd name="T76" fmla="*/ 626 w 1027"/>
                <a:gd name="T77" fmla="*/ 1261 h 1299"/>
                <a:gd name="T78" fmla="*/ 642 w 1027"/>
                <a:gd name="T79" fmla="*/ 1260 h 1299"/>
                <a:gd name="T80" fmla="*/ 658 w 1027"/>
                <a:gd name="T81" fmla="*/ 1260 h 1299"/>
                <a:gd name="T82" fmla="*/ 674 w 1027"/>
                <a:gd name="T83" fmla="*/ 1259 h 1299"/>
                <a:gd name="T84" fmla="*/ 691 w 1027"/>
                <a:gd name="T85" fmla="*/ 1260 h 1299"/>
                <a:gd name="T86" fmla="*/ 707 w 1027"/>
                <a:gd name="T87" fmla="*/ 1259 h 1299"/>
                <a:gd name="T88" fmla="*/ 723 w 1027"/>
                <a:gd name="T89" fmla="*/ 1255 h 1299"/>
                <a:gd name="T90" fmla="*/ 739 w 1027"/>
                <a:gd name="T91" fmla="*/ 1255 h 1299"/>
                <a:gd name="T92" fmla="*/ 755 w 1027"/>
                <a:gd name="T93" fmla="*/ 1256 h 1299"/>
                <a:gd name="T94" fmla="*/ 771 w 1027"/>
                <a:gd name="T95" fmla="*/ 1256 h 1299"/>
                <a:gd name="T96" fmla="*/ 787 w 1027"/>
                <a:gd name="T97" fmla="*/ 1255 h 1299"/>
                <a:gd name="T98" fmla="*/ 803 w 1027"/>
                <a:gd name="T99" fmla="*/ 1255 h 1299"/>
                <a:gd name="T100" fmla="*/ 819 w 1027"/>
                <a:gd name="T101" fmla="*/ 1254 h 1299"/>
                <a:gd name="T102" fmla="*/ 836 w 1027"/>
                <a:gd name="T103" fmla="*/ 1253 h 1299"/>
                <a:gd name="T104" fmla="*/ 852 w 1027"/>
                <a:gd name="T105" fmla="*/ 1253 h 1299"/>
                <a:gd name="T106" fmla="*/ 868 w 1027"/>
                <a:gd name="T107" fmla="*/ 1253 h 1299"/>
                <a:gd name="T108" fmla="*/ 884 w 1027"/>
                <a:gd name="T109" fmla="*/ 1253 h 1299"/>
                <a:gd name="T110" fmla="*/ 900 w 1027"/>
                <a:gd name="T111" fmla="*/ 1247 h 1299"/>
                <a:gd name="T112" fmla="*/ 916 w 1027"/>
                <a:gd name="T113" fmla="*/ 1177 h 1299"/>
                <a:gd name="T114" fmla="*/ 932 w 1027"/>
                <a:gd name="T115" fmla="*/ 1114 h 1299"/>
                <a:gd name="T116" fmla="*/ 948 w 1027"/>
                <a:gd name="T117" fmla="*/ 1155 h 1299"/>
                <a:gd name="T118" fmla="*/ 964 w 1027"/>
                <a:gd name="T119" fmla="*/ 1204 h 1299"/>
                <a:gd name="T120" fmla="*/ 981 w 1027"/>
                <a:gd name="T121" fmla="*/ 1228 h 1299"/>
                <a:gd name="T122" fmla="*/ 997 w 1027"/>
                <a:gd name="T123" fmla="*/ 1236 h 1299"/>
                <a:gd name="T124" fmla="*/ 1013 w 1027"/>
                <a:gd name="T125" fmla="*/ 1239 h 12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27" h="1299">
                  <a:moveTo>
                    <a:pt x="0" y="1289"/>
                  </a:moveTo>
                  <a:lnTo>
                    <a:pt x="2" y="1289"/>
                  </a:lnTo>
                  <a:lnTo>
                    <a:pt x="4" y="1289"/>
                  </a:lnTo>
                  <a:lnTo>
                    <a:pt x="6" y="1289"/>
                  </a:lnTo>
                  <a:lnTo>
                    <a:pt x="8" y="1289"/>
                  </a:lnTo>
                  <a:lnTo>
                    <a:pt x="10" y="1289"/>
                  </a:lnTo>
                  <a:lnTo>
                    <a:pt x="12" y="1289"/>
                  </a:lnTo>
                  <a:lnTo>
                    <a:pt x="14" y="1289"/>
                  </a:lnTo>
                  <a:lnTo>
                    <a:pt x="16" y="1289"/>
                  </a:lnTo>
                  <a:lnTo>
                    <a:pt x="18" y="1289"/>
                  </a:lnTo>
                  <a:lnTo>
                    <a:pt x="20" y="1288"/>
                  </a:lnTo>
                  <a:lnTo>
                    <a:pt x="22" y="1288"/>
                  </a:lnTo>
                  <a:lnTo>
                    <a:pt x="24" y="1288"/>
                  </a:lnTo>
                  <a:lnTo>
                    <a:pt x="26" y="1288"/>
                  </a:lnTo>
                  <a:lnTo>
                    <a:pt x="28" y="1288"/>
                  </a:lnTo>
                  <a:lnTo>
                    <a:pt x="30" y="1288"/>
                  </a:lnTo>
                  <a:lnTo>
                    <a:pt x="32" y="1288"/>
                  </a:lnTo>
                  <a:lnTo>
                    <a:pt x="34" y="1288"/>
                  </a:lnTo>
                  <a:lnTo>
                    <a:pt x="36" y="1288"/>
                  </a:lnTo>
                  <a:lnTo>
                    <a:pt x="38" y="1287"/>
                  </a:lnTo>
                  <a:lnTo>
                    <a:pt x="40" y="1287"/>
                  </a:lnTo>
                  <a:lnTo>
                    <a:pt x="42" y="1287"/>
                  </a:lnTo>
                  <a:lnTo>
                    <a:pt x="44" y="1287"/>
                  </a:lnTo>
                  <a:lnTo>
                    <a:pt x="46" y="1287"/>
                  </a:lnTo>
                  <a:lnTo>
                    <a:pt x="48" y="1287"/>
                  </a:lnTo>
                  <a:lnTo>
                    <a:pt x="50" y="1287"/>
                  </a:lnTo>
                  <a:lnTo>
                    <a:pt x="52" y="1287"/>
                  </a:lnTo>
                  <a:lnTo>
                    <a:pt x="54" y="1287"/>
                  </a:lnTo>
                  <a:lnTo>
                    <a:pt x="56" y="1286"/>
                  </a:lnTo>
                  <a:lnTo>
                    <a:pt x="58" y="1286"/>
                  </a:lnTo>
                  <a:lnTo>
                    <a:pt x="60" y="1286"/>
                  </a:lnTo>
                  <a:lnTo>
                    <a:pt x="62" y="1286"/>
                  </a:lnTo>
                  <a:lnTo>
                    <a:pt x="64" y="1286"/>
                  </a:lnTo>
                  <a:lnTo>
                    <a:pt x="66" y="1286"/>
                  </a:lnTo>
                  <a:lnTo>
                    <a:pt x="68" y="1286"/>
                  </a:lnTo>
                  <a:lnTo>
                    <a:pt x="70" y="1286"/>
                  </a:lnTo>
                  <a:lnTo>
                    <a:pt x="72" y="1286"/>
                  </a:lnTo>
                  <a:lnTo>
                    <a:pt x="74" y="1286"/>
                  </a:lnTo>
                  <a:lnTo>
                    <a:pt x="76" y="1285"/>
                  </a:lnTo>
                  <a:lnTo>
                    <a:pt x="78" y="1285"/>
                  </a:lnTo>
                  <a:lnTo>
                    <a:pt x="80" y="1285"/>
                  </a:lnTo>
                  <a:lnTo>
                    <a:pt x="82" y="1285"/>
                  </a:lnTo>
                  <a:lnTo>
                    <a:pt x="84" y="1285"/>
                  </a:lnTo>
                  <a:lnTo>
                    <a:pt x="86" y="1285"/>
                  </a:lnTo>
                  <a:lnTo>
                    <a:pt x="88" y="1285"/>
                  </a:lnTo>
                  <a:lnTo>
                    <a:pt x="90" y="1285"/>
                  </a:lnTo>
                  <a:lnTo>
                    <a:pt x="92" y="1285"/>
                  </a:lnTo>
                  <a:lnTo>
                    <a:pt x="94" y="1284"/>
                  </a:lnTo>
                  <a:lnTo>
                    <a:pt x="96" y="1284"/>
                  </a:lnTo>
                  <a:lnTo>
                    <a:pt x="98" y="1285"/>
                  </a:lnTo>
                  <a:lnTo>
                    <a:pt x="100" y="1284"/>
                  </a:lnTo>
                  <a:lnTo>
                    <a:pt x="102" y="1284"/>
                  </a:lnTo>
                  <a:lnTo>
                    <a:pt x="104" y="1284"/>
                  </a:lnTo>
                  <a:lnTo>
                    <a:pt x="106" y="1284"/>
                  </a:lnTo>
                  <a:lnTo>
                    <a:pt x="108" y="1284"/>
                  </a:lnTo>
                  <a:lnTo>
                    <a:pt x="110" y="1284"/>
                  </a:lnTo>
                  <a:lnTo>
                    <a:pt x="112" y="1283"/>
                  </a:lnTo>
                  <a:lnTo>
                    <a:pt x="114" y="1283"/>
                  </a:lnTo>
                  <a:lnTo>
                    <a:pt x="116" y="1283"/>
                  </a:lnTo>
                  <a:lnTo>
                    <a:pt x="118" y="1283"/>
                  </a:lnTo>
                  <a:lnTo>
                    <a:pt x="120" y="1283"/>
                  </a:lnTo>
                  <a:lnTo>
                    <a:pt x="123" y="1283"/>
                  </a:lnTo>
                  <a:lnTo>
                    <a:pt x="125" y="1283"/>
                  </a:lnTo>
                  <a:lnTo>
                    <a:pt x="127" y="1283"/>
                  </a:lnTo>
                  <a:lnTo>
                    <a:pt x="129" y="1283"/>
                  </a:lnTo>
                  <a:lnTo>
                    <a:pt x="131" y="1282"/>
                  </a:lnTo>
                  <a:lnTo>
                    <a:pt x="133" y="1282"/>
                  </a:lnTo>
                  <a:lnTo>
                    <a:pt x="135" y="1283"/>
                  </a:lnTo>
                  <a:lnTo>
                    <a:pt x="137" y="1282"/>
                  </a:lnTo>
                  <a:lnTo>
                    <a:pt x="139" y="1282"/>
                  </a:lnTo>
                  <a:lnTo>
                    <a:pt x="141" y="1282"/>
                  </a:lnTo>
                  <a:lnTo>
                    <a:pt x="143" y="1282"/>
                  </a:lnTo>
                  <a:lnTo>
                    <a:pt x="145" y="1282"/>
                  </a:lnTo>
                  <a:lnTo>
                    <a:pt x="147" y="1282"/>
                  </a:lnTo>
                  <a:lnTo>
                    <a:pt x="149" y="1282"/>
                  </a:lnTo>
                  <a:lnTo>
                    <a:pt x="151" y="1281"/>
                  </a:lnTo>
                  <a:lnTo>
                    <a:pt x="153" y="1282"/>
                  </a:lnTo>
                  <a:lnTo>
                    <a:pt x="155" y="1281"/>
                  </a:lnTo>
                  <a:lnTo>
                    <a:pt x="157" y="1281"/>
                  </a:lnTo>
                  <a:lnTo>
                    <a:pt x="159" y="1281"/>
                  </a:lnTo>
                  <a:lnTo>
                    <a:pt x="161" y="1281"/>
                  </a:lnTo>
                  <a:lnTo>
                    <a:pt x="163" y="1282"/>
                  </a:lnTo>
                  <a:lnTo>
                    <a:pt x="165" y="1285"/>
                  </a:lnTo>
                  <a:lnTo>
                    <a:pt x="167" y="1293"/>
                  </a:lnTo>
                  <a:lnTo>
                    <a:pt x="169" y="1299"/>
                  </a:lnTo>
                  <a:lnTo>
                    <a:pt x="171" y="1299"/>
                  </a:lnTo>
                  <a:lnTo>
                    <a:pt x="173" y="1296"/>
                  </a:lnTo>
                  <a:lnTo>
                    <a:pt x="175" y="1293"/>
                  </a:lnTo>
                  <a:lnTo>
                    <a:pt x="177" y="1290"/>
                  </a:lnTo>
                  <a:lnTo>
                    <a:pt x="179" y="1286"/>
                  </a:lnTo>
                  <a:lnTo>
                    <a:pt x="181" y="1284"/>
                  </a:lnTo>
                  <a:lnTo>
                    <a:pt x="183" y="1282"/>
                  </a:lnTo>
                  <a:lnTo>
                    <a:pt x="185" y="1279"/>
                  </a:lnTo>
                  <a:lnTo>
                    <a:pt x="187" y="1272"/>
                  </a:lnTo>
                  <a:lnTo>
                    <a:pt x="189" y="1267"/>
                  </a:lnTo>
                  <a:lnTo>
                    <a:pt x="191" y="1267"/>
                  </a:lnTo>
                  <a:lnTo>
                    <a:pt x="193" y="1267"/>
                  </a:lnTo>
                  <a:lnTo>
                    <a:pt x="195" y="1230"/>
                  </a:lnTo>
                  <a:lnTo>
                    <a:pt x="197" y="967"/>
                  </a:lnTo>
                  <a:lnTo>
                    <a:pt x="199" y="437"/>
                  </a:lnTo>
                  <a:lnTo>
                    <a:pt x="201" y="68"/>
                  </a:lnTo>
                  <a:lnTo>
                    <a:pt x="203" y="0"/>
                  </a:lnTo>
                  <a:lnTo>
                    <a:pt x="205" y="83"/>
                  </a:lnTo>
                  <a:lnTo>
                    <a:pt x="207" y="201"/>
                  </a:lnTo>
                  <a:lnTo>
                    <a:pt x="209" y="363"/>
                  </a:lnTo>
                  <a:lnTo>
                    <a:pt x="211" y="585"/>
                  </a:lnTo>
                  <a:lnTo>
                    <a:pt x="213" y="813"/>
                  </a:lnTo>
                  <a:lnTo>
                    <a:pt x="215" y="994"/>
                  </a:lnTo>
                  <a:lnTo>
                    <a:pt x="217" y="1112"/>
                  </a:lnTo>
                  <a:lnTo>
                    <a:pt x="219" y="1179"/>
                  </a:lnTo>
                  <a:lnTo>
                    <a:pt x="221" y="1214"/>
                  </a:lnTo>
                  <a:lnTo>
                    <a:pt x="223" y="1234"/>
                  </a:lnTo>
                  <a:lnTo>
                    <a:pt x="225" y="1246"/>
                  </a:lnTo>
                  <a:lnTo>
                    <a:pt x="227" y="1254"/>
                  </a:lnTo>
                  <a:lnTo>
                    <a:pt x="229" y="1259"/>
                  </a:lnTo>
                  <a:lnTo>
                    <a:pt x="231" y="1262"/>
                  </a:lnTo>
                  <a:lnTo>
                    <a:pt x="233" y="1263"/>
                  </a:lnTo>
                  <a:lnTo>
                    <a:pt x="235" y="1264"/>
                  </a:lnTo>
                  <a:lnTo>
                    <a:pt x="237" y="1263"/>
                  </a:lnTo>
                  <a:lnTo>
                    <a:pt x="239" y="1262"/>
                  </a:lnTo>
                  <a:lnTo>
                    <a:pt x="241" y="1262"/>
                  </a:lnTo>
                  <a:lnTo>
                    <a:pt x="243" y="1262"/>
                  </a:lnTo>
                  <a:lnTo>
                    <a:pt x="245" y="1263"/>
                  </a:lnTo>
                  <a:lnTo>
                    <a:pt x="247" y="1264"/>
                  </a:lnTo>
                  <a:lnTo>
                    <a:pt x="249" y="1265"/>
                  </a:lnTo>
                  <a:lnTo>
                    <a:pt x="251" y="1266"/>
                  </a:lnTo>
                  <a:lnTo>
                    <a:pt x="253" y="1266"/>
                  </a:lnTo>
                  <a:lnTo>
                    <a:pt x="255" y="1267"/>
                  </a:lnTo>
                  <a:lnTo>
                    <a:pt x="257" y="1267"/>
                  </a:lnTo>
                  <a:lnTo>
                    <a:pt x="259" y="1267"/>
                  </a:lnTo>
                  <a:lnTo>
                    <a:pt x="261" y="1268"/>
                  </a:lnTo>
                  <a:lnTo>
                    <a:pt x="263" y="1268"/>
                  </a:lnTo>
                  <a:lnTo>
                    <a:pt x="266" y="1268"/>
                  </a:lnTo>
                  <a:lnTo>
                    <a:pt x="268" y="1268"/>
                  </a:lnTo>
                  <a:lnTo>
                    <a:pt x="270" y="1268"/>
                  </a:lnTo>
                  <a:lnTo>
                    <a:pt x="272" y="1268"/>
                  </a:lnTo>
                  <a:lnTo>
                    <a:pt x="274" y="1268"/>
                  </a:lnTo>
                  <a:lnTo>
                    <a:pt x="276" y="1266"/>
                  </a:lnTo>
                  <a:lnTo>
                    <a:pt x="278" y="1265"/>
                  </a:lnTo>
                  <a:lnTo>
                    <a:pt x="280" y="1264"/>
                  </a:lnTo>
                  <a:lnTo>
                    <a:pt x="282" y="1265"/>
                  </a:lnTo>
                  <a:lnTo>
                    <a:pt x="284" y="1266"/>
                  </a:lnTo>
                  <a:lnTo>
                    <a:pt x="286" y="1266"/>
                  </a:lnTo>
                  <a:lnTo>
                    <a:pt x="288" y="1267"/>
                  </a:lnTo>
                  <a:lnTo>
                    <a:pt x="290" y="1268"/>
                  </a:lnTo>
                  <a:lnTo>
                    <a:pt x="292" y="1268"/>
                  </a:lnTo>
                  <a:lnTo>
                    <a:pt x="294" y="1269"/>
                  </a:lnTo>
                  <a:lnTo>
                    <a:pt x="296" y="1269"/>
                  </a:lnTo>
                  <a:lnTo>
                    <a:pt x="298" y="1269"/>
                  </a:lnTo>
                  <a:lnTo>
                    <a:pt x="300" y="1269"/>
                  </a:lnTo>
                  <a:lnTo>
                    <a:pt x="302" y="1270"/>
                  </a:lnTo>
                  <a:lnTo>
                    <a:pt x="304" y="1269"/>
                  </a:lnTo>
                  <a:lnTo>
                    <a:pt x="306" y="1269"/>
                  </a:lnTo>
                  <a:lnTo>
                    <a:pt x="308" y="1268"/>
                  </a:lnTo>
                  <a:lnTo>
                    <a:pt x="310" y="1268"/>
                  </a:lnTo>
                  <a:lnTo>
                    <a:pt x="312" y="1268"/>
                  </a:lnTo>
                  <a:lnTo>
                    <a:pt x="314" y="1268"/>
                  </a:lnTo>
                  <a:lnTo>
                    <a:pt x="316" y="1268"/>
                  </a:lnTo>
                  <a:lnTo>
                    <a:pt x="318" y="1268"/>
                  </a:lnTo>
                  <a:lnTo>
                    <a:pt x="320" y="1269"/>
                  </a:lnTo>
                  <a:lnTo>
                    <a:pt x="322" y="1268"/>
                  </a:lnTo>
                  <a:lnTo>
                    <a:pt x="324" y="1268"/>
                  </a:lnTo>
                  <a:lnTo>
                    <a:pt x="326" y="1268"/>
                  </a:lnTo>
                  <a:lnTo>
                    <a:pt x="328" y="1268"/>
                  </a:lnTo>
                  <a:lnTo>
                    <a:pt x="330" y="1268"/>
                  </a:lnTo>
                  <a:lnTo>
                    <a:pt x="332" y="1267"/>
                  </a:lnTo>
                  <a:lnTo>
                    <a:pt x="334" y="1265"/>
                  </a:lnTo>
                  <a:lnTo>
                    <a:pt x="336" y="1263"/>
                  </a:lnTo>
                  <a:lnTo>
                    <a:pt x="338" y="1261"/>
                  </a:lnTo>
                  <a:lnTo>
                    <a:pt x="340" y="1259"/>
                  </a:lnTo>
                  <a:lnTo>
                    <a:pt x="342" y="1258"/>
                  </a:lnTo>
                  <a:lnTo>
                    <a:pt x="344" y="1258"/>
                  </a:lnTo>
                  <a:lnTo>
                    <a:pt x="346" y="1258"/>
                  </a:lnTo>
                  <a:lnTo>
                    <a:pt x="348" y="1259"/>
                  </a:lnTo>
                  <a:lnTo>
                    <a:pt x="350" y="1260"/>
                  </a:lnTo>
                  <a:lnTo>
                    <a:pt x="352" y="1260"/>
                  </a:lnTo>
                  <a:lnTo>
                    <a:pt x="354" y="1261"/>
                  </a:lnTo>
                  <a:lnTo>
                    <a:pt x="356" y="1262"/>
                  </a:lnTo>
                  <a:lnTo>
                    <a:pt x="358" y="1262"/>
                  </a:lnTo>
                  <a:lnTo>
                    <a:pt x="360" y="1263"/>
                  </a:lnTo>
                  <a:lnTo>
                    <a:pt x="362" y="1263"/>
                  </a:lnTo>
                  <a:lnTo>
                    <a:pt x="364" y="1263"/>
                  </a:lnTo>
                  <a:lnTo>
                    <a:pt x="366" y="1264"/>
                  </a:lnTo>
                  <a:lnTo>
                    <a:pt x="368" y="1264"/>
                  </a:lnTo>
                  <a:lnTo>
                    <a:pt x="370" y="1264"/>
                  </a:lnTo>
                  <a:lnTo>
                    <a:pt x="372" y="1264"/>
                  </a:lnTo>
                  <a:lnTo>
                    <a:pt x="374" y="1263"/>
                  </a:lnTo>
                  <a:lnTo>
                    <a:pt x="376" y="1260"/>
                  </a:lnTo>
                  <a:lnTo>
                    <a:pt x="378" y="1256"/>
                  </a:lnTo>
                  <a:lnTo>
                    <a:pt x="380" y="1251"/>
                  </a:lnTo>
                  <a:lnTo>
                    <a:pt x="382" y="1247"/>
                  </a:lnTo>
                  <a:lnTo>
                    <a:pt x="384" y="1245"/>
                  </a:lnTo>
                  <a:lnTo>
                    <a:pt x="386" y="1244"/>
                  </a:lnTo>
                  <a:lnTo>
                    <a:pt x="388" y="1245"/>
                  </a:lnTo>
                  <a:lnTo>
                    <a:pt x="390" y="1246"/>
                  </a:lnTo>
                  <a:lnTo>
                    <a:pt x="392" y="1249"/>
                  </a:lnTo>
                  <a:lnTo>
                    <a:pt x="394" y="1251"/>
                  </a:lnTo>
                  <a:lnTo>
                    <a:pt x="396" y="1253"/>
                  </a:lnTo>
                  <a:lnTo>
                    <a:pt x="399" y="1255"/>
                  </a:lnTo>
                  <a:lnTo>
                    <a:pt x="401" y="1257"/>
                  </a:lnTo>
                  <a:lnTo>
                    <a:pt x="402" y="1260"/>
                  </a:lnTo>
                  <a:lnTo>
                    <a:pt x="404" y="1261"/>
                  </a:lnTo>
                  <a:lnTo>
                    <a:pt x="406" y="1262"/>
                  </a:lnTo>
                  <a:lnTo>
                    <a:pt x="409" y="1263"/>
                  </a:lnTo>
                  <a:lnTo>
                    <a:pt x="411" y="1263"/>
                  </a:lnTo>
                  <a:lnTo>
                    <a:pt x="413" y="1264"/>
                  </a:lnTo>
                  <a:lnTo>
                    <a:pt x="415" y="1264"/>
                  </a:lnTo>
                  <a:lnTo>
                    <a:pt x="417" y="1264"/>
                  </a:lnTo>
                  <a:lnTo>
                    <a:pt x="419" y="1264"/>
                  </a:lnTo>
                  <a:lnTo>
                    <a:pt x="421" y="1265"/>
                  </a:lnTo>
                  <a:lnTo>
                    <a:pt x="423" y="1265"/>
                  </a:lnTo>
                  <a:lnTo>
                    <a:pt x="425" y="1265"/>
                  </a:lnTo>
                  <a:lnTo>
                    <a:pt x="427" y="1265"/>
                  </a:lnTo>
                  <a:lnTo>
                    <a:pt x="429" y="1265"/>
                  </a:lnTo>
                  <a:lnTo>
                    <a:pt x="431" y="1265"/>
                  </a:lnTo>
                  <a:lnTo>
                    <a:pt x="433" y="1265"/>
                  </a:lnTo>
                  <a:lnTo>
                    <a:pt x="435" y="1265"/>
                  </a:lnTo>
                  <a:lnTo>
                    <a:pt x="437" y="1265"/>
                  </a:lnTo>
                  <a:lnTo>
                    <a:pt x="439" y="1265"/>
                  </a:lnTo>
                  <a:lnTo>
                    <a:pt x="441" y="1265"/>
                  </a:lnTo>
                  <a:lnTo>
                    <a:pt x="443" y="1264"/>
                  </a:lnTo>
                  <a:lnTo>
                    <a:pt x="445" y="1263"/>
                  </a:lnTo>
                  <a:lnTo>
                    <a:pt x="447" y="1262"/>
                  </a:lnTo>
                  <a:lnTo>
                    <a:pt x="449" y="1258"/>
                  </a:lnTo>
                  <a:lnTo>
                    <a:pt x="451" y="1252"/>
                  </a:lnTo>
                  <a:lnTo>
                    <a:pt x="453" y="1246"/>
                  </a:lnTo>
                  <a:lnTo>
                    <a:pt x="455" y="1241"/>
                  </a:lnTo>
                  <a:lnTo>
                    <a:pt x="457" y="1238"/>
                  </a:lnTo>
                  <a:lnTo>
                    <a:pt x="459" y="1236"/>
                  </a:lnTo>
                  <a:lnTo>
                    <a:pt x="461" y="1235"/>
                  </a:lnTo>
                  <a:lnTo>
                    <a:pt x="463" y="1236"/>
                  </a:lnTo>
                  <a:lnTo>
                    <a:pt x="465" y="1236"/>
                  </a:lnTo>
                  <a:lnTo>
                    <a:pt x="467" y="1238"/>
                  </a:lnTo>
                  <a:lnTo>
                    <a:pt x="469" y="1239"/>
                  </a:lnTo>
                  <a:lnTo>
                    <a:pt x="471" y="1241"/>
                  </a:lnTo>
                  <a:lnTo>
                    <a:pt x="473" y="1242"/>
                  </a:lnTo>
                  <a:lnTo>
                    <a:pt x="475" y="1244"/>
                  </a:lnTo>
                  <a:lnTo>
                    <a:pt x="477" y="1247"/>
                  </a:lnTo>
                  <a:lnTo>
                    <a:pt x="479" y="1249"/>
                  </a:lnTo>
                  <a:lnTo>
                    <a:pt x="481" y="1251"/>
                  </a:lnTo>
                  <a:lnTo>
                    <a:pt x="483" y="1252"/>
                  </a:lnTo>
                  <a:lnTo>
                    <a:pt x="485" y="1254"/>
                  </a:lnTo>
                  <a:lnTo>
                    <a:pt x="487" y="1255"/>
                  </a:lnTo>
                  <a:lnTo>
                    <a:pt x="489" y="1256"/>
                  </a:lnTo>
                  <a:lnTo>
                    <a:pt x="491" y="1257"/>
                  </a:lnTo>
                  <a:lnTo>
                    <a:pt x="493" y="1258"/>
                  </a:lnTo>
                  <a:lnTo>
                    <a:pt x="495" y="1258"/>
                  </a:lnTo>
                  <a:lnTo>
                    <a:pt x="497" y="1259"/>
                  </a:lnTo>
                  <a:lnTo>
                    <a:pt x="499" y="1259"/>
                  </a:lnTo>
                  <a:lnTo>
                    <a:pt x="501" y="1259"/>
                  </a:lnTo>
                  <a:lnTo>
                    <a:pt x="503" y="1259"/>
                  </a:lnTo>
                  <a:lnTo>
                    <a:pt x="505" y="1260"/>
                  </a:lnTo>
                  <a:lnTo>
                    <a:pt x="507" y="1260"/>
                  </a:lnTo>
                  <a:lnTo>
                    <a:pt x="509" y="1260"/>
                  </a:lnTo>
                  <a:lnTo>
                    <a:pt x="511" y="1260"/>
                  </a:lnTo>
                  <a:lnTo>
                    <a:pt x="513" y="1260"/>
                  </a:lnTo>
                  <a:lnTo>
                    <a:pt x="515" y="1261"/>
                  </a:lnTo>
                  <a:lnTo>
                    <a:pt x="517" y="1261"/>
                  </a:lnTo>
                  <a:lnTo>
                    <a:pt x="519" y="1261"/>
                  </a:lnTo>
                  <a:lnTo>
                    <a:pt x="521" y="1261"/>
                  </a:lnTo>
                  <a:lnTo>
                    <a:pt x="523" y="1261"/>
                  </a:lnTo>
                  <a:lnTo>
                    <a:pt x="525" y="1261"/>
                  </a:lnTo>
                  <a:lnTo>
                    <a:pt x="527" y="1261"/>
                  </a:lnTo>
                  <a:lnTo>
                    <a:pt x="529" y="1261"/>
                  </a:lnTo>
                  <a:lnTo>
                    <a:pt x="531" y="1261"/>
                  </a:lnTo>
                  <a:lnTo>
                    <a:pt x="533" y="1260"/>
                  </a:lnTo>
                  <a:lnTo>
                    <a:pt x="535" y="1259"/>
                  </a:lnTo>
                  <a:lnTo>
                    <a:pt x="537" y="1258"/>
                  </a:lnTo>
                  <a:lnTo>
                    <a:pt x="539" y="1257"/>
                  </a:lnTo>
                  <a:lnTo>
                    <a:pt x="542" y="1255"/>
                  </a:lnTo>
                  <a:lnTo>
                    <a:pt x="544" y="1254"/>
                  </a:lnTo>
                  <a:lnTo>
                    <a:pt x="546" y="1252"/>
                  </a:lnTo>
                  <a:lnTo>
                    <a:pt x="548" y="1252"/>
                  </a:lnTo>
                  <a:lnTo>
                    <a:pt x="549" y="1251"/>
                  </a:lnTo>
                  <a:lnTo>
                    <a:pt x="552" y="1252"/>
                  </a:lnTo>
                  <a:lnTo>
                    <a:pt x="554" y="1252"/>
                  </a:lnTo>
                  <a:lnTo>
                    <a:pt x="556" y="1253"/>
                  </a:lnTo>
                  <a:lnTo>
                    <a:pt x="558" y="1253"/>
                  </a:lnTo>
                  <a:lnTo>
                    <a:pt x="560" y="1254"/>
                  </a:lnTo>
                  <a:lnTo>
                    <a:pt x="562" y="1255"/>
                  </a:lnTo>
                  <a:lnTo>
                    <a:pt x="564" y="1255"/>
                  </a:lnTo>
                  <a:lnTo>
                    <a:pt x="566" y="1256"/>
                  </a:lnTo>
                  <a:lnTo>
                    <a:pt x="568" y="1257"/>
                  </a:lnTo>
                  <a:lnTo>
                    <a:pt x="570" y="1258"/>
                  </a:lnTo>
                  <a:lnTo>
                    <a:pt x="572" y="1258"/>
                  </a:lnTo>
                  <a:lnTo>
                    <a:pt x="574" y="1258"/>
                  </a:lnTo>
                  <a:lnTo>
                    <a:pt x="576" y="1259"/>
                  </a:lnTo>
                  <a:lnTo>
                    <a:pt x="578" y="1259"/>
                  </a:lnTo>
                  <a:lnTo>
                    <a:pt x="580" y="1260"/>
                  </a:lnTo>
                  <a:lnTo>
                    <a:pt x="582" y="1260"/>
                  </a:lnTo>
                  <a:lnTo>
                    <a:pt x="584" y="1260"/>
                  </a:lnTo>
                  <a:lnTo>
                    <a:pt x="586" y="1260"/>
                  </a:lnTo>
                  <a:lnTo>
                    <a:pt x="588" y="1260"/>
                  </a:lnTo>
                  <a:lnTo>
                    <a:pt x="590" y="1261"/>
                  </a:lnTo>
                  <a:lnTo>
                    <a:pt x="592" y="1260"/>
                  </a:lnTo>
                  <a:lnTo>
                    <a:pt x="594" y="1261"/>
                  </a:lnTo>
                  <a:lnTo>
                    <a:pt x="596" y="1261"/>
                  </a:lnTo>
                  <a:lnTo>
                    <a:pt x="598" y="1261"/>
                  </a:lnTo>
                  <a:lnTo>
                    <a:pt x="600" y="1261"/>
                  </a:lnTo>
                  <a:lnTo>
                    <a:pt x="602" y="1261"/>
                  </a:lnTo>
                  <a:lnTo>
                    <a:pt x="604" y="1261"/>
                  </a:lnTo>
                  <a:lnTo>
                    <a:pt x="606" y="1261"/>
                  </a:lnTo>
                  <a:lnTo>
                    <a:pt x="608" y="1261"/>
                  </a:lnTo>
                  <a:lnTo>
                    <a:pt x="610" y="1261"/>
                  </a:lnTo>
                  <a:lnTo>
                    <a:pt x="612" y="1261"/>
                  </a:lnTo>
                  <a:lnTo>
                    <a:pt x="614" y="1261"/>
                  </a:lnTo>
                  <a:lnTo>
                    <a:pt x="616" y="1261"/>
                  </a:lnTo>
                  <a:lnTo>
                    <a:pt x="618" y="1261"/>
                  </a:lnTo>
                  <a:lnTo>
                    <a:pt x="620" y="1261"/>
                  </a:lnTo>
                  <a:lnTo>
                    <a:pt x="622" y="1260"/>
                  </a:lnTo>
                  <a:lnTo>
                    <a:pt x="624" y="1261"/>
                  </a:lnTo>
                  <a:lnTo>
                    <a:pt x="626" y="1261"/>
                  </a:lnTo>
                  <a:lnTo>
                    <a:pt x="628" y="1260"/>
                  </a:lnTo>
                  <a:lnTo>
                    <a:pt x="630" y="1260"/>
                  </a:lnTo>
                  <a:lnTo>
                    <a:pt x="632" y="1260"/>
                  </a:lnTo>
                  <a:lnTo>
                    <a:pt x="634" y="1260"/>
                  </a:lnTo>
                  <a:lnTo>
                    <a:pt x="636" y="1260"/>
                  </a:lnTo>
                  <a:lnTo>
                    <a:pt x="638" y="1260"/>
                  </a:lnTo>
                  <a:lnTo>
                    <a:pt x="640" y="1260"/>
                  </a:lnTo>
                  <a:lnTo>
                    <a:pt x="642" y="1260"/>
                  </a:lnTo>
                  <a:lnTo>
                    <a:pt x="644" y="1260"/>
                  </a:lnTo>
                  <a:lnTo>
                    <a:pt x="646" y="1260"/>
                  </a:lnTo>
                  <a:lnTo>
                    <a:pt x="648" y="1260"/>
                  </a:lnTo>
                  <a:lnTo>
                    <a:pt x="650" y="1260"/>
                  </a:lnTo>
                  <a:lnTo>
                    <a:pt x="652" y="1260"/>
                  </a:lnTo>
                  <a:lnTo>
                    <a:pt x="654" y="1260"/>
                  </a:lnTo>
                  <a:lnTo>
                    <a:pt x="656" y="1260"/>
                  </a:lnTo>
                  <a:lnTo>
                    <a:pt x="658" y="1260"/>
                  </a:lnTo>
                  <a:lnTo>
                    <a:pt x="660" y="1260"/>
                  </a:lnTo>
                  <a:lnTo>
                    <a:pt x="662" y="1260"/>
                  </a:lnTo>
                  <a:lnTo>
                    <a:pt x="664" y="1260"/>
                  </a:lnTo>
                  <a:lnTo>
                    <a:pt x="666" y="1259"/>
                  </a:lnTo>
                  <a:lnTo>
                    <a:pt x="668" y="1259"/>
                  </a:lnTo>
                  <a:lnTo>
                    <a:pt x="670" y="1260"/>
                  </a:lnTo>
                  <a:lnTo>
                    <a:pt x="672" y="1259"/>
                  </a:lnTo>
                  <a:lnTo>
                    <a:pt x="674" y="1259"/>
                  </a:lnTo>
                  <a:lnTo>
                    <a:pt x="676" y="1259"/>
                  </a:lnTo>
                  <a:lnTo>
                    <a:pt x="678" y="1259"/>
                  </a:lnTo>
                  <a:lnTo>
                    <a:pt x="680" y="1260"/>
                  </a:lnTo>
                  <a:lnTo>
                    <a:pt x="682" y="1260"/>
                  </a:lnTo>
                  <a:lnTo>
                    <a:pt x="685" y="1260"/>
                  </a:lnTo>
                  <a:lnTo>
                    <a:pt x="687" y="1260"/>
                  </a:lnTo>
                  <a:lnTo>
                    <a:pt x="689" y="1260"/>
                  </a:lnTo>
                  <a:lnTo>
                    <a:pt x="691" y="1260"/>
                  </a:lnTo>
                  <a:lnTo>
                    <a:pt x="693" y="1260"/>
                  </a:lnTo>
                  <a:lnTo>
                    <a:pt x="695" y="1260"/>
                  </a:lnTo>
                  <a:lnTo>
                    <a:pt x="697" y="1260"/>
                  </a:lnTo>
                  <a:lnTo>
                    <a:pt x="699" y="1260"/>
                  </a:lnTo>
                  <a:lnTo>
                    <a:pt x="701" y="1260"/>
                  </a:lnTo>
                  <a:lnTo>
                    <a:pt x="703" y="1259"/>
                  </a:lnTo>
                  <a:lnTo>
                    <a:pt x="705" y="1259"/>
                  </a:lnTo>
                  <a:lnTo>
                    <a:pt x="707" y="1259"/>
                  </a:lnTo>
                  <a:lnTo>
                    <a:pt x="709" y="1258"/>
                  </a:lnTo>
                  <a:lnTo>
                    <a:pt x="711" y="1258"/>
                  </a:lnTo>
                  <a:lnTo>
                    <a:pt x="713" y="1257"/>
                  </a:lnTo>
                  <a:lnTo>
                    <a:pt x="715" y="1257"/>
                  </a:lnTo>
                  <a:lnTo>
                    <a:pt x="717" y="1257"/>
                  </a:lnTo>
                  <a:lnTo>
                    <a:pt x="719" y="1256"/>
                  </a:lnTo>
                  <a:lnTo>
                    <a:pt x="721" y="1256"/>
                  </a:lnTo>
                  <a:lnTo>
                    <a:pt x="723" y="1255"/>
                  </a:lnTo>
                  <a:lnTo>
                    <a:pt x="725" y="1255"/>
                  </a:lnTo>
                  <a:lnTo>
                    <a:pt x="727" y="1255"/>
                  </a:lnTo>
                  <a:lnTo>
                    <a:pt x="729" y="1255"/>
                  </a:lnTo>
                  <a:lnTo>
                    <a:pt x="731" y="1255"/>
                  </a:lnTo>
                  <a:lnTo>
                    <a:pt x="733" y="1255"/>
                  </a:lnTo>
                  <a:lnTo>
                    <a:pt x="735" y="1255"/>
                  </a:lnTo>
                  <a:lnTo>
                    <a:pt x="737" y="1255"/>
                  </a:lnTo>
                  <a:lnTo>
                    <a:pt x="739" y="1255"/>
                  </a:lnTo>
                  <a:lnTo>
                    <a:pt x="741" y="1255"/>
                  </a:lnTo>
                  <a:lnTo>
                    <a:pt x="743" y="1255"/>
                  </a:lnTo>
                  <a:lnTo>
                    <a:pt x="745" y="1256"/>
                  </a:lnTo>
                  <a:lnTo>
                    <a:pt x="747" y="1256"/>
                  </a:lnTo>
                  <a:lnTo>
                    <a:pt x="749" y="1255"/>
                  </a:lnTo>
                  <a:lnTo>
                    <a:pt x="751" y="1256"/>
                  </a:lnTo>
                  <a:lnTo>
                    <a:pt x="753" y="1256"/>
                  </a:lnTo>
                  <a:lnTo>
                    <a:pt x="755" y="1256"/>
                  </a:lnTo>
                  <a:lnTo>
                    <a:pt x="757" y="1256"/>
                  </a:lnTo>
                  <a:lnTo>
                    <a:pt x="759" y="1256"/>
                  </a:lnTo>
                  <a:lnTo>
                    <a:pt x="761" y="1256"/>
                  </a:lnTo>
                  <a:lnTo>
                    <a:pt x="763" y="1256"/>
                  </a:lnTo>
                  <a:lnTo>
                    <a:pt x="765" y="1256"/>
                  </a:lnTo>
                  <a:lnTo>
                    <a:pt x="767" y="1256"/>
                  </a:lnTo>
                  <a:lnTo>
                    <a:pt x="769" y="1256"/>
                  </a:lnTo>
                  <a:lnTo>
                    <a:pt x="771" y="1256"/>
                  </a:lnTo>
                  <a:lnTo>
                    <a:pt x="773" y="1256"/>
                  </a:lnTo>
                  <a:lnTo>
                    <a:pt x="775" y="1256"/>
                  </a:lnTo>
                  <a:lnTo>
                    <a:pt x="777" y="1255"/>
                  </a:lnTo>
                  <a:lnTo>
                    <a:pt x="779" y="1255"/>
                  </a:lnTo>
                  <a:lnTo>
                    <a:pt x="781" y="1255"/>
                  </a:lnTo>
                  <a:lnTo>
                    <a:pt x="783" y="1255"/>
                  </a:lnTo>
                  <a:lnTo>
                    <a:pt x="785" y="1255"/>
                  </a:lnTo>
                  <a:lnTo>
                    <a:pt x="787" y="1255"/>
                  </a:lnTo>
                  <a:lnTo>
                    <a:pt x="789" y="1255"/>
                  </a:lnTo>
                  <a:lnTo>
                    <a:pt x="791" y="1255"/>
                  </a:lnTo>
                  <a:lnTo>
                    <a:pt x="793" y="1255"/>
                  </a:lnTo>
                  <a:lnTo>
                    <a:pt x="795" y="1255"/>
                  </a:lnTo>
                  <a:lnTo>
                    <a:pt x="797" y="1255"/>
                  </a:lnTo>
                  <a:lnTo>
                    <a:pt x="799" y="1255"/>
                  </a:lnTo>
                  <a:lnTo>
                    <a:pt x="801" y="1255"/>
                  </a:lnTo>
                  <a:lnTo>
                    <a:pt x="803" y="1255"/>
                  </a:lnTo>
                  <a:lnTo>
                    <a:pt x="805" y="1255"/>
                  </a:lnTo>
                  <a:lnTo>
                    <a:pt x="807" y="1255"/>
                  </a:lnTo>
                  <a:lnTo>
                    <a:pt x="809" y="1255"/>
                  </a:lnTo>
                  <a:lnTo>
                    <a:pt x="811" y="1254"/>
                  </a:lnTo>
                  <a:lnTo>
                    <a:pt x="813" y="1254"/>
                  </a:lnTo>
                  <a:lnTo>
                    <a:pt x="815" y="1254"/>
                  </a:lnTo>
                  <a:lnTo>
                    <a:pt x="817" y="1254"/>
                  </a:lnTo>
                  <a:lnTo>
                    <a:pt x="819" y="1254"/>
                  </a:lnTo>
                  <a:lnTo>
                    <a:pt x="821" y="1253"/>
                  </a:lnTo>
                  <a:lnTo>
                    <a:pt x="823" y="1253"/>
                  </a:lnTo>
                  <a:lnTo>
                    <a:pt x="825" y="1253"/>
                  </a:lnTo>
                  <a:lnTo>
                    <a:pt x="828" y="1253"/>
                  </a:lnTo>
                  <a:lnTo>
                    <a:pt x="830" y="1253"/>
                  </a:lnTo>
                  <a:lnTo>
                    <a:pt x="832" y="1253"/>
                  </a:lnTo>
                  <a:lnTo>
                    <a:pt x="834" y="1253"/>
                  </a:lnTo>
                  <a:lnTo>
                    <a:pt x="836" y="1253"/>
                  </a:lnTo>
                  <a:lnTo>
                    <a:pt x="838" y="1254"/>
                  </a:lnTo>
                  <a:lnTo>
                    <a:pt x="840" y="1253"/>
                  </a:lnTo>
                  <a:lnTo>
                    <a:pt x="842" y="1253"/>
                  </a:lnTo>
                  <a:lnTo>
                    <a:pt x="844" y="1253"/>
                  </a:lnTo>
                  <a:lnTo>
                    <a:pt x="846" y="1254"/>
                  </a:lnTo>
                  <a:lnTo>
                    <a:pt x="848" y="1254"/>
                  </a:lnTo>
                  <a:lnTo>
                    <a:pt x="850" y="1253"/>
                  </a:lnTo>
                  <a:lnTo>
                    <a:pt x="852" y="1253"/>
                  </a:lnTo>
                  <a:lnTo>
                    <a:pt x="854" y="1253"/>
                  </a:lnTo>
                  <a:lnTo>
                    <a:pt x="856" y="1254"/>
                  </a:lnTo>
                  <a:lnTo>
                    <a:pt x="858" y="1254"/>
                  </a:lnTo>
                  <a:lnTo>
                    <a:pt x="860" y="1253"/>
                  </a:lnTo>
                  <a:lnTo>
                    <a:pt x="862" y="1253"/>
                  </a:lnTo>
                  <a:lnTo>
                    <a:pt x="864" y="1253"/>
                  </a:lnTo>
                  <a:lnTo>
                    <a:pt x="866" y="1253"/>
                  </a:lnTo>
                  <a:lnTo>
                    <a:pt x="868" y="1253"/>
                  </a:lnTo>
                  <a:lnTo>
                    <a:pt x="870" y="1253"/>
                  </a:lnTo>
                  <a:lnTo>
                    <a:pt x="872" y="1253"/>
                  </a:lnTo>
                  <a:lnTo>
                    <a:pt x="874" y="1253"/>
                  </a:lnTo>
                  <a:lnTo>
                    <a:pt x="876" y="1253"/>
                  </a:lnTo>
                  <a:lnTo>
                    <a:pt x="878" y="1253"/>
                  </a:lnTo>
                  <a:lnTo>
                    <a:pt x="880" y="1253"/>
                  </a:lnTo>
                  <a:lnTo>
                    <a:pt x="882" y="1253"/>
                  </a:lnTo>
                  <a:lnTo>
                    <a:pt x="884" y="1253"/>
                  </a:lnTo>
                  <a:lnTo>
                    <a:pt x="886" y="1253"/>
                  </a:lnTo>
                  <a:lnTo>
                    <a:pt x="888" y="1253"/>
                  </a:lnTo>
                  <a:lnTo>
                    <a:pt x="890" y="1252"/>
                  </a:lnTo>
                  <a:lnTo>
                    <a:pt x="892" y="1252"/>
                  </a:lnTo>
                  <a:lnTo>
                    <a:pt x="894" y="1252"/>
                  </a:lnTo>
                  <a:lnTo>
                    <a:pt x="896" y="1251"/>
                  </a:lnTo>
                  <a:lnTo>
                    <a:pt x="898" y="1249"/>
                  </a:lnTo>
                  <a:lnTo>
                    <a:pt x="900" y="1247"/>
                  </a:lnTo>
                  <a:lnTo>
                    <a:pt x="902" y="1244"/>
                  </a:lnTo>
                  <a:lnTo>
                    <a:pt x="904" y="1240"/>
                  </a:lnTo>
                  <a:lnTo>
                    <a:pt x="906" y="1233"/>
                  </a:lnTo>
                  <a:lnTo>
                    <a:pt x="908" y="1225"/>
                  </a:lnTo>
                  <a:lnTo>
                    <a:pt x="910" y="1215"/>
                  </a:lnTo>
                  <a:lnTo>
                    <a:pt x="912" y="1204"/>
                  </a:lnTo>
                  <a:lnTo>
                    <a:pt x="914" y="1190"/>
                  </a:lnTo>
                  <a:lnTo>
                    <a:pt x="916" y="1177"/>
                  </a:lnTo>
                  <a:lnTo>
                    <a:pt x="918" y="1162"/>
                  </a:lnTo>
                  <a:lnTo>
                    <a:pt x="920" y="1149"/>
                  </a:lnTo>
                  <a:lnTo>
                    <a:pt x="922" y="1137"/>
                  </a:lnTo>
                  <a:lnTo>
                    <a:pt x="924" y="1127"/>
                  </a:lnTo>
                  <a:lnTo>
                    <a:pt x="926" y="1120"/>
                  </a:lnTo>
                  <a:lnTo>
                    <a:pt x="928" y="1115"/>
                  </a:lnTo>
                  <a:lnTo>
                    <a:pt x="930" y="1114"/>
                  </a:lnTo>
                  <a:lnTo>
                    <a:pt x="932" y="1114"/>
                  </a:lnTo>
                  <a:lnTo>
                    <a:pt x="934" y="1116"/>
                  </a:lnTo>
                  <a:lnTo>
                    <a:pt x="936" y="1120"/>
                  </a:lnTo>
                  <a:lnTo>
                    <a:pt x="938" y="1125"/>
                  </a:lnTo>
                  <a:lnTo>
                    <a:pt x="940" y="1130"/>
                  </a:lnTo>
                  <a:lnTo>
                    <a:pt x="942" y="1136"/>
                  </a:lnTo>
                  <a:lnTo>
                    <a:pt x="944" y="1142"/>
                  </a:lnTo>
                  <a:lnTo>
                    <a:pt x="946" y="1148"/>
                  </a:lnTo>
                  <a:lnTo>
                    <a:pt x="948" y="1155"/>
                  </a:lnTo>
                  <a:lnTo>
                    <a:pt x="950" y="1161"/>
                  </a:lnTo>
                  <a:lnTo>
                    <a:pt x="952" y="1168"/>
                  </a:lnTo>
                  <a:lnTo>
                    <a:pt x="954" y="1175"/>
                  </a:lnTo>
                  <a:lnTo>
                    <a:pt x="956" y="1181"/>
                  </a:lnTo>
                  <a:lnTo>
                    <a:pt x="958" y="1188"/>
                  </a:lnTo>
                  <a:lnTo>
                    <a:pt x="961" y="1194"/>
                  </a:lnTo>
                  <a:lnTo>
                    <a:pt x="962" y="1199"/>
                  </a:lnTo>
                  <a:lnTo>
                    <a:pt x="964" y="1204"/>
                  </a:lnTo>
                  <a:lnTo>
                    <a:pt x="966" y="1209"/>
                  </a:lnTo>
                  <a:lnTo>
                    <a:pt x="968" y="1213"/>
                  </a:lnTo>
                  <a:lnTo>
                    <a:pt x="970" y="1216"/>
                  </a:lnTo>
                  <a:lnTo>
                    <a:pt x="973" y="1220"/>
                  </a:lnTo>
                  <a:lnTo>
                    <a:pt x="975" y="1222"/>
                  </a:lnTo>
                  <a:lnTo>
                    <a:pt x="977" y="1224"/>
                  </a:lnTo>
                  <a:lnTo>
                    <a:pt x="979" y="1226"/>
                  </a:lnTo>
                  <a:lnTo>
                    <a:pt x="981" y="1228"/>
                  </a:lnTo>
                  <a:lnTo>
                    <a:pt x="983" y="1229"/>
                  </a:lnTo>
                  <a:lnTo>
                    <a:pt x="985" y="1231"/>
                  </a:lnTo>
                  <a:lnTo>
                    <a:pt x="987" y="1232"/>
                  </a:lnTo>
                  <a:lnTo>
                    <a:pt x="989" y="1232"/>
                  </a:lnTo>
                  <a:lnTo>
                    <a:pt x="991" y="1233"/>
                  </a:lnTo>
                  <a:lnTo>
                    <a:pt x="993" y="1234"/>
                  </a:lnTo>
                  <a:lnTo>
                    <a:pt x="995" y="1235"/>
                  </a:lnTo>
                  <a:lnTo>
                    <a:pt x="997" y="1236"/>
                  </a:lnTo>
                  <a:lnTo>
                    <a:pt x="999" y="1236"/>
                  </a:lnTo>
                  <a:lnTo>
                    <a:pt x="1001" y="1237"/>
                  </a:lnTo>
                  <a:lnTo>
                    <a:pt x="1003" y="1237"/>
                  </a:lnTo>
                  <a:lnTo>
                    <a:pt x="1005" y="1238"/>
                  </a:lnTo>
                  <a:lnTo>
                    <a:pt x="1007" y="1238"/>
                  </a:lnTo>
                  <a:lnTo>
                    <a:pt x="1009" y="1239"/>
                  </a:lnTo>
                  <a:lnTo>
                    <a:pt x="1011" y="1239"/>
                  </a:lnTo>
                  <a:lnTo>
                    <a:pt x="1013" y="1239"/>
                  </a:lnTo>
                  <a:lnTo>
                    <a:pt x="1015" y="1240"/>
                  </a:lnTo>
                  <a:lnTo>
                    <a:pt x="1017" y="1240"/>
                  </a:lnTo>
                  <a:lnTo>
                    <a:pt x="1019" y="1239"/>
                  </a:lnTo>
                  <a:lnTo>
                    <a:pt x="1021" y="1239"/>
                  </a:lnTo>
                  <a:lnTo>
                    <a:pt x="1023" y="1238"/>
                  </a:lnTo>
                  <a:lnTo>
                    <a:pt x="1025" y="1235"/>
                  </a:lnTo>
                  <a:lnTo>
                    <a:pt x="1027" y="1231"/>
                  </a:lnTo>
                </a:path>
              </a:pathLst>
            </a:cu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14" name="Freeform 123"/>
            <p:cNvSpPr>
              <a:spLocks/>
            </p:cNvSpPr>
            <p:nvPr/>
          </p:nvSpPr>
          <p:spPr bwMode="auto">
            <a:xfrm>
              <a:off x="2028825" y="1112838"/>
              <a:ext cx="1247775" cy="1300163"/>
            </a:xfrm>
            <a:custGeom>
              <a:avLst/>
              <a:gdLst>
                <a:gd name="T0" fmla="*/ 12 w 786"/>
                <a:gd name="T1" fmla="*/ 703 h 819"/>
                <a:gd name="T2" fmla="*/ 26 w 786"/>
                <a:gd name="T3" fmla="*/ 435 h 819"/>
                <a:gd name="T4" fmla="*/ 40 w 786"/>
                <a:gd name="T5" fmla="*/ 359 h 819"/>
                <a:gd name="T6" fmla="*/ 54 w 786"/>
                <a:gd name="T7" fmla="*/ 461 h 819"/>
                <a:gd name="T8" fmla="*/ 68 w 786"/>
                <a:gd name="T9" fmla="*/ 632 h 819"/>
                <a:gd name="T10" fmla="*/ 82 w 786"/>
                <a:gd name="T11" fmla="*/ 760 h 819"/>
                <a:gd name="T12" fmla="*/ 97 w 786"/>
                <a:gd name="T13" fmla="*/ 806 h 819"/>
                <a:gd name="T14" fmla="*/ 111 w 786"/>
                <a:gd name="T15" fmla="*/ 817 h 819"/>
                <a:gd name="T16" fmla="*/ 125 w 786"/>
                <a:gd name="T17" fmla="*/ 819 h 819"/>
                <a:gd name="T18" fmla="*/ 139 w 786"/>
                <a:gd name="T19" fmla="*/ 816 h 819"/>
                <a:gd name="T20" fmla="*/ 153 w 786"/>
                <a:gd name="T21" fmla="*/ 810 h 819"/>
                <a:gd name="T22" fmla="*/ 167 w 786"/>
                <a:gd name="T23" fmla="*/ 779 h 819"/>
                <a:gd name="T24" fmla="*/ 181 w 786"/>
                <a:gd name="T25" fmla="*/ 627 h 819"/>
                <a:gd name="T26" fmla="*/ 195 w 786"/>
                <a:gd name="T27" fmla="*/ 360 h 819"/>
                <a:gd name="T28" fmla="*/ 209 w 786"/>
                <a:gd name="T29" fmla="*/ 203 h 819"/>
                <a:gd name="T30" fmla="*/ 224 w 786"/>
                <a:gd name="T31" fmla="*/ 234 h 819"/>
                <a:gd name="T32" fmla="*/ 238 w 786"/>
                <a:gd name="T33" fmla="*/ 377 h 819"/>
                <a:gd name="T34" fmla="*/ 252 w 786"/>
                <a:gd name="T35" fmla="*/ 554 h 819"/>
                <a:gd name="T36" fmla="*/ 266 w 786"/>
                <a:gd name="T37" fmla="*/ 699 h 819"/>
                <a:gd name="T38" fmla="*/ 280 w 786"/>
                <a:gd name="T39" fmla="*/ 774 h 819"/>
                <a:gd name="T40" fmla="*/ 294 w 786"/>
                <a:gd name="T41" fmla="*/ 801 h 819"/>
                <a:gd name="T42" fmla="*/ 308 w 786"/>
                <a:gd name="T43" fmla="*/ 808 h 819"/>
                <a:gd name="T44" fmla="*/ 322 w 786"/>
                <a:gd name="T45" fmla="*/ 810 h 819"/>
                <a:gd name="T46" fmla="*/ 336 w 786"/>
                <a:gd name="T47" fmla="*/ 810 h 819"/>
                <a:gd name="T48" fmla="*/ 350 w 786"/>
                <a:gd name="T49" fmla="*/ 807 h 819"/>
                <a:gd name="T50" fmla="*/ 365 w 786"/>
                <a:gd name="T51" fmla="*/ 792 h 819"/>
                <a:gd name="T52" fmla="*/ 379 w 786"/>
                <a:gd name="T53" fmla="*/ 755 h 819"/>
                <a:gd name="T54" fmla="*/ 393 w 786"/>
                <a:gd name="T55" fmla="*/ 717 h 819"/>
                <a:gd name="T56" fmla="*/ 407 w 786"/>
                <a:gd name="T57" fmla="*/ 711 h 819"/>
                <a:gd name="T58" fmla="*/ 421 w 786"/>
                <a:gd name="T59" fmla="*/ 730 h 819"/>
                <a:gd name="T60" fmla="*/ 435 w 786"/>
                <a:gd name="T61" fmla="*/ 743 h 819"/>
                <a:gd name="T62" fmla="*/ 449 w 786"/>
                <a:gd name="T63" fmla="*/ 686 h 819"/>
                <a:gd name="T64" fmla="*/ 463 w 786"/>
                <a:gd name="T65" fmla="*/ 460 h 819"/>
                <a:gd name="T66" fmla="*/ 477 w 786"/>
                <a:gd name="T67" fmla="*/ 149 h 819"/>
                <a:gd name="T68" fmla="*/ 491 w 786"/>
                <a:gd name="T69" fmla="*/ 2 h 819"/>
                <a:gd name="T70" fmla="*/ 505 w 786"/>
                <a:gd name="T71" fmla="*/ 70 h 819"/>
                <a:gd name="T72" fmla="*/ 520 w 786"/>
                <a:gd name="T73" fmla="*/ 238 h 819"/>
                <a:gd name="T74" fmla="*/ 534 w 786"/>
                <a:gd name="T75" fmla="*/ 429 h 819"/>
                <a:gd name="T76" fmla="*/ 548 w 786"/>
                <a:gd name="T77" fmla="*/ 595 h 819"/>
                <a:gd name="T78" fmla="*/ 562 w 786"/>
                <a:gd name="T79" fmla="*/ 697 h 819"/>
                <a:gd name="T80" fmla="*/ 576 w 786"/>
                <a:gd name="T81" fmla="*/ 740 h 819"/>
                <a:gd name="T82" fmla="*/ 590 w 786"/>
                <a:gd name="T83" fmla="*/ 757 h 819"/>
                <a:gd name="T84" fmla="*/ 604 w 786"/>
                <a:gd name="T85" fmla="*/ 767 h 819"/>
                <a:gd name="T86" fmla="*/ 618 w 786"/>
                <a:gd name="T87" fmla="*/ 777 h 819"/>
                <a:gd name="T88" fmla="*/ 632 w 786"/>
                <a:gd name="T89" fmla="*/ 785 h 819"/>
                <a:gd name="T90" fmla="*/ 646 w 786"/>
                <a:gd name="T91" fmla="*/ 793 h 819"/>
                <a:gd name="T92" fmla="*/ 661 w 786"/>
                <a:gd name="T93" fmla="*/ 800 h 819"/>
                <a:gd name="T94" fmla="*/ 675 w 786"/>
                <a:gd name="T95" fmla="*/ 805 h 819"/>
                <a:gd name="T96" fmla="*/ 689 w 786"/>
                <a:gd name="T97" fmla="*/ 810 h 819"/>
                <a:gd name="T98" fmla="*/ 703 w 786"/>
                <a:gd name="T99" fmla="*/ 813 h 819"/>
                <a:gd name="T100" fmla="*/ 717 w 786"/>
                <a:gd name="T101" fmla="*/ 815 h 819"/>
                <a:gd name="T102" fmla="*/ 731 w 786"/>
                <a:gd name="T103" fmla="*/ 815 h 819"/>
                <a:gd name="T104" fmla="*/ 745 w 786"/>
                <a:gd name="T105" fmla="*/ 815 h 819"/>
                <a:gd name="T106" fmla="*/ 759 w 786"/>
                <a:gd name="T107" fmla="*/ 814 h 819"/>
                <a:gd name="T108" fmla="*/ 773 w 786"/>
                <a:gd name="T109" fmla="*/ 813 h 8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786" h="819">
                  <a:moveTo>
                    <a:pt x="0" y="814"/>
                  </a:moveTo>
                  <a:lnTo>
                    <a:pt x="2" y="808"/>
                  </a:lnTo>
                  <a:lnTo>
                    <a:pt x="4" y="797"/>
                  </a:lnTo>
                  <a:lnTo>
                    <a:pt x="6" y="782"/>
                  </a:lnTo>
                  <a:lnTo>
                    <a:pt x="8" y="762"/>
                  </a:lnTo>
                  <a:lnTo>
                    <a:pt x="10" y="735"/>
                  </a:lnTo>
                  <a:lnTo>
                    <a:pt x="12" y="703"/>
                  </a:lnTo>
                  <a:lnTo>
                    <a:pt x="14" y="666"/>
                  </a:lnTo>
                  <a:lnTo>
                    <a:pt x="16" y="625"/>
                  </a:lnTo>
                  <a:lnTo>
                    <a:pt x="18" y="583"/>
                  </a:lnTo>
                  <a:lnTo>
                    <a:pt x="20" y="542"/>
                  </a:lnTo>
                  <a:lnTo>
                    <a:pt x="22" y="502"/>
                  </a:lnTo>
                  <a:lnTo>
                    <a:pt x="24" y="466"/>
                  </a:lnTo>
                  <a:lnTo>
                    <a:pt x="26" y="435"/>
                  </a:lnTo>
                  <a:lnTo>
                    <a:pt x="28" y="409"/>
                  </a:lnTo>
                  <a:lnTo>
                    <a:pt x="30" y="388"/>
                  </a:lnTo>
                  <a:lnTo>
                    <a:pt x="32" y="372"/>
                  </a:lnTo>
                  <a:lnTo>
                    <a:pt x="34" y="362"/>
                  </a:lnTo>
                  <a:lnTo>
                    <a:pt x="36" y="357"/>
                  </a:lnTo>
                  <a:lnTo>
                    <a:pt x="38" y="356"/>
                  </a:lnTo>
                  <a:lnTo>
                    <a:pt x="40" y="359"/>
                  </a:lnTo>
                  <a:lnTo>
                    <a:pt x="42" y="366"/>
                  </a:lnTo>
                  <a:lnTo>
                    <a:pt x="44" y="376"/>
                  </a:lnTo>
                  <a:lnTo>
                    <a:pt x="46" y="389"/>
                  </a:lnTo>
                  <a:lnTo>
                    <a:pt x="48" y="404"/>
                  </a:lnTo>
                  <a:lnTo>
                    <a:pt x="50" y="421"/>
                  </a:lnTo>
                  <a:lnTo>
                    <a:pt x="52" y="441"/>
                  </a:lnTo>
                  <a:lnTo>
                    <a:pt x="54" y="461"/>
                  </a:lnTo>
                  <a:lnTo>
                    <a:pt x="56" y="483"/>
                  </a:lnTo>
                  <a:lnTo>
                    <a:pt x="58" y="507"/>
                  </a:lnTo>
                  <a:lnTo>
                    <a:pt x="60" y="532"/>
                  </a:lnTo>
                  <a:lnTo>
                    <a:pt x="62" y="557"/>
                  </a:lnTo>
                  <a:lnTo>
                    <a:pt x="64" y="582"/>
                  </a:lnTo>
                  <a:lnTo>
                    <a:pt x="66" y="607"/>
                  </a:lnTo>
                  <a:lnTo>
                    <a:pt x="68" y="632"/>
                  </a:lnTo>
                  <a:lnTo>
                    <a:pt x="70" y="656"/>
                  </a:lnTo>
                  <a:lnTo>
                    <a:pt x="72" y="678"/>
                  </a:lnTo>
                  <a:lnTo>
                    <a:pt x="74" y="698"/>
                  </a:lnTo>
                  <a:lnTo>
                    <a:pt x="76" y="717"/>
                  </a:lnTo>
                  <a:lnTo>
                    <a:pt x="79" y="734"/>
                  </a:lnTo>
                  <a:lnTo>
                    <a:pt x="81" y="748"/>
                  </a:lnTo>
                  <a:lnTo>
                    <a:pt x="82" y="760"/>
                  </a:lnTo>
                  <a:lnTo>
                    <a:pt x="84" y="771"/>
                  </a:lnTo>
                  <a:lnTo>
                    <a:pt x="86" y="780"/>
                  </a:lnTo>
                  <a:lnTo>
                    <a:pt x="89" y="788"/>
                  </a:lnTo>
                  <a:lnTo>
                    <a:pt x="91" y="794"/>
                  </a:lnTo>
                  <a:lnTo>
                    <a:pt x="93" y="799"/>
                  </a:lnTo>
                  <a:lnTo>
                    <a:pt x="95" y="803"/>
                  </a:lnTo>
                  <a:lnTo>
                    <a:pt x="97" y="806"/>
                  </a:lnTo>
                  <a:lnTo>
                    <a:pt x="99" y="809"/>
                  </a:lnTo>
                  <a:lnTo>
                    <a:pt x="101" y="811"/>
                  </a:lnTo>
                  <a:lnTo>
                    <a:pt x="103" y="813"/>
                  </a:lnTo>
                  <a:lnTo>
                    <a:pt x="105" y="814"/>
                  </a:lnTo>
                  <a:lnTo>
                    <a:pt x="107" y="815"/>
                  </a:lnTo>
                  <a:lnTo>
                    <a:pt x="109" y="816"/>
                  </a:lnTo>
                  <a:lnTo>
                    <a:pt x="111" y="817"/>
                  </a:lnTo>
                  <a:lnTo>
                    <a:pt x="113" y="817"/>
                  </a:lnTo>
                  <a:lnTo>
                    <a:pt x="115" y="818"/>
                  </a:lnTo>
                  <a:lnTo>
                    <a:pt x="117" y="818"/>
                  </a:lnTo>
                  <a:lnTo>
                    <a:pt x="119" y="818"/>
                  </a:lnTo>
                  <a:lnTo>
                    <a:pt x="121" y="818"/>
                  </a:lnTo>
                  <a:lnTo>
                    <a:pt x="123" y="818"/>
                  </a:lnTo>
                  <a:lnTo>
                    <a:pt x="125" y="819"/>
                  </a:lnTo>
                  <a:lnTo>
                    <a:pt x="127" y="819"/>
                  </a:lnTo>
                  <a:lnTo>
                    <a:pt x="129" y="818"/>
                  </a:lnTo>
                  <a:lnTo>
                    <a:pt x="131" y="818"/>
                  </a:lnTo>
                  <a:lnTo>
                    <a:pt x="133" y="818"/>
                  </a:lnTo>
                  <a:lnTo>
                    <a:pt x="135" y="818"/>
                  </a:lnTo>
                  <a:lnTo>
                    <a:pt x="137" y="817"/>
                  </a:lnTo>
                  <a:lnTo>
                    <a:pt x="139" y="816"/>
                  </a:lnTo>
                  <a:lnTo>
                    <a:pt x="141" y="816"/>
                  </a:lnTo>
                  <a:lnTo>
                    <a:pt x="143" y="815"/>
                  </a:lnTo>
                  <a:lnTo>
                    <a:pt x="145" y="815"/>
                  </a:lnTo>
                  <a:lnTo>
                    <a:pt x="147" y="814"/>
                  </a:lnTo>
                  <a:lnTo>
                    <a:pt x="149" y="813"/>
                  </a:lnTo>
                  <a:lnTo>
                    <a:pt x="151" y="812"/>
                  </a:lnTo>
                  <a:lnTo>
                    <a:pt x="153" y="810"/>
                  </a:lnTo>
                  <a:lnTo>
                    <a:pt x="155" y="809"/>
                  </a:lnTo>
                  <a:lnTo>
                    <a:pt x="157" y="807"/>
                  </a:lnTo>
                  <a:lnTo>
                    <a:pt x="159" y="804"/>
                  </a:lnTo>
                  <a:lnTo>
                    <a:pt x="161" y="800"/>
                  </a:lnTo>
                  <a:lnTo>
                    <a:pt x="163" y="795"/>
                  </a:lnTo>
                  <a:lnTo>
                    <a:pt x="165" y="788"/>
                  </a:lnTo>
                  <a:lnTo>
                    <a:pt x="167" y="779"/>
                  </a:lnTo>
                  <a:lnTo>
                    <a:pt x="169" y="768"/>
                  </a:lnTo>
                  <a:lnTo>
                    <a:pt x="171" y="753"/>
                  </a:lnTo>
                  <a:lnTo>
                    <a:pt x="173" y="735"/>
                  </a:lnTo>
                  <a:lnTo>
                    <a:pt x="175" y="714"/>
                  </a:lnTo>
                  <a:lnTo>
                    <a:pt x="177" y="689"/>
                  </a:lnTo>
                  <a:lnTo>
                    <a:pt x="179" y="660"/>
                  </a:lnTo>
                  <a:lnTo>
                    <a:pt x="181" y="627"/>
                  </a:lnTo>
                  <a:lnTo>
                    <a:pt x="183" y="592"/>
                  </a:lnTo>
                  <a:lnTo>
                    <a:pt x="185" y="555"/>
                  </a:lnTo>
                  <a:lnTo>
                    <a:pt x="187" y="515"/>
                  </a:lnTo>
                  <a:lnTo>
                    <a:pt x="189" y="474"/>
                  </a:lnTo>
                  <a:lnTo>
                    <a:pt x="191" y="435"/>
                  </a:lnTo>
                  <a:lnTo>
                    <a:pt x="193" y="397"/>
                  </a:lnTo>
                  <a:lnTo>
                    <a:pt x="195" y="360"/>
                  </a:lnTo>
                  <a:lnTo>
                    <a:pt x="197" y="325"/>
                  </a:lnTo>
                  <a:lnTo>
                    <a:pt x="199" y="295"/>
                  </a:lnTo>
                  <a:lnTo>
                    <a:pt x="201" y="269"/>
                  </a:lnTo>
                  <a:lnTo>
                    <a:pt x="203" y="246"/>
                  </a:lnTo>
                  <a:lnTo>
                    <a:pt x="205" y="227"/>
                  </a:lnTo>
                  <a:lnTo>
                    <a:pt x="207" y="212"/>
                  </a:lnTo>
                  <a:lnTo>
                    <a:pt x="209" y="203"/>
                  </a:lnTo>
                  <a:lnTo>
                    <a:pt x="211" y="197"/>
                  </a:lnTo>
                  <a:lnTo>
                    <a:pt x="213" y="195"/>
                  </a:lnTo>
                  <a:lnTo>
                    <a:pt x="215" y="196"/>
                  </a:lnTo>
                  <a:lnTo>
                    <a:pt x="217" y="201"/>
                  </a:lnTo>
                  <a:lnTo>
                    <a:pt x="219" y="209"/>
                  </a:lnTo>
                  <a:lnTo>
                    <a:pt x="222" y="220"/>
                  </a:lnTo>
                  <a:lnTo>
                    <a:pt x="224" y="234"/>
                  </a:lnTo>
                  <a:lnTo>
                    <a:pt x="226" y="249"/>
                  </a:lnTo>
                  <a:lnTo>
                    <a:pt x="228" y="268"/>
                  </a:lnTo>
                  <a:lnTo>
                    <a:pt x="230" y="287"/>
                  </a:lnTo>
                  <a:lnTo>
                    <a:pt x="232" y="307"/>
                  </a:lnTo>
                  <a:lnTo>
                    <a:pt x="234" y="329"/>
                  </a:lnTo>
                  <a:lnTo>
                    <a:pt x="236" y="353"/>
                  </a:lnTo>
                  <a:lnTo>
                    <a:pt x="238" y="377"/>
                  </a:lnTo>
                  <a:lnTo>
                    <a:pt x="240" y="401"/>
                  </a:lnTo>
                  <a:lnTo>
                    <a:pt x="242" y="426"/>
                  </a:lnTo>
                  <a:lnTo>
                    <a:pt x="244" y="452"/>
                  </a:lnTo>
                  <a:lnTo>
                    <a:pt x="246" y="478"/>
                  </a:lnTo>
                  <a:lnTo>
                    <a:pt x="248" y="503"/>
                  </a:lnTo>
                  <a:lnTo>
                    <a:pt x="250" y="528"/>
                  </a:lnTo>
                  <a:lnTo>
                    <a:pt x="252" y="554"/>
                  </a:lnTo>
                  <a:lnTo>
                    <a:pt x="254" y="578"/>
                  </a:lnTo>
                  <a:lnTo>
                    <a:pt x="256" y="602"/>
                  </a:lnTo>
                  <a:lnTo>
                    <a:pt x="258" y="624"/>
                  </a:lnTo>
                  <a:lnTo>
                    <a:pt x="260" y="645"/>
                  </a:lnTo>
                  <a:lnTo>
                    <a:pt x="262" y="664"/>
                  </a:lnTo>
                  <a:lnTo>
                    <a:pt x="264" y="683"/>
                  </a:lnTo>
                  <a:lnTo>
                    <a:pt x="266" y="699"/>
                  </a:lnTo>
                  <a:lnTo>
                    <a:pt x="268" y="714"/>
                  </a:lnTo>
                  <a:lnTo>
                    <a:pt x="270" y="727"/>
                  </a:lnTo>
                  <a:lnTo>
                    <a:pt x="272" y="740"/>
                  </a:lnTo>
                  <a:lnTo>
                    <a:pt x="274" y="750"/>
                  </a:lnTo>
                  <a:lnTo>
                    <a:pt x="276" y="759"/>
                  </a:lnTo>
                  <a:lnTo>
                    <a:pt x="278" y="767"/>
                  </a:lnTo>
                  <a:lnTo>
                    <a:pt x="280" y="774"/>
                  </a:lnTo>
                  <a:lnTo>
                    <a:pt x="282" y="780"/>
                  </a:lnTo>
                  <a:lnTo>
                    <a:pt x="284" y="785"/>
                  </a:lnTo>
                  <a:lnTo>
                    <a:pt x="286" y="789"/>
                  </a:lnTo>
                  <a:lnTo>
                    <a:pt x="288" y="793"/>
                  </a:lnTo>
                  <a:lnTo>
                    <a:pt x="290" y="796"/>
                  </a:lnTo>
                  <a:lnTo>
                    <a:pt x="292" y="799"/>
                  </a:lnTo>
                  <a:lnTo>
                    <a:pt x="294" y="801"/>
                  </a:lnTo>
                  <a:lnTo>
                    <a:pt x="296" y="802"/>
                  </a:lnTo>
                  <a:lnTo>
                    <a:pt x="298" y="804"/>
                  </a:lnTo>
                  <a:lnTo>
                    <a:pt x="300" y="805"/>
                  </a:lnTo>
                  <a:lnTo>
                    <a:pt x="302" y="806"/>
                  </a:lnTo>
                  <a:lnTo>
                    <a:pt x="304" y="807"/>
                  </a:lnTo>
                  <a:lnTo>
                    <a:pt x="306" y="807"/>
                  </a:lnTo>
                  <a:lnTo>
                    <a:pt x="308" y="808"/>
                  </a:lnTo>
                  <a:lnTo>
                    <a:pt x="310" y="808"/>
                  </a:lnTo>
                  <a:lnTo>
                    <a:pt x="312" y="809"/>
                  </a:lnTo>
                  <a:lnTo>
                    <a:pt x="314" y="809"/>
                  </a:lnTo>
                  <a:lnTo>
                    <a:pt x="316" y="809"/>
                  </a:lnTo>
                  <a:lnTo>
                    <a:pt x="318" y="809"/>
                  </a:lnTo>
                  <a:lnTo>
                    <a:pt x="320" y="810"/>
                  </a:lnTo>
                  <a:lnTo>
                    <a:pt x="322" y="810"/>
                  </a:lnTo>
                  <a:lnTo>
                    <a:pt x="324" y="810"/>
                  </a:lnTo>
                  <a:lnTo>
                    <a:pt x="326" y="810"/>
                  </a:lnTo>
                  <a:lnTo>
                    <a:pt x="328" y="810"/>
                  </a:lnTo>
                  <a:lnTo>
                    <a:pt x="330" y="810"/>
                  </a:lnTo>
                  <a:lnTo>
                    <a:pt x="332" y="810"/>
                  </a:lnTo>
                  <a:lnTo>
                    <a:pt x="334" y="810"/>
                  </a:lnTo>
                  <a:lnTo>
                    <a:pt x="336" y="810"/>
                  </a:lnTo>
                  <a:lnTo>
                    <a:pt x="338" y="810"/>
                  </a:lnTo>
                  <a:lnTo>
                    <a:pt x="340" y="810"/>
                  </a:lnTo>
                  <a:lnTo>
                    <a:pt x="342" y="810"/>
                  </a:lnTo>
                  <a:lnTo>
                    <a:pt x="344" y="809"/>
                  </a:lnTo>
                  <a:lnTo>
                    <a:pt x="346" y="809"/>
                  </a:lnTo>
                  <a:lnTo>
                    <a:pt x="348" y="808"/>
                  </a:lnTo>
                  <a:lnTo>
                    <a:pt x="350" y="807"/>
                  </a:lnTo>
                  <a:lnTo>
                    <a:pt x="352" y="806"/>
                  </a:lnTo>
                  <a:lnTo>
                    <a:pt x="354" y="805"/>
                  </a:lnTo>
                  <a:lnTo>
                    <a:pt x="356" y="804"/>
                  </a:lnTo>
                  <a:lnTo>
                    <a:pt x="358" y="801"/>
                  </a:lnTo>
                  <a:lnTo>
                    <a:pt x="360" y="799"/>
                  </a:lnTo>
                  <a:lnTo>
                    <a:pt x="362" y="796"/>
                  </a:lnTo>
                  <a:lnTo>
                    <a:pt x="365" y="792"/>
                  </a:lnTo>
                  <a:lnTo>
                    <a:pt x="367" y="788"/>
                  </a:lnTo>
                  <a:lnTo>
                    <a:pt x="369" y="784"/>
                  </a:lnTo>
                  <a:lnTo>
                    <a:pt x="371" y="778"/>
                  </a:lnTo>
                  <a:lnTo>
                    <a:pt x="373" y="773"/>
                  </a:lnTo>
                  <a:lnTo>
                    <a:pt x="375" y="767"/>
                  </a:lnTo>
                  <a:lnTo>
                    <a:pt x="377" y="761"/>
                  </a:lnTo>
                  <a:lnTo>
                    <a:pt x="379" y="755"/>
                  </a:lnTo>
                  <a:lnTo>
                    <a:pt x="381" y="748"/>
                  </a:lnTo>
                  <a:lnTo>
                    <a:pt x="383" y="742"/>
                  </a:lnTo>
                  <a:lnTo>
                    <a:pt x="385" y="736"/>
                  </a:lnTo>
                  <a:lnTo>
                    <a:pt x="387" y="730"/>
                  </a:lnTo>
                  <a:lnTo>
                    <a:pt x="389" y="725"/>
                  </a:lnTo>
                  <a:lnTo>
                    <a:pt x="391" y="721"/>
                  </a:lnTo>
                  <a:lnTo>
                    <a:pt x="393" y="717"/>
                  </a:lnTo>
                  <a:lnTo>
                    <a:pt x="395" y="714"/>
                  </a:lnTo>
                  <a:lnTo>
                    <a:pt x="397" y="711"/>
                  </a:lnTo>
                  <a:lnTo>
                    <a:pt x="399" y="710"/>
                  </a:lnTo>
                  <a:lnTo>
                    <a:pt x="401" y="709"/>
                  </a:lnTo>
                  <a:lnTo>
                    <a:pt x="403" y="709"/>
                  </a:lnTo>
                  <a:lnTo>
                    <a:pt x="405" y="710"/>
                  </a:lnTo>
                  <a:lnTo>
                    <a:pt x="407" y="711"/>
                  </a:lnTo>
                  <a:lnTo>
                    <a:pt x="409" y="713"/>
                  </a:lnTo>
                  <a:lnTo>
                    <a:pt x="411" y="715"/>
                  </a:lnTo>
                  <a:lnTo>
                    <a:pt x="413" y="718"/>
                  </a:lnTo>
                  <a:lnTo>
                    <a:pt x="415" y="720"/>
                  </a:lnTo>
                  <a:lnTo>
                    <a:pt x="417" y="723"/>
                  </a:lnTo>
                  <a:lnTo>
                    <a:pt x="419" y="727"/>
                  </a:lnTo>
                  <a:lnTo>
                    <a:pt x="421" y="730"/>
                  </a:lnTo>
                  <a:lnTo>
                    <a:pt x="423" y="733"/>
                  </a:lnTo>
                  <a:lnTo>
                    <a:pt x="425" y="736"/>
                  </a:lnTo>
                  <a:lnTo>
                    <a:pt x="427" y="739"/>
                  </a:lnTo>
                  <a:lnTo>
                    <a:pt x="429" y="741"/>
                  </a:lnTo>
                  <a:lnTo>
                    <a:pt x="431" y="743"/>
                  </a:lnTo>
                  <a:lnTo>
                    <a:pt x="433" y="743"/>
                  </a:lnTo>
                  <a:lnTo>
                    <a:pt x="435" y="743"/>
                  </a:lnTo>
                  <a:lnTo>
                    <a:pt x="437" y="742"/>
                  </a:lnTo>
                  <a:lnTo>
                    <a:pt x="439" y="739"/>
                  </a:lnTo>
                  <a:lnTo>
                    <a:pt x="441" y="734"/>
                  </a:lnTo>
                  <a:lnTo>
                    <a:pt x="443" y="727"/>
                  </a:lnTo>
                  <a:lnTo>
                    <a:pt x="445" y="716"/>
                  </a:lnTo>
                  <a:lnTo>
                    <a:pt x="447" y="703"/>
                  </a:lnTo>
                  <a:lnTo>
                    <a:pt x="449" y="686"/>
                  </a:lnTo>
                  <a:lnTo>
                    <a:pt x="451" y="666"/>
                  </a:lnTo>
                  <a:lnTo>
                    <a:pt x="453" y="641"/>
                  </a:lnTo>
                  <a:lnTo>
                    <a:pt x="455" y="612"/>
                  </a:lnTo>
                  <a:lnTo>
                    <a:pt x="457" y="579"/>
                  </a:lnTo>
                  <a:lnTo>
                    <a:pt x="459" y="543"/>
                  </a:lnTo>
                  <a:lnTo>
                    <a:pt x="461" y="503"/>
                  </a:lnTo>
                  <a:lnTo>
                    <a:pt x="463" y="460"/>
                  </a:lnTo>
                  <a:lnTo>
                    <a:pt x="465" y="415"/>
                  </a:lnTo>
                  <a:lnTo>
                    <a:pt x="467" y="368"/>
                  </a:lnTo>
                  <a:lnTo>
                    <a:pt x="469" y="322"/>
                  </a:lnTo>
                  <a:lnTo>
                    <a:pt x="471" y="276"/>
                  </a:lnTo>
                  <a:lnTo>
                    <a:pt x="473" y="231"/>
                  </a:lnTo>
                  <a:lnTo>
                    <a:pt x="475" y="188"/>
                  </a:lnTo>
                  <a:lnTo>
                    <a:pt x="477" y="149"/>
                  </a:lnTo>
                  <a:lnTo>
                    <a:pt x="479" y="115"/>
                  </a:lnTo>
                  <a:lnTo>
                    <a:pt x="481" y="83"/>
                  </a:lnTo>
                  <a:lnTo>
                    <a:pt x="483" y="57"/>
                  </a:lnTo>
                  <a:lnTo>
                    <a:pt x="485" y="35"/>
                  </a:lnTo>
                  <a:lnTo>
                    <a:pt x="487" y="20"/>
                  </a:lnTo>
                  <a:lnTo>
                    <a:pt x="489" y="9"/>
                  </a:lnTo>
                  <a:lnTo>
                    <a:pt x="491" y="2"/>
                  </a:lnTo>
                  <a:lnTo>
                    <a:pt x="493" y="0"/>
                  </a:lnTo>
                  <a:lnTo>
                    <a:pt x="495" y="3"/>
                  </a:lnTo>
                  <a:lnTo>
                    <a:pt x="497" y="11"/>
                  </a:lnTo>
                  <a:lnTo>
                    <a:pt x="499" y="21"/>
                  </a:lnTo>
                  <a:lnTo>
                    <a:pt x="501" y="34"/>
                  </a:lnTo>
                  <a:lnTo>
                    <a:pt x="503" y="51"/>
                  </a:lnTo>
                  <a:lnTo>
                    <a:pt x="505" y="70"/>
                  </a:lnTo>
                  <a:lnTo>
                    <a:pt x="508" y="90"/>
                  </a:lnTo>
                  <a:lnTo>
                    <a:pt x="510" y="113"/>
                  </a:lnTo>
                  <a:lnTo>
                    <a:pt x="512" y="136"/>
                  </a:lnTo>
                  <a:lnTo>
                    <a:pt x="514" y="161"/>
                  </a:lnTo>
                  <a:lnTo>
                    <a:pt x="516" y="186"/>
                  </a:lnTo>
                  <a:lnTo>
                    <a:pt x="518" y="212"/>
                  </a:lnTo>
                  <a:lnTo>
                    <a:pt x="520" y="238"/>
                  </a:lnTo>
                  <a:lnTo>
                    <a:pt x="522" y="266"/>
                  </a:lnTo>
                  <a:lnTo>
                    <a:pt x="524" y="293"/>
                  </a:lnTo>
                  <a:lnTo>
                    <a:pt x="526" y="320"/>
                  </a:lnTo>
                  <a:lnTo>
                    <a:pt x="528" y="347"/>
                  </a:lnTo>
                  <a:lnTo>
                    <a:pt x="530" y="375"/>
                  </a:lnTo>
                  <a:lnTo>
                    <a:pt x="532" y="402"/>
                  </a:lnTo>
                  <a:lnTo>
                    <a:pt x="534" y="429"/>
                  </a:lnTo>
                  <a:lnTo>
                    <a:pt x="536" y="455"/>
                  </a:lnTo>
                  <a:lnTo>
                    <a:pt x="538" y="481"/>
                  </a:lnTo>
                  <a:lnTo>
                    <a:pt x="540" y="506"/>
                  </a:lnTo>
                  <a:lnTo>
                    <a:pt x="542" y="531"/>
                  </a:lnTo>
                  <a:lnTo>
                    <a:pt x="544" y="553"/>
                  </a:lnTo>
                  <a:lnTo>
                    <a:pt x="546" y="575"/>
                  </a:lnTo>
                  <a:lnTo>
                    <a:pt x="548" y="595"/>
                  </a:lnTo>
                  <a:lnTo>
                    <a:pt x="550" y="615"/>
                  </a:lnTo>
                  <a:lnTo>
                    <a:pt x="552" y="632"/>
                  </a:lnTo>
                  <a:lnTo>
                    <a:pt x="554" y="648"/>
                  </a:lnTo>
                  <a:lnTo>
                    <a:pt x="556" y="662"/>
                  </a:lnTo>
                  <a:lnTo>
                    <a:pt x="558" y="675"/>
                  </a:lnTo>
                  <a:lnTo>
                    <a:pt x="560" y="687"/>
                  </a:lnTo>
                  <a:lnTo>
                    <a:pt x="562" y="697"/>
                  </a:lnTo>
                  <a:lnTo>
                    <a:pt x="564" y="706"/>
                  </a:lnTo>
                  <a:lnTo>
                    <a:pt x="566" y="714"/>
                  </a:lnTo>
                  <a:lnTo>
                    <a:pt x="568" y="721"/>
                  </a:lnTo>
                  <a:lnTo>
                    <a:pt x="570" y="727"/>
                  </a:lnTo>
                  <a:lnTo>
                    <a:pt x="572" y="732"/>
                  </a:lnTo>
                  <a:lnTo>
                    <a:pt x="574" y="736"/>
                  </a:lnTo>
                  <a:lnTo>
                    <a:pt x="576" y="740"/>
                  </a:lnTo>
                  <a:lnTo>
                    <a:pt x="578" y="744"/>
                  </a:lnTo>
                  <a:lnTo>
                    <a:pt x="580" y="747"/>
                  </a:lnTo>
                  <a:lnTo>
                    <a:pt x="582" y="749"/>
                  </a:lnTo>
                  <a:lnTo>
                    <a:pt x="584" y="751"/>
                  </a:lnTo>
                  <a:lnTo>
                    <a:pt x="586" y="753"/>
                  </a:lnTo>
                  <a:lnTo>
                    <a:pt x="588" y="756"/>
                  </a:lnTo>
                  <a:lnTo>
                    <a:pt x="590" y="757"/>
                  </a:lnTo>
                  <a:lnTo>
                    <a:pt x="592" y="759"/>
                  </a:lnTo>
                  <a:lnTo>
                    <a:pt x="594" y="760"/>
                  </a:lnTo>
                  <a:lnTo>
                    <a:pt x="596" y="762"/>
                  </a:lnTo>
                  <a:lnTo>
                    <a:pt x="598" y="763"/>
                  </a:lnTo>
                  <a:lnTo>
                    <a:pt x="600" y="765"/>
                  </a:lnTo>
                  <a:lnTo>
                    <a:pt x="602" y="766"/>
                  </a:lnTo>
                  <a:lnTo>
                    <a:pt x="604" y="767"/>
                  </a:lnTo>
                  <a:lnTo>
                    <a:pt x="606" y="769"/>
                  </a:lnTo>
                  <a:lnTo>
                    <a:pt x="608" y="770"/>
                  </a:lnTo>
                  <a:lnTo>
                    <a:pt x="610" y="771"/>
                  </a:lnTo>
                  <a:lnTo>
                    <a:pt x="612" y="773"/>
                  </a:lnTo>
                  <a:lnTo>
                    <a:pt x="614" y="774"/>
                  </a:lnTo>
                  <a:lnTo>
                    <a:pt x="616" y="776"/>
                  </a:lnTo>
                  <a:lnTo>
                    <a:pt x="618" y="777"/>
                  </a:lnTo>
                  <a:lnTo>
                    <a:pt x="620" y="778"/>
                  </a:lnTo>
                  <a:lnTo>
                    <a:pt x="622" y="779"/>
                  </a:lnTo>
                  <a:lnTo>
                    <a:pt x="624" y="780"/>
                  </a:lnTo>
                  <a:lnTo>
                    <a:pt x="626" y="782"/>
                  </a:lnTo>
                  <a:lnTo>
                    <a:pt x="628" y="783"/>
                  </a:lnTo>
                  <a:lnTo>
                    <a:pt x="630" y="784"/>
                  </a:lnTo>
                  <a:lnTo>
                    <a:pt x="632" y="785"/>
                  </a:lnTo>
                  <a:lnTo>
                    <a:pt x="634" y="787"/>
                  </a:lnTo>
                  <a:lnTo>
                    <a:pt x="636" y="788"/>
                  </a:lnTo>
                  <a:lnTo>
                    <a:pt x="638" y="789"/>
                  </a:lnTo>
                  <a:lnTo>
                    <a:pt x="641" y="790"/>
                  </a:lnTo>
                  <a:lnTo>
                    <a:pt x="642" y="791"/>
                  </a:lnTo>
                  <a:lnTo>
                    <a:pt x="644" y="792"/>
                  </a:lnTo>
                  <a:lnTo>
                    <a:pt x="646" y="793"/>
                  </a:lnTo>
                  <a:lnTo>
                    <a:pt x="648" y="794"/>
                  </a:lnTo>
                  <a:lnTo>
                    <a:pt x="651" y="795"/>
                  </a:lnTo>
                  <a:lnTo>
                    <a:pt x="653" y="796"/>
                  </a:lnTo>
                  <a:lnTo>
                    <a:pt x="655" y="797"/>
                  </a:lnTo>
                  <a:lnTo>
                    <a:pt x="657" y="798"/>
                  </a:lnTo>
                  <a:lnTo>
                    <a:pt x="659" y="799"/>
                  </a:lnTo>
                  <a:lnTo>
                    <a:pt x="661" y="800"/>
                  </a:lnTo>
                  <a:lnTo>
                    <a:pt x="663" y="801"/>
                  </a:lnTo>
                  <a:lnTo>
                    <a:pt x="665" y="802"/>
                  </a:lnTo>
                  <a:lnTo>
                    <a:pt x="667" y="803"/>
                  </a:lnTo>
                  <a:lnTo>
                    <a:pt x="669" y="803"/>
                  </a:lnTo>
                  <a:lnTo>
                    <a:pt x="671" y="804"/>
                  </a:lnTo>
                  <a:lnTo>
                    <a:pt x="673" y="805"/>
                  </a:lnTo>
                  <a:lnTo>
                    <a:pt x="675" y="805"/>
                  </a:lnTo>
                  <a:lnTo>
                    <a:pt x="677" y="806"/>
                  </a:lnTo>
                  <a:lnTo>
                    <a:pt x="679" y="807"/>
                  </a:lnTo>
                  <a:lnTo>
                    <a:pt x="681" y="808"/>
                  </a:lnTo>
                  <a:lnTo>
                    <a:pt x="683" y="808"/>
                  </a:lnTo>
                  <a:lnTo>
                    <a:pt x="685" y="809"/>
                  </a:lnTo>
                  <a:lnTo>
                    <a:pt x="687" y="809"/>
                  </a:lnTo>
                  <a:lnTo>
                    <a:pt x="689" y="810"/>
                  </a:lnTo>
                  <a:lnTo>
                    <a:pt x="691" y="811"/>
                  </a:lnTo>
                  <a:lnTo>
                    <a:pt x="693" y="811"/>
                  </a:lnTo>
                  <a:lnTo>
                    <a:pt x="695" y="811"/>
                  </a:lnTo>
                  <a:lnTo>
                    <a:pt x="697" y="812"/>
                  </a:lnTo>
                  <a:lnTo>
                    <a:pt x="699" y="813"/>
                  </a:lnTo>
                  <a:lnTo>
                    <a:pt x="701" y="813"/>
                  </a:lnTo>
                  <a:lnTo>
                    <a:pt x="703" y="813"/>
                  </a:lnTo>
                  <a:lnTo>
                    <a:pt x="705" y="813"/>
                  </a:lnTo>
                  <a:lnTo>
                    <a:pt x="707" y="814"/>
                  </a:lnTo>
                  <a:lnTo>
                    <a:pt x="709" y="814"/>
                  </a:lnTo>
                  <a:lnTo>
                    <a:pt x="711" y="814"/>
                  </a:lnTo>
                  <a:lnTo>
                    <a:pt x="713" y="814"/>
                  </a:lnTo>
                  <a:lnTo>
                    <a:pt x="715" y="815"/>
                  </a:lnTo>
                  <a:lnTo>
                    <a:pt x="717" y="815"/>
                  </a:lnTo>
                  <a:lnTo>
                    <a:pt x="719" y="815"/>
                  </a:lnTo>
                  <a:lnTo>
                    <a:pt x="721" y="815"/>
                  </a:lnTo>
                  <a:lnTo>
                    <a:pt x="723" y="815"/>
                  </a:lnTo>
                  <a:lnTo>
                    <a:pt x="725" y="815"/>
                  </a:lnTo>
                  <a:lnTo>
                    <a:pt x="727" y="816"/>
                  </a:lnTo>
                  <a:lnTo>
                    <a:pt x="729" y="815"/>
                  </a:lnTo>
                  <a:lnTo>
                    <a:pt x="731" y="815"/>
                  </a:lnTo>
                  <a:lnTo>
                    <a:pt x="733" y="815"/>
                  </a:lnTo>
                  <a:lnTo>
                    <a:pt x="735" y="816"/>
                  </a:lnTo>
                  <a:lnTo>
                    <a:pt x="737" y="816"/>
                  </a:lnTo>
                  <a:lnTo>
                    <a:pt x="739" y="815"/>
                  </a:lnTo>
                  <a:lnTo>
                    <a:pt x="741" y="815"/>
                  </a:lnTo>
                  <a:lnTo>
                    <a:pt x="743" y="815"/>
                  </a:lnTo>
                  <a:lnTo>
                    <a:pt x="745" y="815"/>
                  </a:lnTo>
                  <a:lnTo>
                    <a:pt x="747" y="815"/>
                  </a:lnTo>
                  <a:lnTo>
                    <a:pt x="749" y="815"/>
                  </a:lnTo>
                  <a:lnTo>
                    <a:pt x="751" y="815"/>
                  </a:lnTo>
                  <a:lnTo>
                    <a:pt x="753" y="815"/>
                  </a:lnTo>
                  <a:lnTo>
                    <a:pt x="755" y="815"/>
                  </a:lnTo>
                  <a:lnTo>
                    <a:pt x="757" y="814"/>
                  </a:lnTo>
                  <a:lnTo>
                    <a:pt x="759" y="814"/>
                  </a:lnTo>
                  <a:lnTo>
                    <a:pt x="761" y="814"/>
                  </a:lnTo>
                  <a:lnTo>
                    <a:pt x="763" y="814"/>
                  </a:lnTo>
                  <a:lnTo>
                    <a:pt x="765" y="814"/>
                  </a:lnTo>
                  <a:lnTo>
                    <a:pt x="767" y="814"/>
                  </a:lnTo>
                  <a:lnTo>
                    <a:pt x="769" y="814"/>
                  </a:lnTo>
                  <a:lnTo>
                    <a:pt x="771" y="814"/>
                  </a:lnTo>
                  <a:lnTo>
                    <a:pt x="773" y="813"/>
                  </a:lnTo>
                  <a:lnTo>
                    <a:pt x="775" y="813"/>
                  </a:lnTo>
                  <a:lnTo>
                    <a:pt x="777" y="813"/>
                  </a:lnTo>
                  <a:lnTo>
                    <a:pt x="779" y="813"/>
                  </a:lnTo>
                  <a:lnTo>
                    <a:pt x="781" y="813"/>
                  </a:lnTo>
                  <a:lnTo>
                    <a:pt x="783" y="812"/>
                  </a:lnTo>
                  <a:lnTo>
                    <a:pt x="786" y="812"/>
                  </a:lnTo>
                </a:path>
              </a:pathLst>
            </a:custGeom>
            <a:noFill/>
            <a:ln w="9525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grpSp>
        <p:nvGrpSpPr>
          <p:cNvPr id="1119" name="Groupe 1118"/>
          <p:cNvGrpSpPr/>
          <p:nvPr/>
        </p:nvGrpSpPr>
        <p:grpSpPr>
          <a:xfrm>
            <a:off x="3686006" y="7277887"/>
            <a:ext cx="3045624" cy="237221"/>
            <a:chOff x="355283" y="2671763"/>
            <a:chExt cx="3045624" cy="237221"/>
          </a:xfrm>
        </p:grpSpPr>
        <p:sp>
          <p:nvSpPr>
            <p:cNvPr id="7" name="Rectangle 18"/>
            <p:cNvSpPr>
              <a:spLocks noChangeArrowheads="1"/>
            </p:cNvSpPr>
            <p:nvPr/>
          </p:nvSpPr>
          <p:spPr bwMode="auto">
            <a:xfrm>
              <a:off x="355283" y="2755096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Line 19"/>
            <p:cNvSpPr>
              <a:spLocks noChangeShapeType="1"/>
            </p:cNvSpPr>
            <p:nvPr/>
          </p:nvSpPr>
          <p:spPr bwMode="auto">
            <a:xfrm>
              <a:off x="398463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" name="Line 25"/>
            <p:cNvSpPr>
              <a:spLocks noChangeShapeType="1"/>
            </p:cNvSpPr>
            <p:nvPr/>
          </p:nvSpPr>
          <p:spPr bwMode="auto">
            <a:xfrm>
              <a:off x="638175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9" name="Rectangle 30"/>
            <p:cNvSpPr>
              <a:spLocks noChangeArrowheads="1"/>
            </p:cNvSpPr>
            <p:nvPr/>
          </p:nvSpPr>
          <p:spPr bwMode="auto">
            <a:xfrm>
              <a:off x="792798" y="2755096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.5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Line 31"/>
            <p:cNvSpPr>
              <a:spLocks noChangeShapeType="1"/>
            </p:cNvSpPr>
            <p:nvPr/>
          </p:nvSpPr>
          <p:spPr bwMode="auto">
            <a:xfrm>
              <a:off x="877888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" name="Line 37"/>
            <p:cNvSpPr>
              <a:spLocks noChangeShapeType="1"/>
            </p:cNvSpPr>
            <p:nvPr/>
          </p:nvSpPr>
          <p:spPr bwMode="auto">
            <a:xfrm>
              <a:off x="1117600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1" name="Rectangle 42"/>
            <p:cNvSpPr>
              <a:spLocks noChangeArrowheads="1"/>
            </p:cNvSpPr>
            <p:nvPr/>
          </p:nvSpPr>
          <p:spPr bwMode="auto">
            <a:xfrm>
              <a:off x="1272223" y="2755096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.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4" name="Line 43"/>
            <p:cNvSpPr>
              <a:spLocks noChangeShapeType="1"/>
            </p:cNvSpPr>
            <p:nvPr/>
          </p:nvSpPr>
          <p:spPr bwMode="auto">
            <a:xfrm>
              <a:off x="1357313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2" name="Line 49"/>
            <p:cNvSpPr>
              <a:spLocks noChangeShapeType="1"/>
            </p:cNvSpPr>
            <p:nvPr/>
          </p:nvSpPr>
          <p:spPr bwMode="auto">
            <a:xfrm>
              <a:off x="1597025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7" name="Rectangle 54"/>
            <p:cNvSpPr>
              <a:spLocks noChangeArrowheads="1"/>
            </p:cNvSpPr>
            <p:nvPr/>
          </p:nvSpPr>
          <p:spPr bwMode="auto">
            <a:xfrm>
              <a:off x="1751648" y="2755096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.5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8" name="Line 55"/>
            <p:cNvSpPr>
              <a:spLocks noChangeShapeType="1"/>
            </p:cNvSpPr>
            <p:nvPr/>
          </p:nvSpPr>
          <p:spPr bwMode="auto">
            <a:xfrm>
              <a:off x="1836738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4" name="Line 61"/>
            <p:cNvSpPr>
              <a:spLocks noChangeShapeType="1"/>
            </p:cNvSpPr>
            <p:nvPr/>
          </p:nvSpPr>
          <p:spPr bwMode="auto">
            <a:xfrm>
              <a:off x="2076450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9" name="Rectangle 66"/>
            <p:cNvSpPr>
              <a:spLocks noChangeArrowheads="1"/>
            </p:cNvSpPr>
            <p:nvPr/>
          </p:nvSpPr>
          <p:spPr bwMode="auto">
            <a:xfrm>
              <a:off x="2195513" y="275509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.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0" name="Line 67"/>
            <p:cNvSpPr>
              <a:spLocks noChangeShapeType="1"/>
            </p:cNvSpPr>
            <p:nvPr/>
          </p:nvSpPr>
          <p:spPr bwMode="auto">
            <a:xfrm>
              <a:off x="2316163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66" name="Line 73"/>
            <p:cNvSpPr>
              <a:spLocks noChangeShapeType="1"/>
            </p:cNvSpPr>
            <p:nvPr/>
          </p:nvSpPr>
          <p:spPr bwMode="auto">
            <a:xfrm>
              <a:off x="2555875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1" name="Rectangle 78"/>
            <p:cNvSpPr>
              <a:spLocks noChangeArrowheads="1"/>
            </p:cNvSpPr>
            <p:nvPr/>
          </p:nvSpPr>
          <p:spPr bwMode="auto">
            <a:xfrm>
              <a:off x="2674938" y="275509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.5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2" name="Line 79"/>
            <p:cNvSpPr>
              <a:spLocks noChangeShapeType="1"/>
            </p:cNvSpPr>
            <p:nvPr/>
          </p:nvSpPr>
          <p:spPr bwMode="auto">
            <a:xfrm>
              <a:off x="2795588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8" name="Line 85"/>
            <p:cNvSpPr>
              <a:spLocks noChangeShapeType="1"/>
            </p:cNvSpPr>
            <p:nvPr/>
          </p:nvSpPr>
          <p:spPr bwMode="auto">
            <a:xfrm>
              <a:off x="3035300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3" name="Rectangle 90"/>
            <p:cNvSpPr>
              <a:spLocks noChangeArrowheads="1"/>
            </p:cNvSpPr>
            <p:nvPr/>
          </p:nvSpPr>
          <p:spPr bwMode="auto">
            <a:xfrm>
              <a:off x="3154045" y="275509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.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4" name="Line 91"/>
            <p:cNvSpPr>
              <a:spLocks noChangeShapeType="1"/>
            </p:cNvSpPr>
            <p:nvPr/>
          </p:nvSpPr>
          <p:spPr bwMode="auto">
            <a:xfrm>
              <a:off x="3276600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cxnSp>
          <p:nvCxnSpPr>
            <p:cNvPr id="1118" name="Connecteur droit 1117"/>
            <p:cNvCxnSpPr>
              <a:endCxn id="1084" idx="0"/>
            </p:cNvCxnSpPr>
            <p:nvPr/>
          </p:nvCxnSpPr>
          <p:spPr>
            <a:xfrm flipV="1">
              <a:off x="369888" y="2671763"/>
              <a:ext cx="2906712" cy="396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121" name="Connecteur droit 1120"/>
          <p:cNvCxnSpPr>
            <a:stCxn id="731" idx="0"/>
          </p:cNvCxnSpPr>
          <p:nvPr/>
        </p:nvCxnSpPr>
        <p:spPr>
          <a:xfrm flipV="1">
            <a:off x="618693" y="1333747"/>
            <a:ext cx="27352" cy="59441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3" name="Connecteur droit 1122"/>
          <p:cNvCxnSpPr/>
          <p:nvPr/>
        </p:nvCxnSpPr>
        <p:spPr>
          <a:xfrm flipH="1">
            <a:off x="602865" y="1333746"/>
            <a:ext cx="431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4" name="ZoneTexte 1123"/>
          <p:cNvSpPr txBox="1"/>
          <p:nvPr/>
        </p:nvSpPr>
        <p:spPr>
          <a:xfrm>
            <a:off x="980728" y="950580"/>
            <a:ext cx="83067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dirty="0" smtClean="0"/>
              <a:t>OG1RF</a:t>
            </a:r>
            <a:endParaRPr lang="fr-FR" dirty="0"/>
          </a:p>
        </p:txBody>
      </p:sp>
      <p:grpSp>
        <p:nvGrpSpPr>
          <p:cNvPr id="1234" name="Groupe 1233"/>
          <p:cNvGrpSpPr/>
          <p:nvPr/>
        </p:nvGrpSpPr>
        <p:grpSpPr>
          <a:xfrm>
            <a:off x="619187" y="3583362"/>
            <a:ext cx="2878137" cy="1636713"/>
            <a:chOff x="398463" y="3867150"/>
            <a:chExt cx="2878137" cy="1636713"/>
          </a:xfrm>
        </p:grpSpPr>
        <p:sp>
          <p:nvSpPr>
            <p:cNvPr id="1232" name="Freeform 232"/>
            <p:cNvSpPr>
              <a:spLocks/>
            </p:cNvSpPr>
            <p:nvPr/>
          </p:nvSpPr>
          <p:spPr bwMode="auto">
            <a:xfrm>
              <a:off x="398463" y="3867150"/>
              <a:ext cx="1630363" cy="1636713"/>
            </a:xfrm>
            <a:custGeom>
              <a:avLst/>
              <a:gdLst>
                <a:gd name="T0" fmla="*/ 14 w 1027"/>
                <a:gd name="T1" fmla="*/ 1020 h 1031"/>
                <a:gd name="T2" fmla="*/ 30 w 1027"/>
                <a:gd name="T3" fmla="*/ 1020 h 1031"/>
                <a:gd name="T4" fmla="*/ 46 w 1027"/>
                <a:gd name="T5" fmla="*/ 1019 h 1031"/>
                <a:gd name="T6" fmla="*/ 62 w 1027"/>
                <a:gd name="T7" fmla="*/ 1018 h 1031"/>
                <a:gd name="T8" fmla="*/ 78 w 1027"/>
                <a:gd name="T9" fmla="*/ 1017 h 1031"/>
                <a:gd name="T10" fmla="*/ 94 w 1027"/>
                <a:gd name="T11" fmla="*/ 1016 h 1031"/>
                <a:gd name="T12" fmla="*/ 110 w 1027"/>
                <a:gd name="T13" fmla="*/ 1015 h 1031"/>
                <a:gd name="T14" fmla="*/ 127 w 1027"/>
                <a:gd name="T15" fmla="*/ 1015 h 1031"/>
                <a:gd name="T16" fmla="*/ 143 w 1027"/>
                <a:gd name="T17" fmla="*/ 1014 h 1031"/>
                <a:gd name="T18" fmla="*/ 159 w 1027"/>
                <a:gd name="T19" fmla="*/ 1013 h 1031"/>
                <a:gd name="T20" fmla="*/ 175 w 1027"/>
                <a:gd name="T21" fmla="*/ 1025 h 1031"/>
                <a:gd name="T22" fmla="*/ 191 w 1027"/>
                <a:gd name="T23" fmla="*/ 1010 h 1031"/>
                <a:gd name="T24" fmla="*/ 207 w 1027"/>
                <a:gd name="T25" fmla="*/ 200 h 1031"/>
                <a:gd name="T26" fmla="*/ 223 w 1027"/>
                <a:gd name="T27" fmla="*/ 983 h 1031"/>
                <a:gd name="T28" fmla="*/ 239 w 1027"/>
                <a:gd name="T29" fmla="*/ 996 h 1031"/>
                <a:gd name="T30" fmla="*/ 255 w 1027"/>
                <a:gd name="T31" fmla="*/ 1001 h 1031"/>
                <a:gd name="T32" fmla="*/ 272 w 1027"/>
                <a:gd name="T33" fmla="*/ 1002 h 1031"/>
                <a:gd name="T34" fmla="*/ 288 w 1027"/>
                <a:gd name="T35" fmla="*/ 1002 h 1031"/>
                <a:gd name="T36" fmla="*/ 304 w 1027"/>
                <a:gd name="T37" fmla="*/ 1003 h 1031"/>
                <a:gd name="T38" fmla="*/ 320 w 1027"/>
                <a:gd name="T39" fmla="*/ 1003 h 1031"/>
                <a:gd name="T40" fmla="*/ 336 w 1027"/>
                <a:gd name="T41" fmla="*/ 997 h 1031"/>
                <a:gd name="T42" fmla="*/ 352 w 1027"/>
                <a:gd name="T43" fmla="*/ 996 h 1031"/>
                <a:gd name="T44" fmla="*/ 368 w 1027"/>
                <a:gd name="T45" fmla="*/ 999 h 1031"/>
                <a:gd name="T46" fmla="*/ 384 w 1027"/>
                <a:gd name="T47" fmla="*/ 984 h 1031"/>
                <a:gd name="T48" fmla="*/ 401 w 1027"/>
                <a:gd name="T49" fmla="*/ 997 h 1031"/>
                <a:gd name="T50" fmla="*/ 417 w 1027"/>
                <a:gd name="T51" fmla="*/ 1000 h 1031"/>
                <a:gd name="T52" fmla="*/ 433 w 1027"/>
                <a:gd name="T53" fmla="*/ 1000 h 1031"/>
                <a:gd name="T54" fmla="*/ 449 w 1027"/>
                <a:gd name="T55" fmla="*/ 984 h 1031"/>
                <a:gd name="T56" fmla="*/ 465 w 1027"/>
                <a:gd name="T57" fmla="*/ 974 h 1031"/>
                <a:gd name="T58" fmla="*/ 481 w 1027"/>
                <a:gd name="T59" fmla="*/ 989 h 1031"/>
                <a:gd name="T60" fmla="*/ 497 w 1027"/>
                <a:gd name="T61" fmla="*/ 995 h 1031"/>
                <a:gd name="T62" fmla="*/ 513 w 1027"/>
                <a:gd name="T63" fmla="*/ 997 h 1031"/>
                <a:gd name="T64" fmla="*/ 529 w 1027"/>
                <a:gd name="T65" fmla="*/ 992 h 1031"/>
                <a:gd name="T66" fmla="*/ 546 w 1027"/>
                <a:gd name="T67" fmla="*/ 988 h 1031"/>
                <a:gd name="T68" fmla="*/ 562 w 1027"/>
                <a:gd name="T69" fmla="*/ 994 h 1031"/>
                <a:gd name="T70" fmla="*/ 578 w 1027"/>
                <a:gd name="T71" fmla="*/ 996 h 1031"/>
                <a:gd name="T72" fmla="*/ 594 w 1027"/>
                <a:gd name="T73" fmla="*/ 997 h 1031"/>
                <a:gd name="T74" fmla="*/ 610 w 1027"/>
                <a:gd name="T75" fmla="*/ 997 h 1031"/>
                <a:gd name="T76" fmla="*/ 626 w 1027"/>
                <a:gd name="T77" fmla="*/ 997 h 1031"/>
                <a:gd name="T78" fmla="*/ 642 w 1027"/>
                <a:gd name="T79" fmla="*/ 996 h 1031"/>
                <a:gd name="T80" fmla="*/ 658 w 1027"/>
                <a:gd name="T81" fmla="*/ 996 h 1031"/>
                <a:gd name="T82" fmla="*/ 674 w 1027"/>
                <a:gd name="T83" fmla="*/ 996 h 1031"/>
                <a:gd name="T84" fmla="*/ 691 w 1027"/>
                <a:gd name="T85" fmla="*/ 996 h 1031"/>
                <a:gd name="T86" fmla="*/ 707 w 1027"/>
                <a:gd name="T87" fmla="*/ 996 h 1031"/>
                <a:gd name="T88" fmla="*/ 723 w 1027"/>
                <a:gd name="T89" fmla="*/ 995 h 1031"/>
                <a:gd name="T90" fmla="*/ 739 w 1027"/>
                <a:gd name="T91" fmla="*/ 994 h 1031"/>
                <a:gd name="T92" fmla="*/ 755 w 1027"/>
                <a:gd name="T93" fmla="*/ 994 h 1031"/>
                <a:gd name="T94" fmla="*/ 771 w 1027"/>
                <a:gd name="T95" fmla="*/ 994 h 1031"/>
                <a:gd name="T96" fmla="*/ 787 w 1027"/>
                <a:gd name="T97" fmla="*/ 993 h 1031"/>
                <a:gd name="T98" fmla="*/ 803 w 1027"/>
                <a:gd name="T99" fmla="*/ 992 h 1031"/>
                <a:gd name="T100" fmla="*/ 819 w 1027"/>
                <a:gd name="T101" fmla="*/ 992 h 1031"/>
                <a:gd name="T102" fmla="*/ 836 w 1027"/>
                <a:gd name="T103" fmla="*/ 992 h 1031"/>
                <a:gd name="T104" fmla="*/ 852 w 1027"/>
                <a:gd name="T105" fmla="*/ 992 h 1031"/>
                <a:gd name="T106" fmla="*/ 868 w 1027"/>
                <a:gd name="T107" fmla="*/ 992 h 1031"/>
                <a:gd name="T108" fmla="*/ 884 w 1027"/>
                <a:gd name="T109" fmla="*/ 991 h 1031"/>
                <a:gd name="T110" fmla="*/ 900 w 1027"/>
                <a:gd name="T111" fmla="*/ 971 h 1031"/>
                <a:gd name="T112" fmla="*/ 916 w 1027"/>
                <a:gd name="T113" fmla="*/ 910 h 1031"/>
                <a:gd name="T114" fmla="*/ 932 w 1027"/>
                <a:gd name="T115" fmla="*/ 924 h 1031"/>
                <a:gd name="T116" fmla="*/ 948 w 1027"/>
                <a:gd name="T117" fmla="*/ 957 h 1031"/>
                <a:gd name="T118" fmla="*/ 964 w 1027"/>
                <a:gd name="T119" fmla="*/ 977 h 1031"/>
                <a:gd name="T120" fmla="*/ 981 w 1027"/>
                <a:gd name="T121" fmla="*/ 982 h 1031"/>
                <a:gd name="T122" fmla="*/ 997 w 1027"/>
                <a:gd name="T123" fmla="*/ 981 h 1031"/>
                <a:gd name="T124" fmla="*/ 1013 w 1027"/>
                <a:gd name="T125" fmla="*/ 965 h 10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27" h="1031">
                  <a:moveTo>
                    <a:pt x="0" y="1021"/>
                  </a:moveTo>
                  <a:lnTo>
                    <a:pt x="2" y="1021"/>
                  </a:lnTo>
                  <a:lnTo>
                    <a:pt x="4" y="1021"/>
                  </a:lnTo>
                  <a:lnTo>
                    <a:pt x="6" y="1021"/>
                  </a:lnTo>
                  <a:lnTo>
                    <a:pt x="8" y="1021"/>
                  </a:lnTo>
                  <a:lnTo>
                    <a:pt x="10" y="1020"/>
                  </a:lnTo>
                  <a:lnTo>
                    <a:pt x="12" y="1020"/>
                  </a:lnTo>
                  <a:lnTo>
                    <a:pt x="14" y="1020"/>
                  </a:lnTo>
                  <a:lnTo>
                    <a:pt x="16" y="1020"/>
                  </a:lnTo>
                  <a:lnTo>
                    <a:pt x="18" y="1020"/>
                  </a:lnTo>
                  <a:lnTo>
                    <a:pt x="20" y="1020"/>
                  </a:lnTo>
                  <a:lnTo>
                    <a:pt x="22" y="1020"/>
                  </a:lnTo>
                  <a:lnTo>
                    <a:pt x="24" y="1020"/>
                  </a:lnTo>
                  <a:lnTo>
                    <a:pt x="26" y="1020"/>
                  </a:lnTo>
                  <a:lnTo>
                    <a:pt x="28" y="1020"/>
                  </a:lnTo>
                  <a:lnTo>
                    <a:pt x="30" y="1020"/>
                  </a:lnTo>
                  <a:lnTo>
                    <a:pt x="32" y="1020"/>
                  </a:lnTo>
                  <a:lnTo>
                    <a:pt x="34" y="1020"/>
                  </a:lnTo>
                  <a:lnTo>
                    <a:pt x="36" y="1019"/>
                  </a:lnTo>
                  <a:lnTo>
                    <a:pt x="38" y="1019"/>
                  </a:lnTo>
                  <a:lnTo>
                    <a:pt x="40" y="1019"/>
                  </a:lnTo>
                  <a:lnTo>
                    <a:pt x="42" y="1019"/>
                  </a:lnTo>
                  <a:lnTo>
                    <a:pt x="44" y="1019"/>
                  </a:lnTo>
                  <a:lnTo>
                    <a:pt x="46" y="1019"/>
                  </a:lnTo>
                  <a:lnTo>
                    <a:pt x="48" y="1019"/>
                  </a:lnTo>
                  <a:lnTo>
                    <a:pt x="50" y="1019"/>
                  </a:lnTo>
                  <a:lnTo>
                    <a:pt x="52" y="1019"/>
                  </a:lnTo>
                  <a:lnTo>
                    <a:pt x="54" y="1018"/>
                  </a:lnTo>
                  <a:lnTo>
                    <a:pt x="56" y="1018"/>
                  </a:lnTo>
                  <a:lnTo>
                    <a:pt x="58" y="1018"/>
                  </a:lnTo>
                  <a:lnTo>
                    <a:pt x="60" y="1018"/>
                  </a:lnTo>
                  <a:lnTo>
                    <a:pt x="62" y="1018"/>
                  </a:lnTo>
                  <a:lnTo>
                    <a:pt x="64" y="1018"/>
                  </a:lnTo>
                  <a:lnTo>
                    <a:pt x="66" y="1018"/>
                  </a:lnTo>
                  <a:lnTo>
                    <a:pt x="68" y="1018"/>
                  </a:lnTo>
                  <a:lnTo>
                    <a:pt x="70" y="1018"/>
                  </a:lnTo>
                  <a:lnTo>
                    <a:pt x="72" y="1018"/>
                  </a:lnTo>
                  <a:lnTo>
                    <a:pt x="74" y="1017"/>
                  </a:lnTo>
                  <a:lnTo>
                    <a:pt x="76" y="1017"/>
                  </a:lnTo>
                  <a:lnTo>
                    <a:pt x="78" y="1017"/>
                  </a:lnTo>
                  <a:lnTo>
                    <a:pt x="80" y="1017"/>
                  </a:lnTo>
                  <a:lnTo>
                    <a:pt x="82" y="1017"/>
                  </a:lnTo>
                  <a:lnTo>
                    <a:pt x="84" y="1017"/>
                  </a:lnTo>
                  <a:lnTo>
                    <a:pt x="86" y="1017"/>
                  </a:lnTo>
                  <a:lnTo>
                    <a:pt x="88" y="1017"/>
                  </a:lnTo>
                  <a:lnTo>
                    <a:pt x="90" y="1017"/>
                  </a:lnTo>
                  <a:lnTo>
                    <a:pt x="92" y="1016"/>
                  </a:lnTo>
                  <a:lnTo>
                    <a:pt x="94" y="1016"/>
                  </a:lnTo>
                  <a:lnTo>
                    <a:pt x="96" y="1016"/>
                  </a:lnTo>
                  <a:lnTo>
                    <a:pt x="98" y="1016"/>
                  </a:lnTo>
                  <a:lnTo>
                    <a:pt x="100" y="1016"/>
                  </a:lnTo>
                  <a:lnTo>
                    <a:pt x="102" y="1016"/>
                  </a:lnTo>
                  <a:lnTo>
                    <a:pt x="104" y="1016"/>
                  </a:lnTo>
                  <a:lnTo>
                    <a:pt x="106" y="1016"/>
                  </a:lnTo>
                  <a:lnTo>
                    <a:pt x="108" y="1016"/>
                  </a:lnTo>
                  <a:lnTo>
                    <a:pt x="110" y="1015"/>
                  </a:lnTo>
                  <a:lnTo>
                    <a:pt x="112" y="1015"/>
                  </a:lnTo>
                  <a:lnTo>
                    <a:pt x="114" y="1015"/>
                  </a:lnTo>
                  <a:lnTo>
                    <a:pt x="116" y="1015"/>
                  </a:lnTo>
                  <a:lnTo>
                    <a:pt x="118" y="1015"/>
                  </a:lnTo>
                  <a:lnTo>
                    <a:pt x="120" y="1015"/>
                  </a:lnTo>
                  <a:lnTo>
                    <a:pt x="123" y="1015"/>
                  </a:lnTo>
                  <a:lnTo>
                    <a:pt x="125" y="1015"/>
                  </a:lnTo>
                  <a:lnTo>
                    <a:pt x="127" y="1015"/>
                  </a:lnTo>
                  <a:lnTo>
                    <a:pt x="129" y="1015"/>
                  </a:lnTo>
                  <a:lnTo>
                    <a:pt x="131" y="1014"/>
                  </a:lnTo>
                  <a:lnTo>
                    <a:pt x="133" y="1014"/>
                  </a:lnTo>
                  <a:lnTo>
                    <a:pt x="135" y="1015"/>
                  </a:lnTo>
                  <a:lnTo>
                    <a:pt x="137" y="1014"/>
                  </a:lnTo>
                  <a:lnTo>
                    <a:pt x="139" y="1014"/>
                  </a:lnTo>
                  <a:lnTo>
                    <a:pt x="141" y="1014"/>
                  </a:lnTo>
                  <a:lnTo>
                    <a:pt x="143" y="1014"/>
                  </a:lnTo>
                  <a:lnTo>
                    <a:pt x="145" y="1014"/>
                  </a:lnTo>
                  <a:lnTo>
                    <a:pt x="147" y="1014"/>
                  </a:lnTo>
                  <a:lnTo>
                    <a:pt x="149" y="1014"/>
                  </a:lnTo>
                  <a:lnTo>
                    <a:pt x="151" y="1014"/>
                  </a:lnTo>
                  <a:lnTo>
                    <a:pt x="153" y="1014"/>
                  </a:lnTo>
                  <a:lnTo>
                    <a:pt x="155" y="1014"/>
                  </a:lnTo>
                  <a:lnTo>
                    <a:pt x="157" y="1014"/>
                  </a:lnTo>
                  <a:lnTo>
                    <a:pt x="159" y="1013"/>
                  </a:lnTo>
                  <a:lnTo>
                    <a:pt x="161" y="1013"/>
                  </a:lnTo>
                  <a:lnTo>
                    <a:pt x="163" y="1014"/>
                  </a:lnTo>
                  <a:lnTo>
                    <a:pt x="165" y="1019"/>
                  </a:lnTo>
                  <a:lnTo>
                    <a:pt x="167" y="1027"/>
                  </a:lnTo>
                  <a:lnTo>
                    <a:pt x="169" y="1031"/>
                  </a:lnTo>
                  <a:lnTo>
                    <a:pt x="171" y="1031"/>
                  </a:lnTo>
                  <a:lnTo>
                    <a:pt x="173" y="1028"/>
                  </a:lnTo>
                  <a:lnTo>
                    <a:pt x="175" y="1025"/>
                  </a:lnTo>
                  <a:lnTo>
                    <a:pt x="177" y="1021"/>
                  </a:lnTo>
                  <a:lnTo>
                    <a:pt x="179" y="1018"/>
                  </a:lnTo>
                  <a:lnTo>
                    <a:pt x="181" y="1016"/>
                  </a:lnTo>
                  <a:lnTo>
                    <a:pt x="183" y="1015"/>
                  </a:lnTo>
                  <a:lnTo>
                    <a:pt x="185" y="1013"/>
                  </a:lnTo>
                  <a:lnTo>
                    <a:pt x="187" y="1012"/>
                  </a:lnTo>
                  <a:lnTo>
                    <a:pt x="189" y="1011"/>
                  </a:lnTo>
                  <a:lnTo>
                    <a:pt x="191" y="1010"/>
                  </a:lnTo>
                  <a:lnTo>
                    <a:pt x="193" y="1006"/>
                  </a:lnTo>
                  <a:lnTo>
                    <a:pt x="195" y="943"/>
                  </a:lnTo>
                  <a:lnTo>
                    <a:pt x="197" y="647"/>
                  </a:lnTo>
                  <a:lnTo>
                    <a:pt x="199" y="219"/>
                  </a:lnTo>
                  <a:lnTo>
                    <a:pt x="201" y="0"/>
                  </a:lnTo>
                  <a:lnTo>
                    <a:pt x="203" y="4"/>
                  </a:lnTo>
                  <a:lnTo>
                    <a:pt x="205" y="92"/>
                  </a:lnTo>
                  <a:lnTo>
                    <a:pt x="207" y="200"/>
                  </a:lnTo>
                  <a:lnTo>
                    <a:pt x="209" y="355"/>
                  </a:lnTo>
                  <a:lnTo>
                    <a:pt x="211" y="545"/>
                  </a:lnTo>
                  <a:lnTo>
                    <a:pt x="213" y="717"/>
                  </a:lnTo>
                  <a:lnTo>
                    <a:pt x="215" y="840"/>
                  </a:lnTo>
                  <a:lnTo>
                    <a:pt x="217" y="914"/>
                  </a:lnTo>
                  <a:lnTo>
                    <a:pt x="219" y="953"/>
                  </a:lnTo>
                  <a:lnTo>
                    <a:pt x="221" y="973"/>
                  </a:lnTo>
                  <a:lnTo>
                    <a:pt x="223" y="983"/>
                  </a:lnTo>
                  <a:lnTo>
                    <a:pt x="225" y="990"/>
                  </a:lnTo>
                  <a:lnTo>
                    <a:pt x="227" y="994"/>
                  </a:lnTo>
                  <a:lnTo>
                    <a:pt x="229" y="996"/>
                  </a:lnTo>
                  <a:lnTo>
                    <a:pt x="231" y="998"/>
                  </a:lnTo>
                  <a:lnTo>
                    <a:pt x="233" y="998"/>
                  </a:lnTo>
                  <a:lnTo>
                    <a:pt x="235" y="998"/>
                  </a:lnTo>
                  <a:lnTo>
                    <a:pt x="237" y="996"/>
                  </a:lnTo>
                  <a:lnTo>
                    <a:pt x="239" y="996"/>
                  </a:lnTo>
                  <a:lnTo>
                    <a:pt x="241" y="996"/>
                  </a:lnTo>
                  <a:lnTo>
                    <a:pt x="243" y="996"/>
                  </a:lnTo>
                  <a:lnTo>
                    <a:pt x="245" y="997"/>
                  </a:lnTo>
                  <a:lnTo>
                    <a:pt x="247" y="998"/>
                  </a:lnTo>
                  <a:lnTo>
                    <a:pt x="249" y="999"/>
                  </a:lnTo>
                  <a:lnTo>
                    <a:pt x="251" y="1000"/>
                  </a:lnTo>
                  <a:lnTo>
                    <a:pt x="253" y="1000"/>
                  </a:lnTo>
                  <a:lnTo>
                    <a:pt x="255" y="1001"/>
                  </a:lnTo>
                  <a:lnTo>
                    <a:pt x="257" y="1002"/>
                  </a:lnTo>
                  <a:lnTo>
                    <a:pt x="259" y="1002"/>
                  </a:lnTo>
                  <a:lnTo>
                    <a:pt x="261" y="1002"/>
                  </a:lnTo>
                  <a:lnTo>
                    <a:pt x="263" y="1002"/>
                  </a:lnTo>
                  <a:lnTo>
                    <a:pt x="266" y="1002"/>
                  </a:lnTo>
                  <a:lnTo>
                    <a:pt x="268" y="1002"/>
                  </a:lnTo>
                  <a:lnTo>
                    <a:pt x="270" y="1002"/>
                  </a:lnTo>
                  <a:lnTo>
                    <a:pt x="272" y="1002"/>
                  </a:lnTo>
                  <a:lnTo>
                    <a:pt x="274" y="1001"/>
                  </a:lnTo>
                  <a:lnTo>
                    <a:pt x="276" y="1000"/>
                  </a:lnTo>
                  <a:lnTo>
                    <a:pt x="278" y="1000"/>
                  </a:lnTo>
                  <a:lnTo>
                    <a:pt x="280" y="1000"/>
                  </a:lnTo>
                  <a:lnTo>
                    <a:pt x="282" y="1001"/>
                  </a:lnTo>
                  <a:lnTo>
                    <a:pt x="284" y="1002"/>
                  </a:lnTo>
                  <a:lnTo>
                    <a:pt x="286" y="1002"/>
                  </a:lnTo>
                  <a:lnTo>
                    <a:pt x="288" y="1002"/>
                  </a:lnTo>
                  <a:lnTo>
                    <a:pt x="290" y="1003"/>
                  </a:lnTo>
                  <a:lnTo>
                    <a:pt x="292" y="1003"/>
                  </a:lnTo>
                  <a:lnTo>
                    <a:pt x="294" y="1004"/>
                  </a:lnTo>
                  <a:lnTo>
                    <a:pt x="296" y="1004"/>
                  </a:lnTo>
                  <a:lnTo>
                    <a:pt x="298" y="1004"/>
                  </a:lnTo>
                  <a:lnTo>
                    <a:pt x="300" y="1004"/>
                  </a:lnTo>
                  <a:lnTo>
                    <a:pt x="302" y="1004"/>
                  </a:lnTo>
                  <a:lnTo>
                    <a:pt x="304" y="1003"/>
                  </a:lnTo>
                  <a:lnTo>
                    <a:pt x="306" y="1003"/>
                  </a:lnTo>
                  <a:lnTo>
                    <a:pt x="308" y="1003"/>
                  </a:lnTo>
                  <a:lnTo>
                    <a:pt x="310" y="1003"/>
                  </a:lnTo>
                  <a:lnTo>
                    <a:pt x="312" y="1003"/>
                  </a:lnTo>
                  <a:lnTo>
                    <a:pt x="314" y="1003"/>
                  </a:lnTo>
                  <a:lnTo>
                    <a:pt x="316" y="1003"/>
                  </a:lnTo>
                  <a:lnTo>
                    <a:pt x="318" y="1003"/>
                  </a:lnTo>
                  <a:lnTo>
                    <a:pt x="320" y="1003"/>
                  </a:lnTo>
                  <a:lnTo>
                    <a:pt x="322" y="1003"/>
                  </a:lnTo>
                  <a:lnTo>
                    <a:pt x="324" y="1003"/>
                  </a:lnTo>
                  <a:lnTo>
                    <a:pt x="326" y="1003"/>
                  </a:lnTo>
                  <a:lnTo>
                    <a:pt x="328" y="1003"/>
                  </a:lnTo>
                  <a:lnTo>
                    <a:pt x="330" y="1002"/>
                  </a:lnTo>
                  <a:lnTo>
                    <a:pt x="332" y="1000"/>
                  </a:lnTo>
                  <a:lnTo>
                    <a:pt x="334" y="998"/>
                  </a:lnTo>
                  <a:lnTo>
                    <a:pt x="336" y="997"/>
                  </a:lnTo>
                  <a:lnTo>
                    <a:pt x="338" y="996"/>
                  </a:lnTo>
                  <a:lnTo>
                    <a:pt x="340" y="995"/>
                  </a:lnTo>
                  <a:lnTo>
                    <a:pt x="342" y="995"/>
                  </a:lnTo>
                  <a:lnTo>
                    <a:pt x="344" y="995"/>
                  </a:lnTo>
                  <a:lnTo>
                    <a:pt x="346" y="995"/>
                  </a:lnTo>
                  <a:lnTo>
                    <a:pt x="348" y="996"/>
                  </a:lnTo>
                  <a:lnTo>
                    <a:pt x="350" y="996"/>
                  </a:lnTo>
                  <a:lnTo>
                    <a:pt x="352" y="996"/>
                  </a:lnTo>
                  <a:lnTo>
                    <a:pt x="354" y="997"/>
                  </a:lnTo>
                  <a:lnTo>
                    <a:pt x="356" y="998"/>
                  </a:lnTo>
                  <a:lnTo>
                    <a:pt x="358" y="998"/>
                  </a:lnTo>
                  <a:lnTo>
                    <a:pt x="360" y="998"/>
                  </a:lnTo>
                  <a:lnTo>
                    <a:pt x="362" y="999"/>
                  </a:lnTo>
                  <a:lnTo>
                    <a:pt x="364" y="999"/>
                  </a:lnTo>
                  <a:lnTo>
                    <a:pt x="366" y="999"/>
                  </a:lnTo>
                  <a:lnTo>
                    <a:pt x="368" y="999"/>
                  </a:lnTo>
                  <a:lnTo>
                    <a:pt x="370" y="997"/>
                  </a:lnTo>
                  <a:lnTo>
                    <a:pt x="372" y="995"/>
                  </a:lnTo>
                  <a:lnTo>
                    <a:pt x="374" y="991"/>
                  </a:lnTo>
                  <a:lnTo>
                    <a:pt x="376" y="987"/>
                  </a:lnTo>
                  <a:lnTo>
                    <a:pt x="378" y="984"/>
                  </a:lnTo>
                  <a:lnTo>
                    <a:pt x="380" y="983"/>
                  </a:lnTo>
                  <a:lnTo>
                    <a:pt x="382" y="983"/>
                  </a:lnTo>
                  <a:lnTo>
                    <a:pt x="384" y="984"/>
                  </a:lnTo>
                  <a:lnTo>
                    <a:pt x="386" y="985"/>
                  </a:lnTo>
                  <a:lnTo>
                    <a:pt x="388" y="987"/>
                  </a:lnTo>
                  <a:lnTo>
                    <a:pt x="390" y="989"/>
                  </a:lnTo>
                  <a:lnTo>
                    <a:pt x="392" y="991"/>
                  </a:lnTo>
                  <a:lnTo>
                    <a:pt x="394" y="993"/>
                  </a:lnTo>
                  <a:lnTo>
                    <a:pt x="396" y="995"/>
                  </a:lnTo>
                  <a:lnTo>
                    <a:pt x="399" y="996"/>
                  </a:lnTo>
                  <a:lnTo>
                    <a:pt x="401" y="997"/>
                  </a:lnTo>
                  <a:lnTo>
                    <a:pt x="402" y="998"/>
                  </a:lnTo>
                  <a:lnTo>
                    <a:pt x="404" y="999"/>
                  </a:lnTo>
                  <a:lnTo>
                    <a:pt x="406" y="999"/>
                  </a:lnTo>
                  <a:lnTo>
                    <a:pt x="409" y="999"/>
                  </a:lnTo>
                  <a:lnTo>
                    <a:pt x="411" y="1000"/>
                  </a:lnTo>
                  <a:lnTo>
                    <a:pt x="413" y="1000"/>
                  </a:lnTo>
                  <a:lnTo>
                    <a:pt x="415" y="1000"/>
                  </a:lnTo>
                  <a:lnTo>
                    <a:pt x="417" y="1000"/>
                  </a:lnTo>
                  <a:lnTo>
                    <a:pt x="419" y="1000"/>
                  </a:lnTo>
                  <a:lnTo>
                    <a:pt x="421" y="1000"/>
                  </a:lnTo>
                  <a:lnTo>
                    <a:pt x="423" y="1000"/>
                  </a:lnTo>
                  <a:lnTo>
                    <a:pt x="425" y="1000"/>
                  </a:lnTo>
                  <a:lnTo>
                    <a:pt x="427" y="1000"/>
                  </a:lnTo>
                  <a:lnTo>
                    <a:pt x="429" y="1000"/>
                  </a:lnTo>
                  <a:lnTo>
                    <a:pt x="431" y="1000"/>
                  </a:lnTo>
                  <a:lnTo>
                    <a:pt x="433" y="1000"/>
                  </a:lnTo>
                  <a:lnTo>
                    <a:pt x="435" y="1000"/>
                  </a:lnTo>
                  <a:lnTo>
                    <a:pt x="437" y="1000"/>
                  </a:lnTo>
                  <a:lnTo>
                    <a:pt x="439" y="1000"/>
                  </a:lnTo>
                  <a:lnTo>
                    <a:pt x="441" y="1000"/>
                  </a:lnTo>
                  <a:lnTo>
                    <a:pt x="443" y="998"/>
                  </a:lnTo>
                  <a:lnTo>
                    <a:pt x="445" y="995"/>
                  </a:lnTo>
                  <a:lnTo>
                    <a:pt x="447" y="990"/>
                  </a:lnTo>
                  <a:lnTo>
                    <a:pt x="449" y="984"/>
                  </a:lnTo>
                  <a:lnTo>
                    <a:pt x="451" y="978"/>
                  </a:lnTo>
                  <a:lnTo>
                    <a:pt x="453" y="974"/>
                  </a:lnTo>
                  <a:lnTo>
                    <a:pt x="455" y="972"/>
                  </a:lnTo>
                  <a:lnTo>
                    <a:pt x="457" y="971"/>
                  </a:lnTo>
                  <a:lnTo>
                    <a:pt x="459" y="971"/>
                  </a:lnTo>
                  <a:lnTo>
                    <a:pt x="461" y="972"/>
                  </a:lnTo>
                  <a:lnTo>
                    <a:pt x="463" y="973"/>
                  </a:lnTo>
                  <a:lnTo>
                    <a:pt x="465" y="974"/>
                  </a:lnTo>
                  <a:lnTo>
                    <a:pt x="467" y="975"/>
                  </a:lnTo>
                  <a:lnTo>
                    <a:pt x="469" y="977"/>
                  </a:lnTo>
                  <a:lnTo>
                    <a:pt x="471" y="979"/>
                  </a:lnTo>
                  <a:lnTo>
                    <a:pt x="473" y="981"/>
                  </a:lnTo>
                  <a:lnTo>
                    <a:pt x="475" y="983"/>
                  </a:lnTo>
                  <a:lnTo>
                    <a:pt x="477" y="985"/>
                  </a:lnTo>
                  <a:lnTo>
                    <a:pt x="479" y="987"/>
                  </a:lnTo>
                  <a:lnTo>
                    <a:pt x="481" y="989"/>
                  </a:lnTo>
                  <a:lnTo>
                    <a:pt x="483" y="990"/>
                  </a:lnTo>
                  <a:lnTo>
                    <a:pt x="485" y="991"/>
                  </a:lnTo>
                  <a:lnTo>
                    <a:pt x="487" y="992"/>
                  </a:lnTo>
                  <a:lnTo>
                    <a:pt x="489" y="993"/>
                  </a:lnTo>
                  <a:lnTo>
                    <a:pt x="491" y="994"/>
                  </a:lnTo>
                  <a:lnTo>
                    <a:pt x="493" y="994"/>
                  </a:lnTo>
                  <a:lnTo>
                    <a:pt x="495" y="995"/>
                  </a:lnTo>
                  <a:lnTo>
                    <a:pt x="497" y="995"/>
                  </a:lnTo>
                  <a:lnTo>
                    <a:pt x="499" y="995"/>
                  </a:lnTo>
                  <a:lnTo>
                    <a:pt x="501" y="996"/>
                  </a:lnTo>
                  <a:lnTo>
                    <a:pt x="503" y="996"/>
                  </a:lnTo>
                  <a:lnTo>
                    <a:pt x="505" y="996"/>
                  </a:lnTo>
                  <a:lnTo>
                    <a:pt x="507" y="996"/>
                  </a:lnTo>
                  <a:lnTo>
                    <a:pt x="509" y="996"/>
                  </a:lnTo>
                  <a:lnTo>
                    <a:pt x="511" y="996"/>
                  </a:lnTo>
                  <a:lnTo>
                    <a:pt x="513" y="997"/>
                  </a:lnTo>
                  <a:lnTo>
                    <a:pt x="515" y="997"/>
                  </a:lnTo>
                  <a:lnTo>
                    <a:pt x="517" y="996"/>
                  </a:lnTo>
                  <a:lnTo>
                    <a:pt x="519" y="996"/>
                  </a:lnTo>
                  <a:lnTo>
                    <a:pt x="521" y="996"/>
                  </a:lnTo>
                  <a:lnTo>
                    <a:pt x="523" y="996"/>
                  </a:lnTo>
                  <a:lnTo>
                    <a:pt x="525" y="995"/>
                  </a:lnTo>
                  <a:lnTo>
                    <a:pt x="527" y="994"/>
                  </a:lnTo>
                  <a:lnTo>
                    <a:pt x="529" y="992"/>
                  </a:lnTo>
                  <a:lnTo>
                    <a:pt x="531" y="990"/>
                  </a:lnTo>
                  <a:lnTo>
                    <a:pt x="533" y="989"/>
                  </a:lnTo>
                  <a:lnTo>
                    <a:pt x="535" y="987"/>
                  </a:lnTo>
                  <a:lnTo>
                    <a:pt x="537" y="986"/>
                  </a:lnTo>
                  <a:lnTo>
                    <a:pt x="539" y="986"/>
                  </a:lnTo>
                  <a:lnTo>
                    <a:pt x="542" y="987"/>
                  </a:lnTo>
                  <a:lnTo>
                    <a:pt x="544" y="987"/>
                  </a:lnTo>
                  <a:lnTo>
                    <a:pt x="546" y="988"/>
                  </a:lnTo>
                  <a:lnTo>
                    <a:pt x="548" y="989"/>
                  </a:lnTo>
                  <a:lnTo>
                    <a:pt x="549" y="990"/>
                  </a:lnTo>
                  <a:lnTo>
                    <a:pt x="552" y="991"/>
                  </a:lnTo>
                  <a:lnTo>
                    <a:pt x="554" y="992"/>
                  </a:lnTo>
                  <a:lnTo>
                    <a:pt x="556" y="992"/>
                  </a:lnTo>
                  <a:lnTo>
                    <a:pt x="558" y="993"/>
                  </a:lnTo>
                  <a:lnTo>
                    <a:pt x="560" y="994"/>
                  </a:lnTo>
                  <a:lnTo>
                    <a:pt x="562" y="994"/>
                  </a:lnTo>
                  <a:lnTo>
                    <a:pt x="564" y="994"/>
                  </a:lnTo>
                  <a:lnTo>
                    <a:pt x="566" y="995"/>
                  </a:lnTo>
                  <a:lnTo>
                    <a:pt x="568" y="995"/>
                  </a:lnTo>
                  <a:lnTo>
                    <a:pt x="570" y="996"/>
                  </a:lnTo>
                  <a:lnTo>
                    <a:pt x="572" y="996"/>
                  </a:lnTo>
                  <a:lnTo>
                    <a:pt x="574" y="996"/>
                  </a:lnTo>
                  <a:lnTo>
                    <a:pt x="576" y="996"/>
                  </a:lnTo>
                  <a:lnTo>
                    <a:pt x="578" y="996"/>
                  </a:lnTo>
                  <a:lnTo>
                    <a:pt x="580" y="996"/>
                  </a:lnTo>
                  <a:lnTo>
                    <a:pt x="582" y="996"/>
                  </a:lnTo>
                  <a:lnTo>
                    <a:pt x="584" y="996"/>
                  </a:lnTo>
                  <a:lnTo>
                    <a:pt x="586" y="996"/>
                  </a:lnTo>
                  <a:lnTo>
                    <a:pt x="588" y="997"/>
                  </a:lnTo>
                  <a:lnTo>
                    <a:pt x="590" y="997"/>
                  </a:lnTo>
                  <a:lnTo>
                    <a:pt x="592" y="997"/>
                  </a:lnTo>
                  <a:lnTo>
                    <a:pt x="594" y="997"/>
                  </a:lnTo>
                  <a:lnTo>
                    <a:pt x="596" y="997"/>
                  </a:lnTo>
                  <a:lnTo>
                    <a:pt x="598" y="997"/>
                  </a:lnTo>
                  <a:lnTo>
                    <a:pt x="600" y="997"/>
                  </a:lnTo>
                  <a:lnTo>
                    <a:pt x="602" y="997"/>
                  </a:lnTo>
                  <a:lnTo>
                    <a:pt x="604" y="997"/>
                  </a:lnTo>
                  <a:lnTo>
                    <a:pt x="606" y="997"/>
                  </a:lnTo>
                  <a:lnTo>
                    <a:pt x="608" y="997"/>
                  </a:lnTo>
                  <a:lnTo>
                    <a:pt x="610" y="997"/>
                  </a:lnTo>
                  <a:lnTo>
                    <a:pt x="612" y="997"/>
                  </a:lnTo>
                  <a:lnTo>
                    <a:pt x="614" y="997"/>
                  </a:lnTo>
                  <a:lnTo>
                    <a:pt x="616" y="997"/>
                  </a:lnTo>
                  <a:lnTo>
                    <a:pt x="618" y="997"/>
                  </a:lnTo>
                  <a:lnTo>
                    <a:pt x="620" y="997"/>
                  </a:lnTo>
                  <a:lnTo>
                    <a:pt x="622" y="997"/>
                  </a:lnTo>
                  <a:lnTo>
                    <a:pt x="624" y="997"/>
                  </a:lnTo>
                  <a:lnTo>
                    <a:pt x="626" y="997"/>
                  </a:lnTo>
                  <a:lnTo>
                    <a:pt x="628" y="997"/>
                  </a:lnTo>
                  <a:lnTo>
                    <a:pt x="630" y="996"/>
                  </a:lnTo>
                  <a:lnTo>
                    <a:pt x="632" y="996"/>
                  </a:lnTo>
                  <a:lnTo>
                    <a:pt x="634" y="997"/>
                  </a:lnTo>
                  <a:lnTo>
                    <a:pt x="636" y="996"/>
                  </a:lnTo>
                  <a:lnTo>
                    <a:pt x="638" y="996"/>
                  </a:lnTo>
                  <a:lnTo>
                    <a:pt x="640" y="996"/>
                  </a:lnTo>
                  <a:lnTo>
                    <a:pt x="642" y="996"/>
                  </a:lnTo>
                  <a:lnTo>
                    <a:pt x="644" y="996"/>
                  </a:lnTo>
                  <a:lnTo>
                    <a:pt x="646" y="996"/>
                  </a:lnTo>
                  <a:lnTo>
                    <a:pt x="648" y="996"/>
                  </a:lnTo>
                  <a:lnTo>
                    <a:pt x="650" y="996"/>
                  </a:lnTo>
                  <a:lnTo>
                    <a:pt x="652" y="996"/>
                  </a:lnTo>
                  <a:lnTo>
                    <a:pt x="654" y="996"/>
                  </a:lnTo>
                  <a:lnTo>
                    <a:pt x="656" y="996"/>
                  </a:lnTo>
                  <a:lnTo>
                    <a:pt x="658" y="996"/>
                  </a:lnTo>
                  <a:lnTo>
                    <a:pt x="660" y="996"/>
                  </a:lnTo>
                  <a:lnTo>
                    <a:pt x="662" y="996"/>
                  </a:lnTo>
                  <a:lnTo>
                    <a:pt x="664" y="996"/>
                  </a:lnTo>
                  <a:lnTo>
                    <a:pt x="666" y="996"/>
                  </a:lnTo>
                  <a:lnTo>
                    <a:pt x="668" y="996"/>
                  </a:lnTo>
                  <a:lnTo>
                    <a:pt x="670" y="996"/>
                  </a:lnTo>
                  <a:lnTo>
                    <a:pt x="672" y="996"/>
                  </a:lnTo>
                  <a:lnTo>
                    <a:pt x="674" y="996"/>
                  </a:lnTo>
                  <a:lnTo>
                    <a:pt x="676" y="996"/>
                  </a:lnTo>
                  <a:lnTo>
                    <a:pt x="678" y="996"/>
                  </a:lnTo>
                  <a:lnTo>
                    <a:pt x="680" y="996"/>
                  </a:lnTo>
                  <a:lnTo>
                    <a:pt x="682" y="996"/>
                  </a:lnTo>
                  <a:lnTo>
                    <a:pt x="685" y="996"/>
                  </a:lnTo>
                  <a:lnTo>
                    <a:pt x="687" y="996"/>
                  </a:lnTo>
                  <a:lnTo>
                    <a:pt x="689" y="996"/>
                  </a:lnTo>
                  <a:lnTo>
                    <a:pt x="691" y="996"/>
                  </a:lnTo>
                  <a:lnTo>
                    <a:pt x="693" y="996"/>
                  </a:lnTo>
                  <a:lnTo>
                    <a:pt x="695" y="996"/>
                  </a:lnTo>
                  <a:lnTo>
                    <a:pt x="697" y="996"/>
                  </a:lnTo>
                  <a:lnTo>
                    <a:pt x="699" y="996"/>
                  </a:lnTo>
                  <a:lnTo>
                    <a:pt x="701" y="996"/>
                  </a:lnTo>
                  <a:lnTo>
                    <a:pt x="703" y="996"/>
                  </a:lnTo>
                  <a:lnTo>
                    <a:pt x="705" y="996"/>
                  </a:lnTo>
                  <a:lnTo>
                    <a:pt x="707" y="996"/>
                  </a:lnTo>
                  <a:lnTo>
                    <a:pt x="709" y="996"/>
                  </a:lnTo>
                  <a:lnTo>
                    <a:pt x="711" y="995"/>
                  </a:lnTo>
                  <a:lnTo>
                    <a:pt x="713" y="995"/>
                  </a:lnTo>
                  <a:lnTo>
                    <a:pt x="715" y="995"/>
                  </a:lnTo>
                  <a:lnTo>
                    <a:pt x="717" y="995"/>
                  </a:lnTo>
                  <a:lnTo>
                    <a:pt x="719" y="995"/>
                  </a:lnTo>
                  <a:lnTo>
                    <a:pt x="721" y="995"/>
                  </a:lnTo>
                  <a:lnTo>
                    <a:pt x="723" y="995"/>
                  </a:lnTo>
                  <a:lnTo>
                    <a:pt x="725" y="995"/>
                  </a:lnTo>
                  <a:lnTo>
                    <a:pt x="727" y="995"/>
                  </a:lnTo>
                  <a:lnTo>
                    <a:pt x="729" y="995"/>
                  </a:lnTo>
                  <a:lnTo>
                    <a:pt x="731" y="995"/>
                  </a:lnTo>
                  <a:lnTo>
                    <a:pt x="733" y="995"/>
                  </a:lnTo>
                  <a:lnTo>
                    <a:pt x="735" y="995"/>
                  </a:lnTo>
                  <a:lnTo>
                    <a:pt x="737" y="995"/>
                  </a:lnTo>
                  <a:lnTo>
                    <a:pt x="739" y="994"/>
                  </a:lnTo>
                  <a:lnTo>
                    <a:pt x="741" y="994"/>
                  </a:lnTo>
                  <a:lnTo>
                    <a:pt x="743" y="994"/>
                  </a:lnTo>
                  <a:lnTo>
                    <a:pt x="745" y="994"/>
                  </a:lnTo>
                  <a:lnTo>
                    <a:pt x="747" y="994"/>
                  </a:lnTo>
                  <a:lnTo>
                    <a:pt x="749" y="994"/>
                  </a:lnTo>
                  <a:lnTo>
                    <a:pt x="751" y="994"/>
                  </a:lnTo>
                  <a:lnTo>
                    <a:pt x="753" y="994"/>
                  </a:lnTo>
                  <a:lnTo>
                    <a:pt x="755" y="994"/>
                  </a:lnTo>
                  <a:lnTo>
                    <a:pt x="757" y="994"/>
                  </a:lnTo>
                  <a:lnTo>
                    <a:pt x="759" y="994"/>
                  </a:lnTo>
                  <a:lnTo>
                    <a:pt x="761" y="994"/>
                  </a:lnTo>
                  <a:lnTo>
                    <a:pt x="763" y="994"/>
                  </a:lnTo>
                  <a:lnTo>
                    <a:pt x="765" y="994"/>
                  </a:lnTo>
                  <a:lnTo>
                    <a:pt x="767" y="994"/>
                  </a:lnTo>
                  <a:lnTo>
                    <a:pt x="769" y="994"/>
                  </a:lnTo>
                  <a:lnTo>
                    <a:pt x="771" y="994"/>
                  </a:lnTo>
                  <a:lnTo>
                    <a:pt x="773" y="994"/>
                  </a:lnTo>
                  <a:lnTo>
                    <a:pt x="775" y="994"/>
                  </a:lnTo>
                  <a:lnTo>
                    <a:pt x="777" y="994"/>
                  </a:lnTo>
                  <a:lnTo>
                    <a:pt x="779" y="994"/>
                  </a:lnTo>
                  <a:lnTo>
                    <a:pt x="781" y="994"/>
                  </a:lnTo>
                  <a:lnTo>
                    <a:pt x="783" y="994"/>
                  </a:lnTo>
                  <a:lnTo>
                    <a:pt x="785" y="994"/>
                  </a:lnTo>
                  <a:lnTo>
                    <a:pt x="787" y="993"/>
                  </a:lnTo>
                  <a:lnTo>
                    <a:pt x="789" y="993"/>
                  </a:lnTo>
                  <a:lnTo>
                    <a:pt x="791" y="994"/>
                  </a:lnTo>
                  <a:lnTo>
                    <a:pt x="793" y="993"/>
                  </a:lnTo>
                  <a:lnTo>
                    <a:pt x="795" y="993"/>
                  </a:lnTo>
                  <a:lnTo>
                    <a:pt x="797" y="993"/>
                  </a:lnTo>
                  <a:lnTo>
                    <a:pt x="799" y="993"/>
                  </a:lnTo>
                  <a:lnTo>
                    <a:pt x="801" y="993"/>
                  </a:lnTo>
                  <a:lnTo>
                    <a:pt x="803" y="992"/>
                  </a:lnTo>
                  <a:lnTo>
                    <a:pt x="805" y="992"/>
                  </a:lnTo>
                  <a:lnTo>
                    <a:pt x="807" y="992"/>
                  </a:lnTo>
                  <a:lnTo>
                    <a:pt x="809" y="992"/>
                  </a:lnTo>
                  <a:lnTo>
                    <a:pt x="811" y="992"/>
                  </a:lnTo>
                  <a:lnTo>
                    <a:pt x="813" y="992"/>
                  </a:lnTo>
                  <a:lnTo>
                    <a:pt x="815" y="992"/>
                  </a:lnTo>
                  <a:lnTo>
                    <a:pt x="817" y="992"/>
                  </a:lnTo>
                  <a:lnTo>
                    <a:pt x="819" y="992"/>
                  </a:lnTo>
                  <a:lnTo>
                    <a:pt x="821" y="992"/>
                  </a:lnTo>
                  <a:lnTo>
                    <a:pt x="823" y="992"/>
                  </a:lnTo>
                  <a:lnTo>
                    <a:pt x="825" y="992"/>
                  </a:lnTo>
                  <a:lnTo>
                    <a:pt x="828" y="992"/>
                  </a:lnTo>
                  <a:lnTo>
                    <a:pt x="830" y="992"/>
                  </a:lnTo>
                  <a:lnTo>
                    <a:pt x="832" y="992"/>
                  </a:lnTo>
                  <a:lnTo>
                    <a:pt x="834" y="992"/>
                  </a:lnTo>
                  <a:lnTo>
                    <a:pt x="836" y="992"/>
                  </a:lnTo>
                  <a:lnTo>
                    <a:pt x="838" y="992"/>
                  </a:lnTo>
                  <a:lnTo>
                    <a:pt x="840" y="992"/>
                  </a:lnTo>
                  <a:lnTo>
                    <a:pt x="842" y="992"/>
                  </a:lnTo>
                  <a:lnTo>
                    <a:pt x="844" y="992"/>
                  </a:lnTo>
                  <a:lnTo>
                    <a:pt x="846" y="992"/>
                  </a:lnTo>
                  <a:lnTo>
                    <a:pt x="848" y="992"/>
                  </a:lnTo>
                  <a:lnTo>
                    <a:pt x="850" y="992"/>
                  </a:lnTo>
                  <a:lnTo>
                    <a:pt x="852" y="992"/>
                  </a:lnTo>
                  <a:lnTo>
                    <a:pt x="854" y="992"/>
                  </a:lnTo>
                  <a:lnTo>
                    <a:pt x="856" y="992"/>
                  </a:lnTo>
                  <a:lnTo>
                    <a:pt x="858" y="992"/>
                  </a:lnTo>
                  <a:lnTo>
                    <a:pt x="860" y="992"/>
                  </a:lnTo>
                  <a:lnTo>
                    <a:pt x="862" y="992"/>
                  </a:lnTo>
                  <a:lnTo>
                    <a:pt x="864" y="992"/>
                  </a:lnTo>
                  <a:lnTo>
                    <a:pt x="866" y="992"/>
                  </a:lnTo>
                  <a:lnTo>
                    <a:pt x="868" y="992"/>
                  </a:lnTo>
                  <a:lnTo>
                    <a:pt x="870" y="992"/>
                  </a:lnTo>
                  <a:lnTo>
                    <a:pt x="872" y="992"/>
                  </a:lnTo>
                  <a:lnTo>
                    <a:pt x="874" y="992"/>
                  </a:lnTo>
                  <a:lnTo>
                    <a:pt x="876" y="992"/>
                  </a:lnTo>
                  <a:lnTo>
                    <a:pt x="878" y="992"/>
                  </a:lnTo>
                  <a:lnTo>
                    <a:pt x="880" y="991"/>
                  </a:lnTo>
                  <a:lnTo>
                    <a:pt x="882" y="991"/>
                  </a:lnTo>
                  <a:lnTo>
                    <a:pt x="884" y="991"/>
                  </a:lnTo>
                  <a:lnTo>
                    <a:pt x="886" y="991"/>
                  </a:lnTo>
                  <a:lnTo>
                    <a:pt x="888" y="990"/>
                  </a:lnTo>
                  <a:lnTo>
                    <a:pt x="890" y="989"/>
                  </a:lnTo>
                  <a:lnTo>
                    <a:pt x="892" y="987"/>
                  </a:lnTo>
                  <a:lnTo>
                    <a:pt x="894" y="985"/>
                  </a:lnTo>
                  <a:lnTo>
                    <a:pt x="896" y="981"/>
                  </a:lnTo>
                  <a:lnTo>
                    <a:pt x="898" y="976"/>
                  </a:lnTo>
                  <a:lnTo>
                    <a:pt x="900" y="971"/>
                  </a:lnTo>
                  <a:lnTo>
                    <a:pt x="902" y="964"/>
                  </a:lnTo>
                  <a:lnTo>
                    <a:pt x="904" y="956"/>
                  </a:lnTo>
                  <a:lnTo>
                    <a:pt x="906" y="947"/>
                  </a:lnTo>
                  <a:lnTo>
                    <a:pt x="908" y="938"/>
                  </a:lnTo>
                  <a:lnTo>
                    <a:pt x="910" y="929"/>
                  </a:lnTo>
                  <a:lnTo>
                    <a:pt x="912" y="921"/>
                  </a:lnTo>
                  <a:lnTo>
                    <a:pt x="914" y="915"/>
                  </a:lnTo>
                  <a:lnTo>
                    <a:pt x="916" y="910"/>
                  </a:lnTo>
                  <a:lnTo>
                    <a:pt x="918" y="906"/>
                  </a:lnTo>
                  <a:lnTo>
                    <a:pt x="920" y="905"/>
                  </a:lnTo>
                  <a:lnTo>
                    <a:pt x="922" y="906"/>
                  </a:lnTo>
                  <a:lnTo>
                    <a:pt x="924" y="908"/>
                  </a:lnTo>
                  <a:lnTo>
                    <a:pt x="926" y="911"/>
                  </a:lnTo>
                  <a:lnTo>
                    <a:pt x="928" y="915"/>
                  </a:lnTo>
                  <a:lnTo>
                    <a:pt x="930" y="919"/>
                  </a:lnTo>
                  <a:lnTo>
                    <a:pt x="932" y="924"/>
                  </a:lnTo>
                  <a:lnTo>
                    <a:pt x="934" y="928"/>
                  </a:lnTo>
                  <a:lnTo>
                    <a:pt x="936" y="933"/>
                  </a:lnTo>
                  <a:lnTo>
                    <a:pt x="938" y="937"/>
                  </a:lnTo>
                  <a:lnTo>
                    <a:pt x="940" y="942"/>
                  </a:lnTo>
                  <a:lnTo>
                    <a:pt x="942" y="946"/>
                  </a:lnTo>
                  <a:lnTo>
                    <a:pt x="944" y="949"/>
                  </a:lnTo>
                  <a:lnTo>
                    <a:pt x="946" y="953"/>
                  </a:lnTo>
                  <a:lnTo>
                    <a:pt x="948" y="957"/>
                  </a:lnTo>
                  <a:lnTo>
                    <a:pt x="950" y="961"/>
                  </a:lnTo>
                  <a:lnTo>
                    <a:pt x="952" y="964"/>
                  </a:lnTo>
                  <a:lnTo>
                    <a:pt x="954" y="966"/>
                  </a:lnTo>
                  <a:lnTo>
                    <a:pt x="956" y="969"/>
                  </a:lnTo>
                  <a:lnTo>
                    <a:pt x="958" y="972"/>
                  </a:lnTo>
                  <a:lnTo>
                    <a:pt x="961" y="974"/>
                  </a:lnTo>
                  <a:lnTo>
                    <a:pt x="962" y="975"/>
                  </a:lnTo>
                  <a:lnTo>
                    <a:pt x="964" y="977"/>
                  </a:lnTo>
                  <a:lnTo>
                    <a:pt x="966" y="978"/>
                  </a:lnTo>
                  <a:lnTo>
                    <a:pt x="968" y="979"/>
                  </a:lnTo>
                  <a:lnTo>
                    <a:pt x="970" y="980"/>
                  </a:lnTo>
                  <a:lnTo>
                    <a:pt x="973" y="980"/>
                  </a:lnTo>
                  <a:lnTo>
                    <a:pt x="975" y="981"/>
                  </a:lnTo>
                  <a:lnTo>
                    <a:pt x="977" y="981"/>
                  </a:lnTo>
                  <a:lnTo>
                    <a:pt x="979" y="982"/>
                  </a:lnTo>
                  <a:lnTo>
                    <a:pt x="981" y="982"/>
                  </a:lnTo>
                  <a:lnTo>
                    <a:pt x="983" y="982"/>
                  </a:lnTo>
                  <a:lnTo>
                    <a:pt x="985" y="982"/>
                  </a:lnTo>
                  <a:lnTo>
                    <a:pt x="987" y="982"/>
                  </a:lnTo>
                  <a:lnTo>
                    <a:pt x="989" y="982"/>
                  </a:lnTo>
                  <a:lnTo>
                    <a:pt x="991" y="982"/>
                  </a:lnTo>
                  <a:lnTo>
                    <a:pt x="993" y="982"/>
                  </a:lnTo>
                  <a:lnTo>
                    <a:pt x="995" y="982"/>
                  </a:lnTo>
                  <a:lnTo>
                    <a:pt x="997" y="981"/>
                  </a:lnTo>
                  <a:lnTo>
                    <a:pt x="999" y="980"/>
                  </a:lnTo>
                  <a:lnTo>
                    <a:pt x="1001" y="979"/>
                  </a:lnTo>
                  <a:lnTo>
                    <a:pt x="1003" y="977"/>
                  </a:lnTo>
                  <a:lnTo>
                    <a:pt x="1005" y="976"/>
                  </a:lnTo>
                  <a:lnTo>
                    <a:pt x="1007" y="974"/>
                  </a:lnTo>
                  <a:lnTo>
                    <a:pt x="1009" y="972"/>
                  </a:lnTo>
                  <a:lnTo>
                    <a:pt x="1011" y="969"/>
                  </a:lnTo>
                  <a:lnTo>
                    <a:pt x="1013" y="965"/>
                  </a:lnTo>
                  <a:lnTo>
                    <a:pt x="1015" y="960"/>
                  </a:lnTo>
                  <a:lnTo>
                    <a:pt x="1017" y="953"/>
                  </a:lnTo>
                  <a:lnTo>
                    <a:pt x="1019" y="944"/>
                  </a:lnTo>
                  <a:lnTo>
                    <a:pt x="1021" y="932"/>
                  </a:lnTo>
                  <a:lnTo>
                    <a:pt x="1023" y="916"/>
                  </a:lnTo>
                  <a:lnTo>
                    <a:pt x="1025" y="895"/>
                  </a:lnTo>
                  <a:lnTo>
                    <a:pt x="1027" y="86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33" name="Freeform 233"/>
            <p:cNvSpPr>
              <a:spLocks/>
            </p:cNvSpPr>
            <p:nvPr/>
          </p:nvSpPr>
          <p:spPr bwMode="auto">
            <a:xfrm>
              <a:off x="2028825" y="4416425"/>
              <a:ext cx="1247775" cy="1004888"/>
            </a:xfrm>
            <a:custGeom>
              <a:avLst/>
              <a:gdLst>
                <a:gd name="T0" fmla="*/ 12 w 786"/>
                <a:gd name="T1" fmla="*/ 317 h 633"/>
                <a:gd name="T2" fmla="*/ 26 w 786"/>
                <a:gd name="T3" fmla="*/ 278 h 633"/>
                <a:gd name="T4" fmla="*/ 40 w 786"/>
                <a:gd name="T5" fmla="*/ 365 h 633"/>
                <a:gd name="T6" fmla="*/ 54 w 786"/>
                <a:gd name="T7" fmla="*/ 513 h 633"/>
                <a:gd name="T8" fmla="*/ 68 w 786"/>
                <a:gd name="T9" fmla="*/ 603 h 633"/>
                <a:gd name="T10" fmla="*/ 82 w 786"/>
                <a:gd name="T11" fmla="*/ 626 h 633"/>
                <a:gd name="T12" fmla="*/ 97 w 786"/>
                <a:gd name="T13" fmla="*/ 630 h 633"/>
                <a:gd name="T14" fmla="*/ 111 w 786"/>
                <a:gd name="T15" fmla="*/ 630 h 633"/>
                <a:gd name="T16" fmla="*/ 125 w 786"/>
                <a:gd name="T17" fmla="*/ 628 h 633"/>
                <a:gd name="T18" fmla="*/ 139 w 786"/>
                <a:gd name="T19" fmla="*/ 622 h 633"/>
                <a:gd name="T20" fmla="*/ 153 w 786"/>
                <a:gd name="T21" fmla="*/ 568 h 633"/>
                <a:gd name="T22" fmla="*/ 167 w 786"/>
                <a:gd name="T23" fmla="*/ 391 h 633"/>
                <a:gd name="T24" fmla="*/ 181 w 786"/>
                <a:gd name="T25" fmla="*/ 202 h 633"/>
                <a:gd name="T26" fmla="*/ 195 w 786"/>
                <a:gd name="T27" fmla="*/ 165 h 633"/>
                <a:gd name="T28" fmla="*/ 209 w 786"/>
                <a:gd name="T29" fmla="*/ 256 h 633"/>
                <a:gd name="T30" fmla="*/ 224 w 786"/>
                <a:gd name="T31" fmla="*/ 389 h 633"/>
                <a:gd name="T32" fmla="*/ 238 w 786"/>
                <a:gd name="T33" fmla="*/ 514 h 633"/>
                <a:gd name="T34" fmla="*/ 252 w 786"/>
                <a:gd name="T35" fmla="*/ 587 h 633"/>
                <a:gd name="T36" fmla="*/ 266 w 786"/>
                <a:gd name="T37" fmla="*/ 615 h 633"/>
                <a:gd name="T38" fmla="*/ 280 w 786"/>
                <a:gd name="T39" fmla="*/ 623 h 633"/>
                <a:gd name="T40" fmla="*/ 294 w 786"/>
                <a:gd name="T41" fmla="*/ 625 h 633"/>
                <a:gd name="T42" fmla="*/ 308 w 786"/>
                <a:gd name="T43" fmla="*/ 625 h 633"/>
                <a:gd name="T44" fmla="*/ 322 w 786"/>
                <a:gd name="T45" fmla="*/ 625 h 633"/>
                <a:gd name="T46" fmla="*/ 336 w 786"/>
                <a:gd name="T47" fmla="*/ 621 h 633"/>
                <a:gd name="T48" fmla="*/ 350 w 786"/>
                <a:gd name="T49" fmla="*/ 605 h 633"/>
                <a:gd name="T50" fmla="*/ 365 w 786"/>
                <a:gd name="T51" fmla="*/ 573 h 633"/>
                <a:gd name="T52" fmla="*/ 379 w 786"/>
                <a:gd name="T53" fmla="*/ 550 h 633"/>
                <a:gd name="T54" fmla="*/ 393 w 786"/>
                <a:gd name="T55" fmla="*/ 554 h 633"/>
                <a:gd name="T56" fmla="*/ 407 w 786"/>
                <a:gd name="T57" fmla="*/ 570 h 633"/>
                <a:gd name="T58" fmla="*/ 421 w 786"/>
                <a:gd name="T59" fmla="*/ 562 h 633"/>
                <a:gd name="T60" fmla="*/ 435 w 786"/>
                <a:gd name="T61" fmla="*/ 455 h 633"/>
                <a:gd name="T62" fmla="*/ 449 w 786"/>
                <a:gd name="T63" fmla="*/ 218 h 633"/>
                <a:gd name="T64" fmla="*/ 463 w 786"/>
                <a:gd name="T65" fmla="*/ 26 h 633"/>
                <a:gd name="T66" fmla="*/ 477 w 786"/>
                <a:gd name="T67" fmla="*/ 18 h 633"/>
                <a:gd name="T68" fmla="*/ 491 w 786"/>
                <a:gd name="T69" fmla="*/ 133 h 633"/>
                <a:gd name="T70" fmla="*/ 505 w 786"/>
                <a:gd name="T71" fmla="*/ 281 h 633"/>
                <a:gd name="T72" fmla="*/ 520 w 786"/>
                <a:gd name="T73" fmla="*/ 419 h 633"/>
                <a:gd name="T74" fmla="*/ 534 w 786"/>
                <a:gd name="T75" fmla="*/ 515 h 633"/>
                <a:gd name="T76" fmla="*/ 548 w 786"/>
                <a:gd name="T77" fmla="*/ 561 h 633"/>
                <a:gd name="T78" fmla="*/ 562 w 786"/>
                <a:gd name="T79" fmla="*/ 580 h 633"/>
                <a:gd name="T80" fmla="*/ 576 w 786"/>
                <a:gd name="T81" fmla="*/ 591 h 633"/>
                <a:gd name="T82" fmla="*/ 590 w 786"/>
                <a:gd name="T83" fmla="*/ 599 h 633"/>
                <a:gd name="T84" fmla="*/ 604 w 786"/>
                <a:gd name="T85" fmla="*/ 605 h 633"/>
                <a:gd name="T86" fmla="*/ 618 w 786"/>
                <a:gd name="T87" fmla="*/ 610 h 633"/>
                <a:gd name="T88" fmla="*/ 632 w 786"/>
                <a:gd name="T89" fmla="*/ 615 h 633"/>
                <a:gd name="T90" fmla="*/ 646 w 786"/>
                <a:gd name="T91" fmla="*/ 619 h 633"/>
                <a:gd name="T92" fmla="*/ 661 w 786"/>
                <a:gd name="T93" fmla="*/ 623 h 633"/>
                <a:gd name="T94" fmla="*/ 675 w 786"/>
                <a:gd name="T95" fmla="*/ 627 h 633"/>
                <a:gd name="T96" fmla="*/ 689 w 786"/>
                <a:gd name="T97" fmla="*/ 630 h 633"/>
                <a:gd name="T98" fmla="*/ 703 w 786"/>
                <a:gd name="T99" fmla="*/ 632 h 633"/>
                <a:gd name="T100" fmla="*/ 717 w 786"/>
                <a:gd name="T101" fmla="*/ 633 h 633"/>
                <a:gd name="T102" fmla="*/ 731 w 786"/>
                <a:gd name="T103" fmla="*/ 633 h 633"/>
                <a:gd name="T104" fmla="*/ 745 w 786"/>
                <a:gd name="T105" fmla="*/ 632 h 633"/>
                <a:gd name="T106" fmla="*/ 759 w 786"/>
                <a:gd name="T107" fmla="*/ 631 h 633"/>
                <a:gd name="T108" fmla="*/ 773 w 786"/>
                <a:gd name="T109" fmla="*/ 630 h 6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786" h="633">
                  <a:moveTo>
                    <a:pt x="0" y="522"/>
                  </a:moveTo>
                  <a:lnTo>
                    <a:pt x="2" y="491"/>
                  </a:lnTo>
                  <a:lnTo>
                    <a:pt x="4" y="455"/>
                  </a:lnTo>
                  <a:lnTo>
                    <a:pt x="6" y="417"/>
                  </a:lnTo>
                  <a:lnTo>
                    <a:pt x="8" y="380"/>
                  </a:lnTo>
                  <a:lnTo>
                    <a:pt x="10" y="346"/>
                  </a:lnTo>
                  <a:lnTo>
                    <a:pt x="12" y="317"/>
                  </a:lnTo>
                  <a:lnTo>
                    <a:pt x="14" y="294"/>
                  </a:lnTo>
                  <a:lnTo>
                    <a:pt x="16" y="278"/>
                  </a:lnTo>
                  <a:lnTo>
                    <a:pt x="18" y="269"/>
                  </a:lnTo>
                  <a:lnTo>
                    <a:pt x="20" y="265"/>
                  </a:lnTo>
                  <a:lnTo>
                    <a:pt x="22" y="266"/>
                  </a:lnTo>
                  <a:lnTo>
                    <a:pt x="24" y="271"/>
                  </a:lnTo>
                  <a:lnTo>
                    <a:pt x="26" y="278"/>
                  </a:lnTo>
                  <a:lnTo>
                    <a:pt x="28" y="286"/>
                  </a:lnTo>
                  <a:lnTo>
                    <a:pt x="30" y="296"/>
                  </a:lnTo>
                  <a:lnTo>
                    <a:pt x="32" y="307"/>
                  </a:lnTo>
                  <a:lnTo>
                    <a:pt x="34" y="319"/>
                  </a:lnTo>
                  <a:lnTo>
                    <a:pt x="36" y="332"/>
                  </a:lnTo>
                  <a:lnTo>
                    <a:pt x="38" y="348"/>
                  </a:lnTo>
                  <a:lnTo>
                    <a:pt x="40" y="365"/>
                  </a:lnTo>
                  <a:lnTo>
                    <a:pt x="42" y="385"/>
                  </a:lnTo>
                  <a:lnTo>
                    <a:pt x="44" y="405"/>
                  </a:lnTo>
                  <a:lnTo>
                    <a:pt x="46" y="426"/>
                  </a:lnTo>
                  <a:lnTo>
                    <a:pt x="48" y="449"/>
                  </a:lnTo>
                  <a:lnTo>
                    <a:pt x="50" y="472"/>
                  </a:lnTo>
                  <a:lnTo>
                    <a:pt x="52" y="493"/>
                  </a:lnTo>
                  <a:lnTo>
                    <a:pt x="54" y="513"/>
                  </a:lnTo>
                  <a:lnTo>
                    <a:pt x="56" y="532"/>
                  </a:lnTo>
                  <a:lnTo>
                    <a:pt x="58" y="549"/>
                  </a:lnTo>
                  <a:lnTo>
                    <a:pt x="60" y="564"/>
                  </a:lnTo>
                  <a:lnTo>
                    <a:pt x="62" y="576"/>
                  </a:lnTo>
                  <a:lnTo>
                    <a:pt x="64" y="587"/>
                  </a:lnTo>
                  <a:lnTo>
                    <a:pt x="66" y="595"/>
                  </a:lnTo>
                  <a:lnTo>
                    <a:pt x="68" y="603"/>
                  </a:lnTo>
                  <a:lnTo>
                    <a:pt x="70" y="609"/>
                  </a:lnTo>
                  <a:lnTo>
                    <a:pt x="72" y="613"/>
                  </a:lnTo>
                  <a:lnTo>
                    <a:pt x="74" y="617"/>
                  </a:lnTo>
                  <a:lnTo>
                    <a:pt x="76" y="620"/>
                  </a:lnTo>
                  <a:lnTo>
                    <a:pt x="79" y="622"/>
                  </a:lnTo>
                  <a:lnTo>
                    <a:pt x="81" y="624"/>
                  </a:lnTo>
                  <a:lnTo>
                    <a:pt x="82" y="626"/>
                  </a:lnTo>
                  <a:lnTo>
                    <a:pt x="84" y="627"/>
                  </a:lnTo>
                  <a:lnTo>
                    <a:pt x="86" y="628"/>
                  </a:lnTo>
                  <a:lnTo>
                    <a:pt x="89" y="629"/>
                  </a:lnTo>
                  <a:lnTo>
                    <a:pt x="91" y="629"/>
                  </a:lnTo>
                  <a:lnTo>
                    <a:pt x="93" y="630"/>
                  </a:lnTo>
                  <a:lnTo>
                    <a:pt x="95" y="630"/>
                  </a:lnTo>
                  <a:lnTo>
                    <a:pt x="97" y="630"/>
                  </a:lnTo>
                  <a:lnTo>
                    <a:pt x="99" y="631"/>
                  </a:lnTo>
                  <a:lnTo>
                    <a:pt x="101" y="631"/>
                  </a:lnTo>
                  <a:lnTo>
                    <a:pt x="103" y="631"/>
                  </a:lnTo>
                  <a:lnTo>
                    <a:pt x="105" y="631"/>
                  </a:lnTo>
                  <a:lnTo>
                    <a:pt x="107" y="631"/>
                  </a:lnTo>
                  <a:lnTo>
                    <a:pt x="109" y="630"/>
                  </a:lnTo>
                  <a:lnTo>
                    <a:pt x="111" y="630"/>
                  </a:lnTo>
                  <a:lnTo>
                    <a:pt x="113" y="630"/>
                  </a:lnTo>
                  <a:lnTo>
                    <a:pt x="115" y="630"/>
                  </a:lnTo>
                  <a:lnTo>
                    <a:pt x="117" y="629"/>
                  </a:lnTo>
                  <a:lnTo>
                    <a:pt x="119" y="629"/>
                  </a:lnTo>
                  <a:lnTo>
                    <a:pt x="121" y="628"/>
                  </a:lnTo>
                  <a:lnTo>
                    <a:pt x="123" y="628"/>
                  </a:lnTo>
                  <a:lnTo>
                    <a:pt x="125" y="628"/>
                  </a:lnTo>
                  <a:lnTo>
                    <a:pt x="127" y="628"/>
                  </a:lnTo>
                  <a:lnTo>
                    <a:pt x="129" y="627"/>
                  </a:lnTo>
                  <a:lnTo>
                    <a:pt x="131" y="627"/>
                  </a:lnTo>
                  <a:lnTo>
                    <a:pt x="133" y="626"/>
                  </a:lnTo>
                  <a:lnTo>
                    <a:pt x="135" y="625"/>
                  </a:lnTo>
                  <a:lnTo>
                    <a:pt x="137" y="624"/>
                  </a:lnTo>
                  <a:lnTo>
                    <a:pt x="139" y="622"/>
                  </a:lnTo>
                  <a:lnTo>
                    <a:pt x="141" y="619"/>
                  </a:lnTo>
                  <a:lnTo>
                    <a:pt x="143" y="615"/>
                  </a:lnTo>
                  <a:lnTo>
                    <a:pt x="145" y="610"/>
                  </a:lnTo>
                  <a:lnTo>
                    <a:pt x="147" y="603"/>
                  </a:lnTo>
                  <a:lnTo>
                    <a:pt x="149" y="594"/>
                  </a:lnTo>
                  <a:lnTo>
                    <a:pt x="151" y="582"/>
                  </a:lnTo>
                  <a:lnTo>
                    <a:pt x="153" y="568"/>
                  </a:lnTo>
                  <a:lnTo>
                    <a:pt x="155" y="551"/>
                  </a:lnTo>
                  <a:lnTo>
                    <a:pt x="157" y="531"/>
                  </a:lnTo>
                  <a:lnTo>
                    <a:pt x="159" y="507"/>
                  </a:lnTo>
                  <a:lnTo>
                    <a:pt x="161" y="481"/>
                  </a:lnTo>
                  <a:lnTo>
                    <a:pt x="163" y="453"/>
                  </a:lnTo>
                  <a:lnTo>
                    <a:pt x="165" y="423"/>
                  </a:lnTo>
                  <a:lnTo>
                    <a:pt x="167" y="391"/>
                  </a:lnTo>
                  <a:lnTo>
                    <a:pt x="169" y="359"/>
                  </a:lnTo>
                  <a:lnTo>
                    <a:pt x="171" y="328"/>
                  </a:lnTo>
                  <a:lnTo>
                    <a:pt x="173" y="298"/>
                  </a:lnTo>
                  <a:lnTo>
                    <a:pt x="175" y="270"/>
                  </a:lnTo>
                  <a:lnTo>
                    <a:pt x="177" y="244"/>
                  </a:lnTo>
                  <a:lnTo>
                    <a:pt x="179" y="221"/>
                  </a:lnTo>
                  <a:lnTo>
                    <a:pt x="181" y="202"/>
                  </a:lnTo>
                  <a:lnTo>
                    <a:pt x="183" y="186"/>
                  </a:lnTo>
                  <a:lnTo>
                    <a:pt x="185" y="174"/>
                  </a:lnTo>
                  <a:lnTo>
                    <a:pt x="187" y="165"/>
                  </a:lnTo>
                  <a:lnTo>
                    <a:pt x="189" y="160"/>
                  </a:lnTo>
                  <a:lnTo>
                    <a:pt x="191" y="159"/>
                  </a:lnTo>
                  <a:lnTo>
                    <a:pt x="193" y="161"/>
                  </a:lnTo>
                  <a:lnTo>
                    <a:pt x="195" y="165"/>
                  </a:lnTo>
                  <a:lnTo>
                    <a:pt x="197" y="172"/>
                  </a:lnTo>
                  <a:lnTo>
                    <a:pt x="199" y="182"/>
                  </a:lnTo>
                  <a:lnTo>
                    <a:pt x="201" y="194"/>
                  </a:lnTo>
                  <a:lnTo>
                    <a:pt x="203" y="207"/>
                  </a:lnTo>
                  <a:lnTo>
                    <a:pt x="205" y="222"/>
                  </a:lnTo>
                  <a:lnTo>
                    <a:pt x="207" y="238"/>
                  </a:lnTo>
                  <a:lnTo>
                    <a:pt x="209" y="256"/>
                  </a:lnTo>
                  <a:lnTo>
                    <a:pt x="211" y="273"/>
                  </a:lnTo>
                  <a:lnTo>
                    <a:pt x="213" y="292"/>
                  </a:lnTo>
                  <a:lnTo>
                    <a:pt x="215" y="311"/>
                  </a:lnTo>
                  <a:lnTo>
                    <a:pt x="217" y="331"/>
                  </a:lnTo>
                  <a:lnTo>
                    <a:pt x="219" y="350"/>
                  </a:lnTo>
                  <a:lnTo>
                    <a:pt x="222" y="369"/>
                  </a:lnTo>
                  <a:lnTo>
                    <a:pt x="224" y="389"/>
                  </a:lnTo>
                  <a:lnTo>
                    <a:pt x="226" y="409"/>
                  </a:lnTo>
                  <a:lnTo>
                    <a:pt x="228" y="429"/>
                  </a:lnTo>
                  <a:lnTo>
                    <a:pt x="230" y="447"/>
                  </a:lnTo>
                  <a:lnTo>
                    <a:pt x="232" y="465"/>
                  </a:lnTo>
                  <a:lnTo>
                    <a:pt x="234" y="482"/>
                  </a:lnTo>
                  <a:lnTo>
                    <a:pt x="236" y="499"/>
                  </a:lnTo>
                  <a:lnTo>
                    <a:pt x="238" y="514"/>
                  </a:lnTo>
                  <a:lnTo>
                    <a:pt x="240" y="528"/>
                  </a:lnTo>
                  <a:lnTo>
                    <a:pt x="242" y="541"/>
                  </a:lnTo>
                  <a:lnTo>
                    <a:pt x="244" y="552"/>
                  </a:lnTo>
                  <a:lnTo>
                    <a:pt x="246" y="563"/>
                  </a:lnTo>
                  <a:lnTo>
                    <a:pt x="248" y="572"/>
                  </a:lnTo>
                  <a:lnTo>
                    <a:pt x="250" y="580"/>
                  </a:lnTo>
                  <a:lnTo>
                    <a:pt x="252" y="587"/>
                  </a:lnTo>
                  <a:lnTo>
                    <a:pt x="254" y="593"/>
                  </a:lnTo>
                  <a:lnTo>
                    <a:pt x="256" y="598"/>
                  </a:lnTo>
                  <a:lnTo>
                    <a:pt x="258" y="603"/>
                  </a:lnTo>
                  <a:lnTo>
                    <a:pt x="260" y="606"/>
                  </a:lnTo>
                  <a:lnTo>
                    <a:pt x="262" y="610"/>
                  </a:lnTo>
                  <a:lnTo>
                    <a:pt x="264" y="612"/>
                  </a:lnTo>
                  <a:lnTo>
                    <a:pt x="266" y="615"/>
                  </a:lnTo>
                  <a:lnTo>
                    <a:pt x="268" y="617"/>
                  </a:lnTo>
                  <a:lnTo>
                    <a:pt x="270" y="618"/>
                  </a:lnTo>
                  <a:lnTo>
                    <a:pt x="272" y="619"/>
                  </a:lnTo>
                  <a:lnTo>
                    <a:pt x="274" y="621"/>
                  </a:lnTo>
                  <a:lnTo>
                    <a:pt x="276" y="621"/>
                  </a:lnTo>
                  <a:lnTo>
                    <a:pt x="278" y="622"/>
                  </a:lnTo>
                  <a:lnTo>
                    <a:pt x="280" y="623"/>
                  </a:lnTo>
                  <a:lnTo>
                    <a:pt x="282" y="623"/>
                  </a:lnTo>
                  <a:lnTo>
                    <a:pt x="284" y="624"/>
                  </a:lnTo>
                  <a:lnTo>
                    <a:pt x="286" y="624"/>
                  </a:lnTo>
                  <a:lnTo>
                    <a:pt x="288" y="624"/>
                  </a:lnTo>
                  <a:lnTo>
                    <a:pt x="290" y="624"/>
                  </a:lnTo>
                  <a:lnTo>
                    <a:pt x="292" y="625"/>
                  </a:lnTo>
                  <a:lnTo>
                    <a:pt x="294" y="625"/>
                  </a:lnTo>
                  <a:lnTo>
                    <a:pt x="296" y="625"/>
                  </a:lnTo>
                  <a:lnTo>
                    <a:pt x="298" y="625"/>
                  </a:lnTo>
                  <a:lnTo>
                    <a:pt x="300" y="625"/>
                  </a:lnTo>
                  <a:lnTo>
                    <a:pt x="302" y="625"/>
                  </a:lnTo>
                  <a:lnTo>
                    <a:pt x="304" y="625"/>
                  </a:lnTo>
                  <a:lnTo>
                    <a:pt x="306" y="625"/>
                  </a:lnTo>
                  <a:lnTo>
                    <a:pt x="308" y="625"/>
                  </a:lnTo>
                  <a:lnTo>
                    <a:pt x="310" y="626"/>
                  </a:lnTo>
                  <a:lnTo>
                    <a:pt x="312" y="626"/>
                  </a:lnTo>
                  <a:lnTo>
                    <a:pt x="314" y="625"/>
                  </a:lnTo>
                  <a:lnTo>
                    <a:pt x="316" y="625"/>
                  </a:lnTo>
                  <a:lnTo>
                    <a:pt x="318" y="625"/>
                  </a:lnTo>
                  <a:lnTo>
                    <a:pt x="320" y="625"/>
                  </a:lnTo>
                  <a:lnTo>
                    <a:pt x="322" y="625"/>
                  </a:lnTo>
                  <a:lnTo>
                    <a:pt x="324" y="625"/>
                  </a:lnTo>
                  <a:lnTo>
                    <a:pt x="326" y="625"/>
                  </a:lnTo>
                  <a:lnTo>
                    <a:pt x="328" y="625"/>
                  </a:lnTo>
                  <a:lnTo>
                    <a:pt x="330" y="624"/>
                  </a:lnTo>
                  <a:lnTo>
                    <a:pt x="332" y="623"/>
                  </a:lnTo>
                  <a:lnTo>
                    <a:pt x="334" y="622"/>
                  </a:lnTo>
                  <a:lnTo>
                    <a:pt x="336" y="621"/>
                  </a:lnTo>
                  <a:lnTo>
                    <a:pt x="338" y="620"/>
                  </a:lnTo>
                  <a:lnTo>
                    <a:pt x="340" y="619"/>
                  </a:lnTo>
                  <a:lnTo>
                    <a:pt x="342" y="617"/>
                  </a:lnTo>
                  <a:lnTo>
                    <a:pt x="344" y="614"/>
                  </a:lnTo>
                  <a:lnTo>
                    <a:pt x="346" y="612"/>
                  </a:lnTo>
                  <a:lnTo>
                    <a:pt x="348" y="609"/>
                  </a:lnTo>
                  <a:lnTo>
                    <a:pt x="350" y="605"/>
                  </a:lnTo>
                  <a:lnTo>
                    <a:pt x="352" y="601"/>
                  </a:lnTo>
                  <a:lnTo>
                    <a:pt x="354" y="597"/>
                  </a:lnTo>
                  <a:lnTo>
                    <a:pt x="356" y="592"/>
                  </a:lnTo>
                  <a:lnTo>
                    <a:pt x="358" y="587"/>
                  </a:lnTo>
                  <a:lnTo>
                    <a:pt x="360" y="582"/>
                  </a:lnTo>
                  <a:lnTo>
                    <a:pt x="362" y="577"/>
                  </a:lnTo>
                  <a:lnTo>
                    <a:pt x="365" y="573"/>
                  </a:lnTo>
                  <a:lnTo>
                    <a:pt x="367" y="568"/>
                  </a:lnTo>
                  <a:lnTo>
                    <a:pt x="369" y="564"/>
                  </a:lnTo>
                  <a:lnTo>
                    <a:pt x="371" y="560"/>
                  </a:lnTo>
                  <a:lnTo>
                    <a:pt x="373" y="556"/>
                  </a:lnTo>
                  <a:lnTo>
                    <a:pt x="375" y="554"/>
                  </a:lnTo>
                  <a:lnTo>
                    <a:pt x="377" y="551"/>
                  </a:lnTo>
                  <a:lnTo>
                    <a:pt x="379" y="550"/>
                  </a:lnTo>
                  <a:lnTo>
                    <a:pt x="381" y="549"/>
                  </a:lnTo>
                  <a:lnTo>
                    <a:pt x="383" y="548"/>
                  </a:lnTo>
                  <a:lnTo>
                    <a:pt x="385" y="549"/>
                  </a:lnTo>
                  <a:lnTo>
                    <a:pt x="387" y="550"/>
                  </a:lnTo>
                  <a:lnTo>
                    <a:pt x="389" y="551"/>
                  </a:lnTo>
                  <a:lnTo>
                    <a:pt x="391" y="552"/>
                  </a:lnTo>
                  <a:lnTo>
                    <a:pt x="393" y="554"/>
                  </a:lnTo>
                  <a:lnTo>
                    <a:pt x="395" y="556"/>
                  </a:lnTo>
                  <a:lnTo>
                    <a:pt x="397" y="558"/>
                  </a:lnTo>
                  <a:lnTo>
                    <a:pt x="399" y="561"/>
                  </a:lnTo>
                  <a:lnTo>
                    <a:pt x="401" y="563"/>
                  </a:lnTo>
                  <a:lnTo>
                    <a:pt x="403" y="566"/>
                  </a:lnTo>
                  <a:lnTo>
                    <a:pt x="405" y="568"/>
                  </a:lnTo>
                  <a:lnTo>
                    <a:pt x="407" y="570"/>
                  </a:lnTo>
                  <a:lnTo>
                    <a:pt x="409" y="571"/>
                  </a:lnTo>
                  <a:lnTo>
                    <a:pt x="411" y="572"/>
                  </a:lnTo>
                  <a:lnTo>
                    <a:pt x="413" y="572"/>
                  </a:lnTo>
                  <a:lnTo>
                    <a:pt x="415" y="572"/>
                  </a:lnTo>
                  <a:lnTo>
                    <a:pt x="417" y="570"/>
                  </a:lnTo>
                  <a:lnTo>
                    <a:pt x="419" y="567"/>
                  </a:lnTo>
                  <a:lnTo>
                    <a:pt x="421" y="562"/>
                  </a:lnTo>
                  <a:lnTo>
                    <a:pt x="423" y="555"/>
                  </a:lnTo>
                  <a:lnTo>
                    <a:pt x="425" y="546"/>
                  </a:lnTo>
                  <a:lnTo>
                    <a:pt x="427" y="534"/>
                  </a:lnTo>
                  <a:lnTo>
                    <a:pt x="429" y="519"/>
                  </a:lnTo>
                  <a:lnTo>
                    <a:pt x="431" y="501"/>
                  </a:lnTo>
                  <a:lnTo>
                    <a:pt x="433" y="480"/>
                  </a:lnTo>
                  <a:lnTo>
                    <a:pt x="435" y="455"/>
                  </a:lnTo>
                  <a:lnTo>
                    <a:pt x="437" y="427"/>
                  </a:lnTo>
                  <a:lnTo>
                    <a:pt x="439" y="396"/>
                  </a:lnTo>
                  <a:lnTo>
                    <a:pt x="441" y="363"/>
                  </a:lnTo>
                  <a:lnTo>
                    <a:pt x="443" y="329"/>
                  </a:lnTo>
                  <a:lnTo>
                    <a:pt x="445" y="292"/>
                  </a:lnTo>
                  <a:lnTo>
                    <a:pt x="447" y="255"/>
                  </a:lnTo>
                  <a:lnTo>
                    <a:pt x="449" y="218"/>
                  </a:lnTo>
                  <a:lnTo>
                    <a:pt x="451" y="183"/>
                  </a:lnTo>
                  <a:lnTo>
                    <a:pt x="453" y="149"/>
                  </a:lnTo>
                  <a:lnTo>
                    <a:pt x="455" y="118"/>
                  </a:lnTo>
                  <a:lnTo>
                    <a:pt x="457" y="88"/>
                  </a:lnTo>
                  <a:lnTo>
                    <a:pt x="459" y="64"/>
                  </a:lnTo>
                  <a:lnTo>
                    <a:pt x="461" y="43"/>
                  </a:lnTo>
                  <a:lnTo>
                    <a:pt x="463" y="26"/>
                  </a:lnTo>
                  <a:lnTo>
                    <a:pt x="465" y="13"/>
                  </a:lnTo>
                  <a:lnTo>
                    <a:pt x="467" y="4"/>
                  </a:lnTo>
                  <a:lnTo>
                    <a:pt x="469" y="0"/>
                  </a:lnTo>
                  <a:lnTo>
                    <a:pt x="471" y="0"/>
                  </a:lnTo>
                  <a:lnTo>
                    <a:pt x="473" y="2"/>
                  </a:lnTo>
                  <a:lnTo>
                    <a:pt x="475" y="8"/>
                  </a:lnTo>
                  <a:lnTo>
                    <a:pt x="477" y="18"/>
                  </a:lnTo>
                  <a:lnTo>
                    <a:pt x="479" y="29"/>
                  </a:lnTo>
                  <a:lnTo>
                    <a:pt x="481" y="43"/>
                  </a:lnTo>
                  <a:lnTo>
                    <a:pt x="483" y="58"/>
                  </a:lnTo>
                  <a:lnTo>
                    <a:pt x="485" y="75"/>
                  </a:lnTo>
                  <a:lnTo>
                    <a:pt x="487" y="94"/>
                  </a:lnTo>
                  <a:lnTo>
                    <a:pt x="489" y="113"/>
                  </a:lnTo>
                  <a:lnTo>
                    <a:pt x="491" y="133"/>
                  </a:lnTo>
                  <a:lnTo>
                    <a:pt x="493" y="153"/>
                  </a:lnTo>
                  <a:lnTo>
                    <a:pt x="495" y="174"/>
                  </a:lnTo>
                  <a:lnTo>
                    <a:pt x="497" y="195"/>
                  </a:lnTo>
                  <a:lnTo>
                    <a:pt x="499" y="216"/>
                  </a:lnTo>
                  <a:lnTo>
                    <a:pt x="501" y="237"/>
                  </a:lnTo>
                  <a:lnTo>
                    <a:pt x="503" y="259"/>
                  </a:lnTo>
                  <a:lnTo>
                    <a:pt x="505" y="281"/>
                  </a:lnTo>
                  <a:lnTo>
                    <a:pt x="508" y="301"/>
                  </a:lnTo>
                  <a:lnTo>
                    <a:pt x="510" y="322"/>
                  </a:lnTo>
                  <a:lnTo>
                    <a:pt x="512" y="343"/>
                  </a:lnTo>
                  <a:lnTo>
                    <a:pt x="514" y="364"/>
                  </a:lnTo>
                  <a:lnTo>
                    <a:pt x="516" y="383"/>
                  </a:lnTo>
                  <a:lnTo>
                    <a:pt x="518" y="401"/>
                  </a:lnTo>
                  <a:lnTo>
                    <a:pt x="520" y="419"/>
                  </a:lnTo>
                  <a:lnTo>
                    <a:pt x="522" y="437"/>
                  </a:lnTo>
                  <a:lnTo>
                    <a:pt x="524" y="453"/>
                  </a:lnTo>
                  <a:lnTo>
                    <a:pt x="526" y="467"/>
                  </a:lnTo>
                  <a:lnTo>
                    <a:pt x="528" y="481"/>
                  </a:lnTo>
                  <a:lnTo>
                    <a:pt x="530" y="493"/>
                  </a:lnTo>
                  <a:lnTo>
                    <a:pt x="532" y="505"/>
                  </a:lnTo>
                  <a:lnTo>
                    <a:pt x="534" y="515"/>
                  </a:lnTo>
                  <a:lnTo>
                    <a:pt x="536" y="524"/>
                  </a:lnTo>
                  <a:lnTo>
                    <a:pt x="538" y="532"/>
                  </a:lnTo>
                  <a:lnTo>
                    <a:pt x="540" y="540"/>
                  </a:lnTo>
                  <a:lnTo>
                    <a:pt x="542" y="546"/>
                  </a:lnTo>
                  <a:lnTo>
                    <a:pt x="544" y="552"/>
                  </a:lnTo>
                  <a:lnTo>
                    <a:pt x="546" y="557"/>
                  </a:lnTo>
                  <a:lnTo>
                    <a:pt x="548" y="561"/>
                  </a:lnTo>
                  <a:lnTo>
                    <a:pt x="550" y="565"/>
                  </a:lnTo>
                  <a:lnTo>
                    <a:pt x="552" y="568"/>
                  </a:lnTo>
                  <a:lnTo>
                    <a:pt x="554" y="571"/>
                  </a:lnTo>
                  <a:lnTo>
                    <a:pt x="556" y="574"/>
                  </a:lnTo>
                  <a:lnTo>
                    <a:pt x="558" y="576"/>
                  </a:lnTo>
                  <a:lnTo>
                    <a:pt x="560" y="578"/>
                  </a:lnTo>
                  <a:lnTo>
                    <a:pt x="562" y="580"/>
                  </a:lnTo>
                  <a:lnTo>
                    <a:pt x="564" y="582"/>
                  </a:lnTo>
                  <a:lnTo>
                    <a:pt x="566" y="584"/>
                  </a:lnTo>
                  <a:lnTo>
                    <a:pt x="568" y="585"/>
                  </a:lnTo>
                  <a:lnTo>
                    <a:pt x="570" y="587"/>
                  </a:lnTo>
                  <a:lnTo>
                    <a:pt x="572" y="588"/>
                  </a:lnTo>
                  <a:lnTo>
                    <a:pt x="574" y="590"/>
                  </a:lnTo>
                  <a:lnTo>
                    <a:pt x="576" y="591"/>
                  </a:lnTo>
                  <a:lnTo>
                    <a:pt x="578" y="592"/>
                  </a:lnTo>
                  <a:lnTo>
                    <a:pt x="580" y="593"/>
                  </a:lnTo>
                  <a:lnTo>
                    <a:pt x="582" y="594"/>
                  </a:lnTo>
                  <a:lnTo>
                    <a:pt x="584" y="595"/>
                  </a:lnTo>
                  <a:lnTo>
                    <a:pt x="586" y="597"/>
                  </a:lnTo>
                  <a:lnTo>
                    <a:pt x="588" y="598"/>
                  </a:lnTo>
                  <a:lnTo>
                    <a:pt x="590" y="599"/>
                  </a:lnTo>
                  <a:lnTo>
                    <a:pt x="592" y="600"/>
                  </a:lnTo>
                  <a:lnTo>
                    <a:pt x="594" y="601"/>
                  </a:lnTo>
                  <a:lnTo>
                    <a:pt x="596" y="602"/>
                  </a:lnTo>
                  <a:lnTo>
                    <a:pt x="598" y="603"/>
                  </a:lnTo>
                  <a:lnTo>
                    <a:pt x="600" y="603"/>
                  </a:lnTo>
                  <a:lnTo>
                    <a:pt x="602" y="604"/>
                  </a:lnTo>
                  <a:lnTo>
                    <a:pt x="604" y="605"/>
                  </a:lnTo>
                  <a:lnTo>
                    <a:pt x="606" y="606"/>
                  </a:lnTo>
                  <a:lnTo>
                    <a:pt x="608" y="607"/>
                  </a:lnTo>
                  <a:lnTo>
                    <a:pt x="610" y="607"/>
                  </a:lnTo>
                  <a:lnTo>
                    <a:pt x="612" y="608"/>
                  </a:lnTo>
                  <a:lnTo>
                    <a:pt x="614" y="609"/>
                  </a:lnTo>
                  <a:lnTo>
                    <a:pt x="616" y="610"/>
                  </a:lnTo>
                  <a:lnTo>
                    <a:pt x="618" y="610"/>
                  </a:lnTo>
                  <a:lnTo>
                    <a:pt x="620" y="611"/>
                  </a:lnTo>
                  <a:lnTo>
                    <a:pt x="622" y="611"/>
                  </a:lnTo>
                  <a:lnTo>
                    <a:pt x="624" y="612"/>
                  </a:lnTo>
                  <a:lnTo>
                    <a:pt x="626" y="613"/>
                  </a:lnTo>
                  <a:lnTo>
                    <a:pt x="628" y="613"/>
                  </a:lnTo>
                  <a:lnTo>
                    <a:pt x="630" y="614"/>
                  </a:lnTo>
                  <a:lnTo>
                    <a:pt x="632" y="615"/>
                  </a:lnTo>
                  <a:lnTo>
                    <a:pt x="634" y="615"/>
                  </a:lnTo>
                  <a:lnTo>
                    <a:pt x="636" y="616"/>
                  </a:lnTo>
                  <a:lnTo>
                    <a:pt x="638" y="616"/>
                  </a:lnTo>
                  <a:lnTo>
                    <a:pt x="641" y="617"/>
                  </a:lnTo>
                  <a:lnTo>
                    <a:pt x="642" y="618"/>
                  </a:lnTo>
                  <a:lnTo>
                    <a:pt x="644" y="618"/>
                  </a:lnTo>
                  <a:lnTo>
                    <a:pt x="646" y="619"/>
                  </a:lnTo>
                  <a:lnTo>
                    <a:pt x="648" y="619"/>
                  </a:lnTo>
                  <a:lnTo>
                    <a:pt x="651" y="620"/>
                  </a:lnTo>
                  <a:lnTo>
                    <a:pt x="653" y="621"/>
                  </a:lnTo>
                  <a:lnTo>
                    <a:pt x="655" y="621"/>
                  </a:lnTo>
                  <a:lnTo>
                    <a:pt x="657" y="622"/>
                  </a:lnTo>
                  <a:lnTo>
                    <a:pt x="659" y="622"/>
                  </a:lnTo>
                  <a:lnTo>
                    <a:pt x="661" y="623"/>
                  </a:lnTo>
                  <a:lnTo>
                    <a:pt x="663" y="624"/>
                  </a:lnTo>
                  <a:lnTo>
                    <a:pt x="665" y="624"/>
                  </a:lnTo>
                  <a:lnTo>
                    <a:pt x="667" y="625"/>
                  </a:lnTo>
                  <a:lnTo>
                    <a:pt x="669" y="625"/>
                  </a:lnTo>
                  <a:lnTo>
                    <a:pt x="671" y="626"/>
                  </a:lnTo>
                  <a:lnTo>
                    <a:pt x="673" y="626"/>
                  </a:lnTo>
                  <a:lnTo>
                    <a:pt x="675" y="627"/>
                  </a:lnTo>
                  <a:lnTo>
                    <a:pt x="677" y="627"/>
                  </a:lnTo>
                  <a:lnTo>
                    <a:pt x="679" y="628"/>
                  </a:lnTo>
                  <a:lnTo>
                    <a:pt x="681" y="628"/>
                  </a:lnTo>
                  <a:lnTo>
                    <a:pt x="683" y="629"/>
                  </a:lnTo>
                  <a:lnTo>
                    <a:pt x="685" y="629"/>
                  </a:lnTo>
                  <a:lnTo>
                    <a:pt x="687" y="630"/>
                  </a:lnTo>
                  <a:lnTo>
                    <a:pt x="689" y="630"/>
                  </a:lnTo>
                  <a:lnTo>
                    <a:pt x="691" y="630"/>
                  </a:lnTo>
                  <a:lnTo>
                    <a:pt x="693" y="631"/>
                  </a:lnTo>
                  <a:lnTo>
                    <a:pt x="695" y="631"/>
                  </a:lnTo>
                  <a:lnTo>
                    <a:pt x="697" y="631"/>
                  </a:lnTo>
                  <a:lnTo>
                    <a:pt x="699" y="632"/>
                  </a:lnTo>
                  <a:lnTo>
                    <a:pt x="701" y="632"/>
                  </a:lnTo>
                  <a:lnTo>
                    <a:pt x="703" y="632"/>
                  </a:lnTo>
                  <a:lnTo>
                    <a:pt x="705" y="632"/>
                  </a:lnTo>
                  <a:lnTo>
                    <a:pt x="707" y="633"/>
                  </a:lnTo>
                  <a:lnTo>
                    <a:pt x="709" y="633"/>
                  </a:lnTo>
                  <a:lnTo>
                    <a:pt x="711" y="633"/>
                  </a:lnTo>
                  <a:lnTo>
                    <a:pt x="713" y="633"/>
                  </a:lnTo>
                  <a:lnTo>
                    <a:pt x="715" y="633"/>
                  </a:lnTo>
                  <a:lnTo>
                    <a:pt x="717" y="633"/>
                  </a:lnTo>
                  <a:lnTo>
                    <a:pt x="719" y="633"/>
                  </a:lnTo>
                  <a:lnTo>
                    <a:pt x="721" y="633"/>
                  </a:lnTo>
                  <a:lnTo>
                    <a:pt x="723" y="633"/>
                  </a:lnTo>
                  <a:lnTo>
                    <a:pt x="725" y="633"/>
                  </a:lnTo>
                  <a:lnTo>
                    <a:pt x="727" y="633"/>
                  </a:lnTo>
                  <a:lnTo>
                    <a:pt x="729" y="633"/>
                  </a:lnTo>
                  <a:lnTo>
                    <a:pt x="731" y="633"/>
                  </a:lnTo>
                  <a:lnTo>
                    <a:pt x="733" y="633"/>
                  </a:lnTo>
                  <a:lnTo>
                    <a:pt x="735" y="633"/>
                  </a:lnTo>
                  <a:lnTo>
                    <a:pt x="737" y="633"/>
                  </a:lnTo>
                  <a:lnTo>
                    <a:pt x="739" y="633"/>
                  </a:lnTo>
                  <a:lnTo>
                    <a:pt x="741" y="632"/>
                  </a:lnTo>
                  <a:lnTo>
                    <a:pt x="743" y="632"/>
                  </a:lnTo>
                  <a:lnTo>
                    <a:pt x="745" y="632"/>
                  </a:lnTo>
                  <a:lnTo>
                    <a:pt x="747" y="632"/>
                  </a:lnTo>
                  <a:lnTo>
                    <a:pt x="749" y="632"/>
                  </a:lnTo>
                  <a:lnTo>
                    <a:pt x="751" y="632"/>
                  </a:lnTo>
                  <a:lnTo>
                    <a:pt x="753" y="632"/>
                  </a:lnTo>
                  <a:lnTo>
                    <a:pt x="755" y="631"/>
                  </a:lnTo>
                  <a:lnTo>
                    <a:pt x="757" y="631"/>
                  </a:lnTo>
                  <a:lnTo>
                    <a:pt x="759" y="631"/>
                  </a:lnTo>
                  <a:lnTo>
                    <a:pt x="761" y="631"/>
                  </a:lnTo>
                  <a:lnTo>
                    <a:pt x="763" y="631"/>
                  </a:lnTo>
                  <a:lnTo>
                    <a:pt x="765" y="630"/>
                  </a:lnTo>
                  <a:lnTo>
                    <a:pt x="767" y="630"/>
                  </a:lnTo>
                  <a:lnTo>
                    <a:pt x="769" y="630"/>
                  </a:lnTo>
                  <a:lnTo>
                    <a:pt x="771" y="630"/>
                  </a:lnTo>
                  <a:lnTo>
                    <a:pt x="773" y="630"/>
                  </a:lnTo>
                  <a:lnTo>
                    <a:pt x="775" y="629"/>
                  </a:lnTo>
                  <a:lnTo>
                    <a:pt x="777" y="629"/>
                  </a:lnTo>
                  <a:lnTo>
                    <a:pt x="779" y="629"/>
                  </a:lnTo>
                  <a:lnTo>
                    <a:pt x="781" y="629"/>
                  </a:lnTo>
                  <a:lnTo>
                    <a:pt x="783" y="629"/>
                  </a:lnTo>
                  <a:lnTo>
                    <a:pt x="786" y="62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1235" name="ZoneTexte 1234"/>
          <p:cNvSpPr txBox="1"/>
          <p:nvPr/>
        </p:nvSpPr>
        <p:spPr>
          <a:xfrm>
            <a:off x="980728" y="3395274"/>
            <a:ext cx="72699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OPDV</a:t>
            </a:r>
            <a:endParaRPr lang="fr-FR" i="1" dirty="0"/>
          </a:p>
        </p:txBody>
      </p:sp>
      <p:grpSp>
        <p:nvGrpSpPr>
          <p:cNvPr id="1349" name="Groupe 1348"/>
          <p:cNvGrpSpPr/>
          <p:nvPr/>
        </p:nvGrpSpPr>
        <p:grpSpPr>
          <a:xfrm>
            <a:off x="619187" y="5606504"/>
            <a:ext cx="2878137" cy="1701800"/>
            <a:chOff x="398463" y="6367463"/>
            <a:chExt cx="2878137" cy="1701800"/>
          </a:xfrm>
        </p:grpSpPr>
        <p:sp>
          <p:nvSpPr>
            <p:cNvPr id="1347" name="Freeform 346"/>
            <p:cNvSpPr>
              <a:spLocks/>
            </p:cNvSpPr>
            <p:nvPr/>
          </p:nvSpPr>
          <p:spPr bwMode="auto">
            <a:xfrm>
              <a:off x="398463" y="6673850"/>
              <a:ext cx="1630363" cy="1395413"/>
            </a:xfrm>
            <a:custGeom>
              <a:avLst/>
              <a:gdLst>
                <a:gd name="T0" fmla="*/ 14 w 1027"/>
                <a:gd name="T1" fmla="*/ 854 h 879"/>
                <a:gd name="T2" fmla="*/ 30 w 1027"/>
                <a:gd name="T3" fmla="*/ 852 h 879"/>
                <a:gd name="T4" fmla="*/ 46 w 1027"/>
                <a:gd name="T5" fmla="*/ 851 h 879"/>
                <a:gd name="T6" fmla="*/ 62 w 1027"/>
                <a:gd name="T7" fmla="*/ 850 h 879"/>
                <a:gd name="T8" fmla="*/ 78 w 1027"/>
                <a:gd name="T9" fmla="*/ 847 h 879"/>
                <a:gd name="T10" fmla="*/ 94 w 1027"/>
                <a:gd name="T11" fmla="*/ 846 h 879"/>
                <a:gd name="T12" fmla="*/ 110 w 1027"/>
                <a:gd name="T13" fmla="*/ 844 h 879"/>
                <a:gd name="T14" fmla="*/ 127 w 1027"/>
                <a:gd name="T15" fmla="*/ 843 h 879"/>
                <a:gd name="T16" fmla="*/ 143 w 1027"/>
                <a:gd name="T17" fmla="*/ 842 h 879"/>
                <a:gd name="T18" fmla="*/ 159 w 1027"/>
                <a:gd name="T19" fmla="*/ 840 h 879"/>
                <a:gd name="T20" fmla="*/ 175 w 1027"/>
                <a:gd name="T21" fmla="*/ 869 h 879"/>
                <a:gd name="T22" fmla="*/ 191 w 1027"/>
                <a:gd name="T23" fmla="*/ 834 h 879"/>
                <a:gd name="T24" fmla="*/ 207 w 1027"/>
                <a:gd name="T25" fmla="*/ 150 h 879"/>
                <a:gd name="T26" fmla="*/ 223 w 1027"/>
                <a:gd name="T27" fmla="*/ 808 h 879"/>
                <a:gd name="T28" fmla="*/ 239 w 1027"/>
                <a:gd name="T29" fmla="*/ 823 h 879"/>
                <a:gd name="T30" fmla="*/ 255 w 1027"/>
                <a:gd name="T31" fmla="*/ 826 h 879"/>
                <a:gd name="T32" fmla="*/ 272 w 1027"/>
                <a:gd name="T33" fmla="*/ 825 h 879"/>
                <a:gd name="T34" fmla="*/ 288 w 1027"/>
                <a:gd name="T35" fmla="*/ 824 h 879"/>
                <a:gd name="T36" fmla="*/ 304 w 1027"/>
                <a:gd name="T37" fmla="*/ 826 h 879"/>
                <a:gd name="T38" fmla="*/ 320 w 1027"/>
                <a:gd name="T39" fmla="*/ 825 h 879"/>
                <a:gd name="T40" fmla="*/ 336 w 1027"/>
                <a:gd name="T41" fmla="*/ 805 h 879"/>
                <a:gd name="T42" fmla="*/ 352 w 1027"/>
                <a:gd name="T43" fmla="*/ 812 h 879"/>
                <a:gd name="T44" fmla="*/ 368 w 1027"/>
                <a:gd name="T45" fmla="*/ 817 h 879"/>
                <a:gd name="T46" fmla="*/ 384 w 1027"/>
                <a:gd name="T47" fmla="*/ 797 h 879"/>
                <a:gd name="T48" fmla="*/ 401 w 1027"/>
                <a:gd name="T49" fmla="*/ 813 h 879"/>
                <a:gd name="T50" fmla="*/ 417 w 1027"/>
                <a:gd name="T51" fmla="*/ 816 h 879"/>
                <a:gd name="T52" fmla="*/ 433 w 1027"/>
                <a:gd name="T53" fmla="*/ 816 h 879"/>
                <a:gd name="T54" fmla="*/ 449 w 1027"/>
                <a:gd name="T55" fmla="*/ 811 h 879"/>
                <a:gd name="T56" fmla="*/ 465 w 1027"/>
                <a:gd name="T57" fmla="*/ 801 h 879"/>
                <a:gd name="T58" fmla="*/ 481 w 1027"/>
                <a:gd name="T59" fmla="*/ 809 h 879"/>
                <a:gd name="T60" fmla="*/ 497 w 1027"/>
                <a:gd name="T61" fmla="*/ 813 h 879"/>
                <a:gd name="T62" fmla="*/ 513 w 1027"/>
                <a:gd name="T63" fmla="*/ 814 h 879"/>
                <a:gd name="T64" fmla="*/ 529 w 1027"/>
                <a:gd name="T65" fmla="*/ 808 h 879"/>
                <a:gd name="T66" fmla="*/ 546 w 1027"/>
                <a:gd name="T67" fmla="*/ 807 h 879"/>
                <a:gd name="T68" fmla="*/ 562 w 1027"/>
                <a:gd name="T69" fmla="*/ 810 h 879"/>
                <a:gd name="T70" fmla="*/ 578 w 1027"/>
                <a:gd name="T71" fmla="*/ 810 h 879"/>
                <a:gd name="T72" fmla="*/ 594 w 1027"/>
                <a:gd name="T73" fmla="*/ 810 h 879"/>
                <a:gd name="T74" fmla="*/ 610 w 1027"/>
                <a:gd name="T75" fmla="*/ 810 h 879"/>
                <a:gd name="T76" fmla="*/ 626 w 1027"/>
                <a:gd name="T77" fmla="*/ 810 h 879"/>
                <a:gd name="T78" fmla="*/ 642 w 1027"/>
                <a:gd name="T79" fmla="*/ 808 h 879"/>
                <a:gd name="T80" fmla="*/ 658 w 1027"/>
                <a:gd name="T81" fmla="*/ 807 h 879"/>
                <a:gd name="T82" fmla="*/ 674 w 1027"/>
                <a:gd name="T83" fmla="*/ 807 h 879"/>
                <a:gd name="T84" fmla="*/ 691 w 1027"/>
                <a:gd name="T85" fmla="*/ 808 h 879"/>
                <a:gd name="T86" fmla="*/ 707 w 1027"/>
                <a:gd name="T87" fmla="*/ 807 h 879"/>
                <a:gd name="T88" fmla="*/ 723 w 1027"/>
                <a:gd name="T89" fmla="*/ 805 h 879"/>
                <a:gd name="T90" fmla="*/ 739 w 1027"/>
                <a:gd name="T91" fmla="*/ 803 h 879"/>
                <a:gd name="T92" fmla="*/ 755 w 1027"/>
                <a:gd name="T93" fmla="*/ 802 h 879"/>
                <a:gd name="T94" fmla="*/ 771 w 1027"/>
                <a:gd name="T95" fmla="*/ 799 h 879"/>
                <a:gd name="T96" fmla="*/ 787 w 1027"/>
                <a:gd name="T97" fmla="*/ 800 h 879"/>
                <a:gd name="T98" fmla="*/ 803 w 1027"/>
                <a:gd name="T99" fmla="*/ 798 h 879"/>
                <a:gd name="T100" fmla="*/ 819 w 1027"/>
                <a:gd name="T101" fmla="*/ 798 h 879"/>
                <a:gd name="T102" fmla="*/ 836 w 1027"/>
                <a:gd name="T103" fmla="*/ 798 h 879"/>
                <a:gd name="T104" fmla="*/ 852 w 1027"/>
                <a:gd name="T105" fmla="*/ 798 h 879"/>
                <a:gd name="T106" fmla="*/ 868 w 1027"/>
                <a:gd name="T107" fmla="*/ 798 h 879"/>
                <a:gd name="T108" fmla="*/ 884 w 1027"/>
                <a:gd name="T109" fmla="*/ 793 h 879"/>
                <a:gd name="T110" fmla="*/ 900 w 1027"/>
                <a:gd name="T111" fmla="*/ 690 h 879"/>
                <a:gd name="T112" fmla="*/ 916 w 1027"/>
                <a:gd name="T113" fmla="*/ 469 h 879"/>
                <a:gd name="T114" fmla="*/ 932 w 1027"/>
                <a:gd name="T115" fmla="*/ 543 h 879"/>
                <a:gd name="T116" fmla="*/ 948 w 1027"/>
                <a:gd name="T117" fmla="*/ 675 h 879"/>
                <a:gd name="T118" fmla="*/ 964 w 1027"/>
                <a:gd name="T119" fmla="*/ 746 h 879"/>
                <a:gd name="T120" fmla="*/ 981 w 1027"/>
                <a:gd name="T121" fmla="*/ 767 h 879"/>
                <a:gd name="T122" fmla="*/ 997 w 1027"/>
                <a:gd name="T123" fmla="*/ 775 h 879"/>
                <a:gd name="T124" fmla="*/ 1013 w 1027"/>
                <a:gd name="T125" fmla="*/ 776 h 8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27" h="879">
                  <a:moveTo>
                    <a:pt x="0" y="856"/>
                  </a:moveTo>
                  <a:lnTo>
                    <a:pt x="2" y="855"/>
                  </a:lnTo>
                  <a:lnTo>
                    <a:pt x="4" y="855"/>
                  </a:lnTo>
                  <a:lnTo>
                    <a:pt x="6" y="856"/>
                  </a:lnTo>
                  <a:lnTo>
                    <a:pt x="8" y="855"/>
                  </a:lnTo>
                  <a:lnTo>
                    <a:pt x="10" y="855"/>
                  </a:lnTo>
                  <a:lnTo>
                    <a:pt x="12" y="854"/>
                  </a:lnTo>
                  <a:lnTo>
                    <a:pt x="14" y="854"/>
                  </a:lnTo>
                  <a:lnTo>
                    <a:pt x="16" y="855"/>
                  </a:lnTo>
                  <a:lnTo>
                    <a:pt x="18" y="854"/>
                  </a:lnTo>
                  <a:lnTo>
                    <a:pt x="20" y="854"/>
                  </a:lnTo>
                  <a:lnTo>
                    <a:pt x="22" y="853"/>
                  </a:lnTo>
                  <a:lnTo>
                    <a:pt x="24" y="854"/>
                  </a:lnTo>
                  <a:lnTo>
                    <a:pt x="26" y="853"/>
                  </a:lnTo>
                  <a:lnTo>
                    <a:pt x="28" y="853"/>
                  </a:lnTo>
                  <a:lnTo>
                    <a:pt x="30" y="852"/>
                  </a:lnTo>
                  <a:lnTo>
                    <a:pt x="32" y="852"/>
                  </a:lnTo>
                  <a:lnTo>
                    <a:pt x="34" y="853"/>
                  </a:lnTo>
                  <a:lnTo>
                    <a:pt x="36" y="852"/>
                  </a:lnTo>
                  <a:lnTo>
                    <a:pt x="38" y="852"/>
                  </a:lnTo>
                  <a:lnTo>
                    <a:pt x="40" y="851"/>
                  </a:lnTo>
                  <a:lnTo>
                    <a:pt x="42" y="851"/>
                  </a:lnTo>
                  <a:lnTo>
                    <a:pt x="44" y="851"/>
                  </a:lnTo>
                  <a:lnTo>
                    <a:pt x="46" y="851"/>
                  </a:lnTo>
                  <a:lnTo>
                    <a:pt x="48" y="851"/>
                  </a:lnTo>
                  <a:lnTo>
                    <a:pt x="50" y="850"/>
                  </a:lnTo>
                  <a:lnTo>
                    <a:pt x="52" y="851"/>
                  </a:lnTo>
                  <a:lnTo>
                    <a:pt x="54" y="850"/>
                  </a:lnTo>
                  <a:lnTo>
                    <a:pt x="56" y="850"/>
                  </a:lnTo>
                  <a:lnTo>
                    <a:pt x="58" y="850"/>
                  </a:lnTo>
                  <a:lnTo>
                    <a:pt x="60" y="849"/>
                  </a:lnTo>
                  <a:lnTo>
                    <a:pt x="62" y="850"/>
                  </a:lnTo>
                  <a:lnTo>
                    <a:pt x="64" y="849"/>
                  </a:lnTo>
                  <a:lnTo>
                    <a:pt x="66" y="849"/>
                  </a:lnTo>
                  <a:lnTo>
                    <a:pt x="68" y="848"/>
                  </a:lnTo>
                  <a:lnTo>
                    <a:pt x="70" y="848"/>
                  </a:lnTo>
                  <a:lnTo>
                    <a:pt x="72" y="848"/>
                  </a:lnTo>
                  <a:lnTo>
                    <a:pt x="74" y="848"/>
                  </a:lnTo>
                  <a:lnTo>
                    <a:pt x="76" y="848"/>
                  </a:lnTo>
                  <a:lnTo>
                    <a:pt x="78" y="847"/>
                  </a:lnTo>
                  <a:lnTo>
                    <a:pt x="80" y="848"/>
                  </a:lnTo>
                  <a:lnTo>
                    <a:pt x="82" y="847"/>
                  </a:lnTo>
                  <a:lnTo>
                    <a:pt x="84" y="847"/>
                  </a:lnTo>
                  <a:lnTo>
                    <a:pt x="86" y="847"/>
                  </a:lnTo>
                  <a:lnTo>
                    <a:pt x="88" y="847"/>
                  </a:lnTo>
                  <a:lnTo>
                    <a:pt x="90" y="847"/>
                  </a:lnTo>
                  <a:lnTo>
                    <a:pt x="92" y="846"/>
                  </a:lnTo>
                  <a:lnTo>
                    <a:pt x="94" y="846"/>
                  </a:lnTo>
                  <a:lnTo>
                    <a:pt x="96" y="846"/>
                  </a:lnTo>
                  <a:lnTo>
                    <a:pt x="98" y="846"/>
                  </a:lnTo>
                  <a:lnTo>
                    <a:pt x="100" y="846"/>
                  </a:lnTo>
                  <a:lnTo>
                    <a:pt x="102" y="845"/>
                  </a:lnTo>
                  <a:lnTo>
                    <a:pt x="104" y="845"/>
                  </a:lnTo>
                  <a:lnTo>
                    <a:pt x="106" y="845"/>
                  </a:lnTo>
                  <a:lnTo>
                    <a:pt x="108" y="845"/>
                  </a:lnTo>
                  <a:lnTo>
                    <a:pt x="110" y="844"/>
                  </a:lnTo>
                  <a:lnTo>
                    <a:pt x="112" y="844"/>
                  </a:lnTo>
                  <a:lnTo>
                    <a:pt x="114" y="844"/>
                  </a:lnTo>
                  <a:lnTo>
                    <a:pt x="116" y="844"/>
                  </a:lnTo>
                  <a:lnTo>
                    <a:pt x="118" y="844"/>
                  </a:lnTo>
                  <a:lnTo>
                    <a:pt x="121" y="844"/>
                  </a:lnTo>
                  <a:lnTo>
                    <a:pt x="123" y="843"/>
                  </a:lnTo>
                  <a:lnTo>
                    <a:pt x="125" y="843"/>
                  </a:lnTo>
                  <a:lnTo>
                    <a:pt x="127" y="843"/>
                  </a:lnTo>
                  <a:lnTo>
                    <a:pt x="129" y="843"/>
                  </a:lnTo>
                  <a:lnTo>
                    <a:pt x="131" y="842"/>
                  </a:lnTo>
                  <a:lnTo>
                    <a:pt x="133" y="842"/>
                  </a:lnTo>
                  <a:lnTo>
                    <a:pt x="135" y="842"/>
                  </a:lnTo>
                  <a:lnTo>
                    <a:pt x="137" y="843"/>
                  </a:lnTo>
                  <a:lnTo>
                    <a:pt x="139" y="842"/>
                  </a:lnTo>
                  <a:lnTo>
                    <a:pt x="141" y="842"/>
                  </a:lnTo>
                  <a:lnTo>
                    <a:pt x="143" y="842"/>
                  </a:lnTo>
                  <a:lnTo>
                    <a:pt x="145" y="842"/>
                  </a:lnTo>
                  <a:lnTo>
                    <a:pt x="147" y="842"/>
                  </a:lnTo>
                  <a:lnTo>
                    <a:pt x="149" y="841"/>
                  </a:lnTo>
                  <a:lnTo>
                    <a:pt x="151" y="841"/>
                  </a:lnTo>
                  <a:lnTo>
                    <a:pt x="153" y="841"/>
                  </a:lnTo>
                  <a:lnTo>
                    <a:pt x="155" y="841"/>
                  </a:lnTo>
                  <a:lnTo>
                    <a:pt x="157" y="841"/>
                  </a:lnTo>
                  <a:lnTo>
                    <a:pt x="159" y="840"/>
                  </a:lnTo>
                  <a:lnTo>
                    <a:pt x="161" y="840"/>
                  </a:lnTo>
                  <a:lnTo>
                    <a:pt x="163" y="840"/>
                  </a:lnTo>
                  <a:lnTo>
                    <a:pt x="165" y="844"/>
                  </a:lnTo>
                  <a:lnTo>
                    <a:pt x="167" y="858"/>
                  </a:lnTo>
                  <a:lnTo>
                    <a:pt x="169" y="875"/>
                  </a:lnTo>
                  <a:lnTo>
                    <a:pt x="171" y="879"/>
                  </a:lnTo>
                  <a:lnTo>
                    <a:pt x="173" y="875"/>
                  </a:lnTo>
                  <a:lnTo>
                    <a:pt x="175" y="869"/>
                  </a:lnTo>
                  <a:lnTo>
                    <a:pt x="177" y="862"/>
                  </a:lnTo>
                  <a:lnTo>
                    <a:pt x="179" y="854"/>
                  </a:lnTo>
                  <a:lnTo>
                    <a:pt x="181" y="849"/>
                  </a:lnTo>
                  <a:lnTo>
                    <a:pt x="183" y="845"/>
                  </a:lnTo>
                  <a:lnTo>
                    <a:pt x="185" y="842"/>
                  </a:lnTo>
                  <a:lnTo>
                    <a:pt x="187" y="838"/>
                  </a:lnTo>
                  <a:lnTo>
                    <a:pt x="189" y="834"/>
                  </a:lnTo>
                  <a:lnTo>
                    <a:pt x="191" y="834"/>
                  </a:lnTo>
                  <a:lnTo>
                    <a:pt x="193" y="834"/>
                  </a:lnTo>
                  <a:lnTo>
                    <a:pt x="195" y="826"/>
                  </a:lnTo>
                  <a:lnTo>
                    <a:pt x="197" y="738"/>
                  </a:lnTo>
                  <a:lnTo>
                    <a:pt x="199" y="447"/>
                  </a:lnTo>
                  <a:lnTo>
                    <a:pt x="201" y="115"/>
                  </a:lnTo>
                  <a:lnTo>
                    <a:pt x="203" y="0"/>
                  </a:lnTo>
                  <a:lnTo>
                    <a:pt x="205" y="52"/>
                  </a:lnTo>
                  <a:lnTo>
                    <a:pt x="207" y="150"/>
                  </a:lnTo>
                  <a:lnTo>
                    <a:pt x="209" y="270"/>
                  </a:lnTo>
                  <a:lnTo>
                    <a:pt x="211" y="424"/>
                  </a:lnTo>
                  <a:lnTo>
                    <a:pt x="213" y="575"/>
                  </a:lnTo>
                  <a:lnTo>
                    <a:pt x="215" y="687"/>
                  </a:lnTo>
                  <a:lnTo>
                    <a:pt x="217" y="754"/>
                  </a:lnTo>
                  <a:lnTo>
                    <a:pt x="219" y="787"/>
                  </a:lnTo>
                  <a:lnTo>
                    <a:pt x="221" y="801"/>
                  </a:lnTo>
                  <a:lnTo>
                    <a:pt x="223" y="808"/>
                  </a:lnTo>
                  <a:lnTo>
                    <a:pt x="225" y="813"/>
                  </a:lnTo>
                  <a:lnTo>
                    <a:pt x="227" y="816"/>
                  </a:lnTo>
                  <a:lnTo>
                    <a:pt x="229" y="819"/>
                  </a:lnTo>
                  <a:lnTo>
                    <a:pt x="231" y="821"/>
                  </a:lnTo>
                  <a:lnTo>
                    <a:pt x="233" y="823"/>
                  </a:lnTo>
                  <a:lnTo>
                    <a:pt x="235" y="824"/>
                  </a:lnTo>
                  <a:lnTo>
                    <a:pt x="237" y="824"/>
                  </a:lnTo>
                  <a:lnTo>
                    <a:pt x="239" y="823"/>
                  </a:lnTo>
                  <a:lnTo>
                    <a:pt x="241" y="823"/>
                  </a:lnTo>
                  <a:lnTo>
                    <a:pt x="243" y="823"/>
                  </a:lnTo>
                  <a:lnTo>
                    <a:pt x="245" y="823"/>
                  </a:lnTo>
                  <a:lnTo>
                    <a:pt x="247" y="824"/>
                  </a:lnTo>
                  <a:lnTo>
                    <a:pt x="249" y="825"/>
                  </a:lnTo>
                  <a:lnTo>
                    <a:pt x="251" y="825"/>
                  </a:lnTo>
                  <a:lnTo>
                    <a:pt x="253" y="825"/>
                  </a:lnTo>
                  <a:lnTo>
                    <a:pt x="255" y="826"/>
                  </a:lnTo>
                  <a:lnTo>
                    <a:pt x="257" y="826"/>
                  </a:lnTo>
                  <a:lnTo>
                    <a:pt x="259" y="826"/>
                  </a:lnTo>
                  <a:lnTo>
                    <a:pt x="261" y="826"/>
                  </a:lnTo>
                  <a:lnTo>
                    <a:pt x="264" y="826"/>
                  </a:lnTo>
                  <a:lnTo>
                    <a:pt x="266" y="826"/>
                  </a:lnTo>
                  <a:lnTo>
                    <a:pt x="268" y="826"/>
                  </a:lnTo>
                  <a:lnTo>
                    <a:pt x="270" y="825"/>
                  </a:lnTo>
                  <a:lnTo>
                    <a:pt x="272" y="825"/>
                  </a:lnTo>
                  <a:lnTo>
                    <a:pt x="274" y="824"/>
                  </a:lnTo>
                  <a:lnTo>
                    <a:pt x="276" y="822"/>
                  </a:lnTo>
                  <a:lnTo>
                    <a:pt x="278" y="821"/>
                  </a:lnTo>
                  <a:lnTo>
                    <a:pt x="280" y="822"/>
                  </a:lnTo>
                  <a:lnTo>
                    <a:pt x="282" y="823"/>
                  </a:lnTo>
                  <a:lnTo>
                    <a:pt x="284" y="824"/>
                  </a:lnTo>
                  <a:lnTo>
                    <a:pt x="286" y="824"/>
                  </a:lnTo>
                  <a:lnTo>
                    <a:pt x="288" y="824"/>
                  </a:lnTo>
                  <a:lnTo>
                    <a:pt x="290" y="825"/>
                  </a:lnTo>
                  <a:lnTo>
                    <a:pt x="292" y="826"/>
                  </a:lnTo>
                  <a:lnTo>
                    <a:pt x="294" y="826"/>
                  </a:lnTo>
                  <a:lnTo>
                    <a:pt x="296" y="826"/>
                  </a:lnTo>
                  <a:lnTo>
                    <a:pt x="298" y="826"/>
                  </a:lnTo>
                  <a:lnTo>
                    <a:pt x="300" y="826"/>
                  </a:lnTo>
                  <a:lnTo>
                    <a:pt x="302" y="827"/>
                  </a:lnTo>
                  <a:lnTo>
                    <a:pt x="304" y="826"/>
                  </a:lnTo>
                  <a:lnTo>
                    <a:pt x="306" y="826"/>
                  </a:lnTo>
                  <a:lnTo>
                    <a:pt x="308" y="826"/>
                  </a:lnTo>
                  <a:lnTo>
                    <a:pt x="310" y="825"/>
                  </a:lnTo>
                  <a:lnTo>
                    <a:pt x="312" y="826"/>
                  </a:lnTo>
                  <a:lnTo>
                    <a:pt x="314" y="825"/>
                  </a:lnTo>
                  <a:lnTo>
                    <a:pt x="316" y="825"/>
                  </a:lnTo>
                  <a:lnTo>
                    <a:pt x="318" y="825"/>
                  </a:lnTo>
                  <a:lnTo>
                    <a:pt x="320" y="825"/>
                  </a:lnTo>
                  <a:lnTo>
                    <a:pt x="322" y="824"/>
                  </a:lnTo>
                  <a:lnTo>
                    <a:pt x="324" y="823"/>
                  </a:lnTo>
                  <a:lnTo>
                    <a:pt x="326" y="822"/>
                  </a:lnTo>
                  <a:lnTo>
                    <a:pt x="328" y="820"/>
                  </a:lnTo>
                  <a:lnTo>
                    <a:pt x="330" y="818"/>
                  </a:lnTo>
                  <a:lnTo>
                    <a:pt x="332" y="813"/>
                  </a:lnTo>
                  <a:lnTo>
                    <a:pt x="334" y="808"/>
                  </a:lnTo>
                  <a:lnTo>
                    <a:pt x="336" y="805"/>
                  </a:lnTo>
                  <a:lnTo>
                    <a:pt x="338" y="803"/>
                  </a:lnTo>
                  <a:lnTo>
                    <a:pt x="340" y="803"/>
                  </a:lnTo>
                  <a:lnTo>
                    <a:pt x="342" y="804"/>
                  </a:lnTo>
                  <a:lnTo>
                    <a:pt x="344" y="805"/>
                  </a:lnTo>
                  <a:lnTo>
                    <a:pt x="346" y="807"/>
                  </a:lnTo>
                  <a:lnTo>
                    <a:pt x="348" y="809"/>
                  </a:lnTo>
                  <a:lnTo>
                    <a:pt x="350" y="811"/>
                  </a:lnTo>
                  <a:lnTo>
                    <a:pt x="352" y="812"/>
                  </a:lnTo>
                  <a:lnTo>
                    <a:pt x="354" y="813"/>
                  </a:lnTo>
                  <a:lnTo>
                    <a:pt x="356" y="814"/>
                  </a:lnTo>
                  <a:lnTo>
                    <a:pt x="358" y="816"/>
                  </a:lnTo>
                  <a:lnTo>
                    <a:pt x="360" y="816"/>
                  </a:lnTo>
                  <a:lnTo>
                    <a:pt x="362" y="817"/>
                  </a:lnTo>
                  <a:lnTo>
                    <a:pt x="364" y="817"/>
                  </a:lnTo>
                  <a:lnTo>
                    <a:pt x="366" y="817"/>
                  </a:lnTo>
                  <a:lnTo>
                    <a:pt x="368" y="817"/>
                  </a:lnTo>
                  <a:lnTo>
                    <a:pt x="370" y="814"/>
                  </a:lnTo>
                  <a:lnTo>
                    <a:pt x="372" y="812"/>
                  </a:lnTo>
                  <a:lnTo>
                    <a:pt x="374" y="806"/>
                  </a:lnTo>
                  <a:lnTo>
                    <a:pt x="376" y="801"/>
                  </a:lnTo>
                  <a:lnTo>
                    <a:pt x="378" y="797"/>
                  </a:lnTo>
                  <a:lnTo>
                    <a:pt x="380" y="795"/>
                  </a:lnTo>
                  <a:lnTo>
                    <a:pt x="382" y="795"/>
                  </a:lnTo>
                  <a:lnTo>
                    <a:pt x="384" y="797"/>
                  </a:lnTo>
                  <a:lnTo>
                    <a:pt x="386" y="799"/>
                  </a:lnTo>
                  <a:lnTo>
                    <a:pt x="388" y="801"/>
                  </a:lnTo>
                  <a:lnTo>
                    <a:pt x="390" y="803"/>
                  </a:lnTo>
                  <a:lnTo>
                    <a:pt x="392" y="806"/>
                  </a:lnTo>
                  <a:lnTo>
                    <a:pt x="394" y="809"/>
                  </a:lnTo>
                  <a:lnTo>
                    <a:pt x="397" y="811"/>
                  </a:lnTo>
                  <a:lnTo>
                    <a:pt x="399" y="812"/>
                  </a:lnTo>
                  <a:lnTo>
                    <a:pt x="401" y="813"/>
                  </a:lnTo>
                  <a:lnTo>
                    <a:pt x="402" y="814"/>
                  </a:lnTo>
                  <a:lnTo>
                    <a:pt x="404" y="815"/>
                  </a:lnTo>
                  <a:lnTo>
                    <a:pt x="407" y="815"/>
                  </a:lnTo>
                  <a:lnTo>
                    <a:pt x="409" y="815"/>
                  </a:lnTo>
                  <a:lnTo>
                    <a:pt x="411" y="816"/>
                  </a:lnTo>
                  <a:lnTo>
                    <a:pt x="413" y="816"/>
                  </a:lnTo>
                  <a:lnTo>
                    <a:pt x="415" y="816"/>
                  </a:lnTo>
                  <a:lnTo>
                    <a:pt x="417" y="816"/>
                  </a:lnTo>
                  <a:lnTo>
                    <a:pt x="419" y="816"/>
                  </a:lnTo>
                  <a:lnTo>
                    <a:pt x="421" y="816"/>
                  </a:lnTo>
                  <a:lnTo>
                    <a:pt x="423" y="816"/>
                  </a:lnTo>
                  <a:lnTo>
                    <a:pt x="425" y="816"/>
                  </a:lnTo>
                  <a:lnTo>
                    <a:pt x="427" y="816"/>
                  </a:lnTo>
                  <a:lnTo>
                    <a:pt x="429" y="816"/>
                  </a:lnTo>
                  <a:lnTo>
                    <a:pt x="431" y="816"/>
                  </a:lnTo>
                  <a:lnTo>
                    <a:pt x="433" y="816"/>
                  </a:lnTo>
                  <a:lnTo>
                    <a:pt x="435" y="816"/>
                  </a:lnTo>
                  <a:lnTo>
                    <a:pt x="437" y="815"/>
                  </a:lnTo>
                  <a:lnTo>
                    <a:pt x="439" y="816"/>
                  </a:lnTo>
                  <a:lnTo>
                    <a:pt x="441" y="816"/>
                  </a:lnTo>
                  <a:lnTo>
                    <a:pt x="443" y="816"/>
                  </a:lnTo>
                  <a:lnTo>
                    <a:pt x="445" y="815"/>
                  </a:lnTo>
                  <a:lnTo>
                    <a:pt x="447" y="813"/>
                  </a:lnTo>
                  <a:lnTo>
                    <a:pt x="449" y="811"/>
                  </a:lnTo>
                  <a:lnTo>
                    <a:pt x="451" y="808"/>
                  </a:lnTo>
                  <a:lnTo>
                    <a:pt x="453" y="805"/>
                  </a:lnTo>
                  <a:lnTo>
                    <a:pt x="455" y="802"/>
                  </a:lnTo>
                  <a:lnTo>
                    <a:pt x="457" y="800"/>
                  </a:lnTo>
                  <a:lnTo>
                    <a:pt x="459" y="800"/>
                  </a:lnTo>
                  <a:lnTo>
                    <a:pt x="461" y="800"/>
                  </a:lnTo>
                  <a:lnTo>
                    <a:pt x="463" y="800"/>
                  </a:lnTo>
                  <a:lnTo>
                    <a:pt x="465" y="801"/>
                  </a:lnTo>
                  <a:lnTo>
                    <a:pt x="467" y="802"/>
                  </a:lnTo>
                  <a:lnTo>
                    <a:pt x="469" y="804"/>
                  </a:lnTo>
                  <a:lnTo>
                    <a:pt x="471" y="805"/>
                  </a:lnTo>
                  <a:lnTo>
                    <a:pt x="473" y="805"/>
                  </a:lnTo>
                  <a:lnTo>
                    <a:pt x="475" y="807"/>
                  </a:lnTo>
                  <a:lnTo>
                    <a:pt x="477" y="808"/>
                  </a:lnTo>
                  <a:lnTo>
                    <a:pt x="479" y="809"/>
                  </a:lnTo>
                  <a:lnTo>
                    <a:pt x="481" y="809"/>
                  </a:lnTo>
                  <a:lnTo>
                    <a:pt x="483" y="810"/>
                  </a:lnTo>
                  <a:lnTo>
                    <a:pt x="485" y="810"/>
                  </a:lnTo>
                  <a:lnTo>
                    <a:pt x="487" y="811"/>
                  </a:lnTo>
                  <a:lnTo>
                    <a:pt x="489" y="811"/>
                  </a:lnTo>
                  <a:lnTo>
                    <a:pt x="491" y="811"/>
                  </a:lnTo>
                  <a:lnTo>
                    <a:pt x="493" y="812"/>
                  </a:lnTo>
                  <a:lnTo>
                    <a:pt x="495" y="812"/>
                  </a:lnTo>
                  <a:lnTo>
                    <a:pt x="497" y="813"/>
                  </a:lnTo>
                  <a:lnTo>
                    <a:pt x="499" y="813"/>
                  </a:lnTo>
                  <a:lnTo>
                    <a:pt x="501" y="813"/>
                  </a:lnTo>
                  <a:lnTo>
                    <a:pt x="503" y="813"/>
                  </a:lnTo>
                  <a:lnTo>
                    <a:pt x="505" y="814"/>
                  </a:lnTo>
                  <a:lnTo>
                    <a:pt x="507" y="814"/>
                  </a:lnTo>
                  <a:lnTo>
                    <a:pt x="509" y="814"/>
                  </a:lnTo>
                  <a:lnTo>
                    <a:pt x="511" y="814"/>
                  </a:lnTo>
                  <a:lnTo>
                    <a:pt x="513" y="814"/>
                  </a:lnTo>
                  <a:lnTo>
                    <a:pt x="515" y="814"/>
                  </a:lnTo>
                  <a:lnTo>
                    <a:pt x="517" y="813"/>
                  </a:lnTo>
                  <a:lnTo>
                    <a:pt x="519" y="813"/>
                  </a:lnTo>
                  <a:lnTo>
                    <a:pt x="521" y="813"/>
                  </a:lnTo>
                  <a:lnTo>
                    <a:pt x="523" y="812"/>
                  </a:lnTo>
                  <a:lnTo>
                    <a:pt x="525" y="811"/>
                  </a:lnTo>
                  <a:lnTo>
                    <a:pt x="527" y="810"/>
                  </a:lnTo>
                  <a:lnTo>
                    <a:pt x="529" y="808"/>
                  </a:lnTo>
                  <a:lnTo>
                    <a:pt x="531" y="807"/>
                  </a:lnTo>
                  <a:lnTo>
                    <a:pt x="533" y="807"/>
                  </a:lnTo>
                  <a:lnTo>
                    <a:pt x="535" y="806"/>
                  </a:lnTo>
                  <a:lnTo>
                    <a:pt x="537" y="806"/>
                  </a:lnTo>
                  <a:lnTo>
                    <a:pt x="540" y="806"/>
                  </a:lnTo>
                  <a:lnTo>
                    <a:pt x="542" y="807"/>
                  </a:lnTo>
                  <a:lnTo>
                    <a:pt x="544" y="807"/>
                  </a:lnTo>
                  <a:lnTo>
                    <a:pt x="546" y="807"/>
                  </a:lnTo>
                  <a:lnTo>
                    <a:pt x="548" y="808"/>
                  </a:lnTo>
                  <a:lnTo>
                    <a:pt x="550" y="808"/>
                  </a:lnTo>
                  <a:lnTo>
                    <a:pt x="552" y="809"/>
                  </a:lnTo>
                  <a:lnTo>
                    <a:pt x="554" y="809"/>
                  </a:lnTo>
                  <a:lnTo>
                    <a:pt x="556" y="809"/>
                  </a:lnTo>
                  <a:lnTo>
                    <a:pt x="558" y="809"/>
                  </a:lnTo>
                  <a:lnTo>
                    <a:pt x="560" y="809"/>
                  </a:lnTo>
                  <a:lnTo>
                    <a:pt x="562" y="810"/>
                  </a:lnTo>
                  <a:lnTo>
                    <a:pt x="564" y="810"/>
                  </a:lnTo>
                  <a:lnTo>
                    <a:pt x="566" y="810"/>
                  </a:lnTo>
                  <a:lnTo>
                    <a:pt x="568" y="810"/>
                  </a:lnTo>
                  <a:lnTo>
                    <a:pt x="570" y="810"/>
                  </a:lnTo>
                  <a:lnTo>
                    <a:pt x="572" y="810"/>
                  </a:lnTo>
                  <a:lnTo>
                    <a:pt x="574" y="810"/>
                  </a:lnTo>
                  <a:lnTo>
                    <a:pt x="576" y="810"/>
                  </a:lnTo>
                  <a:lnTo>
                    <a:pt x="578" y="810"/>
                  </a:lnTo>
                  <a:lnTo>
                    <a:pt x="580" y="810"/>
                  </a:lnTo>
                  <a:lnTo>
                    <a:pt x="582" y="810"/>
                  </a:lnTo>
                  <a:lnTo>
                    <a:pt x="584" y="810"/>
                  </a:lnTo>
                  <a:lnTo>
                    <a:pt x="586" y="810"/>
                  </a:lnTo>
                  <a:lnTo>
                    <a:pt x="588" y="810"/>
                  </a:lnTo>
                  <a:lnTo>
                    <a:pt x="590" y="810"/>
                  </a:lnTo>
                  <a:lnTo>
                    <a:pt x="592" y="810"/>
                  </a:lnTo>
                  <a:lnTo>
                    <a:pt x="594" y="810"/>
                  </a:lnTo>
                  <a:lnTo>
                    <a:pt x="596" y="810"/>
                  </a:lnTo>
                  <a:lnTo>
                    <a:pt x="598" y="810"/>
                  </a:lnTo>
                  <a:lnTo>
                    <a:pt x="600" y="810"/>
                  </a:lnTo>
                  <a:lnTo>
                    <a:pt x="602" y="810"/>
                  </a:lnTo>
                  <a:lnTo>
                    <a:pt x="604" y="810"/>
                  </a:lnTo>
                  <a:lnTo>
                    <a:pt x="606" y="810"/>
                  </a:lnTo>
                  <a:lnTo>
                    <a:pt x="608" y="810"/>
                  </a:lnTo>
                  <a:lnTo>
                    <a:pt x="610" y="810"/>
                  </a:lnTo>
                  <a:lnTo>
                    <a:pt x="612" y="810"/>
                  </a:lnTo>
                  <a:lnTo>
                    <a:pt x="614" y="810"/>
                  </a:lnTo>
                  <a:lnTo>
                    <a:pt x="616" y="810"/>
                  </a:lnTo>
                  <a:lnTo>
                    <a:pt x="618" y="810"/>
                  </a:lnTo>
                  <a:lnTo>
                    <a:pt x="620" y="810"/>
                  </a:lnTo>
                  <a:lnTo>
                    <a:pt x="622" y="810"/>
                  </a:lnTo>
                  <a:lnTo>
                    <a:pt x="624" y="810"/>
                  </a:lnTo>
                  <a:lnTo>
                    <a:pt x="626" y="810"/>
                  </a:lnTo>
                  <a:lnTo>
                    <a:pt x="628" y="809"/>
                  </a:lnTo>
                  <a:lnTo>
                    <a:pt x="630" y="809"/>
                  </a:lnTo>
                  <a:lnTo>
                    <a:pt x="632" y="809"/>
                  </a:lnTo>
                  <a:lnTo>
                    <a:pt x="634" y="809"/>
                  </a:lnTo>
                  <a:lnTo>
                    <a:pt x="636" y="809"/>
                  </a:lnTo>
                  <a:lnTo>
                    <a:pt x="638" y="808"/>
                  </a:lnTo>
                  <a:lnTo>
                    <a:pt x="640" y="808"/>
                  </a:lnTo>
                  <a:lnTo>
                    <a:pt x="642" y="808"/>
                  </a:lnTo>
                  <a:lnTo>
                    <a:pt x="644" y="808"/>
                  </a:lnTo>
                  <a:lnTo>
                    <a:pt x="646" y="808"/>
                  </a:lnTo>
                  <a:lnTo>
                    <a:pt x="648" y="807"/>
                  </a:lnTo>
                  <a:lnTo>
                    <a:pt x="650" y="807"/>
                  </a:lnTo>
                  <a:lnTo>
                    <a:pt x="652" y="807"/>
                  </a:lnTo>
                  <a:lnTo>
                    <a:pt x="654" y="807"/>
                  </a:lnTo>
                  <a:lnTo>
                    <a:pt x="656" y="807"/>
                  </a:lnTo>
                  <a:lnTo>
                    <a:pt x="658" y="807"/>
                  </a:lnTo>
                  <a:lnTo>
                    <a:pt x="660" y="807"/>
                  </a:lnTo>
                  <a:lnTo>
                    <a:pt x="662" y="807"/>
                  </a:lnTo>
                  <a:lnTo>
                    <a:pt x="664" y="807"/>
                  </a:lnTo>
                  <a:lnTo>
                    <a:pt x="666" y="807"/>
                  </a:lnTo>
                  <a:lnTo>
                    <a:pt x="668" y="807"/>
                  </a:lnTo>
                  <a:lnTo>
                    <a:pt x="670" y="807"/>
                  </a:lnTo>
                  <a:lnTo>
                    <a:pt x="672" y="807"/>
                  </a:lnTo>
                  <a:lnTo>
                    <a:pt x="674" y="807"/>
                  </a:lnTo>
                  <a:lnTo>
                    <a:pt x="676" y="806"/>
                  </a:lnTo>
                  <a:lnTo>
                    <a:pt x="678" y="806"/>
                  </a:lnTo>
                  <a:lnTo>
                    <a:pt x="680" y="807"/>
                  </a:lnTo>
                  <a:lnTo>
                    <a:pt x="683" y="807"/>
                  </a:lnTo>
                  <a:lnTo>
                    <a:pt x="685" y="807"/>
                  </a:lnTo>
                  <a:lnTo>
                    <a:pt x="687" y="807"/>
                  </a:lnTo>
                  <a:lnTo>
                    <a:pt x="689" y="807"/>
                  </a:lnTo>
                  <a:lnTo>
                    <a:pt x="691" y="808"/>
                  </a:lnTo>
                  <a:lnTo>
                    <a:pt x="693" y="808"/>
                  </a:lnTo>
                  <a:lnTo>
                    <a:pt x="695" y="808"/>
                  </a:lnTo>
                  <a:lnTo>
                    <a:pt x="697" y="808"/>
                  </a:lnTo>
                  <a:lnTo>
                    <a:pt x="699" y="808"/>
                  </a:lnTo>
                  <a:lnTo>
                    <a:pt x="701" y="808"/>
                  </a:lnTo>
                  <a:lnTo>
                    <a:pt x="703" y="808"/>
                  </a:lnTo>
                  <a:lnTo>
                    <a:pt x="705" y="807"/>
                  </a:lnTo>
                  <a:lnTo>
                    <a:pt x="707" y="807"/>
                  </a:lnTo>
                  <a:lnTo>
                    <a:pt x="709" y="807"/>
                  </a:lnTo>
                  <a:lnTo>
                    <a:pt x="711" y="806"/>
                  </a:lnTo>
                  <a:lnTo>
                    <a:pt x="713" y="806"/>
                  </a:lnTo>
                  <a:lnTo>
                    <a:pt x="715" y="806"/>
                  </a:lnTo>
                  <a:lnTo>
                    <a:pt x="717" y="805"/>
                  </a:lnTo>
                  <a:lnTo>
                    <a:pt x="719" y="806"/>
                  </a:lnTo>
                  <a:lnTo>
                    <a:pt x="721" y="805"/>
                  </a:lnTo>
                  <a:lnTo>
                    <a:pt x="723" y="805"/>
                  </a:lnTo>
                  <a:lnTo>
                    <a:pt x="725" y="804"/>
                  </a:lnTo>
                  <a:lnTo>
                    <a:pt x="727" y="804"/>
                  </a:lnTo>
                  <a:lnTo>
                    <a:pt x="729" y="804"/>
                  </a:lnTo>
                  <a:lnTo>
                    <a:pt x="731" y="804"/>
                  </a:lnTo>
                  <a:lnTo>
                    <a:pt x="733" y="803"/>
                  </a:lnTo>
                  <a:lnTo>
                    <a:pt x="735" y="803"/>
                  </a:lnTo>
                  <a:lnTo>
                    <a:pt x="737" y="804"/>
                  </a:lnTo>
                  <a:lnTo>
                    <a:pt x="739" y="803"/>
                  </a:lnTo>
                  <a:lnTo>
                    <a:pt x="741" y="803"/>
                  </a:lnTo>
                  <a:lnTo>
                    <a:pt x="743" y="803"/>
                  </a:lnTo>
                  <a:lnTo>
                    <a:pt x="745" y="803"/>
                  </a:lnTo>
                  <a:lnTo>
                    <a:pt x="747" y="803"/>
                  </a:lnTo>
                  <a:lnTo>
                    <a:pt x="749" y="802"/>
                  </a:lnTo>
                  <a:lnTo>
                    <a:pt x="751" y="802"/>
                  </a:lnTo>
                  <a:lnTo>
                    <a:pt x="753" y="802"/>
                  </a:lnTo>
                  <a:lnTo>
                    <a:pt x="755" y="802"/>
                  </a:lnTo>
                  <a:lnTo>
                    <a:pt x="757" y="801"/>
                  </a:lnTo>
                  <a:lnTo>
                    <a:pt x="759" y="801"/>
                  </a:lnTo>
                  <a:lnTo>
                    <a:pt x="761" y="800"/>
                  </a:lnTo>
                  <a:lnTo>
                    <a:pt x="763" y="800"/>
                  </a:lnTo>
                  <a:lnTo>
                    <a:pt x="765" y="800"/>
                  </a:lnTo>
                  <a:lnTo>
                    <a:pt x="767" y="800"/>
                  </a:lnTo>
                  <a:lnTo>
                    <a:pt x="769" y="799"/>
                  </a:lnTo>
                  <a:lnTo>
                    <a:pt x="771" y="799"/>
                  </a:lnTo>
                  <a:lnTo>
                    <a:pt x="773" y="800"/>
                  </a:lnTo>
                  <a:lnTo>
                    <a:pt x="775" y="800"/>
                  </a:lnTo>
                  <a:lnTo>
                    <a:pt x="777" y="800"/>
                  </a:lnTo>
                  <a:lnTo>
                    <a:pt x="779" y="799"/>
                  </a:lnTo>
                  <a:lnTo>
                    <a:pt x="781" y="799"/>
                  </a:lnTo>
                  <a:lnTo>
                    <a:pt x="783" y="800"/>
                  </a:lnTo>
                  <a:lnTo>
                    <a:pt x="785" y="800"/>
                  </a:lnTo>
                  <a:lnTo>
                    <a:pt x="787" y="800"/>
                  </a:lnTo>
                  <a:lnTo>
                    <a:pt x="789" y="799"/>
                  </a:lnTo>
                  <a:lnTo>
                    <a:pt x="791" y="800"/>
                  </a:lnTo>
                  <a:lnTo>
                    <a:pt x="793" y="800"/>
                  </a:lnTo>
                  <a:lnTo>
                    <a:pt x="795" y="799"/>
                  </a:lnTo>
                  <a:lnTo>
                    <a:pt x="797" y="798"/>
                  </a:lnTo>
                  <a:lnTo>
                    <a:pt x="799" y="798"/>
                  </a:lnTo>
                  <a:lnTo>
                    <a:pt x="801" y="798"/>
                  </a:lnTo>
                  <a:lnTo>
                    <a:pt x="803" y="798"/>
                  </a:lnTo>
                  <a:lnTo>
                    <a:pt x="805" y="798"/>
                  </a:lnTo>
                  <a:lnTo>
                    <a:pt x="807" y="798"/>
                  </a:lnTo>
                  <a:lnTo>
                    <a:pt x="809" y="798"/>
                  </a:lnTo>
                  <a:lnTo>
                    <a:pt x="811" y="798"/>
                  </a:lnTo>
                  <a:lnTo>
                    <a:pt x="813" y="798"/>
                  </a:lnTo>
                  <a:lnTo>
                    <a:pt x="815" y="798"/>
                  </a:lnTo>
                  <a:lnTo>
                    <a:pt x="817" y="798"/>
                  </a:lnTo>
                  <a:lnTo>
                    <a:pt x="819" y="798"/>
                  </a:lnTo>
                  <a:lnTo>
                    <a:pt x="821" y="799"/>
                  </a:lnTo>
                  <a:lnTo>
                    <a:pt x="823" y="798"/>
                  </a:lnTo>
                  <a:lnTo>
                    <a:pt x="826" y="798"/>
                  </a:lnTo>
                  <a:lnTo>
                    <a:pt x="828" y="798"/>
                  </a:lnTo>
                  <a:lnTo>
                    <a:pt x="830" y="799"/>
                  </a:lnTo>
                  <a:lnTo>
                    <a:pt x="832" y="799"/>
                  </a:lnTo>
                  <a:lnTo>
                    <a:pt x="834" y="798"/>
                  </a:lnTo>
                  <a:lnTo>
                    <a:pt x="836" y="798"/>
                  </a:lnTo>
                  <a:lnTo>
                    <a:pt x="838" y="798"/>
                  </a:lnTo>
                  <a:lnTo>
                    <a:pt x="840" y="799"/>
                  </a:lnTo>
                  <a:lnTo>
                    <a:pt x="842" y="798"/>
                  </a:lnTo>
                  <a:lnTo>
                    <a:pt x="844" y="798"/>
                  </a:lnTo>
                  <a:lnTo>
                    <a:pt x="846" y="798"/>
                  </a:lnTo>
                  <a:lnTo>
                    <a:pt x="848" y="798"/>
                  </a:lnTo>
                  <a:lnTo>
                    <a:pt x="850" y="798"/>
                  </a:lnTo>
                  <a:lnTo>
                    <a:pt x="852" y="798"/>
                  </a:lnTo>
                  <a:lnTo>
                    <a:pt x="854" y="798"/>
                  </a:lnTo>
                  <a:lnTo>
                    <a:pt x="856" y="798"/>
                  </a:lnTo>
                  <a:lnTo>
                    <a:pt x="858" y="798"/>
                  </a:lnTo>
                  <a:lnTo>
                    <a:pt x="860" y="797"/>
                  </a:lnTo>
                  <a:lnTo>
                    <a:pt x="862" y="797"/>
                  </a:lnTo>
                  <a:lnTo>
                    <a:pt x="864" y="797"/>
                  </a:lnTo>
                  <a:lnTo>
                    <a:pt x="866" y="798"/>
                  </a:lnTo>
                  <a:lnTo>
                    <a:pt x="868" y="798"/>
                  </a:lnTo>
                  <a:lnTo>
                    <a:pt x="870" y="797"/>
                  </a:lnTo>
                  <a:lnTo>
                    <a:pt x="872" y="797"/>
                  </a:lnTo>
                  <a:lnTo>
                    <a:pt x="874" y="797"/>
                  </a:lnTo>
                  <a:lnTo>
                    <a:pt x="876" y="797"/>
                  </a:lnTo>
                  <a:lnTo>
                    <a:pt x="878" y="796"/>
                  </a:lnTo>
                  <a:lnTo>
                    <a:pt x="880" y="795"/>
                  </a:lnTo>
                  <a:lnTo>
                    <a:pt x="882" y="795"/>
                  </a:lnTo>
                  <a:lnTo>
                    <a:pt x="884" y="793"/>
                  </a:lnTo>
                  <a:lnTo>
                    <a:pt x="886" y="791"/>
                  </a:lnTo>
                  <a:lnTo>
                    <a:pt x="888" y="786"/>
                  </a:lnTo>
                  <a:lnTo>
                    <a:pt x="890" y="779"/>
                  </a:lnTo>
                  <a:lnTo>
                    <a:pt x="892" y="770"/>
                  </a:lnTo>
                  <a:lnTo>
                    <a:pt x="894" y="757"/>
                  </a:lnTo>
                  <a:lnTo>
                    <a:pt x="896" y="739"/>
                  </a:lnTo>
                  <a:lnTo>
                    <a:pt x="898" y="717"/>
                  </a:lnTo>
                  <a:lnTo>
                    <a:pt x="900" y="690"/>
                  </a:lnTo>
                  <a:lnTo>
                    <a:pt x="902" y="659"/>
                  </a:lnTo>
                  <a:lnTo>
                    <a:pt x="904" y="625"/>
                  </a:lnTo>
                  <a:lnTo>
                    <a:pt x="906" y="591"/>
                  </a:lnTo>
                  <a:lnTo>
                    <a:pt x="908" y="558"/>
                  </a:lnTo>
                  <a:lnTo>
                    <a:pt x="910" y="527"/>
                  </a:lnTo>
                  <a:lnTo>
                    <a:pt x="912" y="501"/>
                  </a:lnTo>
                  <a:lnTo>
                    <a:pt x="914" y="482"/>
                  </a:lnTo>
                  <a:lnTo>
                    <a:pt x="916" y="469"/>
                  </a:lnTo>
                  <a:lnTo>
                    <a:pt x="918" y="463"/>
                  </a:lnTo>
                  <a:lnTo>
                    <a:pt x="920" y="463"/>
                  </a:lnTo>
                  <a:lnTo>
                    <a:pt x="922" y="470"/>
                  </a:lnTo>
                  <a:lnTo>
                    <a:pt x="924" y="480"/>
                  </a:lnTo>
                  <a:lnTo>
                    <a:pt x="926" y="493"/>
                  </a:lnTo>
                  <a:lnTo>
                    <a:pt x="928" y="508"/>
                  </a:lnTo>
                  <a:lnTo>
                    <a:pt x="930" y="526"/>
                  </a:lnTo>
                  <a:lnTo>
                    <a:pt x="932" y="543"/>
                  </a:lnTo>
                  <a:lnTo>
                    <a:pt x="934" y="560"/>
                  </a:lnTo>
                  <a:lnTo>
                    <a:pt x="936" y="578"/>
                  </a:lnTo>
                  <a:lnTo>
                    <a:pt x="938" y="596"/>
                  </a:lnTo>
                  <a:lnTo>
                    <a:pt x="940" y="613"/>
                  </a:lnTo>
                  <a:lnTo>
                    <a:pt x="942" y="629"/>
                  </a:lnTo>
                  <a:lnTo>
                    <a:pt x="944" y="645"/>
                  </a:lnTo>
                  <a:lnTo>
                    <a:pt x="946" y="660"/>
                  </a:lnTo>
                  <a:lnTo>
                    <a:pt x="948" y="675"/>
                  </a:lnTo>
                  <a:lnTo>
                    <a:pt x="950" y="688"/>
                  </a:lnTo>
                  <a:lnTo>
                    <a:pt x="952" y="700"/>
                  </a:lnTo>
                  <a:lnTo>
                    <a:pt x="954" y="710"/>
                  </a:lnTo>
                  <a:lnTo>
                    <a:pt x="956" y="720"/>
                  </a:lnTo>
                  <a:lnTo>
                    <a:pt x="958" y="728"/>
                  </a:lnTo>
                  <a:lnTo>
                    <a:pt x="961" y="735"/>
                  </a:lnTo>
                  <a:lnTo>
                    <a:pt x="962" y="741"/>
                  </a:lnTo>
                  <a:lnTo>
                    <a:pt x="964" y="746"/>
                  </a:lnTo>
                  <a:lnTo>
                    <a:pt x="966" y="751"/>
                  </a:lnTo>
                  <a:lnTo>
                    <a:pt x="968" y="754"/>
                  </a:lnTo>
                  <a:lnTo>
                    <a:pt x="971" y="757"/>
                  </a:lnTo>
                  <a:lnTo>
                    <a:pt x="973" y="760"/>
                  </a:lnTo>
                  <a:lnTo>
                    <a:pt x="975" y="762"/>
                  </a:lnTo>
                  <a:lnTo>
                    <a:pt x="977" y="764"/>
                  </a:lnTo>
                  <a:lnTo>
                    <a:pt x="979" y="766"/>
                  </a:lnTo>
                  <a:lnTo>
                    <a:pt x="981" y="767"/>
                  </a:lnTo>
                  <a:lnTo>
                    <a:pt x="983" y="768"/>
                  </a:lnTo>
                  <a:lnTo>
                    <a:pt x="985" y="769"/>
                  </a:lnTo>
                  <a:lnTo>
                    <a:pt x="987" y="771"/>
                  </a:lnTo>
                  <a:lnTo>
                    <a:pt x="989" y="772"/>
                  </a:lnTo>
                  <a:lnTo>
                    <a:pt x="991" y="772"/>
                  </a:lnTo>
                  <a:lnTo>
                    <a:pt x="993" y="773"/>
                  </a:lnTo>
                  <a:lnTo>
                    <a:pt x="995" y="774"/>
                  </a:lnTo>
                  <a:lnTo>
                    <a:pt x="997" y="775"/>
                  </a:lnTo>
                  <a:lnTo>
                    <a:pt x="999" y="775"/>
                  </a:lnTo>
                  <a:lnTo>
                    <a:pt x="1001" y="775"/>
                  </a:lnTo>
                  <a:lnTo>
                    <a:pt x="1003" y="776"/>
                  </a:lnTo>
                  <a:lnTo>
                    <a:pt x="1005" y="776"/>
                  </a:lnTo>
                  <a:lnTo>
                    <a:pt x="1007" y="777"/>
                  </a:lnTo>
                  <a:lnTo>
                    <a:pt x="1009" y="776"/>
                  </a:lnTo>
                  <a:lnTo>
                    <a:pt x="1011" y="776"/>
                  </a:lnTo>
                  <a:lnTo>
                    <a:pt x="1013" y="776"/>
                  </a:lnTo>
                  <a:lnTo>
                    <a:pt x="1015" y="776"/>
                  </a:lnTo>
                  <a:lnTo>
                    <a:pt x="1017" y="774"/>
                  </a:lnTo>
                  <a:lnTo>
                    <a:pt x="1019" y="772"/>
                  </a:lnTo>
                  <a:lnTo>
                    <a:pt x="1021" y="770"/>
                  </a:lnTo>
                  <a:lnTo>
                    <a:pt x="1023" y="768"/>
                  </a:lnTo>
                  <a:lnTo>
                    <a:pt x="1025" y="763"/>
                  </a:lnTo>
                  <a:lnTo>
                    <a:pt x="1027" y="75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48" name="Freeform 347"/>
            <p:cNvSpPr>
              <a:spLocks/>
            </p:cNvSpPr>
            <p:nvPr/>
          </p:nvSpPr>
          <p:spPr bwMode="auto">
            <a:xfrm>
              <a:off x="2028825" y="6367463"/>
              <a:ext cx="1247775" cy="1549400"/>
            </a:xfrm>
            <a:custGeom>
              <a:avLst/>
              <a:gdLst>
                <a:gd name="T0" fmla="*/ 12 w 786"/>
                <a:gd name="T1" fmla="*/ 908 h 976"/>
                <a:gd name="T2" fmla="*/ 26 w 786"/>
                <a:gd name="T3" fmla="*/ 914 h 976"/>
                <a:gd name="T4" fmla="*/ 40 w 786"/>
                <a:gd name="T5" fmla="*/ 937 h 976"/>
                <a:gd name="T6" fmla="*/ 54 w 786"/>
                <a:gd name="T7" fmla="*/ 963 h 976"/>
                <a:gd name="T8" fmla="*/ 68 w 786"/>
                <a:gd name="T9" fmla="*/ 971 h 976"/>
                <a:gd name="T10" fmla="*/ 82 w 786"/>
                <a:gd name="T11" fmla="*/ 974 h 976"/>
                <a:gd name="T12" fmla="*/ 97 w 786"/>
                <a:gd name="T13" fmla="*/ 974 h 976"/>
                <a:gd name="T14" fmla="*/ 111 w 786"/>
                <a:gd name="T15" fmla="*/ 974 h 976"/>
                <a:gd name="T16" fmla="*/ 125 w 786"/>
                <a:gd name="T17" fmla="*/ 972 h 976"/>
                <a:gd name="T18" fmla="*/ 139 w 786"/>
                <a:gd name="T19" fmla="*/ 944 h 976"/>
                <a:gd name="T20" fmla="*/ 153 w 786"/>
                <a:gd name="T21" fmla="*/ 779 h 976"/>
                <a:gd name="T22" fmla="*/ 167 w 786"/>
                <a:gd name="T23" fmla="*/ 427 h 976"/>
                <a:gd name="T24" fmla="*/ 181 w 786"/>
                <a:gd name="T25" fmla="*/ 197 h 976"/>
                <a:gd name="T26" fmla="*/ 195 w 786"/>
                <a:gd name="T27" fmla="*/ 268 h 976"/>
                <a:gd name="T28" fmla="*/ 209 w 786"/>
                <a:gd name="T29" fmla="*/ 481 h 976"/>
                <a:gd name="T30" fmla="*/ 224 w 786"/>
                <a:gd name="T31" fmla="*/ 704 h 976"/>
                <a:gd name="T32" fmla="*/ 238 w 786"/>
                <a:gd name="T33" fmla="*/ 864 h 976"/>
                <a:gd name="T34" fmla="*/ 252 w 786"/>
                <a:gd name="T35" fmla="*/ 934 h 976"/>
                <a:gd name="T36" fmla="*/ 266 w 786"/>
                <a:gd name="T37" fmla="*/ 957 h 976"/>
                <a:gd name="T38" fmla="*/ 280 w 786"/>
                <a:gd name="T39" fmla="*/ 962 h 976"/>
                <a:gd name="T40" fmla="*/ 294 w 786"/>
                <a:gd name="T41" fmla="*/ 963 h 976"/>
                <a:gd name="T42" fmla="*/ 308 w 786"/>
                <a:gd name="T43" fmla="*/ 963 h 976"/>
                <a:gd name="T44" fmla="*/ 322 w 786"/>
                <a:gd name="T45" fmla="*/ 964 h 976"/>
                <a:gd name="T46" fmla="*/ 336 w 786"/>
                <a:gd name="T47" fmla="*/ 963 h 976"/>
                <a:gd name="T48" fmla="*/ 350 w 786"/>
                <a:gd name="T49" fmla="*/ 960 h 976"/>
                <a:gd name="T50" fmla="*/ 365 w 786"/>
                <a:gd name="T51" fmla="*/ 956 h 976"/>
                <a:gd name="T52" fmla="*/ 379 w 786"/>
                <a:gd name="T53" fmla="*/ 954 h 976"/>
                <a:gd name="T54" fmla="*/ 393 w 786"/>
                <a:gd name="T55" fmla="*/ 954 h 976"/>
                <a:gd name="T56" fmla="*/ 407 w 786"/>
                <a:gd name="T57" fmla="*/ 943 h 976"/>
                <a:gd name="T58" fmla="*/ 421 w 786"/>
                <a:gd name="T59" fmla="*/ 857 h 976"/>
                <a:gd name="T60" fmla="*/ 435 w 786"/>
                <a:gd name="T61" fmla="*/ 576 h 976"/>
                <a:gd name="T62" fmla="*/ 449 w 786"/>
                <a:gd name="T63" fmla="*/ 180 h 976"/>
                <a:gd name="T64" fmla="*/ 463 w 786"/>
                <a:gd name="T65" fmla="*/ 0 h 976"/>
                <a:gd name="T66" fmla="*/ 477 w 786"/>
                <a:gd name="T67" fmla="*/ 105 h 976"/>
                <a:gd name="T68" fmla="*/ 491 w 786"/>
                <a:gd name="T69" fmla="*/ 325 h 976"/>
                <a:gd name="T70" fmla="*/ 506 w 786"/>
                <a:gd name="T71" fmla="*/ 556 h 976"/>
                <a:gd name="T72" fmla="*/ 520 w 786"/>
                <a:gd name="T73" fmla="*/ 746 h 976"/>
                <a:gd name="T74" fmla="*/ 534 w 786"/>
                <a:gd name="T75" fmla="*/ 861 h 976"/>
                <a:gd name="T76" fmla="*/ 548 w 786"/>
                <a:gd name="T77" fmla="*/ 909 h 976"/>
                <a:gd name="T78" fmla="*/ 562 w 786"/>
                <a:gd name="T79" fmla="*/ 927 h 976"/>
                <a:gd name="T80" fmla="*/ 576 w 786"/>
                <a:gd name="T81" fmla="*/ 933 h 976"/>
                <a:gd name="T82" fmla="*/ 590 w 786"/>
                <a:gd name="T83" fmla="*/ 937 h 976"/>
                <a:gd name="T84" fmla="*/ 604 w 786"/>
                <a:gd name="T85" fmla="*/ 939 h 976"/>
                <a:gd name="T86" fmla="*/ 618 w 786"/>
                <a:gd name="T87" fmla="*/ 942 h 976"/>
                <a:gd name="T88" fmla="*/ 632 w 786"/>
                <a:gd name="T89" fmla="*/ 946 h 976"/>
                <a:gd name="T90" fmla="*/ 646 w 786"/>
                <a:gd name="T91" fmla="*/ 953 h 976"/>
                <a:gd name="T92" fmla="*/ 661 w 786"/>
                <a:gd name="T93" fmla="*/ 960 h 976"/>
                <a:gd name="T94" fmla="*/ 675 w 786"/>
                <a:gd name="T95" fmla="*/ 966 h 976"/>
                <a:gd name="T96" fmla="*/ 689 w 786"/>
                <a:gd name="T97" fmla="*/ 971 h 976"/>
                <a:gd name="T98" fmla="*/ 703 w 786"/>
                <a:gd name="T99" fmla="*/ 975 h 976"/>
                <a:gd name="T100" fmla="*/ 717 w 786"/>
                <a:gd name="T101" fmla="*/ 976 h 976"/>
                <a:gd name="T102" fmla="*/ 731 w 786"/>
                <a:gd name="T103" fmla="*/ 975 h 976"/>
                <a:gd name="T104" fmla="*/ 745 w 786"/>
                <a:gd name="T105" fmla="*/ 974 h 976"/>
                <a:gd name="T106" fmla="*/ 759 w 786"/>
                <a:gd name="T107" fmla="*/ 971 h 976"/>
                <a:gd name="T108" fmla="*/ 773 w 786"/>
                <a:gd name="T109" fmla="*/ 968 h 9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786" h="976">
                  <a:moveTo>
                    <a:pt x="0" y="951"/>
                  </a:moveTo>
                  <a:lnTo>
                    <a:pt x="2" y="944"/>
                  </a:lnTo>
                  <a:lnTo>
                    <a:pt x="4" y="937"/>
                  </a:lnTo>
                  <a:lnTo>
                    <a:pt x="6" y="930"/>
                  </a:lnTo>
                  <a:lnTo>
                    <a:pt x="8" y="921"/>
                  </a:lnTo>
                  <a:lnTo>
                    <a:pt x="10" y="914"/>
                  </a:lnTo>
                  <a:lnTo>
                    <a:pt x="12" y="908"/>
                  </a:lnTo>
                  <a:lnTo>
                    <a:pt x="14" y="905"/>
                  </a:lnTo>
                  <a:lnTo>
                    <a:pt x="16" y="903"/>
                  </a:lnTo>
                  <a:lnTo>
                    <a:pt x="18" y="903"/>
                  </a:lnTo>
                  <a:lnTo>
                    <a:pt x="20" y="905"/>
                  </a:lnTo>
                  <a:lnTo>
                    <a:pt x="22" y="907"/>
                  </a:lnTo>
                  <a:lnTo>
                    <a:pt x="24" y="911"/>
                  </a:lnTo>
                  <a:lnTo>
                    <a:pt x="26" y="914"/>
                  </a:lnTo>
                  <a:lnTo>
                    <a:pt x="28" y="917"/>
                  </a:lnTo>
                  <a:lnTo>
                    <a:pt x="30" y="920"/>
                  </a:lnTo>
                  <a:lnTo>
                    <a:pt x="32" y="923"/>
                  </a:lnTo>
                  <a:lnTo>
                    <a:pt x="34" y="927"/>
                  </a:lnTo>
                  <a:lnTo>
                    <a:pt x="36" y="930"/>
                  </a:lnTo>
                  <a:lnTo>
                    <a:pt x="38" y="933"/>
                  </a:lnTo>
                  <a:lnTo>
                    <a:pt x="40" y="937"/>
                  </a:lnTo>
                  <a:lnTo>
                    <a:pt x="42" y="942"/>
                  </a:lnTo>
                  <a:lnTo>
                    <a:pt x="44" y="946"/>
                  </a:lnTo>
                  <a:lnTo>
                    <a:pt x="46" y="949"/>
                  </a:lnTo>
                  <a:lnTo>
                    <a:pt x="48" y="953"/>
                  </a:lnTo>
                  <a:lnTo>
                    <a:pt x="50" y="957"/>
                  </a:lnTo>
                  <a:lnTo>
                    <a:pt x="52" y="960"/>
                  </a:lnTo>
                  <a:lnTo>
                    <a:pt x="54" y="963"/>
                  </a:lnTo>
                  <a:lnTo>
                    <a:pt x="56" y="964"/>
                  </a:lnTo>
                  <a:lnTo>
                    <a:pt x="58" y="966"/>
                  </a:lnTo>
                  <a:lnTo>
                    <a:pt x="60" y="968"/>
                  </a:lnTo>
                  <a:lnTo>
                    <a:pt x="62" y="969"/>
                  </a:lnTo>
                  <a:lnTo>
                    <a:pt x="64" y="970"/>
                  </a:lnTo>
                  <a:lnTo>
                    <a:pt x="66" y="970"/>
                  </a:lnTo>
                  <a:lnTo>
                    <a:pt x="68" y="971"/>
                  </a:lnTo>
                  <a:lnTo>
                    <a:pt x="70" y="972"/>
                  </a:lnTo>
                  <a:lnTo>
                    <a:pt x="72" y="972"/>
                  </a:lnTo>
                  <a:lnTo>
                    <a:pt x="74" y="972"/>
                  </a:lnTo>
                  <a:lnTo>
                    <a:pt x="77" y="973"/>
                  </a:lnTo>
                  <a:lnTo>
                    <a:pt x="79" y="973"/>
                  </a:lnTo>
                  <a:lnTo>
                    <a:pt x="81" y="974"/>
                  </a:lnTo>
                  <a:lnTo>
                    <a:pt x="82" y="974"/>
                  </a:lnTo>
                  <a:lnTo>
                    <a:pt x="84" y="974"/>
                  </a:lnTo>
                  <a:lnTo>
                    <a:pt x="87" y="974"/>
                  </a:lnTo>
                  <a:lnTo>
                    <a:pt x="89" y="974"/>
                  </a:lnTo>
                  <a:lnTo>
                    <a:pt x="91" y="974"/>
                  </a:lnTo>
                  <a:lnTo>
                    <a:pt x="93" y="974"/>
                  </a:lnTo>
                  <a:lnTo>
                    <a:pt x="95" y="974"/>
                  </a:lnTo>
                  <a:lnTo>
                    <a:pt x="97" y="974"/>
                  </a:lnTo>
                  <a:lnTo>
                    <a:pt x="99" y="975"/>
                  </a:lnTo>
                  <a:lnTo>
                    <a:pt x="101" y="975"/>
                  </a:lnTo>
                  <a:lnTo>
                    <a:pt x="103" y="974"/>
                  </a:lnTo>
                  <a:lnTo>
                    <a:pt x="105" y="974"/>
                  </a:lnTo>
                  <a:lnTo>
                    <a:pt x="107" y="975"/>
                  </a:lnTo>
                  <a:lnTo>
                    <a:pt x="109" y="975"/>
                  </a:lnTo>
                  <a:lnTo>
                    <a:pt x="111" y="974"/>
                  </a:lnTo>
                  <a:lnTo>
                    <a:pt x="113" y="974"/>
                  </a:lnTo>
                  <a:lnTo>
                    <a:pt x="115" y="974"/>
                  </a:lnTo>
                  <a:lnTo>
                    <a:pt x="117" y="974"/>
                  </a:lnTo>
                  <a:lnTo>
                    <a:pt x="119" y="974"/>
                  </a:lnTo>
                  <a:lnTo>
                    <a:pt x="121" y="973"/>
                  </a:lnTo>
                  <a:lnTo>
                    <a:pt x="123" y="973"/>
                  </a:lnTo>
                  <a:lnTo>
                    <a:pt x="125" y="972"/>
                  </a:lnTo>
                  <a:lnTo>
                    <a:pt x="127" y="971"/>
                  </a:lnTo>
                  <a:lnTo>
                    <a:pt x="129" y="969"/>
                  </a:lnTo>
                  <a:lnTo>
                    <a:pt x="131" y="967"/>
                  </a:lnTo>
                  <a:lnTo>
                    <a:pt x="133" y="964"/>
                  </a:lnTo>
                  <a:lnTo>
                    <a:pt x="135" y="959"/>
                  </a:lnTo>
                  <a:lnTo>
                    <a:pt x="137" y="953"/>
                  </a:lnTo>
                  <a:lnTo>
                    <a:pt x="139" y="944"/>
                  </a:lnTo>
                  <a:lnTo>
                    <a:pt x="141" y="933"/>
                  </a:lnTo>
                  <a:lnTo>
                    <a:pt x="143" y="919"/>
                  </a:lnTo>
                  <a:lnTo>
                    <a:pt x="145" y="901"/>
                  </a:lnTo>
                  <a:lnTo>
                    <a:pt x="147" y="878"/>
                  </a:lnTo>
                  <a:lnTo>
                    <a:pt x="149" y="850"/>
                  </a:lnTo>
                  <a:lnTo>
                    <a:pt x="151" y="817"/>
                  </a:lnTo>
                  <a:lnTo>
                    <a:pt x="153" y="779"/>
                  </a:lnTo>
                  <a:lnTo>
                    <a:pt x="155" y="737"/>
                  </a:lnTo>
                  <a:lnTo>
                    <a:pt x="157" y="690"/>
                  </a:lnTo>
                  <a:lnTo>
                    <a:pt x="159" y="640"/>
                  </a:lnTo>
                  <a:lnTo>
                    <a:pt x="161" y="587"/>
                  </a:lnTo>
                  <a:lnTo>
                    <a:pt x="163" y="532"/>
                  </a:lnTo>
                  <a:lnTo>
                    <a:pt x="165" y="479"/>
                  </a:lnTo>
                  <a:lnTo>
                    <a:pt x="167" y="427"/>
                  </a:lnTo>
                  <a:lnTo>
                    <a:pt x="169" y="378"/>
                  </a:lnTo>
                  <a:lnTo>
                    <a:pt x="171" y="332"/>
                  </a:lnTo>
                  <a:lnTo>
                    <a:pt x="173" y="292"/>
                  </a:lnTo>
                  <a:lnTo>
                    <a:pt x="175" y="259"/>
                  </a:lnTo>
                  <a:lnTo>
                    <a:pt x="177" y="232"/>
                  </a:lnTo>
                  <a:lnTo>
                    <a:pt x="179" y="211"/>
                  </a:lnTo>
                  <a:lnTo>
                    <a:pt x="181" y="197"/>
                  </a:lnTo>
                  <a:lnTo>
                    <a:pt x="183" y="192"/>
                  </a:lnTo>
                  <a:lnTo>
                    <a:pt x="185" y="192"/>
                  </a:lnTo>
                  <a:lnTo>
                    <a:pt x="187" y="197"/>
                  </a:lnTo>
                  <a:lnTo>
                    <a:pt x="189" y="208"/>
                  </a:lnTo>
                  <a:lnTo>
                    <a:pt x="191" y="224"/>
                  </a:lnTo>
                  <a:lnTo>
                    <a:pt x="193" y="244"/>
                  </a:lnTo>
                  <a:lnTo>
                    <a:pt x="195" y="268"/>
                  </a:lnTo>
                  <a:lnTo>
                    <a:pt x="197" y="293"/>
                  </a:lnTo>
                  <a:lnTo>
                    <a:pt x="199" y="322"/>
                  </a:lnTo>
                  <a:lnTo>
                    <a:pt x="201" y="352"/>
                  </a:lnTo>
                  <a:lnTo>
                    <a:pt x="203" y="383"/>
                  </a:lnTo>
                  <a:lnTo>
                    <a:pt x="205" y="414"/>
                  </a:lnTo>
                  <a:lnTo>
                    <a:pt x="207" y="447"/>
                  </a:lnTo>
                  <a:lnTo>
                    <a:pt x="209" y="481"/>
                  </a:lnTo>
                  <a:lnTo>
                    <a:pt x="211" y="514"/>
                  </a:lnTo>
                  <a:lnTo>
                    <a:pt x="213" y="547"/>
                  </a:lnTo>
                  <a:lnTo>
                    <a:pt x="215" y="580"/>
                  </a:lnTo>
                  <a:lnTo>
                    <a:pt x="217" y="613"/>
                  </a:lnTo>
                  <a:lnTo>
                    <a:pt x="220" y="645"/>
                  </a:lnTo>
                  <a:lnTo>
                    <a:pt x="222" y="675"/>
                  </a:lnTo>
                  <a:lnTo>
                    <a:pt x="224" y="704"/>
                  </a:lnTo>
                  <a:lnTo>
                    <a:pt x="226" y="733"/>
                  </a:lnTo>
                  <a:lnTo>
                    <a:pt x="228" y="760"/>
                  </a:lnTo>
                  <a:lnTo>
                    <a:pt x="230" y="784"/>
                  </a:lnTo>
                  <a:lnTo>
                    <a:pt x="232" y="806"/>
                  </a:lnTo>
                  <a:lnTo>
                    <a:pt x="234" y="827"/>
                  </a:lnTo>
                  <a:lnTo>
                    <a:pt x="236" y="846"/>
                  </a:lnTo>
                  <a:lnTo>
                    <a:pt x="238" y="864"/>
                  </a:lnTo>
                  <a:lnTo>
                    <a:pt x="240" y="878"/>
                  </a:lnTo>
                  <a:lnTo>
                    <a:pt x="242" y="891"/>
                  </a:lnTo>
                  <a:lnTo>
                    <a:pt x="244" y="902"/>
                  </a:lnTo>
                  <a:lnTo>
                    <a:pt x="246" y="912"/>
                  </a:lnTo>
                  <a:lnTo>
                    <a:pt x="248" y="921"/>
                  </a:lnTo>
                  <a:lnTo>
                    <a:pt x="250" y="928"/>
                  </a:lnTo>
                  <a:lnTo>
                    <a:pt x="252" y="934"/>
                  </a:lnTo>
                  <a:lnTo>
                    <a:pt x="254" y="939"/>
                  </a:lnTo>
                  <a:lnTo>
                    <a:pt x="256" y="944"/>
                  </a:lnTo>
                  <a:lnTo>
                    <a:pt x="258" y="947"/>
                  </a:lnTo>
                  <a:lnTo>
                    <a:pt x="260" y="950"/>
                  </a:lnTo>
                  <a:lnTo>
                    <a:pt x="262" y="952"/>
                  </a:lnTo>
                  <a:lnTo>
                    <a:pt x="264" y="955"/>
                  </a:lnTo>
                  <a:lnTo>
                    <a:pt x="266" y="957"/>
                  </a:lnTo>
                  <a:lnTo>
                    <a:pt x="268" y="958"/>
                  </a:lnTo>
                  <a:lnTo>
                    <a:pt x="270" y="958"/>
                  </a:lnTo>
                  <a:lnTo>
                    <a:pt x="272" y="960"/>
                  </a:lnTo>
                  <a:lnTo>
                    <a:pt x="274" y="961"/>
                  </a:lnTo>
                  <a:lnTo>
                    <a:pt x="276" y="961"/>
                  </a:lnTo>
                  <a:lnTo>
                    <a:pt x="278" y="961"/>
                  </a:lnTo>
                  <a:lnTo>
                    <a:pt x="280" y="962"/>
                  </a:lnTo>
                  <a:lnTo>
                    <a:pt x="282" y="962"/>
                  </a:lnTo>
                  <a:lnTo>
                    <a:pt x="284" y="963"/>
                  </a:lnTo>
                  <a:lnTo>
                    <a:pt x="286" y="963"/>
                  </a:lnTo>
                  <a:lnTo>
                    <a:pt x="288" y="963"/>
                  </a:lnTo>
                  <a:lnTo>
                    <a:pt x="290" y="963"/>
                  </a:lnTo>
                  <a:lnTo>
                    <a:pt x="292" y="963"/>
                  </a:lnTo>
                  <a:lnTo>
                    <a:pt x="294" y="963"/>
                  </a:lnTo>
                  <a:lnTo>
                    <a:pt x="296" y="963"/>
                  </a:lnTo>
                  <a:lnTo>
                    <a:pt x="298" y="963"/>
                  </a:lnTo>
                  <a:lnTo>
                    <a:pt x="300" y="963"/>
                  </a:lnTo>
                  <a:lnTo>
                    <a:pt x="302" y="964"/>
                  </a:lnTo>
                  <a:lnTo>
                    <a:pt x="304" y="964"/>
                  </a:lnTo>
                  <a:lnTo>
                    <a:pt x="306" y="963"/>
                  </a:lnTo>
                  <a:lnTo>
                    <a:pt x="308" y="963"/>
                  </a:lnTo>
                  <a:lnTo>
                    <a:pt x="310" y="964"/>
                  </a:lnTo>
                  <a:lnTo>
                    <a:pt x="312" y="964"/>
                  </a:lnTo>
                  <a:lnTo>
                    <a:pt x="314" y="964"/>
                  </a:lnTo>
                  <a:lnTo>
                    <a:pt x="316" y="963"/>
                  </a:lnTo>
                  <a:lnTo>
                    <a:pt x="318" y="964"/>
                  </a:lnTo>
                  <a:lnTo>
                    <a:pt x="320" y="964"/>
                  </a:lnTo>
                  <a:lnTo>
                    <a:pt x="322" y="964"/>
                  </a:lnTo>
                  <a:lnTo>
                    <a:pt x="324" y="963"/>
                  </a:lnTo>
                  <a:lnTo>
                    <a:pt x="326" y="963"/>
                  </a:lnTo>
                  <a:lnTo>
                    <a:pt x="328" y="963"/>
                  </a:lnTo>
                  <a:lnTo>
                    <a:pt x="330" y="964"/>
                  </a:lnTo>
                  <a:lnTo>
                    <a:pt x="332" y="963"/>
                  </a:lnTo>
                  <a:lnTo>
                    <a:pt x="334" y="963"/>
                  </a:lnTo>
                  <a:lnTo>
                    <a:pt x="336" y="963"/>
                  </a:lnTo>
                  <a:lnTo>
                    <a:pt x="338" y="963"/>
                  </a:lnTo>
                  <a:lnTo>
                    <a:pt x="340" y="962"/>
                  </a:lnTo>
                  <a:lnTo>
                    <a:pt x="342" y="962"/>
                  </a:lnTo>
                  <a:lnTo>
                    <a:pt x="344" y="961"/>
                  </a:lnTo>
                  <a:lnTo>
                    <a:pt x="346" y="961"/>
                  </a:lnTo>
                  <a:lnTo>
                    <a:pt x="348" y="961"/>
                  </a:lnTo>
                  <a:lnTo>
                    <a:pt x="350" y="960"/>
                  </a:lnTo>
                  <a:lnTo>
                    <a:pt x="352" y="959"/>
                  </a:lnTo>
                  <a:lnTo>
                    <a:pt x="354" y="959"/>
                  </a:lnTo>
                  <a:lnTo>
                    <a:pt x="356" y="958"/>
                  </a:lnTo>
                  <a:lnTo>
                    <a:pt x="358" y="958"/>
                  </a:lnTo>
                  <a:lnTo>
                    <a:pt x="360" y="957"/>
                  </a:lnTo>
                  <a:lnTo>
                    <a:pt x="363" y="956"/>
                  </a:lnTo>
                  <a:lnTo>
                    <a:pt x="365" y="956"/>
                  </a:lnTo>
                  <a:lnTo>
                    <a:pt x="367" y="956"/>
                  </a:lnTo>
                  <a:lnTo>
                    <a:pt x="369" y="955"/>
                  </a:lnTo>
                  <a:lnTo>
                    <a:pt x="371" y="954"/>
                  </a:lnTo>
                  <a:lnTo>
                    <a:pt x="373" y="954"/>
                  </a:lnTo>
                  <a:lnTo>
                    <a:pt x="375" y="954"/>
                  </a:lnTo>
                  <a:lnTo>
                    <a:pt x="377" y="954"/>
                  </a:lnTo>
                  <a:lnTo>
                    <a:pt x="379" y="954"/>
                  </a:lnTo>
                  <a:lnTo>
                    <a:pt x="381" y="954"/>
                  </a:lnTo>
                  <a:lnTo>
                    <a:pt x="383" y="954"/>
                  </a:lnTo>
                  <a:lnTo>
                    <a:pt x="385" y="954"/>
                  </a:lnTo>
                  <a:lnTo>
                    <a:pt x="387" y="954"/>
                  </a:lnTo>
                  <a:lnTo>
                    <a:pt x="389" y="954"/>
                  </a:lnTo>
                  <a:lnTo>
                    <a:pt x="391" y="954"/>
                  </a:lnTo>
                  <a:lnTo>
                    <a:pt x="393" y="954"/>
                  </a:lnTo>
                  <a:lnTo>
                    <a:pt x="395" y="954"/>
                  </a:lnTo>
                  <a:lnTo>
                    <a:pt x="397" y="954"/>
                  </a:lnTo>
                  <a:lnTo>
                    <a:pt x="399" y="953"/>
                  </a:lnTo>
                  <a:lnTo>
                    <a:pt x="401" y="951"/>
                  </a:lnTo>
                  <a:lnTo>
                    <a:pt x="403" y="950"/>
                  </a:lnTo>
                  <a:lnTo>
                    <a:pt x="405" y="947"/>
                  </a:lnTo>
                  <a:lnTo>
                    <a:pt x="407" y="943"/>
                  </a:lnTo>
                  <a:lnTo>
                    <a:pt x="409" y="938"/>
                  </a:lnTo>
                  <a:lnTo>
                    <a:pt x="411" y="932"/>
                  </a:lnTo>
                  <a:lnTo>
                    <a:pt x="413" y="923"/>
                  </a:lnTo>
                  <a:lnTo>
                    <a:pt x="415" y="911"/>
                  </a:lnTo>
                  <a:lnTo>
                    <a:pt x="417" y="897"/>
                  </a:lnTo>
                  <a:lnTo>
                    <a:pt x="419" y="879"/>
                  </a:lnTo>
                  <a:lnTo>
                    <a:pt x="421" y="857"/>
                  </a:lnTo>
                  <a:lnTo>
                    <a:pt x="423" y="831"/>
                  </a:lnTo>
                  <a:lnTo>
                    <a:pt x="425" y="800"/>
                  </a:lnTo>
                  <a:lnTo>
                    <a:pt x="427" y="765"/>
                  </a:lnTo>
                  <a:lnTo>
                    <a:pt x="429" y="724"/>
                  </a:lnTo>
                  <a:lnTo>
                    <a:pt x="431" y="678"/>
                  </a:lnTo>
                  <a:lnTo>
                    <a:pt x="433" y="629"/>
                  </a:lnTo>
                  <a:lnTo>
                    <a:pt x="435" y="576"/>
                  </a:lnTo>
                  <a:lnTo>
                    <a:pt x="437" y="520"/>
                  </a:lnTo>
                  <a:lnTo>
                    <a:pt x="439" y="460"/>
                  </a:lnTo>
                  <a:lnTo>
                    <a:pt x="441" y="401"/>
                  </a:lnTo>
                  <a:lnTo>
                    <a:pt x="443" y="343"/>
                  </a:lnTo>
                  <a:lnTo>
                    <a:pt x="445" y="287"/>
                  </a:lnTo>
                  <a:lnTo>
                    <a:pt x="447" y="232"/>
                  </a:lnTo>
                  <a:lnTo>
                    <a:pt x="449" y="180"/>
                  </a:lnTo>
                  <a:lnTo>
                    <a:pt x="451" y="136"/>
                  </a:lnTo>
                  <a:lnTo>
                    <a:pt x="453" y="97"/>
                  </a:lnTo>
                  <a:lnTo>
                    <a:pt x="455" y="64"/>
                  </a:lnTo>
                  <a:lnTo>
                    <a:pt x="457" y="36"/>
                  </a:lnTo>
                  <a:lnTo>
                    <a:pt x="459" y="17"/>
                  </a:lnTo>
                  <a:lnTo>
                    <a:pt x="461" y="5"/>
                  </a:lnTo>
                  <a:lnTo>
                    <a:pt x="463" y="0"/>
                  </a:lnTo>
                  <a:lnTo>
                    <a:pt x="465" y="0"/>
                  </a:lnTo>
                  <a:lnTo>
                    <a:pt x="467" y="6"/>
                  </a:lnTo>
                  <a:lnTo>
                    <a:pt x="469" y="19"/>
                  </a:lnTo>
                  <a:lnTo>
                    <a:pt x="471" y="36"/>
                  </a:lnTo>
                  <a:lnTo>
                    <a:pt x="473" y="55"/>
                  </a:lnTo>
                  <a:lnTo>
                    <a:pt x="475" y="79"/>
                  </a:lnTo>
                  <a:lnTo>
                    <a:pt x="477" y="105"/>
                  </a:lnTo>
                  <a:lnTo>
                    <a:pt x="479" y="134"/>
                  </a:lnTo>
                  <a:lnTo>
                    <a:pt x="481" y="164"/>
                  </a:lnTo>
                  <a:lnTo>
                    <a:pt x="483" y="195"/>
                  </a:lnTo>
                  <a:lnTo>
                    <a:pt x="485" y="227"/>
                  </a:lnTo>
                  <a:lnTo>
                    <a:pt x="487" y="260"/>
                  </a:lnTo>
                  <a:lnTo>
                    <a:pt x="489" y="292"/>
                  </a:lnTo>
                  <a:lnTo>
                    <a:pt x="491" y="325"/>
                  </a:lnTo>
                  <a:lnTo>
                    <a:pt x="493" y="358"/>
                  </a:lnTo>
                  <a:lnTo>
                    <a:pt x="495" y="392"/>
                  </a:lnTo>
                  <a:lnTo>
                    <a:pt x="497" y="426"/>
                  </a:lnTo>
                  <a:lnTo>
                    <a:pt x="499" y="458"/>
                  </a:lnTo>
                  <a:lnTo>
                    <a:pt x="501" y="491"/>
                  </a:lnTo>
                  <a:lnTo>
                    <a:pt x="503" y="523"/>
                  </a:lnTo>
                  <a:lnTo>
                    <a:pt x="506" y="556"/>
                  </a:lnTo>
                  <a:lnTo>
                    <a:pt x="508" y="586"/>
                  </a:lnTo>
                  <a:lnTo>
                    <a:pt x="510" y="615"/>
                  </a:lnTo>
                  <a:lnTo>
                    <a:pt x="512" y="645"/>
                  </a:lnTo>
                  <a:lnTo>
                    <a:pt x="514" y="673"/>
                  </a:lnTo>
                  <a:lnTo>
                    <a:pt x="516" y="699"/>
                  </a:lnTo>
                  <a:lnTo>
                    <a:pt x="518" y="723"/>
                  </a:lnTo>
                  <a:lnTo>
                    <a:pt x="520" y="746"/>
                  </a:lnTo>
                  <a:lnTo>
                    <a:pt x="522" y="767"/>
                  </a:lnTo>
                  <a:lnTo>
                    <a:pt x="524" y="787"/>
                  </a:lnTo>
                  <a:lnTo>
                    <a:pt x="526" y="805"/>
                  </a:lnTo>
                  <a:lnTo>
                    <a:pt x="528" y="821"/>
                  </a:lnTo>
                  <a:lnTo>
                    <a:pt x="530" y="836"/>
                  </a:lnTo>
                  <a:lnTo>
                    <a:pt x="532" y="849"/>
                  </a:lnTo>
                  <a:lnTo>
                    <a:pt x="534" y="861"/>
                  </a:lnTo>
                  <a:lnTo>
                    <a:pt x="536" y="871"/>
                  </a:lnTo>
                  <a:lnTo>
                    <a:pt x="538" y="879"/>
                  </a:lnTo>
                  <a:lnTo>
                    <a:pt x="540" y="887"/>
                  </a:lnTo>
                  <a:lnTo>
                    <a:pt x="542" y="894"/>
                  </a:lnTo>
                  <a:lnTo>
                    <a:pt x="544" y="900"/>
                  </a:lnTo>
                  <a:lnTo>
                    <a:pt x="546" y="905"/>
                  </a:lnTo>
                  <a:lnTo>
                    <a:pt x="548" y="909"/>
                  </a:lnTo>
                  <a:lnTo>
                    <a:pt x="550" y="913"/>
                  </a:lnTo>
                  <a:lnTo>
                    <a:pt x="552" y="917"/>
                  </a:lnTo>
                  <a:lnTo>
                    <a:pt x="554" y="920"/>
                  </a:lnTo>
                  <a:lnTo>
                    <a:pt x="556" y="922"/>
                  </a:lnTo>
                  <a:lnTo>
                    <a:pt x="558" y="924"/>
                  </a:lnTo>
                  <a:lnTo>
                    <a:pt x="560" y="926"/>
                  </a:lnTo>
                  <a:lnTo>
                    <a:pt x="562" y="927"/>
                  </a:lnTo>
                  <a:lnTo>
                    <a:pt x="564" y="928"/>
                  </a:lnTo>
                  <a:lnTo>
                    <a:pt x="566" y="929"/>
                  </a:lnTo>
                  <a:lnTo>
                    <a:pt x="568" y="930"/>
                  </a:lnTo>
                  <a:lnTo>
                    <a:pt x="570" y="932"/>
                  </a:lnTo>
                  <a:lnTo>
                    <a:pt x="572" y="933"/>
                  </a:lnTo>
                  <a:lnTo>
                    <a:pt x="574" y="933"/>
                  </a:lnTo>
                  <a:lnTo>
                    <a:pt x="576" y="933"/>
                  </a:lnTo>
                  <a:lnTo>
                    <a:pt x="578" y="934"/>
                  </a:lnTo>
                  <a:lnTo>
                    <a:pt x="580" y="935"/>
                  </a:lnTo>
                  <a:lnTo>
                    <a:pt x="582" y="935"/>
                  </a:lnTo>
                  <a:lnTo>
                    <a:pt x="584" y="935"/>
                  </a:lnTo>
                  <a:lnTo>
                    <a:pt x="586" y="936"/>
                  </a:lnTo>
                  <a:lnTo>
                    <a:pt x="588" y="937"/>
                  </a:lnTo>
                  <a:lnTo>
                    <a:pt x="590" y="937"/>
                  </a:lnTo>
                  <a:lnTo>
                    <a:pt x="592" y="937"/>
                  </a:lnTo>
                  <a:lnTo>
                    <a:pt x="594" y="937"/>
                  </a:lnTo>
                  <a:lnTo>
                    <a:pt x="596" y="938"/>
                  </a:lnTo>
                  <a:lnTo>
                    <a:pt x="598" y="938"/>
                  </a:lnTo>
                  <a:lnTo>
                    <a:pt x="600" y="939"/>
                  </a:lnTo>
                  <a:lnTo>
                    <a:pt x="602" y="938"/>
                  </a:lnTo>
                  <a:lnTo>
                    <a:pt x="604" y="939"/>
                  </a:lnTo>
                  <a:lnTo>
                    <a:pt x="606" y="940"/>
                  </a:lnTo>
                  <a:lnTo>
                    <a:pt x="608" y="940"/>
                  </a:lnTo>
                  <a:lnTo>
                    <a:pt x="610" y="940"/>
                  </a:lnTo>
                  <a:lnTo>
                    <a:pt x="612" y="941"/>
                  </a:lnTo>
                  <a:lnTo>
                    <a:pt x="614" y="941"/>
                  </a:lnTo>
                  <a:lnTo>
                    <a:pt x="616" y="942"/>
                  </a:lnTo>
                  <a:lnTo>
                    <a:pt x="618" y="942"/>
                  </a:lnTo>
                  <a:lnTo>
                    <a:pt x="620" y="942"/>
                  </a:lnTo>
                  <a:lnTo>
                    <a:pt x="622" y="943"/>
                  </a:lnTo>
                  <a:lnTo>
                    <a:pt x="624" y="944"/>
                  </a:lnTo>
                  <a:lnTo>
                    <a:pt x="626" y="945"/>
                  </a:lnTo>
                  <a:lnTo>
                    <a:pt x="628" y="945"/>
                  </a:lnTo>
                  <a:lnTo>
                    <a:pt x="630" y="946"/>
                  </a:lnTo>
                  <a:lnTo>
                    <a:pt x="632" y="946"/>
                  </a:lnTo>
                  <a:lnTo>
                    <a:pt x="634" y="947"/>
                  </a:lnTo>
                  <a:lnTo>
                    <a:pt x="636" y="948"/>
                  </a:lnTo>
                  <a:lnTo>
                    <a:pt x="639" y="949"/>
                  </a:lnTo>
                  <a:lnTo>
                    <a:pt x="641" y="950"/>
                  </a:lnTo>
                  <a:lnTo>
                    <a:pt x="642" y="951"/>
                  </a:lnTo>
                  <a:lnTo>
                    <a:pt x="644" y="952"/>
                  </a:lnTo>
                  <a:lnTo>
                    <a:pt x="646" y="953"/>
                  </a:lnTo>
                  <a:lnTo>
                    <a:pt x="649" y="954"/>
                  </a:lnTo>
                  <a:lnTo>
                    <a:pt x="651" y="955"/>
                  </a:lnTo>
                  <a:lnTo>
                    <a:pt x="653" y="956"/>
                  </a:lnTo>
                  <a:lnTo>
                    <a:pt x="655" y="957"/>
                  </a:lnTo>
                  <a:lnTo>
                    <a:pt x="657" y="958"/>
                  </a:lnTo>
                  <a:lnTo>
                    <a:pt x="659" y="958"/>
                  </a:lnTo>
                  <a:lnTo>
                    <a:pt x="661" y="960"/>
                  </a:lnTo>
                  <a:lnTo>
                    <a:pt x="663" y="961"/>
                  </a:lnTo>
                  <a:lnTo>
                    <a:pt x="665" y="962"/>
                  </a:lnTo>
                  <a:lnTo>
                    <a:pt x="667" y="962"/>
                  </a:lnTo>
                  <a:lnTo>
                    <a:pt x="669" y="963"/>
                  </a:lnTo>
                  <a:lnTo>
                    <a:pt x="671" y="964"/>
                  </a:lnTo>
                  <a:lnTo>
                    <a:pt x="673" y="965"/>
                  </a:lnTo>
                  <a:lnTo>
                    <a:pt x="675" y="966"/>
                  </a:lnTo>
                  <a:lnTo>
                    <a:pt x="677" y="967"/>
                  </a:lnTo>
                  <a:lnTo>
                    <a:pt x="679" y="968"/>
                  </a:lnTo>
                  <a:lnTo>
                    <a:pt x="681" y="969"/>
                  </a:lnTo>
                  <a:lnTo>
                    <a:pt x="683" y="969"/>
                  </a:lnTo>
                  <a:lnTo>
                    <a:pt x="685" y="970"/>
                  </a:lnTo>
                  <a:lnTo>
                    <a:pt x="687" y="971"/>
                  </a:lnTo>
                  <a:lnTo>
                    <a:pt x="689" y="971"/>
                  </a:lnTo>
                  <a:lnTo>
                    <a:pt x="691" y="972"/>
                  </a:lnTo>
                  <a:lnTo>
                    <a:pt x="693" y="973"/>
                  </a:lnTo>
                  <a:lnTo>
                    <a:pt x="695" y="973"/>
                  </a:lnTo>
                  <a:lnTo>
                    <a:pt x="697" y="974"/>
                  </a:lnTo>
                  <a:lnTo>
                    <a:pt x="699" y="974"/>
                  </a:lnTo>
                  <a:lnTo>
                    <a:pt x="701" y="975"/>
                  </a:lnTo>
                  <a:lnTo>
                    <a:pt x="703" y="975"/>
                  </a:lnTo>
                  <a:lnTo>
                    <a:pt x="705" y="975"/>
                  </a:lnTo>
                  <a:lnTo>
                    <a:pt x="707" y="975"/>
                  </a:lnTo>
                  <a:lnTo>
                    <a:pt x="709" y="976"/>
                  </a:lnTo>
                  <a:lnTo>
                    <a:pt x="711" y="976"/>
                  </a:lnTo>
                  <a:lnTo>
                    <a:pt x="713" y="976"/>
                  </a:lnTo>
                  <a:lnTo>
                    <a:pt x="715" y="976"/>
                  </a:lnTo>
                  <a:lnTo>
                    <a:pt x="717" y="976"/>
                  </a:lnTo>
                  <a:lnTo>
                    <a:pt x="719" y="976"/>
                  </a:lnTo>
                  <a:lnTo>
                    <a:pt x="721" y="976"/>
                  </a:lnTo>
                  <a:lnTo>
                    <a:pt x="723" y="976"/>
                  </a:lnTo>
                  <a:lnTo>
                    <a:pt x="725" y="976"/>
                  </a:lnTo>
                  <a:lnTo>
                    <a:pt x="727" y="976"/>
                  </a:lnTo>
                  <a:lnTo>
                    <a:pt x="729" y="976"/>
                  </a:lnTo>
                  <a:lnTo>
                    <a:pt x="731" y="975"/>
                  </a:lnTo>
                  <a:lnTo>
                    <a:pt x="733" y="975"/>
                  </a:lnTo>
                  <a:lnTo>
                    <a:pt x="735" y="975"/>
                  </a:lnTo>
                  <a:lnTo>
                    <a:pt x="737" y="975"/>
                  </a:lnTo>
                  <a:lnTo>
                    <a:pt x="739" y="975"/>
                  </a:lnTo>
                  <a:lnTo>
                    <a:pt x="741" y="974"/>
                  </a:lnTo>
                  <a:lnTo>
                    <a:pt x="743" y="974"/>
                  </a:lnTo>
                  <a:lnTo>
                    <a:pt x="745" y="974"/>
                  </a:lnTo>
                  <a:lnTo>
                    <a:pt x="747" y="974"/>
                  </a:lnTo>
                  <a:lnTo>
                    <a:pt x="749" y="973"/>
                  </a:lnTo>
                  <a:lnTo>
                    <a:pt x="751" y="973"/>
                  </a:lnTo>
                  <a:lnTo>
                    <a:pt x="753" y="972"/>
                  </a:lnTo>
                  <a:lnTo>
                    <a:pt x="755" y="972"/>
                  </a:lnTo>
                  <a:lnTo>
                    <a:pt x="757" y="971"/>
                  </a:lnTo>
                  <a:lnTo>
                    <a:pt x="759" y="971"/>
                  </a:lnTo>
                  <a:lnTo>
                    <a:pt x="761" y="970"/>
                  </a:lnTo>
                  <a:lnTo>
                    <a:pt x="763" y="970"/>
                  </a:lnTo>
                  <a:lnTo>
                    <a:pt x="765" y="970"/>
                  </a:lnTo>
                  <a:lnTo>
                    <a:pt x="767" y="969"/>
                  </a:lnTo>
                  <a:lnTo>
                    <a:pt x="769" y="969"/>
                  </a:lnTo>
                  <a:lnTo>
                    <a:pt x="771" y="968"/>
                  </a:lnTo>
                  <a:lnTo>
                    <a:pt x="773" y="968"/>
                  </a:lnTo>
                  <a:lnTo>
                    <a:pt x="775" y="967"/>
                  </a:lnTo>
                  <a:lnTo>
                    <a:pt x="777" y="967"/>
                  </a:lnTo>
                  <a:lnTo>
                    <a:pt x="779" y="966"/>
                  </a:lnTo>
                  <a:lnTo>
                    <a:pt x="781" y="966"/>
                  </a:lnTo>
                  <a:lnTo>
                    <a:pt x="784" y="965"/>
                  </a:lnTo>
                  <a:lnTo>
                    <a:pt x="786" y="96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1350" name="ZoneTexte 1349"/>
          <p:cNvSpPr txBox="1"/>
          <p:nvPr/>
        </p:nvSpPr>
        <p:spPr>
          <a:xfrm>
            <a:off x="980728" y="5402841"/>
            <a:ext cx="206223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OPDV_11720::Tn2.5</a:t>
            </a:r>
            <a:endParaRPr lang="fr-FR" dirty="0"/>
          </a:p>
        </p:txBody>
      </p:sp>
      <p:grpSp>
        <p:nvGrpSpPr>
          <p:cNvPr id="1483" name="Groupe 1482"/>
          <p:cNvGrpSpPr/>
          <p:nvPr/>
        </p:nvGrpSpPr>
        <p:grpSpPr>
          <a:xfrm>
            <a:off x="3664740" y="1438522"/>
            <a:ext cx="2876550" cy="1857375"/>
            <a:chOff x="3741738" y="566738"/>
            <a:chExt cx="2876550" cy="1857375"/>
          </a:xfrm>
        </p:grpSpPr>
        <p:sp>
          <p:nvSpPr>
            <p:cNvPr id="1481" name="Freeform 478"/>
            <p:cNvSpPr>
              <a:spLocks/>
            </p:cNvSpPr>
            <p:nvPr/>
          </p:nvSpPr>
          <p:spPr bwMode="auto">
            <a:xfrm>
              <a:off x="3741738" y="1792288"/>
              <a:ext cx="1628775" cy="631825"/>
            </a:xfrm>
            <a:custGeom>
              <a:avLst/>
              <a:gdLst>
                <a:gd name="T0" fmla="*/ 14 w 1026"/>
                <a:gd name="T1" fmla="*/ 386 h 398"/>
                <a:gd name="T2" fmla="*/ 30 w 1026"/>
                <a:gd name="T3" fmla="*/ 385 h 398"/>
                <a:gd name="T4" fmla="*/ 46 w 1026"/>
                <a:gd name="T5" fmla="*/ 384 h 398"/>
                <a:gd name="T6" fmla="*/ 62 w 1026"/>
                <a:gd name="T7" fmla="*/ 384 h 398"/>
                <a:gd name="T8" fmla="*/ 78 w 1026"/>
                <a:gd name="T9" fmla="*/ 383 h 398"/>
                <a:gd name="T10" fmla="*/ 94 w 1026"/>
                <a:gd name="T11" fmla="*/ 382 h 398"/>
                <a:gd name="T12" fmla="*/ 110 w 1026"/>
                <a:gd name="T13" fmla="*/ 381 h 398"/>
                <a:gd name="T14" fmla="*/ 126 w 1026"/>
                <a:gd name="T15" fmla="*/ 381 h 398"/>
                <a:gd name="T16" fmla="*/ 142 w 1026"/>
                <a:gd name="T17" fmla="*/ 380 h 398"/>
                <a:gd name="T18" fmla="*/ 159 w 1026"/>
                <a:gd name="T19" fmla="*/ 379 h 398"/>
                <a:gd name="T20" fmla="*/ 175 w 1026"/>
                <a:gd name="T21" fmla="*/ 393 h 398"/>
                <a:gd name="T22" fmla="*/ 191 w 1026"/>
                <a:gd name="T23" fmla="*/ 371 h 398"/>
                <a:gd name="T24" fmla="*/ 207 w 1026"/>
                <a:gd name="T25" fmla="*/ 141 h 398"/>
                <a:gd name="T26" fmla="*/ 223 w 1026"/>
                <a:gd name="T27" fmla="*/ 369 h 398"/>
                <a:gd name="T28" fmla="*/ 239 w 1026"/>
                <a:gd name="T29" fmla="*/ 365 h 398"/>
                <a:gd name="T30" fmla="*/ 255 w 1026"/>
                <a:gd name="T31" fmla="*/ 369 h 398"/>
                <a:gd name="T32" fmla="*/ 271 w 1026"/>
                <a:gd name="T33" fmla="*/ 367 h 398"/>
                <a:gd name="T34" fmla="*/ 288 w 1026"/>
                <a:gd name="T35" fmla="*/ 369 h 398"/>
                <a:gd name="T36" fmla="*/ 304 w 1026"/>
                <a:gd name="T37" fmla="*/ 371 h 398"/>
                <a:gd name="T38" fmla="*/ 320 w 1026"/>
                <a:gd name="T39" fmla="*/ 370 h 398"/>
                <a:gd name="T40" fmla="*/ 336 w 1026"/>
                <a:gd name="T41" fmla="*/ 361 h 398"/>
                <a:gd name="T42" fmla="*/ 352 w 1026"/>
                <a:gd name="T43" fmla="*/ 366 h 398"/>
                <a:gd name="T44" fmla="*/ 368 w 1026"/>
                <a:gd name="T45" fmla="*/ 366 h 398"/>
                <a:gd name="T46" fmla="*/ 384 w 1026"/>
                <a:gd name="T47" fmla="*/ 362 h 398"/>
                <a:gd name="T48" fmla="*/ 400 w 1026"/>
                <a:gd name="T49" fmla="*/ 366 h 398"/>
                <a:gd name="T50" fmla="*/ 416 w 1026"/>
                <a:gd name="T51" fmla="*/ 366 h 398"/>
                <a:gd name="T52" fmla="*/ 432 w 1026"/>
                <a:gd name="T53" fmla="*/ 366 h 398"/>
                <a:gd name="T54" fmla="*/ 448 w 1026"/>
                <a:gd name="T55" fmla="*/ 363 h 398"/>
                <a:gd name="T56" fmla="*/ 465 w 1026"/>
                <a:gd name="T57" fmla="*/ 360 h 398"/>
                <a:gd name="T58" fmla="*/ 481 w 1026"/>
                <a:gd name="T59" fmla="*/ 363 h 398"/>
                <a:gd name="T60" fmla="*/ 497 w 1026"/>
                <a:gd name="T61" fmla="*/ 364 h 398"/>
                <a:gd name="T62" fmla="*/ 513 w 1026"/>
                <a:gd name="T63" fmla="*/ 363 h 398"/>
                <a:gd name="T64" fmla="*/ 529 w 1026"/>
                <a:gd name="T65" fmla="*/ 353 h 398"/>
                <a:gd name="T66" fmla="*/ 545 w 1026"/>
                <a:gd name="T67" fmla="*/ 358 h 398"/>
                <a:gd name="T68" fmla="*/ 561 w 1026"/>
                <a:gd name="T69" fmla="*/ 361 h 398"/>
                <a:gd name="T70" fmla="*/ 577 w 1026"/>
                <a:gd name="T71" fmla="*/ 361 h 398"/>
                <a:gd name="T72" fmla="*/ 594 w 1026"/>
                <a:gd name="T73" fmla="*/ 362 h 398"/>
                <a:gd name="T74" fmla="*/ 610 w 1026"/>
                <a:gd name="T75" fmla="*/ 361 h 398"/>
                <a:gd name="T76" fmla="*/ 626 w 1026"/>
                <a:gd name="T77" fmla="*/ 361 h 398"/>
                <a:gd name="T78" fmla="*/ 642 w 1026"/>
                <a:gd name="T79" fmla="*/ 360 h 398"/>
                <a:gd name="T80" fmla="*/ 658 w 1026"/>
                <a:gd name="T81" fmla="*/ 359 h 398"/>
                <a:gd name="T82" fmla="*/ 674 w 1026"/>
                <a:gd name="T83" fmla="*/ 359 h 398"/>
                <a:gd name="T84" fmla="*/ 690 w 1026"/>
                <a:gd name="T85" fmla="*/ 361 h 398"/>
                <a:gd name="T86" fmla="*/ 706 w 1026"/>
                <a:gd name="T87" fmla="*/ 361 h 398"/>
                <a:gd name="T88" fmla="*/ 722 w 1026"/>
                <a:gd name="T89" fmla="*/ 359 h 398"/>
                <a:gd name="T90" fmla="*/ 738 w 1026"/>
                <a:gd name="T91" fmla="*/ 357 h 398"/>
                <a:gd name="T92" fmla="*/ 755 w 1026"/>
                <a:gd name="T93" fmla="*/ 357 h 398"/>
                <a:gd name="T94" fmla="*/ 771 w 1026"/>
                <a:gd name="T95" fmla="*/ 357 h 398"/>
                <a:gd name="T96" fmla="*/ 787 w 1026"/>
                <a:gd name="T97" fmla="*/ 355 h 398"/>
                <a:gd name="T98" fmla="*/ 803 w 1026"/>
                <a:gd name="T99" fmla="*/ 349 h 398"/>
                <a:gd name="T100" fmla="*/ 819 w 1026"/>
                <a:gd name="T101" fmla="*/ 351 h 398"/>
                <a:gd name="T102" fmla="*/ 835 w 1026"/>
                <a:gd name="T103" fmla="*/ 352 h 398"/>
                <a:gd name="T104" fmla="*/ 851 w 1026"/>
                <a:gd name="T105" fmla="*/ 352 h 398"/>
                <a:gd name="T106" fmla="*/ 867 w 1026"/>
                <a:gd name="T107" fmla="*/ 351 h 398"/>
                <a:gd name="T108" fmla="*/ 883 w 1026"/>
                <a:gd name="T109" fmla="*/ 327 h 398"/>
                <a:gd name="T110" fmla="*/ 900 w 1026"/>
                <a:gd name="T111" fmla="*/ 104 h 398"/>
                <a:gd name="T112" fmla="*/ 916 w 1026"/>
                <a:gd name="T113" fmla="*/ 14 h 398"/>
                <a:gd name="T114" fmla="*/ 932 w 1026"/>
                <a:gd name="T115" fmla="*/ 165 h 398"/>
                <a:gd name="T116" fmla="*/ 948 w 1026"/>
                <a:gd name="T117" fmla="*/ 288 h 398"/>
                <a:gd name="T118" fmla="*/ 964 w 1026"/>
                <a:gd name="T119" fmla="*/ 325 h 398"/>
                <a:gd name="T120" fmla="*/ 980 w 1026"/>
                <a:gd name="T121" fmla="*/ 333 h 398"/>
                <a:gd name="T122" fmla="*/ 996 w 1026"/>
                <a:gd name="T123" fmla="*/ 334 h 398"/>
                <a:gd name="T124" fmla="*/ 1012 w 1026"/>
                <a:gd name="T125" fmla="*/ 334 h 3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26" h="398">
                  <a:moveTo>
                    <a:pt x="0" y="387"/>
                  </a:moveTo>
                  <a:lnTo>
                    <a:pt x="2" y="386"/>
                  </a:lnTo>
                  <a:lnTo>
                    <a:pt x="4" y="386"/>
                  </a:lnTo>
                  <a:lnTo>
                    <a:pt x="6" y="387"/>
                  </a:lnTo>
                  <a:lnTo>
                    <a:pt x="8" y="386"/>
                  </a:lnTo>
                  <a:lnTo>
                    <a:pt x="10" y="386"/>
                  </a:lnTo>
                  <a:lnTo>
                    <a:pt x="12" y="386"/>
                  </a:lnTo>
                  <a:lnTo>
                    <a:pt x="14" y="386"/>
                  </a:lnTo>
                  <a:lnTo>
                    <a:pt x="16" y="386"/>
                  </a:lnTo>
                  <a:lnTo>
                    <a:pt x="18" y="386"/>
                  </a:lnTo>
                  <a:lnTo>
                    <a:pt x="20" y="385"/>
                  </a:lnTo>
                  <a:lnTo>
                    <a:pt x="22" y="385"/>
                  </a:lnTo>
                  <a:lnTo>
                    <a:pt x="24" y="386"/>
                  </a:lnTo>
                  <a:lnTo>
                    <a:pt x="26" y="385"/>
                  </a:lnTo>
                  <a:lnTo>
                    <a:pt x="28" y="385"/>
                  </a:lnTo>
                  <a:lnTo>
                    <a:pt x="30" y="385"/>
                  </a:lnTo>
                  <a:lnTo>
                    <a:pt x="32" y="385"/>
                  </a:lnTo>
                  <a:lnTo>
                    <a:pt x="34" y="385"/>
                  </a:lnTo>
                  <a:lnTo>
                    <a:pt x="36" y="385"/>
                  </a:lnTo>
                  <a:lnTo>
                    <a:pt x="38" y="385"/>
                  </a:lnTo>
                  <a:lnTo>
                    <a:pt x="40" y="385"/>
                  </a:lnTo>
                  <a:lnTo>
                    <a:pt x="42" y="385"/>
                  </a:lnTo>
                  <a:lnTo>
                    <a:pt x="44" y="385"/>
                  </a:lnTo>
                  <a:lnTo>
                    <a:pt x="46" y="384"/>
                  </a:lnTo>
                  <a:lnTo>
                    <a:pt x="48" y="384"/>
                  </a:lnTo>
                  <a:lnTo>
                    <a:pt x="50" y="384"/>
                  </a:lnTo>
                  <a:lnTo>
                    <a:pt x="52" y="384"/>
                  </a:lnTo>
                  <a:lnTo>
                    <a:pt x="54" y="384"/>
                  </a:lnTo>
                  <a:lnTo>
                    <a:pt x="56" y="384"/>
                  </a:lnTo>
                  <a:lnTo>
                    <a:pt x="58" y="384"/>
                  </a:lnTo>
                  <a:lnTo>
                    <a:pt x="60" y="384"/>
                  </a:lnTo>
                  <a:lnTo>
                    <a:pt x="62" y="384"/>
                  </a:lnTo>
                  <a:lnTo>
                    <a:pt x="64" y="383"/>
                  </a:lnTo>
                  <a:lnTo>
                    <a:pt x="66" y="383"/>
                  </a:lnTo>
                  <a:lnTo>
                    <a:pt x="68" y="383"/>
                  </a:lnTo>
                  <a:lnTo>
                    <a:pt x="70" y="383"/>
                  </a:lnTo>
                  <a:lnTo>
                    <a:pt x="72" y="383"/>
                  </a:lnTo>
                  <a:lnTo>
                    <a:pt x="74" y="383"/>
                  </a:lnTo>
                  <a:lnTo>
                    <a:pt x="76" y="383"/>
                  </a:lnTo>
                  <a:lnTo>
                    <a:pt x="78" y="383"/>
                  </a:lnTo>
                  <a:lnTo>
                    <a:pt x="80" y="383"/>
                  </a:lnTo>
                  <a:lnTo>
                    <a:pt x="82" y="382"/>
                  </a:lnTo>
                  <a:lnTo>
                    <a:pt x="84" y="382"/>
                  </a:lnTo>
                  <a:lnTo>
                    <a:pt x="86" y="382"/>
                  </a:lnTo>
                  <a:lnTo>
                    <a:pt x="88" y="382"/>
                  </a:lnTo>
                  <a:lnTo>
                    <a:pt x="90" y="382"/>
                  </a:lnTo>
                  <a:lnTo>
                    <a:pt x="92" y="382"/>
                  </a:lnTo>
                  <a:lnTo>
                    <a:pt x="94" y="382"/>
                  </a:lnTo>
                  <a:lnTo>
                    <a:pt x="96" y="382"/>
                  </a:lnTo>
                  <a:lnTo>
                    <a:pt x="98" y="382"/>
                  </a:lnTo>
                  <a:lnTo>
                    <a:pt x="100" y="381"/>
                  </a:lnTo>
                  <a:lnTo>
                    <a:pt x="102" y="381"/>
                  </a:lnTo>
                  <a:lnTo>
                    <a:pt x="104" y="381"/>
                  </a:lnTo>
                  <a:lnTo>
                    <a:pt x="106" y="381"/>
                  </a:lnTo>
                  <a:lnTo>
                    <a:pt x="108" y="381"/>
                  </a:lnTo>
                  <a:lnTo>
                    <a:pt x="110" y="381"/>
                  </a:lnTo>
                  <a:lnTo>
                    <a:pt x="112" y="381"/>
                  </a:lnTo>
                  <a:lnTo>
                    <a:pt x="114" y="381"/>
                  </a:lnTo>
                  <a:lnTo>
                    <a:pt x="116" y="381"/>
                  </a:lnTo>
                  <a:lnTo>
                    <a:pt x="118" y="381"/>
                  </a:lnTo>
                  <a:lnTo>
                    <a:pt x="120" y="381"/>
                  </a:lnTo>
                  <a:lnTo>
                    <a:pt x="122" y="380"/>
                  </a:lnTo>
                  <a:lnTo>
                    <a:pt x="124" y="380"/>
                  </a:lnTo>
                  <a:lnTo>
                    <a:pt x="126" y="381"/>
                  </a:lnTo>
                  <a:lnTo>
                    <a:pt x="128" y="380"/>
                  </a:lnTo>
                  <a:lnTo>
                    <a:pt x="130" y="380"/>
                  </a:lnTo>
                  <a:lnTo>
                    <a:pt x="133" y="380"/>
                  </a:lnTo>
                  <a:lnTo>
                    <a:pt x="135" y="380"/>
                  </a:lnTo>
                  <a:lnTo>
                    <a:pt x="136" y="380"/>
                  </a:lnTo>
                  <a:lnTo>
                    <a:pt x="138" y="380"/>
                  </a:lnTo>
                  <a:lnTo>
                    <a:pt x="140" y="380"/>
                  </a:lnTo>
                  <a:lnTo>
                    <a:pt x="142" y="380"/>
                  </a:lnTo>
                  <a:lnTo>
                    <a:pt x="145" y="380"/>
                  </a:lnTo>
                  <a:lnTo>
                    <a:pt x="147" y="380"/>
                  </a:lnTo>
                  <a:lnTo>
                    <a:pt x="149" y="379"/>
                  </a:lnTo>
                  <a:lnTo>
                    <a:pt x="151" y="379"/>
                  </a:lnTo>
                  <a:lnTo>
                    <a:pt x="153" y="379"/>
                  </a:lnTo>
                  <a:lnTo>
                    <a:pt x="155" y="379"/>
                  </a:lnTo>
                  <a:lnTo>
                    <a:pt x="157" y="379"/>
                  </a:lnTo>
                  <a:lnTo>
                    <a:pt x="159" y="379"/>
                  </a:lnTo>
                  <a:lnTo>
                    <a:pt x="161" y="379"/>
                  </a:lnTo>
                  <a:lnTo>
                    <a:pt x="163" y="379"/>
                  </a:lnTo>
                  <a:lnTo>
                    <a:pt x="165" y="383"/>
                  </a:lnTo>
                  <a:lnTo>
                    <a:pt x="167" y="392"/>
                  </a:lnTo>
                  <a:lnTo>
                    <a:pt x="169" y="398"/>
                  </a:lnTo>
                  <a:lnTo>
                    <a:pt x="171" y="398"/>
                  </a:lnTo>
                  <a:lnTo>
                    <a:pt x="173" y="395"/>
                  </a:lnTo>
                  <a:lnTo>
                    <a:pt x="175" y="393"/>
                  </a:lnTo>
                  <a:lnTo>
                    <a:pt x="177" y="389"/>
                  </a:lnTo>
                  <a:lnTo>
                    <a:pt x="179" y="385"/>
                  </a:lnTo>
                  <a:lnTo>
                    <a:pt x="181" y="383"/>
                  </a:lnTo>
                  <a:lnTo>
                    <a:pt x="183" y="381"/>
                  </a:lnTo>
                  <a:lnTo>
                    <a:pt x="185" y="378"/>
                  </a:lnTo>
                  <a:lnTo>
                    <a:pt x="187" y="374"/>
                  </a:lnTo>
                  <a:lnTo>
                    <a:pt x="189" y="371"/>
                  </a:lnTo>
                  <a:lnTo>
                    <a:pt x="191" y="371"/>
                  </a:lnTo>
                  <a:lnTo>
                    <a:pt x="193" y="372"/>
                  </a:lnTo>
                  <a:lnTo>
                    <a:pt x="195" y="360"/>
                  </a:lnTo>
                  <a:lnTo>
                    <a:pt x="197" y="296"/>
                  </a:lnTo>
                  <a:lnTo>
                    <a:pt x="199" y="173"/>
                  </a:lnTo>
                  <a:lnTo>
                    <a:pt x="201" y="85"/>
                  </a:lnTo>
                  <a:lnTo>
                    <a:pt x="203" y="74"/>
                  </a:lnTo>
                  <a:lnTo>
                    <a:pt x="205" y="101"/>
                  </a:lnTo>
                  <a:lnTo>
                    <a:pt x="207" y="141"/>
                  </a:lnTo>
                  <a:lnTo>
                    <a:pt x="209" y="194"/>
                  </a:lnTo>
                  <a:lnTo>
                    <a:pt x="211" y="252"/>
                  </a:lnTo>
                  <a:lnTo>
                    <a:pt x="213" y="301"/>
                  </a:lnTo>
                  <a:lnTo>
                    <a:pt x="215" y="335"/>
                  </a:lnTo>
                  <a:lnTo>
                    <a:pt x="217" y="354"/>
                  </a:lnTo>
                  <a:lnTo>
                    <a:pt x="219" y="363"/>
                  </a:lnTo>
                  <a:lnTo>
                    <a:pt x="221" y="367"/>
                  </a:lnTo>
                  <a:lnTo>
                    <a:pt x="223" y="369"/>
                  </a:lnTo>
                  <a:lnTo>
                    <a:pt x="225" y="371"/>
                  </a:lnTo>
                  <a:lnTo>
                    <a:pt x="227" y="372"/>
                  </a:lnTo>
                  <a:lnTo>
                    <a:pt x="229" y="372"/>
                  </a:lnTo>
                  <a:lnTo>
                    <a:pt x="231" y="371"/>
                  </a:lnTo>
                  <a:lnTo>
                    <a:pt x="233" y="370"/>
                  </a:lnTo>
                  <a:lnTo>
                    <a:pt x="235" y="368"/>
                  </a:lnTo>
                  <a:lnTo>
                    <a:pt x="237" y="366"/>
                  </a:lnTo>
                  <a:lnTo>
                    <a:pt x="239" y="365"/>
                  </a:lnTo>
                  <a:lnTo>
                    <a:pt x="241" y="364"/>
                  </a:lnTo>
                  <a:lnTo>
                    <a:pt x="243" y="364"/>
                  </a:lnTo>
                  <a:lnTo>
                    <a:pt x="245" y="365"/>
                  </a:lnTo>
                  <a:lnTo>
                    <a:pt x="247" y="366"/>
                  </a:lnTo>
                  <a:lnTo>
                    <a:pt x="249" y="367"/>
                  </a:lnTo>
                  <a:lnTo>
                    <a:pt x="251" y="367"/>
                  </a:lnTo>
                  <a:lnTo>
                    <a:pt x="253" y="368"/>
                  </a:lnTo>
                  <a:lnTo>
                    <a:pt x="255" y="369"/>
                  </a:lnTo>
                  <a:lnTo>
                    <a:pt x="257" y="369"/>
                  </a:lnTo>
                  <a:lnTo>
                    <a:pt x="259" y="370"/>
                  </a:lnTo>
                  <a:lnTo>
                    <a:pt x="261" y="370"/>
                  </a:lnTo>
                  <a:lnTo>
                    <a:pt x="263" y="370"/>
                  </a:lnTo>
                  <a:lnTo>
                    <a:pt x="265" y="370"/>
                  </a:lnTo>
                  <a:lnTo>
                    <a:pt x="267" y="369"/>
                  </a:lnTo>
                  <a:lnTo>
                    <a:pt x="269" y="369"/>
                  </a:lnTo>
                  <a:lnTo>
                    <a:pt x="271" y="367"/>
                  </a:lnTo>
                  <a:lnTo>
                    <a:pt x="273" y="365"/>
                  </a:lnTo>
                  <a:lnTo>
                    <a:pt x="275" y="365"/>
                  </a:lnTo>
                  <a:lnTo>
                    <a:pt x="277" y="365"/>
                  </a:lnTo>
                  <a:lnTo>
                    <a:pt x="279" y="366"/>
                  </a:lnTo>
                  <a:lnTo>
                    <a:pt x="281" y="367"/>
                  </a:lnTo>
                  <a:lnTo>
                    <a:pt x="283" y="368"/>
                  </a:lnTo>
                  <a:lnTo>
                    <a:pt x="285" y="369"/>
                  </a:lnTo>
                  <a:lnTo>
                    <a:pt x="288" y="369"/>
                  </a:lnTo>
                  <a:lnTo>
                    <a:pt x="290" y="370"/>
                  </a:lnTo>
                  <a:lnTo>
                    <a:pt x="291" y="370"/>
                  </a:lnTo>
                  <a:lnTo>
                    <a:pt x="293" y="371"/>
                  </a:lnTo>
                  <a:lnTo>
                    <a:pt x="295" y="371"/>
                  </a:lnTo>
                  <a:lnTo>
                    <a:pt x="298" y="371"/>
                  </a:lnTo>
                  <a:lnTo>
                    <a:pt x="300" y="371"/>
                  </a:lnTo>
                  <a:lnTo>
                    <a:pt x="302" y="371"/>
                  </a:lnTo>
                  <a:lnTo>
                    <a:pt x="304" y="371"/>
                  </a:lnTo>
                  <a:lnTo>
                    <a:pt x="306" y="371"/>
                  </a:lnTo>
                  <a:lnTo>
                    <a:pt x="308" y="370"/>
                  </a:lnTo>
                  <a:lnTo>
                    <a:pt x="310" y="371"/>
                  </a:lnTo>
                  <a:lnTo>
                    <a:pt x="312" y="371"/>
                  </a:lnTo>
                  <a:lnTo>
                    <a:pt x="314" y="371"/>
                  </a:lnTo>
                  <a:lnTo>
                    <a:pt x="316" y="370"/>
                  </a:lnTo>
                  <a:lnTo>
                    <a:pt x="318" y="370"/>
                  </a:lnTo>
                  <a:lnTo>
                    <a:pt x="320" y="370"/>
                  </a:lnTo>
                  <a:lnTo>
                    <a:pt x="322" y="370"/>
                  </a:lnTo>
                  <a:lnTo>
                    <a:pt x="324" y="370"/>
                  </a:lnTo>
                  <a:lnTo>
                    <a:pt x="326" y="369"/>
                  </a:lnTo>
                  <a:lnTo>
                    <a:pt x="328" y="368"/>
                  </a:lnTo>
                  <a:lnTo>
                    <a:pt x="330" y="366"/>
                  </a:lnTo>
                  <a:lnTo>
                    <a:pt x="332" y="364"/>
                  </a:lnTo>
                  <a:lnTo>
                    <a:pt x="334" y="362"/>
                  </a:lnTo>
                  <a:lnTo>
                    <a:pt x="336" y="361"/>
                  </a:lnTo>
                  <a:lnTo>
                    <a:pt x="338" y="361"/>
                  </a:lnTo>
                  <a:lnTo>
                    <a:pt x="340" y="361"/>
                  </a:lnTo>
                  <a:lnTo>
                    <a:pt x="342" y="362"/>
                  </a:lnTo>
                  <a:lnTo>
                    <a:pt x="344" y="363"/>
                  </a:lnTo>
                  <a:lnTo>
                    <a:pt x="346" y="364"/>
                  </a:lnTo>
                  <a:lnTo>
                    <a:pt x="348" y="365"/>
                  </a:lnTo>
                  <a:lnTo>
                    <a:pt x="350" y="366"/>
                  </a:lnTo>
                  <a:lnTo>
                    <a:pt x="352" y="366"/>
                  </a:lnTo>
                  <a:lnTo>
                    <a:pt x="354" y="367"/>
                  </a:lnTo>
                  <a:lnTo>
                    <a:pt x="356" y="367"/>
                  </a:lnTo>
                  <a:lnTo>
                    <a:pt x="358" y="368"/>
                  </a:lnTo>
                  <a:lnTo>
                    <a:pt x="360" y="368"/>
                  </a:lnTo>
                  <a:lnTo>
                    <a:pt x="362" y="368"/>
                  </a:lnTo>
                  <a:lnTo>
                    <a:pt x="364" y="367"/>
                  </a:lnTo>
                  <a:lnTo>
                    <a:pt x="366" y="367"/>
                  </a:lnTo>
                  <a:lnTo>
                    <a:pt x="368" y="366"/>
                  </a:lnTo>
                  <a:lnTo>
                    <a:pt x="370" y="364"/>
                  </a:lnTo>
                  <a:lnTo>
                    <a:pt x="372" y="362"/>
                  </a:lnTo>
                  <a:lnTo>
                    <a:pt x="374" y="361"/>
                  </a:lnTo>
                  <a:lnTo>
                    <a:pt x="376" y="360"/>
                  </a:lnTo>
                  <a:lnTo>
                    <a:pt x="378" y="360"/>
                  </a:lnTo>
                  <a:lnTo>
                    <a:pt x="380" y="360"/>
                  </a:lnTo>
                  <a:lnTo>
                    <a:pt x="382" y="361"/>
                  </a:lnTo>
                  <a:lnTo>
                    <a:pt x="384" y="362"/>
                  </a:lnTo>
                  <a:lnTo>
                    <a:pt x="386" y="363"/>
                  </a:lnTo>
                  <a:lnTo>
                    <a:pt x="388" y="363"/>
                  </a:lnTo>
                  <a:lnTo>
                    <a:pt x="390" y="364"/>
                  </a:lnTo>
                  <a:lnTo>
                    <a:pt x="392" y="365"/>
                  </a:lnTo>
                  <a:lnTo>
                    <a:pt x="394" y="365"/>
                  </a:lnTo>
                  <a:lnTo>
                    <a:pt x="396" y="366"/>
                  </a:lnTo>
                  <a:lnTo>
                    <a:pt x="398" y="366"/>
                  </a:lnTo>
                  <a:lnTo>
                    <a:pt x="400" y="366"/>
                  </a:lnTo>
                  <a:lnTo>
                    <a:pt x="402" y="366"/>
                  </a:lnTo>
                  <a:lnTo>
                    <a:pt x="404" y="366"/>
                  </a:lnTo>
                  <a:lnTo>
                    <a:pt x="406" y="366"/>
                  </a:lnTo>
                  <a:lnTo>
                    <a:pt x="408" y="366"/>
                  </a:lnTo>
                  <a:lnTo>
                    <a:pt x="410" y="366"/>
                  </a:lnTo>
                  <a:lnTo>
                    <a:pt x="412" y="366"/>
                  </a:lnTo>
                  <a:lnTo>
                    <a:pt x="414" y="366"/>
                  </a:lnTo>
                  <a:lnTo>
                    <a:pt x="416" y="366"/>
                  </a:lnTo>
                  <a:lnTo>
                    <a:pt x="418" y="366"/>
                  </a:lnTo>
                  <a:lnTo>
                    <a:pt x="420" y="366"/>
                  </a:lnTo>
                  <a:lnTo>
                    <a:pt x="422" y="366"/>
                  </a:lnTo>
                  <a:lnTo>
                    <a:pt x="424" y="366"/>
                  </a:lnTo>
                  <a:lnTo>
                    <a:pt x="426" y="366"/>
                  </a:lnTo>
                  <a:lnTo>
                    <a:pt x="428" y="366"/>
                  </a:lnTo>
                  <a:lnTo>
                    <a:pt x="430" y="366"/>
                  </a:lnTo>
                  <a:lnTo>
                    <a:pt x="432" y="366"/>
                  </a:lnTo>
                  <a:lnTo>
                    <a:pt x="434" y="366"/>
                  </a:lnTo>
                  <a:lnTo>
                    <a:pt x="436" y="366"/>
                  </a:lnTo>
                  <a:lnTo>
                    <a:pt x="438" y="366"/>
                  </a:lnTo>
                  <a:lnTo>
                    <a:pt x="441" y="366"/>
                  </a:lnTo>
                  <a:lnTo>
                    <a:pt x="443" y="365"/>
                  </a:lnTo>
                  <a:lnTo>
                    <a:pt x="445" y="365"/>
                  </a:lnTo>
                  <a:lnTo>
                    <a:pt x="446" y="364"/>
                  </a:lnTo>
                  <a:lnTo>
                    <a:pt x="448" y="363"/>
                  </a:lnTo>
                  <a:lnTo>
                    <a:pt x="451" y="361"/>
                  </a:lnTo>
                  <a:lnTo>
                    <a:pt x="453" y="360"/>
                  </a:lnTo>
                  <a:lnTo>
                    <a:pt x="455" y="359"/>
                  </a:lnTo>
                  <a:lnTo>
                    <a:pt x="457" y="359"/>
                  </a:lnTo>
                  <a:lnTo>
                    <a:pt x="459" y="359"/>
                  </a:lnTo>
                  <a:lnTo>
                    <a:pt x="461" y="359"/>
                  </a:lnTo>
                  <a:lnTo>
                    <a:pt x="463" y="359"/>
                  </a:lnTo>
                  <a:lnTo>
                    <a:pt x="465" y="360"/>
                  </a:lnTo>
                  <a:lnTo>
                    <a:pt x="467" y="360"/>
                  </a:lnTo>
                  <a:lnTo>
                    <a:pt x="469" y="361"/>
                  </a:lnTo>
                  <a:lnTo>
                    <a:pt x="471" y="361"/>
                  </a:lnTo>
                  <a:lnTo>
                    <a:pt x="473" y="361"/>
                  </a:lnTo>
                  <a:lnTo>
                    <a:pt x="475" y="362"/>
                  </a:lnTo>
                  <a:lnTo>
                    <a:pt x="477" y="362"/>
                  </a:lnTo>
                  <a:lnTo>
                    <a:pt x="479" y="363"/>
                  </a:lnTo>
                  <a:lnTo>
                    <a:pt x="481" y="363"/>
                  </a:lnTo>
                  <a:lnTo>
                    <a:pt x="483" y="363"/>
                  </a:lnTo>
                  <a:lnTo>
                    <a:pt x="485" y="363"/>
                  </a:lnTo>
                  <a:lnTo>
                    <a:pt x="487" y="363"/>
                  </a:lnTo>
                  <a:lnTo>
                    <a:pt x="489" y="363"/>
                  </a:lnTo>
                  <a:lnTo>
                    <a:pt x="491" y="363"/>
                  </a:lnTo>
                  <a:lnTo>
                    <a:pt x="493" y="363"/>
                  </a:lnTo>
                  <a:lnTo>
                    <a:pt x="495" y="364"/>
                  </a:lnTo>
                  <a:lnTo>
                    <a:pt x="497" y="364"/>
                  </a:lnTo>
                  <a:lnTo>
                    <a:pt x="499" y="364"/>
                  </a:lnTo>
                  <a:lnTo>
                    <a:pt x="501" y="364"/>
                  </a:lnTo>
                  <a:lnTo>
                    <a:pt x="503" y="364"/>
                  </a:lnTo>
                  <a:lnTo>
                    <a:pt x="505" y="364"/>
                  </a:lnTo>
                  <a:lnTo>
                    <a:pt x="507" y="364"/>
                  </a:lnTo>
                  <a:lnTo>
                    <a:pt x="509" y="364"/>
                  </a:lnTo>
                  <a:lnTo>
                    <a:pt x="511" y="364"/>
                  </a:lnTo>
                  <a:lnTo>
                    <a:pt x="513" y="363"/>
                  </a:lnTo>
                  <a:lnTo>
                    <a:pt x="515" y="363"/>
                  </a:lnTo>
                  <a:lnTo>
                    <a:pt x="517" y="361"/>
                  </a:lnTo>
                  <a:lnTo>
                    <a:pt x="519" y="360"/>
                  </a:lnTo>
                  <a:lnTo>
                    <a:pt x="521" y="358"/>
                  </a:lnTo>
                  <a:lnTo>
                    <a:pt x="523" y="356"/>
                  </a:lnTo>
                  <a:lnTo>
                    <a:pt x="525" y="354"/>
                  </a:lnTo>
                  <a:lnTo>
                    <a:pt x="527" y="353"/>
                  </a:lnTo>
                  <a:lnTo>
                    <a:pt x="529" y="353"/>
                  </a:lnTo>
                  <a:lnTo>
                    <a:pt x="531" y="353"/>
                  </a:lnTo>
                  <a:lnTo>
                    <a:pt x="533" y="354"/>
                  </a:lnTo>
                  <a:lnTo>
                    <a:pt x="535" y="354"/>
                  </a:lnTo>
                  <a:lnTo>
                    <a:pt x="537" y="355"/>
                  </a:lnTo>
                  <a:lnTo>
                    <a:pt x="539" y="356"/>
                  </a:lnTo>
                  <a:lnTo>
                    <a:pt x="541" y="357"/>
                  </a:lnTo>
                  <a:lnTo>
                    <a:pt x="543" y="357"/>
                  </a:lnTo>
                  <a:lnTo>
                    <a:pt x="545" y="358"/>
                  </a:lnTo>
                  <a:lnTo>
                    <a:pt x="547" y="358"/>
                  </a:lnTo>
                  <a:lnTo>
                    <a:pt x="549" y="359"/>
                  </a:lnTo>
                  <a:lnTo>
                    <a:pt x="551" y="359"/>
                  </a:lnTo>
                  <a:lnTo>
                    <a:pt x="553" y="360"/>
                  </a:lnTo>
                  <a:lnTo>
                    <a:pt x="555" y="360"/>
                  </a:lnTo>
                  <a:lnTo>
                    <a:pt x="557" y="360"/>
                  </a:lnTo>
                  <a:lnTo>
                    <a:pt x="559" y="360"/>
                  </a:lnTo>
                  <a:lnTo>
                    <a:pt x="561" y="361"/>
                  </a:lnTo>
                  <a:lnTo>
                    <a:pt x="563" y="360"/>
                  </a:lnTo>
                  <a:lnTo>
                    <a:pt x="565" y="360"/>
                  </a:lnTo>
                  <a:lnTo>
                    <a:pt x="567" y="361"/>
                  </a:lnTo>
                  <a:lnTo>
                    <a:pt x="569" y="361"/>
                  </a:lnTo>
                  <a:lnTo>
                    <a:pt x="571" y="361"/>
                  </a:lnTo>
                  <a:lnTo>
                    <a:pt x="573" y="361"/>
                  </a:lnTo>
                  <a:lnTo>
                    <a:pt x="575" y="361"/>
                  </a:lnTo>
                  <a:lnTo>
                    <a:pt x="577" y="361"/>
                  </a:lnTo>
                  <a:lnTo>
                    <a:pt x="579" y="361"/>
                  </a:lnTo>
                  <a:lnTo>
                    <a:pt x="581" y="361"/>
                  </a:lnTo>
                  <a:lnTo>
                    <a:pt x="583" y="361"/>
                  </a:lnTo>
                  <a:lnTo>
                    <a:pt x="585" y="361"/>
                  </a:lnTo>
                  <a:lnTo>
                    <a:pt x="587" y="362"/>
                  </a:lnTo>
                  <a:lnTo>
                    <a:pt x="589" y="362"/>
                  </a:lnTo>
                  <a:lnTo>
                    <a:pt x="591" y="362"/>
                  </a:lnTo>
                  <a:lnTo>
                    <a:pt x="594" y="362"/>
                  </a:lnTo>
                  <a:lnTo>
                    <a:pt x="596" y="362"/>
                  </a:lnTo>
                  <a:lnTo>
                    <a:pt x="598" y="362"/>
                  </a:lnTo>
                  <a:lnTo>
                    <a:pt x="600" y="361"/>
                  </a:lnTo>
                  <a:lnTo>
                    <a:pt x="602" y="361"/>
                  </a:lnTo>
                  <a:lnTo>
                    <a:pt x="604" y="361"/>
                  </a:lnTo>
                  <a:lnTo>
                    <a:pt x="606" y="361"/>
                  </a:lnTo>
                  <a:lnTo>
                    <a:pt x="608" y="362"/>
                  </a:lnTo>
                  <a:lnTo>
                    <a:pt x="610" y="361"/>
                  </a:lnTo>
                  <a:lnTo>
                    <a:pt x="612" y="361"/>
                  </a:lnTo>
                  <a:lnTo>
                    <a:pt x="614" y="361"/>
                  </a:lnTo>
                  <a:lnTo>
                    <a:pt x="616" y="362"/>
                  </a:lnTo>
                  <a:lnTo>
                    <a:pt x="618" y="362"/>
                  </a:lnTo>
                  <a:lnTo>
                    <a:pt x="620" y="361"/>
                  </a:lnTo>
                  <a:lnTo>
                    <a:pt x="622" y="361"/>
                  </a:lnTo>
                  <a:lnTo>
                    <a:pt x="624" y="361"/>
                  </a:lnTo>
                  <a:lnTo>
                    <a:pt x="626" y="361"/>
                  </a:lnTo>
                  <a:lnTo>
                    <a:pt x="628" y="361"/>
                  </a:lnTo>
                  <a:lnTo>
                    <a:pt x="630" y="361"/>
                  </a:lnTo>
                  <a:lnTo>
                    <a:pt x="632" y="360"/>
                  </a:lnTo>
                  <a:lnTo>
                    <a:pt x="634" y="360"/>
                  </a:lnTo>
                  <a:lnTo>
                    <a:pt x="636" y="360"/>
                  </a:lnTo>
                  <a:lnTo>
                    <a:pt x="638" y="360"/>
                  </a:lnTo>
                  <a:lnTo>
                    <a:pt x="640" y="360"/>
                  </a:lnTo>
                  <a:lnTo>
                    <a:pt x="642" y="360"/>
                  </a:lnTo>
                  <a:lnTo>
                    <a:pt x="644" y="360"/>
                  </a:lnTo>
                  <a:lnTo>
                    <a:pt x="646" y="360"/>
                  </a:lnTo>
                  <a:lnTo>
                    <a:pt x="648" y="359"/>
                  </a:lnTo>
                  <a:lnTo>
                    <a:pt x="650" y="359"/>
                  </a:lnTo>
                  <a:lnTo>
                    <a:pt x="652" y="359"/>
                  </a:lnTo>
                  <a:lnTo>
                    <a:pt x="654" y="359"/>
                  </a:lnTo>
                  <a:lnTo>
                    <a:pt x="656" y="359"/>
                  </a:lnTo>
                  <a:lnTo>
                    <a:pt x="658" y="359"/>
                  </a:lnTo>
                  <a:lnTo>
                    <a:pt x="660" y="359"/>
                  </a:lnTo>
                  <a:lnTo>
                    <a:pt x="662" y="359"/>
                  </a:lnTo>
                  <a:lnTo>
                    <a:pt x="664" y="359"/>
                  </a:lnTo>
                  <a:lnTo>
                    <a:pt x="666" y="359"/>
                  </a:lnTo>
                  <a:lnTo>
                    <a:pt x="668" y="359"/>
                  </a:lnTo>
                  <a:lnTo>
                    <a:pt x="670" y="359"/>
                  </a:lnTo>
                  <a:lnTo>
                    <a:pt x="672" y="359"/>
                  </a:lnTo>
                  <a:lnTo>
                    <a:pt x="674" y="359"/>
                  </a:lnTo>
                  <a:lnTo>
                    <a:pt x="676" y="358"/>
                  </a:lnTo>
                  <a:lnTo>
                    <a:pt x="678" y="359"/>
                  </a:lnTo>
                  <a:lnTo>
                    <a:pt x="680" y="359"/>
                  </a:lnTo>
                  <a:lnTo>
                    <a:pt x="682" y="359"/>
                  </a:lnTo>
                  <a:lnTo>
                    <a:pt x="684" y="360"/>
                  </a:lnTo>
                  <a:lnTo>
                    <a:pt x="686" y="360"/>
                  </a:lnTo>
                  <a:lnTo>
                    <a:pt x="688" y="360"/>
                  </a:lnTo>
                  <a:lnTo>
                    <a:pt x="690" y="361"/>
                  </a:lnTo>
                  <a:lnTo>
                    <a:pt x="692" y="361"/>
                  </a:lnTo>
                  <a:lnTo>
                    <a:pt x="694" y="362"/>
                  </a:lnTo>
                  <a:lnTo>
                    <a:pt x="696" y="362"/>
                  </a:lnTo>
                  <a:lnTo>
                    <a:pt x="698" y="362"/>
                  </a:lnTo>
                  <a:lnTo>
                    <a:pt x="700" y="362"/>
                  </a:lnTo>
                  <a:lnTo>
                    <a:pt x="702" y="361"/>
                  </a:lnTo>
                  <a:lnTo>
                    <a:pt x="704" y="361"/>
                  </a:lnTo>
                  <a:lnTo>
                    <a:pt x="706" y="361"/>
                  </a:lnTo>
                  <a:lnTo>
                    <a:pt x="708" y="361"/>
                  </a:lnTo>
                  <a:lnTo>
                    <a:pt x="710" y="360"/>
                  </a:lnTo>
                  <a:lnTo>
                    <a:pt x="712" y="360"/>
                  </a:lnTo>
                  <a:lnTo>
                    <a:pt x="714" y="360"/>
                  </a:lnTo>
                  <a:lnTo>
                    <a:pt x="716" y="360"/>
                  </a:lnTo>
                  <a:lnTo>
                    <a:pt x="718" y="359"/>
                  </a:lnTo>
                  <a:lnTo>
                    <a:pt x="720" y="359"/>
                  </a:lnTo>
                  <a:lnTo>
                    <a:pt x="722" y="359"/>
                  </a:lnTo>
                  <a:lnTo>
                    <a:pt x="724" y="358"/>
                  </a:lnTo>
                  <a:lnTo>
                    <a:pt x="726" y="358"/>
                  </a:lnTo>
                  <a:lnTo>
                    <a:pt x="728" y="358"/>
                  </a:lnTo>
                  <a:lnTo>
                    <a:pt x="730" y="358"/>
                  </a:lnTo>
                  <a:lnTo>
                    <a:pt x="732" y="357"/>
                  </a:lnTo>
                  <a:lnTo>
                    <a:pt x="734" y="357"/>
                  </a:lnTo>
                  <a:lnTo>
                    <a:pt x="736" y="357"/>
                  </a:lnTo>
                  <a:lnTo>
                    <a:pt x="738" y="357"/>
                  </a:lnTo>
                  <a:lnTo>
                    <a:pt x="740" y="357"/>
                  </a:lnTo>
                  <a:lnTo>
                    <a:pt x="742" y="357"/>
                  </a:lnTo>
                  <a:lnTo>
                    <a:pt x="744" y="357"/>
                  </a:lnTo>
                  <a:lnTo>
                    <a:pt x="747" y="357"/>
                  </a:lnTo>
                  <a:lnTo>
                    <a:pt x="749" y="357"/>
                  </a:lnTo>
                  <a:lnTo>
                    <a:pt x="751" y="356"/>
                  </a:lnTo>
                  <a:lnTo>
                    <a:pt x="753" y="356"/>
                  </a:lnTo>
                  <a:lnTo>
                    <a:pt x="755" y="357"/>
                  </a:lnTo>
                  <a:lnTo>
                    <a:pt x="757" y="356"/>
                  </a:lnTo>
                  <a:lnTo>
                    <a:pt x="759" y="356"/>
                  </a:lnTo>
                  <a:lnTo>
                    <a:pt x="761" y="356"/>
                  </a:lnTo>
                  <a:lnTo>
                    <a:pt x="763" y="357"/>
                  </a:lnTo>
                  <a:lnTo>
                    <a:pt x="765" y="357"/>
                  </a:lnTo>
                  <a:lnTo>
                    <a:pt x="767" y="357"/>
                  </a:lnTo>
                  <a:lnTo>
                    <a:pt x="769" y="357"/>
                  </a:lnTo>
                  <a:lnTo>
                    <a:pt x="771" y="357"/>
                  </a:lnTo>
                  <a:lnTo>
                    <a:pt x="773" y="357"/>
                  </a:lnTo>
                  <a:lnTo>
                    <a:pt x="775" y="357"/>
                  </a:lnTo>
                  <a:lnTo>
                    <a:pt x="777" y="357"/>
                  </a:lnTo>
                  <a:lnTo>
                    <a:pt x="779" y="357"/>
                  </a:lnTo>
                  <a:lnTo>
                    <a:pt x="781" y="356"/>
                  </a:lnTo>
                  <a:lnTo>
                    <a:pt x="783" y="356"/>
                  </a:lnTo>
                  <a:lnTo>
                    <a:pt x="785" y="355"/>
                  </a:lnTo>
                  <a:lnTo>
                    <a:pt x="787" y="355"/>
                  </a:lnTo>
                  <a:lnTo>
                    <a:pt x="789" y="354"/>
                  </a:lnTo>
                  <a:lnTo>
                    <a:pt x="791" y="353"/>
                  </a:lnTo>
                  <a:lnTo>
                    <a:pt x="793" y="352"/>
                  </a:lnTo>
                  <a:lnTo>
                    <a:pt x="795" y="351"/>
                  </a:lnTo>
                  <a:lnTo>
                    <a:pt x="797" y="350"/>
                  </a:lnTo>
                  <a:lnTo>
                    <a:pt x="799" y="350"/>
                  </a:lnTo>
                  <a:lnTo>
                    <a:pt x="801" y="349"/>
                  </a:lnTo>
                  <a:lnTo>
                    <a:pt x="803" y="349"/>
                  </a:lnTo>
                  <a:lnTo>
                    <a:pt x="805" y="349"/>
                  </a:lnTo>
                  <a:lnTo>
                    <a:pt x="807" y="349"/>
                  </a:lnTo>
                  <a:lnTo>
                    <a:pt x="809" y="349"/>
                  </a:lnTo>
                  <a:lnTo>
                    <a:pt x="811" y="349"/>
                  </a:lnTo>
                  <a:lnTo>
                    <a:pt x="813" y="350"/>
                  </a:lnTo>
                  <a:lnTo>
                    <a:pt x="815" y="350"/>
                  </a:lnTo>
                  <a:lnTo>
                    <a:pt x="817" y="350"/>
                  </a:lnTo>
                  <a:lnTo>
                    <a:pt x="819" y="351"/>
                  </a:lnTo>
                  <a:lnTo>
                    <a:pt x="821" y="351"/>
                  </a:lnTo>
                  <a:lnTo>
                    <a:pt x="823" y="351"/>
                  </a:lnTo>
                  <a:lnTo>
                    <a:pt x="825" y="351"/>
                  </a:lnTo>
                  <a:lnTo>
                    <a:pt x="827" y="351"/>
                  </a:lnTo>
                  <a:lnTo>
                    <a:pt x="829" y="351"/>
                  </a:lnTo>
                  <a:lnTo>
                    <a:pt x="831" y="351"/>
                  </a:lnTo>
                  <a:lnTo>
                    <a:pt x="833" y="351"/>
                  </a:lnTo>
                  <a:lnTo>
                    <a:pt x="835" y="352"/>
                  </a:lnTo>
                  <a:lnTo>
                    <a:pt x="837" y="352"/>
                  </a:lnTo>
                  <a:lnTo>
                    <a:pt x="839" y="352"/>
                  </a:lnTo>
                  <a:lnTo>
                    <a:pt x="841" y="352"/>
                  </a:lnTo>
                  <a:lnTo>
                    <a:pt x="843" y="352"/>
                  </a:lnTo>
                  <a:lnTo>
                    <a:pt x="845" y="352"/>
                  </a:lnTo>
                  <a:lnTo>
                    <a:pt x="847" y="352"/>
                  </a:lnTo>
                  <a:lnTo>
                    <a:pt x="849" y="352"/>
                  </a:lnTo>
                  <a:lnTo>
                    <a:pt x="851" y="352"/>
                  </a:lnTo>
                  <a:lnTo>
                    <a:pt x="853" y="352"/>
                  </a:lnTo>
                  <a:lnTo>
                    <a:pt x="855" y="352"/>
                  </a:lnTo>
                  <a:lnTo>
                    <a:pt x="857" y="352"/>
                  </a:lnTo>
                  <a:lnTo>
                    <a:pt x="859" y="352"/>
                  </a:lnTo>
                  <a:lnTo>
                    <a:pt x="861" y="352"/>
                  </a:lnTo>
                  <a:lnTo>
                    <a:pt x="863" y="352"/>
                  </a:lnTo>
                  <a:lnTo>
                    <a:pt x="865" y="352"/>
                  </a:lnTo>
                  <a:lnTo>
                    <a:pt x="867" y="351"/>
                  </a:lnTo>
                  <a:lnTo>
                    <a:pt x="869" y="351"/>
                  </a:lnTo>
                  <a:lnTo>
                    <a:pt x="871" y="351"/>
                  </a:lnTo>
                  <a:lnTo>
                    <a:pt x="873" y="350"/>
                  </a:lnTo>
                  <a:lnTo>
                    <a:pt x="875" y="349"/>
                  </a:lnTo>
                  <a:lnTo>
                    <a:pt x="877" y="346"/>
                  </a:lnTo>
                  <a:lnTo>
                    <a:pt x="879" y="342"/>
                  </a:lnTo>
                  <a:lnTo>
                    <a:pt x="881" y="336"/>
                  </a:lnTo>
                  <a:lnTo>
                    <a:pt x="883" y="327"/>
                  </a:lnTo>
                  <a:lnTo>
                    <a:pt x="885" y="314"/>
                  </a:lnTo>
                  <a:lnTo>
                    <a:pt x="887" y="296"/>
                  </a:lnTo>
                  <a:lnTo>
                    <a:pt x="889" y="273"/>
                  </a:lnTo>
                  <a:lnTo>
                    <a:pt x="891" y="245"/>
                  </a:lnTo>
                  <a:lnTo>
                    <a:pt x="893" y="212"/>
                  </a:lnTo>
                  <a:lnTo>
                    <a:pt x="895" y="177"/>
                  </a:lnTo>
                  <a:lnTo>
                    <a:pt x="897" y="140"/>
                  </a:lnTo>
                  <a:lnTo>
                    <a:pt x="900" y="104"/>
                  </a:lnTo>
                  <a:lnTo>
                    <a:pt x="902" y="72"/>
                  </a:lnTo>
                  <a:lnTo>
                    <a:pt x="904" y="44"/>
                  </a:lnTo>
                  <a:lnTo>
                    <a:pt x="906" y="23"/>
                  </a:lnTo>
                  <a:lnTo>
                    <a:pt x="908" y="9"/>
                  </a:lnTo>
                  <a:lnTo>
                    <a:pt x="910" y="1"/>
                  </a:lnTo>
                  <a:lnTo>
                    <a:pt x="912" y="0"/>
                  </a:lnTo>
                  <a:lnTo>
                    <a:pt x="914" y="5"/>
                  </a:lnTo>
                  <a:lnTo>
                    <a:pt x="916" y="14"/>
                  </a:lnTo>
                  <a:lnTo>
                    <a:pt x="918" y="27"/>
                  </a:lnTo>
                  <a:lnTo>
                    <a:pt x="920" y="43"/>
                  </a:lnTo>
                  <a:lnTo>
                    <a:pt x="922" y="61"/>
                  </a:lnTo>
                  <a:lnTo>
                    <a:pt x="924" y="80"/>
                  </a:lnTo>
                  <a:lnTo>
                    <a:pt x="926" y="100"/>
                  </a:lnTo>
                  <a:lnTo>
                    <a:pt x="928" y="122"/>
                  </a:lnTo>
                  <a:lnTo>
                    <a:pt x="930" y="144"/>
                  </a:lnTo>
                  <a:lnTo>
                    <a:pt x="932" y="165"/>
                  </a:lnTo>
                  <a:lnTo>
                    <a:pt x="934" y="185"/>
                  </a:lnTo>
                  <a:lnTo>
                    <a:pt x="936" y="205"/>
                  </a:lnTo>
                  <a:lnTo>
                    <a:pt x="938" y="223"/>
                  </a:lnTo>
                  <a:lnTo>
                    <a:pt x="940" y="240"/>
                  </a:lnTo>
                  <a:lnTo>
                    <a:pt x="942" y="255"/>
                  </a:lnTo>
                  <a:lnTo>
                    <a:pt x="944" y="267"/>
                  </a:lnTo>
                  <a:lnTo>
                    <a:pt x="946" y="279"/>
                  </a:lnTo>
                  <a:lnTo>
                    <a:pt x="948" y="288"/>
                  </a:lnTo>
                  <a:lnTo>
                    <a:pt x="950" y="297"/>
                  </a:lnTo>
                  <a:lnTo>
                    <a:pt x="952" y="303"/>
                  </a:lnTo>
                  <a:lnTo>
                    <a:pt x="954" y="308"/>
                  </a:lnTo>
                  <a:lnTo>
                    <a:pt x="956" y="313"/>
                  </a:lnTo>
                  <a:lnTo>
                    <a:pt x="958" y="317"/>
                  </a:lnTo>
                  <a:lnTo>
                    <a:pt x="960" y="320"/>
                  </a:lnTo>
                  <a:lnTo>
                    <a:pt x="962" y="323"/>
                  </a:lnTo>
                  <a:lnTo>
                    <a:pt x="964" y="325"/>
                  </a:lnTo>
                  <a:lnTo>
                    <a:pt x="966" y="327"/>
                  </a:lnTo>
                  <a:lnTo>
                    <a:pt x="968" y="328"/>
                  </a:lnTo>
                  <a:lnTo>
                    <a:pt x="970" y="330"/>
                  </a:lnTo>
                  <a:lnTo>
                    <a:pt x="972" y="330"/>
                  </a:lnTo>
                  <a:lnTo>
                    <a:pt x="974" y="331"/>
                  </a:lnTo>
                  <a:lnTo>
                    <a:pt x="976" y="332"/>
                  </a:lnTo>
                  <a:lnTo>
                    <a:pt x="978" y="332"/>
                  </a:lnTo>
                  <a:lnTo>
                    <a:pt x="980" y="333"/>
                  </a:lnTo>
                  <a:lnTo>
                    <a:pt x="982" y="333"/>
                  </a:lnTo>
                  <a:lnTo>
                    <a:pt x="984" y="333"/>
                  </a:lnTo>
                  <a:lnTo>
                    <a:pt x="986" y="333"/>
                  </a:lnTo>
                  <a:lnTo>
                    <a:pt x="988" y="333"/>
                  </a:lnTo>
                  <a:lnTo>
                    <a:pt x="990" y="333"/>
                  </a:lnTo>
                  <a:lnTo>
                    <a:pt x="992" y="333"/>
                  </a:lnTo>
                  <a:lnTo>
                    <a:pt x="994" y="334"/>
                  </a:lnTo>
                  <a:lnTo>
                    <a:pt x="996" y="334"/>
                  </a:lnTo>
                  <a:lnTo>
                    <a:pt x="998" y="334"/>
                  </a:lnTo>
                  <a:lnTo>
                    <a:pt x="1000" y="334"/>
                  </a:lnTo>
                  <a:lnTo>
                    <a:pt x="1002" y="334"/>
                  </a:lnTo>
                  <a:lnTo>
                    <a:pt x="1004" y="334"/>
                  </a:lnTo>
                  <a:lnTo>
                    <a:pt x="1006" y="334"/>
                  </a:lnTo>
                  <a:lnTo>
                    <a:pt x="1008" y="334"/>
                  </a:lnTo>
                  <a:lnTo>
                    <a:pt x="1010" y="334"/>
                  </a:lnTo>
                  <a:lnTo>
                    <a:pt x="1012" y="334"/>
                  </a:lnTo>
                  <a:lnTo>
                    <a:pt x="1014" y="334"/>
                  </a:lnTo>
                  <a:lnTo>
                    <a:pt x="1016" y="333"/>
                  </a:lnTo>
                  <a:lnTo>
                    <a:pt x="1018" y="333"/>
                  </a:lnTo>
                  <a:lnTo>
                    <a:pt x="1020" y="332"/>
                  </a:lnTo>
                  <a:lnTo>
                    <a:pt x="1022" y="330"/>
                  </a:lnTo>
                  <a:lnTo>
                    <a:pt x="1024" y="329"/>
                  </a:lnTo>
                  <a:lnTo>
                    <a:pt x="1026" y="327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482" name="Freeform 479"/>
            <p:cNvSpPr>
              <a:spLocks/>
            </p:cNvSpPr>
            <p:nvPr/>
          </p:nvSpPr>
          <p:spPr bwMode="auto">
            <a:xfrm>
              <a:off x="5370513" y="566738"/>
              <a:ext cx="1247775" cy="1763713"/>
            </a:xfrm>
            <a:custGeom>
              <a:avLst/>
              <a:gdLst>
                <a:gd name="T0" fmla="*/ 12 w 786"/>
                <a:gd name="T1" fmla="*/ 1093 h 1111"/>
                <a:gd name="T2" fmla="*/ 27 w 786"/>
                <a:gd name="T3" fmla="*/ 1101 h 1111"/>
                <a:gd name="T4" fmla="*/ 41 w 786"/>
                <a:gd name="T5" fmla="*/ 1104 h 1111"/>
                <a:gd name="T6" fmla="*/ 55 w 786"/>
                <a:gd name="T7" fmla="*/ 1106 h 1111"/>
                <a:gd name="T8" fmla="*/ 69 w 786"/>
                <a:gd name="T9" fmla="*/ 1107 h 1111"/>
                <a:gd name="T10" fmla="*/ 83 w 786"/>
                <a:gd name="T11" fmla="*/ 1110 h 1111"/>
                <a:gd name="T12" fmla="*/ 97 w 786"/>
                <a:gd name="T13" fmla="*/ 1111 h 1111"/>
                <a:gd name="T14" fmla="*/ 111 w 786"/>
                <a:gd name="T15" fmla="*/ 1108 h 1111"/>
                <a:gd name="T16" fmla="*/ 125 w 786"/>
                <a:gd name="T17" fmla="*/ 1052 h 1111"/>
                <a:gd name="T18" fmla="*/ 139 w 786"/>
                <a:gd name="T19" fmla="*/ 765 h 1111"/>
                <a:gd name="T20" fmla="*/ 153 w 786"/>
                <a:gd name="T21" fmla="*/ 328 h 1111"/>
                <a:gd name="T22" fmla="*/ 167 w 786"/>
                <a:gd name="T23" fmla="*/ 140 h 1111"/>
                <a:gd name="T24" fmla="*/ 182 w 786"/>
                <a:gd name="T25" fmla="*/ 224 h 1111"/>
                <a:gd name="T26" fmla="*/ 196 w 786"/>
                <a:gd name="T27" fmla="*/ 457 h 1111"/>
                <a:gd name="T28" fmla="*/ 210 w 786"/>
                <a:gd name="T29" fmla="*/ 747 h 1111"/>
                <a:gd name="T30" fmla="*/ 224 w 786"/>
                <a:gd name="T31" fmla="*/ 966 h 1111"/>
                <a:gd name="T32" fmla="*/ 238 w 786"/>
                <a:gd name="T33" fmla="*/ 1063 h 1111"/>
                <a:gd name="T34" fmla="*/ 252 w 786"/>
                <a:gd name="T35" fmla="*/ 1091 h 1111"/>
                <a:gd name="T36" fmla="*/ 266 w 786"/>
                <a:gd name="T37" fmla="*/ 1098 h 1111"/>
                <a:gd name="T38" fmla="*/ 280 w 786"/>
                <a:gd name="T39" fmla="*/ 1100 h 1111"/>
                <a:gd name="T40" fmla="*/ 294 w 786"/>
                <a:gd name="T41" fmla="*/ 1101 h 1111"/>
                <a:gd name="T42" fmla="*/ 308 w 786"/>
                <a:gd name="T43" fmla="*/ 1102 h 1111"/>
                <a:gd name="T44" fmla="*/ 323 w 786"/>
                <a:gd name="T45" fmla="*/ 1102 h 1111"/>
                <a:gd name="T46" fmla="*/ 337 w 786"/>
                <a:gd name="T47" fmla="*/ 1099 h 1111"/>
                <a:gd name="T48" fmla="*/ 351 w 786"/>
                <a:gd name="T49" fmla="*/ 1095 h 1111"/>
                <a:gd name="T50" fmla="*/ 365 w 786"/>
                <a:gd name="T51" fmla="*/ 1093 h 1111"/>
                <a:gd name="T52" fmla="*/ 379 w 786"/>
                <a:gd name="T53" fmla="*/ 1093 h 1111"/>
                <a:gd name="T54" fmla="*/ 393 w 786"/>
                <a:gd name="T55" fmla="*/ 1073 h 1111"/>
                <a:gd name="T56" fmla="*/ 407 w 786"/>
                <a:gd name="T57" fmla="*/ 938 h 1111"/>
                <a:gd name="T58" fmla="*/ 421 w 786"/>
                <a:gd name="T59" fmla="*/ 559 h 1111"/>
                <a:gd name="T60" fmla="*/ 435 w 786"/>
                <a:gd name="T61" fmla="*/ 135 h 1111"/>
                <a:gd name="T62" fmla="*/ 449 w 786"/>
                <a:gd name="T63" fmla="*/ 2 h 1111"/>
                <a:gd name="T64" fmla="*/ 463 w 786"/>
                <a:gd name="T65" fmla="*/ 149 h 1111"/>
                <a:gd name="T66" fmla="*/ 478 w 786"/>
                <a:gd name="T67" fmla="*/ 400 h 1111"/>
                <a:gd name="T68" fmla="*/ 492 w 786"/>
                <a:gd name="T69" fmla="*/ 663 h 1111"/>
                <a:gd name="T70" fmla="*/ 506 w 786"/>
                <a:gd name="T71" fmla="*/ 875 h 1111"/>
                <a:gd name="T72" fmla="*/ 520 w 786"/>
                <a:gd name="T73" fmla="*/ 994 h 1111"/>
                <a:gd name="T74" fmla="*/ 534 w 786"/>
                <a:gd name="T75" fmla="*/ 1043 h 1111"/>
                <a:gd name="T76" fmla="*/ 548 w 786"/>
                <a:gd name="T77" fmla="*/ 1060 h 1111"/>
                <a:gd name="T78" fmla="*/ 562 w 786"/>
                <a:gd name="T79" fmla="*/ 1068 h 1111"/>
                <a:gd name="T80" fmla="*/ 576 w 786"/>
                <a:gd name="T81" fmla="*/ 1071 h 1111"/>
                <a:gd name="T82" fmla="*/ 590 w 786"/>
                <a:gd name="T83" fmla="*/ 1074 h 1111"/>
                <a:gd name="T84" fmla="*/ 604 w 786"/>
                <a:gd name="T85" fmla="*/ 1077 h 1111"/>
                <a:gd name="T86" fmla="*/ 618 w 786"/>
                <a:gd name="T87" fmla="*/ 1080 h 1111"/>
                <a:gd name="T88" fmla="*/ 633 w 786"/>
                <a:gd name="T89" fmla="*/ 1085 h 1111"/>
                <a:gd name="T90" fmla="*/ 647 w 786"/>
                <a:gd name="T91" fmla="*/ 1090 h 1111"/>
                <a:gd name="T92" fmla="*/ 661 w 786"/>
                <a:gd name="T93" fmla="*/ 1094 h 1111"/>
                <a:gd name="T94" fmla="*/ 675 w 786"/>
                <a:gd name="T95" fmla="*/ 1098 h 1111"/>
                <a:gd name="T96" fmla="*/ 689 w 786"/>
                <a:gd name="T97" fmla="*/ 1101 h 1111"/>
                <a:gd name="T98" fmla="*/ 703 w 786"/>
                <a:gd name="T99" fmla="*/ 1103 h 1111"/>
                <a:gd name="T100" fmla="*/ 717 w 786"/>
                <a:gd name="T101" fmla="*/ 1104 h 1111"/>
                <a:gd name="T102" fmla="*/ 731 w 786"/>
                <a:gd name="T103" fmla="*/ 1104 h 1111"/>
                <a:gd name="T104" fmla="*/ 745 w 786"/>
                <a:gd name="T105" fmla="*/ 1102 h 1111"/>
                <a:gd name="T106" fmla="*/ 759 w 786"/>
                <a:gd name="T107" fmla="*/ 1101 h 1111"/>
                <a:gd name="T108" fmla="*/ 773 w 786"/>
                <a:gd name="T109" fmla="*/ 1099 h 1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786" h="1111">
                  <a:moveTo>
                    <a:pt x="0" y="1099"/>
                  </a:moveTo>
                  <a:lnTo>
                    <a:pt x="2" y="1097"/>
                  </a:lnTo>
                  <a:lnTo>
                    <a:pt x="4" y="1095"/>
                  </a:lnTo>
                  <a:lnTo>
                    <a:pt x="6" y="1094"/>
                  </a:lnTo>
                  <a:lnTo>
                    <a:pt x="8" y="1093"/>
                  </a:lnTo>
                  <a:lnTo>
                    <a:pt x="10" y="1092"/>
                  </a:lnTo>
                  <a:lnTo>
                    <a:pt x="12" y="1093"/>
                  </a:lnTo>
                  <a:lnTo>
                    <a:pt x="14" y="1094"/>
                  </a:lnTo>
                  <a:lnTo>
                    <a:pt x="16" y="1095"/>
                  </a:lnTo>
                  <a:lnTo>
                    <a:pt x="18" y="1096"/>
                  </a:lnTo>
                  <a:lnTo>
                    <a:pt x="20" y="1097"/>
                  </a:lnTo>
                  <a:lnTo>
                    <a:pt x="22" y="1099"/>
                  </a:lnTo>
                  <a:lnTo>
                    <a:pt x="24" y="1100"/>
                  </a:lnTo>
                  <a:lnTo>
                    <a:pt x="27" y="1101"/>
                  </a:lnTo>
                  <a:lnTo>
                    <a:pt x="29" y="1101"/>
                  </a:lnTo>
                  <a:lnTo>
                    <a:pt x="31" y="1102"/>
                  </a:lnTo>
                  <a:lnTo>
                    <a:pt x="33" y="1102"/>
                  </a:lnTo>
                  <a:lnTo>
                    <a:pt x="35" y="1103"/>
                  </a:lnTo>
                  <a:lnTo>
                    <a:pt x="37" y="1103"/>
                  </a:lnTo>
                  <a:lnTo>
                    <a:pt x="39" y="1103"/>
                  </a:lnTo>
                  <a:lnTo>
                    <a:pt x="41" y="1104"/>
                  </a:lnTo>
                  <a:lnTo>
                    <a:pt x="43" y="1104"/>
                  </a:lnTo>
                  <a:lnTo>
                    <a:pt x="45" y="1105"/>
                  </a:lnTo>
                  <a:lnTo>
                    <a:pt x="47" y="1105"/>
                  </a:lnTo>
                  <a:lnTo>
                    <a:pt x="49" y="1105"/>
                  </a:lnTo>
                  <a:lnTo>
                    <a:pt x="51" y="1106"/>
                  </a:lnTo>
                  <a:lnTo>
                    <a:pt x="53" y="1106"/>
                  </a:lnTo>
                  <a:lnTo>
                    <a:pt x="55" y="1106"/>
                  </a:lnTo>
                  <a:lnTo>
                    <a:pt x="57" y="1106"/>
                  </a:lnTo>
                  <a:lnTo>
                    <a:pt x="59" y="1106"/>
                  </a:lnTo>
                  <a:lnTo>
                    <a:pt x="61" y="1107"/>
                  </a:lnTo>
                  <a:lnTo>
                    <a:pt x="63" y="1107"/>
                  </a:lnTo>
                  <a:lnTo>
                    <a:pt x="65" y="1107"/>
                  </a:lnTo>
                  <a:lnTo>
                    <a:pt x="67" y="1107"/>
                  </a:lnTo>
                  <a:lnTo>
                    <a:pt x="69" y="1107"/>
                  </a:lnTo>
                  <a:lnTo>
                    <a:pt x="71" y="1108"/>
                  </a:lnTo>
                  <a:lnTo>
                    <a:pt x="73" y="1108"/>
                  </a:lnTo>
                  <a:lnTo>
                    <a:pt x="75" y="1108"/>
                  </a:lnTo>
                  <a:lnTo>
                    <a:pt x="77" y="1109"/>
                  </a:lnTo>
                  <a:lnTo>
                    <a:pt x="79" y="1109"/>
                  </a:lnTo>
                  <a:lnTo>
                    <a:pt x="81" y="1110"/>
                  </a:lnTo>
                  <a:lnTo>
                    <a:pt x="83" y="1110"/>
                  </a:lnTo>
                  <a:lnTo>
                    <a:pt x="85" y="1110"/>
                  </a:lnTo>
                  <a:lnTo>
                    <a:pt x="87" y="1110"/>
                  </a:lnTo>
                  <a:lnTo>
                    <a:pt x="89" y="1111"/>
                  </a:lnTo>
                  <a:lnTo>
                    <a:pt x="91" y="1111"/>
                  </a:lnTo>
                  <a:lnTo>
                    <a:pt x="93" y="1111"/>
                  </a:lnTo>
                  <a:lnTo>
                    <a:pt x="95" y="1111"/>
                  </a:lnTo>
                  <a:lnTo>
                    <a:pt x="97" y="1111"/>
                  </a:lnTo>
                  <a:lnTo>
                    <a:pt x="99" y="1111"/>
                  </a:lnTo>
                  <a:lnTo>
                    <a:pt x="101" y="1111"/>
                  </a:lnTo>
                  <a:lnTo>
                    <a:pt x="103" y="1111"/>
                  </a:lnTo>
                  <a:lnTo>
                    <a:pt x="105" y="1110"/>
                  </a:lnTo>
                  <a:lnTo>
                    <a:pt x="107" y="1110"/>
                  </a:lnTo>
                  <a:lnTo>
                    <a:pt x="109" y="1109"/>
                  </a:lnTo>
                  <a:lnTo>
                    <a:pt x="111" y="1108"/>
                  </a:lnTo>
                  <a:lnTo>
                    <a:pt x="113" y="1105"/>
                  </a:lnTo>
                  <a:lnTo>
                    <a:pt x="115" y="1102"/>
                  </a:lnTo>
                  <a:lnTo>
                    <a:pt x="117" y="1098"/>
                  </a:lnTo>
                  <a:lnTo>
                    <a:pt x="119" y="1091"/>
                  </a:lnTo>
                  <a:lnTo>
                    <a:pt x="121" y="1082"/>
                  </a:lnTo>
                  <a:lnTo>
                    <a:pt x="123" y="1069"/>
                  </a:lnTo>
                  <a:lnTo>
                    <a:pt x="125" y="1052"/>
                  </a:lnTo>
                  <a:lnTo>
                    <a:pt x="127" y="1030"/>
                  </a:lnTo>
                  <a:lnTo>
                    <a:pt x="129" y="1003"/>
                  </a:lnTo>
                  <a:lnTo>
                    <a:pt x="131" y="969"/>
                  </a:lnTo>
                  <a:lnTo>
                    <a:pt x="133" y="927"/>
                  </a:lnTo>
                  <a:lnTo>
                    <a:pt x="135" y="879"/>
                  </a:lnTo>
                  <a:lnTo>
                    <a:pt x="137" y="825"/>
                  </a:lnTo>
                  <a:lnTo>
                    <a:pt x="139" y="765"/>
                  </a:lnTo>
                  <a:lnTo>
                    <a:pt x="141" y="702"/>
                  </a:lnTo>
                  <a:lnTo>
                    <a:pt x="143" y="634"/>
                  </a:lnTo>
                  <a:lnTo>
                    <a:pt x="145" y="567"/>
                  </a:lnTo>
                  <a:lnTo>
                    <a:pt x="147" y="503"/>
                  </a:lnTo>
                  <a:lnTo>
                    <a:pt x="149" y="441"/>
                  </a:lnTo>
                  <a:lnTo>
                    <a:pt x="151" y="382"/>
                  </a:lnTo>
                  <a:lnTo>
                    <a:pt x="153" y="328"/>
                  </a:lnTo>
                  <a:lnTo>
                    <a:pt x="155" y="282"/>
                  </a:lnTo>
                  <a:lnTo>
                    <a:pt x="157" y="242"/>
                  </a:lnTo>
                  <a:lnTo>
                    <a:pt x="159" y="209"/>
                  </a:lnTo>
                  <a:lnTo>
                    <a:pt x="161" y="181"/>
                  </a:lnTo>
                  <a:lnTo>
                    <a:pt x="163" y="161"/>
                  </a:lnTo>
                  <a:lnTo>
                    <a:pt x="165" y="147"/>
                  </a:lnTo>
                  <a:lnTo>
                    <a:pt x="167" y="140"/>
                  </a:lnTo>
                  <a:lnTo>
                    <a:pt x="170" y="138"/>
                  </a:lnTo>
                  <a:lnTo>
                    <a:pt x="171" y="141"/>
                  </a:lnTo>
                  <a:lnTo>
                    <a:pt x="173" y="150"/>
                  </a:lnTo>
                  <a:lnTo>
                    <a:pt x="175" y="162"/>
                  </a:lnTo>
                  <a:lnTo>
                    <a:pt x="177" y="179"/>
                  </a:lnTo>
                  <a:lnTo>
                    <a:pt x="180" y="199"/>
                  </a:lnTo>
                  <a:lnTo>
                    <a:pt x="182" y="224"/>
                  </a:lnTo>
                  <a:lnTo>
                    <a:pt x="184" y="251"/>
                  </a:lnTo>
                  <a:lnTo>
                    <a:pt x="186" y="280"/>
                  </a:lnTo>
                  <a:lnTo>
                    <a:pt x="188" y="311"/>
                  </a:lnTo>
                  <a:lnTo>
                    <a:pt x="190" y="345"/>
                  </a:lnTo>
                  <a:lnTo>
                    <a:pt x="192" y="381"/>
                  </a:lnTo>
                  <a:lnTo>
                    <a:pt x="194" y="418"/>
                  </a:lnTo>
                  <a:lnTo>
                    <a:pt x="196" y="457"/>
                  </a:lnTo>
                  <a:lnTo>
                    <a:pt x="198" y="498"/>
                  </a:lnTo>
                  <a:lnTo>
                    <a:pt x="200" y="539"/>
                  </a:lnTo>
                  <a:lnTo>
                    <a:pt x="202" y="581"/>
                  </a:lnTo>
                  <a:lnTo>
                    <a:pt x="204" y="623"/>
                  </a:lnTo>
                  <a:lnTo>
                    <a:pt x="206" y="665"/>
                  </a:lnTo>
                  <a:lnTo>
                    <a:pt x="208" y="706"/>
                  </a:lnTo>
                  <a:lnTo>
                    <a:pt x="210" y="747"/>
                  </a:lnTo>
                  <a:lnTo>
                    <a:pt x="212" y="786"/>
                  </a:lnTo>
                  <a:lnTo>
                    <a:pt x="214" y="822"/>
                  </a:lnTo>
                  <a:lnTo>
                    <a:pt x="216" y="856"/>
                  </a:lnTo>
                  <a:lnTo>
                    <a:pt x="218" y="888"/>
                  </a:lnTo>
                  <a:lnTo>
                    <a:pt x="220" y="917"/>
                  </a:lnTo>
                  <a:lnTo>
                    <a:pt x="222" y="943"/>
                  </a:lnTo>
                  <a:lnTo>
                    <a:pt x="224" y="966"/>
                  </a:lnTo>
                  <a:lnTo>
                    <a:pt x="226" y="987"/>
                  </a:lnTo>
                  <a:lnTo>
                    <a:pt x="228" y="1005"/>
                  </a:lnTo>
                  <a:lnTo>
                    <a:pt x="230" y="1020"/>
                  </a:lnTo>
                  <a:lnTo>
                    <a:pt x="232" y="1033"/>
                  </a:lnTo>
                  <a:lnTo>
                    <a:pt x="234" y="1045"/>
                  </a:lnTo>
                  <a:lnTo>
                    <a:pt x="236" y="1055"/>
                  </a:lnTo>
                  <a:lnTo>
                    <a:pt x="238" y="1063"/>
                  </a:lnTo>
                  <a:lnTo>
                    <a:pt x="240" y="1069"/>
                  </a:lnTo>
                  <a:lnTo>
                    <a:pt x="242" y="1075"/>
                  </a:lnTo>
                  <a:lnTo>
                    <a:pt x="244" y="1079"/>
                  </a:lnTo>
                  <a:lnTo>
                    <a:pt x="246" y="1084"/>
                  </a:lnTo>
                  <a:lnTo>
                    <a:pt x="248" y="1087"/>
                  </a:lnTo>
                  <a:lnTo>
                    <a:pt x="250" y="1089"/>
                  </a:lnTo>
                  <a:lnTo>
                    <a:pt x="252" y="1091"/>
                  </a:lnTo>
                  <a:lnTo>
                    <a:pt x="254" y="1093"/>
                  </a:lnTo>
                  <a:lnTo>
                    <a:pt x="256" y="1094"/>
                  </a:lnTo>
                  <a:lnTo>
                    <a:pt x="258" y="1096"/>
                  </a:lnTo>
                  <a:lnTo>
                    <a:pt x="260" y="1096"/>
                  </a:lnTo>
                  <a:lnTo>
                    <a:pt x="262" y="1097"/>
                  </a:lnTo>
                  <a:lnTo>
                    <a:pt x="264" y="1098"/>
                  </a:lnTo>
                  <a:lnTo>
                    <a:pt x="266" y="1098"/>
                  </a:lnTo>
                  <a:lnTo>
                    <a:pt x="268" y="1099"/>
                  </a:lnTo>
                  <a:lnTo>
                    <a:pt x="270" y="1099"/>
                  </a:lnTo>
                  <a:lnTo>
                    <a:pt x="272" y="1099"/>
                  </a:lnTo>
                  <a:lnTo>
                    <a:pt x="274" y="1100"/>
                  </a:lnTo>
                  <a:lnTo>
                    <a:pt x="276" y="1100"/>
                  </a:lnTo>
                  <a:lnTo>
                    <a:pt x="278" y="1100"/>
                  </a:lnTo>
                  <a:lnTo>
                    <a:pt x="280" y="1100"/>
                  </a:lnTo>
                  <a:lnTo>
                    <a:pt x="282" y="1101"/>
                  </a:lnTo>
                  <a:lnTo>
                    <a:pt x="284" y="1101"/>
                  </a:lnTo>
                  <a:lnTo>
                    <a:pt x="286" y="1101"/>
                  </a:lnTo>
                  <a:lnTo>
                    <a:pt x="288" y="1101"/>
                  </a:lnTo>
                  <a:lnTo>
                    <a:pt x="290" y="1101"/>
                  </a:lnTo>
                  <a:lnTo>
                    <a:pt x="292" y="1101"/>
                  </a:lnTo>
                  <a:lnTo>
                    <a:pt x="294" y="1101"/>
                  </a:lnTo>
                  <a:lnTo>
                    <a:pt x="296" y="1101"/>
                  </a:lnTo>
                  <a:lnTo>
                    <a:pt x="298" y="1102"/>
                  </a:lnTo>
                  <a:lnTo>
                    <a:pt x="300" y="1102"/>
                  </a:lnTo>
                  <a:lnTo>
                    <a:pt x="302" y="1102"/>
                  </a:lnTo>
                  <a:lnTo>
                    <a:pt x="304" y="1102"/>
                  </a:lnTo>
                  <a:lnTo>
                    <a:pt x="306" y="1102"/>
                  </a:lnTo>
                  <a:lnTo>
                    <a:pt x="308" y="1102"/>
                  </a:lnTo>
                  <a:lnTo>
                    <a:pt x="310" y="1102"/>
                  </a:lnTo>
                  <a:lnTo>
                    <a:pt x="312" y="1102"/>
                  </a:lnTo>
                  <a:lnTo>
                    <a:pt x="314" y="1102"/>
                  </a:lnTo>
                  <a:lnTo>
                    <a:pt x="316" y="1102"/>
                  </a:lnTo>
                  <a:lnTo>
                    <a:pt x="318" y="1102"/>
                  </a:lnTo>
                  <a:lnTo>
                    <a:pt x="320" y="1102"/>
                  </a:lnTo>
                  <a:lnTo>
                    <a:pt x="323" y="1102"/>
                  </a:lnTo>
                  <a:lnTo>
                    <a:pt x="325" y="1101"/>
                  </a:lnTo>
                  <a:lnTo>
                    <a:pt x="327" y="1101"/>
                  </a:lnTo>
                  <a:lnTo>
                    <a:pt x="328" y="1101"/>
                  </a:lnTo>
                  <a:lnTo>
                    <a:pt x="330" y="1100"/>
                  </a:lnTo>
                  <a:lnTo>
                    <a:pt x="333" y="1100"/>
                  </a:lnTo>
                  <a:lnTo>
                    <a:pt x="335" y="1099"/>
                  </a:lnTo>
                  <a:lnTo>
                    <a:pt x="337" y="1099"/>
                  </a:lnTo>
                  <a:lnTo>
                    <a:pt x="339" y="1098"/>
                  </a:lnTo>
                  <a:lnTo>
                    <a:pt x="341" y="1098"/>
                  </a:lnTo>
                  <a:lnTo>
                    <a:pt x="343" y="1097"/>
                  </a:lnTo>
                  <a:lnTo>
                    <a:pt x="345" y="1097"/>
                  </a:lnTo>
                  <a:lnTo>
                    <a:pt x="347" y="1096"/>
                  </a:lnTo>
                  <a:lnTo>
                    <a:pt x="349" y="1096"/>
                  </a:lnTo>
                  <a:lnTo>
                    <a:pt x="351" y="1095"/>
                  </a:lnTo>
                  <a:lnTo>
                    <a:pt x="353" y="1095"/>
                  </a:lnTo>
                  <a:lnTo>
                    <a:pt x="355" y="1094"/>
                  </a:lnTo>
                  <a:lnTo>
                    <a:pt x="357" y="1094"/>
                  </a:lnTo>
                  <a:lnTo>
                    <a:pt x="359" y="1094"/>
                  </a:lnTo>
                  <a:lnTo>
                    <a:pt x="361" y="1094"/>
                  </a:lnTo>
                  <a:lnTo>
                    <a:pt x="363" y="1093"/>
                  </a:lnTo>
                  <a:lnTo>
                    <a:pt x="365" y="1093"/>
                  </a:lnTo>
                  <a:lnTo>
                    <a:pt x="367" y="1094"/>
                  </a:lnTo>
                  <a:lnTo>
                    <a:pt x="369" y="1094"/>
                  </a:lnTo>
                  <a:lnTo>
                    <a:pt x="371" y="1093"/>
                  </a:lnTo>
                  <a:lnTo>
                    <a:pt x="373" y="1093"/>
                  </a:lnTo>
                  <a:lnTo>
                    <a:pt x="375" y="1093"/>
                  </a:lnTo>
                  <a:lnTo>
                    <a:pt x="377" y="1093"/>
                  </a:lnTo>
                  <a:lnTo>
                    <a:pt x="379" y="1093"/>
                  </a:lnTo>
                  <a:lnTo>
                    <a:pt x="381" y="1092"/>
                  </a:lnTo>
                  <a:lnTo>
                    <a:pt x="383" y="1091"/>
                  </a:lnTo>
                  <a:lnTo>
                    <a:pt x="385" y="1090"/>
                  </a:lnTo>
                  <a:lnTo>
                    <a:pt x="387" y="1088"/>
                  </a:lnTo>
                  <a:lnTo>
                    <a:pt x="389" y="1084"/>
                  </a:lnTo>
                  <a:lnTo>
                    <a:pt x="391" y="1080"/>
                  </a:lnTo>
                  <a:lnTo>
                    <a:pt x="393" y="1073"/>
                  </a:lnTo>
                  <a:lnTo>
                    <a:pt x="395" y="1065"/>
                  </a:lnTo>
                  <a:lnTo>
                    <a:pt x="397" y="1054"/>
                  </a:lnTo>
                  <a:lnTo>
                    <a:pt x="399" y="1039"/>
                  </a:lnTo>
                  <a:lnTo>
                    <a:pt x="401" y="1021"/>
                  </a:lnTo>
                  <a:lnTo>
                    <a:pt x="403" y="999"/>
                  </a:lnTo>
                  <a:lnTo>
                    <a:pt x="405" y="971"/>
                  </a:lnTo>
                  <a:lnTo>
                    <a:pt x="407" y="938"/>
                  </a:lnTo>
                  <a:lnTo>
                    <a:pt x="409" y="900"/>
                  </a:lnTo>
                  <a:lnTo>
                    <a:pt x="411" y="855"/>
                  </a:lnTo>
                  <a:lnTo>
                    <a:pt x="413" y="805"/>
                  </a:lnTo>
                  <a:lnTo>
                    <a:pt x="415" y="750"/>
                  </a:lnTo>
                  <a:lnTo>
                    <a:pt x="417" y="690"/>
                  </a:lnTo>
                  <a:lnTo>
                    <a:pt x="419" y="626"/>
                  </a:lnTo>
                  <a:lnTo>
                    <a:pt x="421" y="559"/>
                  </a:lnTo>
                  <a:lnTo>
                    <a:pt x="423" y="491"/>
                  </a:lnTo>
                  <a:lnTo>
                    <a:pt x="425" y="425"/>
                  </a:lnTo>
                  <a:lnTo>
                    <a:pt x="427" y="359"/>
                  </a:lnTo>
                  <a:lnTo>
                    <a:pt x="429" y="295"/>
                  </a:lnTo>
                  <a:lnTo>
                    <a:pt x="431" y="235"/>
                  </a:lnTo>
                  <a:lnTo>
                    <a:pt x="433" y="182"/>
                  </a:lnTo>
                  <a:lnTo>
                    <a:pt x="435" y="135"/>
                  </a:lnTo>
                  <a:lnTo>
                    <a:pt x="437" y="94"/>
                  </a:lnTo>
                  <a:lnTo>
                    <a:pt x="439" y="59"/>
                  </a:lnTo>
                  <a:lnTo>
                    <a:pt x="441" y="34"/>
                  </a:lnTo>
                  <a:lnTo>
                    <a:pt x="443" y="16"/>
                  </a:lnTo>
                  <a:lnTo>
                    <a:pt x="445" y="5"/>
                  </a:lnTo>
                  <a:lnTo>
                    <a:pt x="447" y="0"/>
                  </a:lnTo>
                  <a:lnTo>
                    <a:pt x="449" y="2"/>
                  </a:lnTo>
                  <a:lnTo>
                    <a:pt x="451" y="11"/>
                  </a:lnTo>
                  <a:lnTo>
                    <a:pt x="453" y="25"/>
                  </a:lnTo>
                  <a:lnTo>
                    <a:pt x="455" y="43"/>
                  </a:lnTo>
                  <a:lnTo>
                    <a:pt x="457" y="64"/>
                  </a:lnTo>
                  <a:lnTo>
                    <a:pt x="459" y="90"/>
                  </a:lnTo>
                  <a:lnTo>
                    <a:pt x="461" y="119"/>
                  </a:lnTo>
                  <a:lnTo>
                    <a:pt x="463" y="149"/>
                  </a:lnTo>
                  <a:lnTo>
                    <a:pt x="465" y="182"/>
                  </a:lnTo>
                  <a:lnTo>
                    <a:pt x="467" y="216"/>
                  </a:lnTo>
                  <a:lnTo>
                    <a:pt x="469" y="252"/>
                  </a:lnTo>
                  <a:lnTo>
                    <a:pt x="471" y="287"/>
                  </a:lnTo>
                  <a:lnTo>
                    <a:pt x="473" y="324"/>
                  </a:lnTo>
                  <a:lnTo>
                    <a:pt x="476" y="362"/>
                  </a:lnTo>
                  <a:lnTo>
                    <a:pt x="478" y="400"/>
                  </a:lnTo>
                  <a:lnTo>
                    <a:pt x="480" y="438"/>
                  </a:lnTo>
                  <a:lnTo>
                    <a:pt x="482" y="476"/>
                  </a:lnTo>
                  <a:lnTo>
                    <a:pt x="483" y="514"/>
                  </a:lnTo>
                  <a:lnTo>
                    <a:pt x="486" y="552"/>
                  </a:lnTo>
                  <a:lnTo>
                    <a:pt x="488" y="590"/>
                  </a:lnTo>
                  <a:lnTo>
                    <a:pt x="490" y="627"/>
                  </a:lnTo>
                  <a:lnTo>
                    <a:pt x="492" y="663"/>
                  </a:lnTo>
                  <a:lnTo>
                    <a:pt x="494" y="698"/>
                  </a:lnTo>
                  <a:lnTo>
                    <a:pt x="496" y="732"/>
                  </a:lnTo>
                  <a:lnTo>
                    <a:pt x="498" y="764"/>
                  </a:lnTo>
                  <a:lnTo>
                    <a:pt x="500" y="794"/>
                  </a:lnTo>
                  <a:lnTo>
                    <a:pt x="502" y="823"/>
                  </a:lnTo>
                  <a:lnTo>
                    <a:pt x="504" y="850"/>
                  </a:lnTo>
                  <a:lnTo>
                    <a:pt x="506" y="875"/>
                  </a:lnTo>
                  <a:lnTo>
                    <a:pt x="508" y="897"/>
                  </a:lnTo>
                  <a:lnTo>
                    <a:pt x="510" y="918"/>
                  </a:lnTo>
                  <a:lnTo>
                    <a:pt x="512" y="937"/>
                  </a:lnTo>
                  <a:lnTo>
                    <a:pt x="514" y="954"/>
                  </a:lnTo>
                  <a:lnTo>
                    <a:pt x="516" y="969"/>
                  </a:lnTo>
                  <a:lnTo>
                    <a:pt x="518" y="982"/>
                  </a:lnTo>
                  <a:lnTo>
                    <a:pt x="520" y="994"/>
                  </a:lnTo>
                  <a:lnTo>
                    <a:pt x="522" y="1004"/>
                  </a:lnTo>
                  <a:lnTo>
                    <a:pt x="524" y="1013"/>
                  </a:lnTo>
                  <a:lnTo>
                    <a:pt x="526" y="1021"/>
                  </a:lnTo>
                  <a:lnTo>
                    <a:pt x="528" y="1028"/>
                  </a:lnTo>
                  <a:lnTo>
                    <a:pt x="530" y="1033"/>
                  </a:lnTo>
                  <a:lnTo>
                    <a:pt x="532" y="1039"/>
                  </a:lnTo>
                  <a:lnTo>
                    <a:pt x="534" y="1043"/>
                  </a:lnTo>
                  <a:lnTo>
                    <a:pt x="536" y="1047"/>
                  </a:lnTo>
                  <a:lnTo>
                    <a:pt x="538" y="1050"/>
                  </a:lnTo>
                  <a:lnTo>
                    <a:pt x="540" y="1053"/>
                  </a:lnTo>
                  <a:lnTo>
                    <a:pt x="542" y="1055"/>
                  </a:lnTo>
                  <a:lnTo>
                    <a:pt x="544" y="1057"/>
                  </a:lnTo>
                  <a:lnTo>
                    <a:pt x="546" y="1059"/>
                  </a:lnTo>
                  <a:lnTo>
                    <a:pt x="548" y="1060"/>
                  </a:lnTo>
                  <a:lnTo>
                    <a:pt x="550" y="1062"/>
                  </a:lnTo>
                  <a:lnTo>
                    <a:pt x="552" y="1063"/>
                  </a:lnTo>
                  <a:lnTo>
                    <a:pt x="554" y="1064"/>
                  </a:lnTo>
                  <a:lnTo>
                    <a:pt x="556" y="1065"/>
                  </a:lnTo>
                  <a:lnTo>
                    <a:pt x="558" y="1066"/>
                  </a:lnTo>
                  <a:lnTo>
                    <a:pt x="560" y="1067"/>
                  </a:lnTo>
                  <a:lnTo>
                    <a:pt x="562" y="1068"/>
                  </a:lnTo>
                  <a:lnTo>
                    <a:pt x="564" y="1068"/>
                  </a:lnTo>
                  <a:lnTo>
                    <a:pt x="566" y="1069"/>
                  </a:lnTo>
                  <a:lnTo>
                    <a:pt x="568" y="1069"/>
                  </a:lnTo>
                  <a:lnTo>
                    <a:pt x="570" y="1070"/>
                  </a:lnTo>
                  <a:lnTo>
                    <a:pt x="572" y="1071"/>
                  </a:lnTo>
                  <a:lnTo>
                    <a:pt x="574" y="1071"/>
                  </a:lnTo>
                  <a:lnTo>
                    <a:pt x="576" y="1071"/>
                  </a:lnTo>
                  <a:lnTo>
                    <a:pt x="578" y="1072"/>
                  </a:lnTo>
                  <a:lnTo>
                    <a:pt x="580" y="1073"/>
                  </a:lnTo>
                  <a:lnTo>
                    <a:pt x="582" y="1073"/>
                  </a:lnTo>
                  <a:lnTo>
                    <a:pt x="584" y="1073"/>
                  </a:lnTo>
                  <a:lnTo>
                    <a:pt x="586" y="1074"/>
                  </a:lnTo>
                  <a:lnTo>
                    <a:pt x="588" y="1074"/>
                  </a:lnTo>
                  <a:lnTo>
                    <a:pt x="590" y="1074"/>
                  </a:lnTo>
                  <a:lnTo>
                    <a:pt x="592" y="1075"/>
                  </a:lnTo>
                  <a:lnTo>
                    <a:pt x="594" y="1075"/>
                  </a:lnTo>
                  <a:lnTo>
                    <a:pt x="596" y="1075"/>
                  </a:lnTo>
                  <a:lnTo>
                    <a:pt x="598" y="1076"/>
                  </a:lnTo>
                  <a:lnTo>
                    <a:pt x="600" y="1076"/>
                  </a:lnTo>
                  <a:lnTo>
                    <a:pt x="602" y="1076"/>
                  </a:lnTo>
                  <a:lnTo>
                    <a:pt x="604" y="1077"/>
                  </a:lnTo>
                  <a:lnTo>
                    <a:pt x="606" y="1077"/>
                  </a:lnTo>
                  <a:lnTo>
                    <a:pt x="608" y="1078"/>
                  </a:lnTo>
                  <a:lnTo>
                    <a:pt x="610" y="1078"/>
                  </a:lnTo>
                  <a:lnTo>
                    <a:pt x="612" y="1078"/>
                  </a:lnTo>
                  <a:lnTo>
                    <a:pt x="614" y="1079"/>
                  </a:lnTo>
                  <a:lnTo>
                    <a:pt x="616" y="1080"/>
                  </a:lnTo>
                  <a:lnTo>
                    <a:pt x="618" y="1080"/>
                  </a:lnTo>
                  <a:lnTo>
                    <a:pt x="620" y="1081"/>
                  </a:lnTo>
                  <a:lnTo>
                    <a:pt x="622" y="1082"/>
                  </a:lnTo>
                  <a:lnTo>
                    <a:pt x="624" y="1082"/>
                  </a:lnTo>
                  <a:lnTo>
                    <a:pt x="626" y="1083"/>
                  </a:lnTo>
                  <a:lnTo>
                    <a:pt x="629" y="1084"/>
                  </a:lnTo>
                  <a:lnTo>
                    <a:pt x="631" y="1084"/>
                  </a:lnTo>
                  <a:lnTo>
                    <a:pt x="633" y="1085"/>
                  </a:lnTo>
                  <a:lnTo>
                    <a:pt x="635" y="1086"/>
                  </a:lnTo>
                  <a:lnTo>
                    <a:pt x="637" y="1086"/>
                  </a:lnTo>
                  <a:lnTo>
                    <a:pt x="639" y="1087"/>
                  </a:lnTo>
                  <a:lnTo>
                    <a:pt x="641" y="1087"/>
                  </a:lnTo>
                  <a:lnTo>
                    <a:pt x="643" y="1088"/>
                  </a:lnTo>
                  <a:lnTo>
                    <a:pt x="645" y="1089"/>
                  </a:lnTo>
                  <a:lnTo>
                    <a:pt x="647" y="1090"/>
                  </a:lnTo>
                  <a:lnTo>
                    <a:pt x="649" y="1090"/>
                  </a:lnTo>
                  <a:lnTo>
                    <a:pt x="651" y="1091"/>
                  </a:lnTo>
                  <a:lnTo>
                    <a:pt x="653" y="1092"/>
                  </a:lnTo>
                  <a:lnTo>
                    <a:pt x="655" y="1093"/>
                  </a:lnTo>
                  <a:lnTo>
                    <a:pt x="657" y="1093"/>
                  </a:lnTo>
                  <a:lnTo>
                    <a:pt x="659" y="1093"/>
                  </a:lnTo>
                  <a:lnTo>
                    <a:pt x="661" y="1094"/>
                  </a:lnTo>
                  <a:lnTo>
                    <a:pt x="663" y="1095"/>
                  </a:lnTo>
                  <a:lnTo>
                    <a:pt x="665" y="1096"/>
                  </a:lnTo>
                  <a:lnTo>
                    <a:pt x="667" y="1096"/>
                  </a:lnTo>
                  <a:lnTo>
                    <a:pt x="669" y="1097"/>
                  </a:lnTo>
                  <a:lnTo>
                    <a:pt x="671" y="1097"/>
                  </a:lnTo>
                  <a:lnTo>
                    <a:pt x="673" y="1098"/>
                  </a:lnTo>
                  <a:lnTo>
                    <a:pt x="675" y="1098"/>
                  </a:lnTo>
                  <a:lnTo>
                    <a:pt x="677" y="1099"/>
                  </a:lnTo>
                  <a:lnTo>
                    <a:pt x="679" y="1099"/>
                  </a:lnTo>
                  <a:lnTo>
                    <a:pt x="681" y="1100"/>
                  </a:lnTo>
                  <a:lnTo>
                    <a:pt x="683" y="1101"/>
                  </a:lnTo>
                  <a:lnTo>
                    <a:pt x="685" y="1101"/>
                  </a:lnTo>
                  <a:lnTo>
                    <a:pt x="687" y="1101"/>
                  </a:lnTo>
                  <a:lnTo>
                    <a:pt x="689" y="1101"/>
                  </a:lnTo>
                  <a:lnTo>
                    <a:pt x="691" y="1102"/>
                  </a:lnTo>
                  <a:lnTo>
                    <a:pt x="693" y="1102"/>
                  </a:lnTo>
                  <a:lnTo>
                    <a:pt x="695" y="1102"/>
                  </a:lnTo>
                  <a:lnTo>
                    <a:pt x="697" y="1103"/>
                  </a:lnTo>
                  <a:lnTo>
                    <a:pt x="699" y="1103"/>
                  </a:lnTo>
                  <a:lnTo>
                    <a:pt x="701" y="1103"/>
                  </a:lnTo>
                  <a:lnTo>
                    <a:pt x="703" y="1103"/>
                  </a:lnTo>
                  <a:lnTo>
                    <a:pt x="705" y="1104"/>
                  </a:lnTo>
                  <a:lnTo>
                    <a:pt x="707" y="1104"/>
                  </a:lnTo>
                  <a:lnTo>
                    <a:pt x="709" y="1104"/>
                  </a:lnTo>
                  <a:lnTo>
                    <a:pt x="711" y="1104"/>
                  </a:lnTo>
                  <a:lnTo>
                    <a:pt x="713" y="1104"/>
                  </a:lnTo>
                  <a:lnTo>
                    <a:pt x="715" y="1104"/>
                  </a:lnTo>
                  <a:lnTo>
                    <a:pt x="717" y="1104"/>
                  </a:lnTo>
                  <a:lnTo>
                    <a:pt x="719" y="1104"/>
                  </a:lnTo>
                  <a:lnTo>
                    <a:pt x="721" y="1104"/>
                  </a:lnTo>
                  <a:lnTo>
                    <a:pt x="723" y="1104"/>
                  </a:lnTo>
                  <a:lnTo>
                    <a:pt x="725" y="1104"/>
                  </a:lnTo>
                  <a:lnTo>
                    <a:pt x="727" y="1104"/>
                  </a:lnTo>
                  <a:lnTo>
                    <a:pt x="729" y="1104"/>
                  </a:lnTo>
                  <a:lnTo>
                    <a:pt x="731" y="1104"/>
                  </a:lnTo>
                  <a:lnTo>
                    <a:pt x="733" y="1103"/>
                  </a:lnTo>
                  <a:lnTo>
                    <a:pt x="735" y="1103"/>
                  </a:lnTo>
                  <a:lnTo>
                    <a:pt x="737" y="1103"/>
                  </a:lnTo>
                  <a:lnTo>
                    <a:pt x="739" y="1103"/>
                  </a:lnTo>
                  <a:lnTo>
                    <a:pt x="741" y="1103"/>
                  </a:lnTo>
                  <a:lnTo>
                    <a:pt x="743" y="1102"/>
                  </a:lnTo>
                  <a:lnTo>
                    <a:pt x="745" y="1102"/>
                  </a:lnTo>
                  <a:lnTo>
                    <a:pt x="747" y="1102"/>
                  </a:lnTo>
                  <a:lnTo>
                    <a:pt x="749" y="1102"/>
                  </a:lnTo>
                  <a:lnTo>
                    <a:pt x="751" y="1101"/>
                  </a:lnTo>
                  <a:lnTo>
                    <a:pt x="753" y="1101"/>
                  </a:lnTo>
                  <a:lnTo>
                    <a:pt x="755" y="1101"/>
                  </a:lnTo>
                  <a:lnTo>
                    <a:pt x="757" y="1101"/>
                  </a:lnTo>
                  <a:lnTo>
                    <a:pt x="759" y="1101"/>
                  </a:lnTo>
                  <a:lnTo>
                    <a:pt x="761" y="1100"/>
                  </a:lnTo>
                  <a:lnTo>
                    <a:pt x="763" y="1100"/>
                  </a:lnTo>
                  <a:lnTo>
                    <a:pt x="765" y="1100"/>
                  </a:lnTo>
                  <a:lnTo>
                    <a:pt x="767" y="1100"/>
                  </a:lnTo>
                  <a:lnTo>
                    <a:pt x="769" y="1099"/>
                  </a:lnTo>
                  <a:lnTo>
                    <a:pt x="771" y="1099"/>
                  </a:lnTo>
                  <a:lnTo>
                    <a:pt x="773" y="1099"/>
                  </a:lnTo>
                  <a:lnTo>
                    <a:pt x="775" y="1099"/>
                  </a:lnTo>
                  <a:lnTo>
                    <a:pt x="777" y="1098"/>
                  </a:lnTo>
                  <a:lnTo>
                    <a:pt x="779" y="1098"/>
                  </a:lnTo>
                  <a:lnTo>
                    <a:pt x="781" y="1098"/>
                  </a:lnTo>
                  <a:lnTo>
                    <a:pt x="784" y="1098"/>
                  </a:lnTo>
                  <a:lnTo>
                    <a:pt x="786" y="1097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1484" name="ZoneTexte 1483"/>
          <p:cNvSpPr txBox="1"/>
          <p:nvPr/>
        </p:nvSpPr>
        <p:spPr>
          <a:xfrm>
            <a:off x="3717032" y="950580"/>
            <a:ext cx="206223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OPDV_11707::Tn2.8</a:t>
            </a:r>
            <a:endParaRPr lang="fr-FR" i="1" dirty="0"/>
          </a:p>
        </p:txBody>
      </p:sp>
      <p:grpSp>
        <p:nvGrpSpPr>
          <p:cNvPr id="1599" name="Groupe 1598"/>
          <p:cNvGrpSpPr/>
          <p:nvPr/>
        </p:nvGrpSpPr>
        <p:grpSpPr>
          <a:xfrm>
            <a:off x="3664740" y="3338873"/>
            <a:ext cx="2876550" cy="1792288"/>
            <a:chOff x="3741738" y="3708400"/>
            <a:chExt cx="2876550" cy="1792288"/>
          </a:xfrm>
        </p:grpSpPr>
        <p:sp>
          <p:nvSpPr>
            <p:cNvPr id="1597" name="Freeform 593"/>
            <p:cNvSpPr>
              <a:spLocks/>
            </p:cNvSpPr>
            <p:nvPr/>
          </p:nvSpPr>
          <p:spPr bwMode="auto">
            <a:xfrm>
              <a:off x="3741738" y="4989513"/>
              <a:ext cx="1628775" cy="511175"/>
            </a:xfrm>
            <a:custGeom>
              <a:avLst/>
              <a:gdLst>
                <a:gd name="T0" fmla="*/ 14 w 1026"/>
                <a:gd name="T1" fmla="*/ 314 h 322"/>
                <a:gd name="T2" fmla="*/ 30 w 1026"/>
                <a:gd name="T3" fmla="*/ 313 h 322"/>
                <a:gd name="T4" fmla="*/ 46 w 1026"/>
                <a:gd name="T5" fmla="*/ 312 h 322"/>
                <a:gd name="T6" fmla="*/ 62 w 1026"/>
                <a:gd name="T7" fmla="*/ 312 h 322"/>
                <a:gd name="T8" fmla="*/ 78 w 1026"/>
                <a:gd name="T9" fmla="*/ 311 h 322"/>
                <a:gd name="T10" fmla="*/ 94 w 1026"/>
                <a:gd name="T11" fmla="*/ 311 h 322"/>
                <a:gd name="T12" fmla="*/ 110 w 1026"/>
                <a:gd name="T13" fmla="*/ 310 h 322"/>
                <a:gd name="T14" fmla="*/ 126 w 1026"/>
                <a:gd name="T15" fmla="*/ 310 h 322"/>
                <a:gd name="T16" fmla="*/ 143 w 1026"/>
                <a:gd name="T17" fmla="*/ 309 h 322"/>
                <a:gd name="T18" fmla="*/ 159 w 1026"/>
                <a:gd name="T19" fmla="*/ 309 h 322"/>
                <a:gd name="T20" fmla="*/ 175 w 1026"/>
                <a:gd name="T21" fmla="*/ 317 h 322"/>
                <a:gd name="T22" fmla="*/ 191 w 1026"/>
                <a:gd name="T23" fmla="*/ 307 h 322"/>
                <a:gd name="T24" fmla="*/ 207 w 1026"/>
                <a:gd name="T25" fmla="*/ 251 h 322"/>
                <a:gd name="T26" fmla="*/ 223 w 1026"/>
                <a:gd name="T27" fmla="*/ 305 h 322"/>
                <a:gd name="T28" fmla="*/ 239 w 1026"/>
                <a:gd name="T29" fmla="*/ 301 h 322"/>
                <a:gd name="T30" fmla="*/ 255 w 1026"/>
                <a:gd name="T31" fmla="*/ 305 h 322"/>
                <a:gd name="T32" fmla="*/ 271 w 1026"/>
                <a:gd name="T33" fmla="*/ 299 h 322"/>
                <a:gd name="T34" fmla="*/ 288 w 1026"/>
                <a:gd name="T35" fmla="*/ 303 h 322"/>
                <a:gd name="T36" fmla="*/ 304 w 1026"/>
                <a:gd name="T37" fmla="*/ 304 h 322"/>
                <a:gd name="T38" fmla="*/ 320 w 1026"/>
                <a:gd name="T39" fmla="*/ 303 h 322"/>
                <a:gd name="T40" fmla="*/ 336 w 1026"/>
                <a:gd name="T41" fmla="*/ 286 h 322"/>
                <a:gd name="T42" fmla="*/ 352 w 1026"/>
                <a:gd name="T43" fmla="*/ 298 h 322"/>
                <a:gd name="T44" fmla="*/ 368 w 1026"/>
                <a:gd name="T45" fmla="*/ 299 h 322"/>
                <a:gd name="T46" fmla="*/ 384 w 1026"/>
                <a:gd name="T47" fmla="*/ 299 h 322"/>
                <a:gd name="T48" fmla="*/ 400 w 1026"/>
                <a:gd name="T49" fmla="*/ 300 h 322"/>
                <a:gd name="T50" fmla="*/ 416 w 1026"/>
                <a:gd name="T51" fmla="*/ 299 h 322"/>
                <a:gd name="T52" fmla="*/ 432 w 1026"/>
                <a:gd name="T53" fmla="*/ 299 h 322"/>
                <a:gd name="T54" fmla="*/ 449 w 1026"/>
                <a:gd name="T55" fmla="*/ 298 h 322"/>
                <a:gd name="T56" fmla="*/ 465 w 1026"/>
                <a:gd name="T57" fmla="*/ 298 h 322"/>
                <a:gd name="T58" fmla="*/ 481 w 1026"/>
                <a:gd name="T59" fmla="*/ 298 h 322"/>
                <a:gd name="T60" fmla="*/ 497 w 1026"/>
                <a:gd name="T61" fmla="*/ 299 h 322"/>
                <a:gd name="T62" fmla="*/ 513 w 1026"/>
                <a:gd name="T63" fmla="*/ 296 h 322"/>
                <a:gd name="T64" fmla="*/ 529 w 1026"/>
                <a:gd name="T65" fmla="*/ 291 h 322"/>
                <a:gd name="T66" fmla="*/ 545 w 1026"/>
                <a:gd name="T67" fmla="*/ 295 h 322"/>
                <a:gd name="T68" fmla="*/ 561 w 1026"/>
                <a:gd name="T69" fmla="*/ 296 h 322"/>
                <a:gd name="T70" fmla="*/ 577 w 1026"/>
                <a:gd name="T71" fmla="*/ 296 h 322"/>
                <a:gd name="T72" fmla="*/ 594 w 1026"/>
                <a:gd name="T73" fmla="*/ 299 h 322"/>
                <a:gd name="T74" fmla="*/ 610 w 1026"/>
                <a:gd name="T75" fmla="*/ 302 h 322"/>
                <a:gd name="T76" fmla="*/ 626 w 1026"/>
                <a:gd name="T77" fmla="*/ 303 h 322"/>
                <a:gd name="T78" fmla="*/ 642 w 1026"/>
                <a:gd name="T79" fmla="*/ 301 h 322"/>
                <a:gd name="T80" fmla="*/ 658 w 1026"/>
                <a:gd name="T81" fmla="*/ 300 h 322"/>
                <a:gd name="T82" fmla="*/ 674 w 1026"/>
                <a:gd name="T83" fmla="*/ 299 h 322"/>
                <a:gd name="T84" fmla="*/ 690 w 1026"/>
                <a:gd name="T85" fmla="*/ 299 h 322"/>
                <a:gd name="T86" fmla="*/ 706 w 1026"/>
                <a:gd name="T87" fmla="*/ 299 h 322"/>
                <a:gd name="T88" fmla="*/ 722 w 1026"/>
                <a:gd name="T89" fmla="*/ 297 h 322"/>
                <a:gd name="T90" fmla="*/ 738 w 1026"/>
                <a:gd name="T91" fmla="*/ 295 h 322"/>
                <a:gd name="T92" fmla="*/ 755 w 1026"/>
                <a:gd name="T93" fmla="*/ 294 h 322"/>
                <a:gd name="T94" fmla="*/ 771 w 1026"/>
                <a:gd name="T95" fmla="*/ 294 h 322"/>
                <a:gd name="T96" fmla="*/ 787 w 1026"/>
                <a:gd name="T97" fmla="*/ 290 h 322"/>
                <a:gd name="T98" fmla="*/ 803 w 1026"/>
                <a:gd name="T99" fmla="*/ 287 h 322"/>
                <a:gd name="T100" fmla="*/ 819 w 1026"/>
                <a:gd name="T101" fmla="*/ 289 h 322"/>
                <a:gd name="T102" fmla="*/ 835 w 1026"/>
                <a:gd name="T103" fmla="*/ 290 h 322"/>
                <a:gd name="T104" fmla="*/ 851 w 1026"/>
                <a:gd name="T105" fmla="*/ 290 h 322"/>
                <a:gd name="T106" fmla="*/ 867 w 1026"/>
                <a:gd name="T107" fmla="*/ 288 h 322"/>
                <a:gd name="T108" fmla="*/ 883 w 1026"/>
                <a:gd name="T109" fmla="*/ 220 h 322"/>
                <a:gd name="T110" fmla="*/ 900 w 1026"/>
                <a:gd name="T111" fmla="*/ 15 h 322"/>
                <a:gd name="T112" fmla="*/ 916 w 1026"/>
                <a:gd name="T113" fmla="*/ 46 h 322"/>
                <a:gd name="T114" fmla="*/ 932 w 1026"/>
                <a:gd name="T115" fmla="*/ 176 h 322"/>
                <a:gd name="T116" fmla="*/ 948 w 1026"/>
                <a:gd name="T117" fmla="*/ 256 h 322"/>
                <a:gd name="T118" fmla="*/ 964 w 1026"/>
                <a:gd name="T119" fmla="*/ 270 h 322"/>
                <a:gd name="T120" fmla="*/ 980 w 1026"/>
                <a:gd name="T121" fmla="*/ 239 h 322"/>
                <a:gd name="T122" fmla="*/ 996 w 1026"/>
                <a:gd name="T123" fmla="*/ 206 h 322"/>
                <a:gd name="T124" fmla="*/ 1012 w 1026"/>
                <a:gd name="T125" fmla="*/ 195 h 3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26" h="322">
                  <a:moveTo>
                    <a:pt x="0" y="314"/>
                  </a:moveTo>
                  <a:lnTo>
                    <a:pt x="2" y="314"/>
                  </a:lnTo>
                  <a:lnTo>
                    <a:pt x="4" y="314"/>
                  </a:lnTo>
                  <a:lnTo>
                    <a:pt x="6" y="314"/>
                  </a:lnTo>
                  <a:lnTo>
                    <a:pt x="8" y="314"/>
                  </a:lnTo>
                  <a:lnTo>
                    <a:pt x="10" y="314"/>
                  </a:lnTo>
                  <a:lnTo>
                    <a:pt x="12" y="314"/>
                  </a:lnTo>
                  <a:lnTo>
                    <a:pt x="14" y="314"/>
                  </a:lnTo>
                  <a:lnTo>
                    <a:pt x="16" y="314"/>
                  </a:lnTo>
                  <a:lnTo>
                    <a:pt x="18" y="313"/>
                  </a:lnTo>
                  <a:lnTo>
                    <a:pt x="20" y="313"/>
                  </a:lnTo>
                  <a:lnTo>
                    <a:pt x="22" y="313"/>
                  </a:lnTo>
                  <a:lnTo>
                    <a:pt x="24" y="313"/>
                  </a:lnTo>
                  <a:lnTo>
                    <a:pt x="26" y="313"/>
                  </a:lnTo>
                  <a:lnTo>
                    <a:pt x="28" y="313"/>
                  </a:lnTo>
                  <a:lnTo>
                    <a:pt x="30" y="313"/>
                  </a:lnTo>
                  <a:lnTo>
                    <a:pt x="32" y="313"/>
                  </a:lnTo>
                  <a:lnTo>
                    <a:pt x="34" y="313"/>
                  </a:lnTo>
                  <a:lnTo>
                    <a:pt x="36" y="313"/>
                  </a:lnTo>
                  <a:lnTo>
                    <a:pt x="38" y="313"/>
                  </a:lnTo>
                  <a:lnTo>
                    <a:pt x="40" y="313"/>
                  </a:lnTo>
                  <a:lnTo>
                    <a:pt x="42" y="313"/>
                  </a:lnTo>
                  <a:lnTo>
                    <a:pt x="44" y="313"/>
                  </a:lnTo>
                  <a:lnTo>
                    <a:pt x="46" y="312"/>
                  </a:lnTo>
                  <a:lnTo>
                    <a:pt x="48" y="312"/>
                  </a:lnTo>
                  <a:lnTo>
                    <a:pt x="50" y="312"/>
                  </a:lnTo>
                  <a:lnTo>
                    <a:pt x="52" y="312"/>
                  </a:lnTo>
                  <a:lnTo>
                    <a:pt x="54" y="312"/>
                  </a:lnTo>
                  <a:lnTo>
                    <a:pt x="56" y="312"/>
                  </a:lnTo>
                  <a:lnTo>
                    <a:pt x="58" y="312"/>
                  </a:lnTo>
                  <a:lnTo>
                    <a:pt x="60" y="312"/>
                  </a:lnTo>
                  <a:lnTo>
                    <a:pt x="62" y="312"/>
                  </a:lnTo>
                  <a:lnTo>
                    <a:pt x="64" y="312"/>
                  </a:lnTo>
                  <a:lnTo>
                    <a:pt x="66" y="312"/>
                  </a:lnTo>
                  <a:lnTo>
                    <a:pt x="68" y="312"/>
                  </a:lnTo>
                  <a:lnTo>
                    <a:pt x="70" y="312"/>
                  </a:lnTo>
                  <a:lnTo>
                    <a:pt x="72" y="312"/>
                  </a:lnTo>
                  <a:lnTo>
                    <a:pt x="74" y="311"/>
                  </a:lnTo>
                  <a:lnTo>
                    <a:pt x="76" y="311"/>
                  </a:lnTo>
                  <a:lnTo>
                    <a:pt x="78" y="311"/>
                  </a:lnTo>
                  <a:lnTo>
                    <a:pt x="80" y="311"/>
                  </a:lnTo>
                  <a:lnTo>
                    <a:pt x="82" y="311"/>
                  </a:lnTo>
                  <a:lnTo>
                    <a:pt x="84" y="311"/>
                  </a:lnTo>
                  <a:lnTo>
                    <a:pt x="86" y="311"/>
                  </a:lnTo>
                  <a:lnTo>
                    <a:pt x="88" y="311"/>
                  </a:lnTo>
                  <a:lnTo>
                    <a:pt x="90" y="311"/>
                  </a:lnTo>
                  <a:lnTo>
                    <a:pt x="92" y="311"/>
                  </a:lnTo>
                  <a:lnTo>
                    <a:pt x="94" y="311"/>
                  </a:lnTo>
                  <a:lnTo>
                    <a:pt x="96" y="311"/>
                  </a:lnTo>
                  <a:lnTo>
                    <a:pt x="98" y="311"/>
                  </a:lnTo>
                  <a:lnTo>
                    <a:pt x="100" y="310"/>
                  </a:lnTo>
                  <a:lnTo>
                    <a:pt x="102" y="310"/>
                  </a:lnTo>
                  <a:lnTo>
                    <a:pt x="104" y="310"/>
                  </a:lnTo>
                  <a:lnTo>
                    <a:pt x="106" y="310"/>
                  </a:lnTo>
                  <a:lnTo>
                    <a:pt x="108" y="310"/>
                  </a:lnTo>
                  <a:lnTo>
                    <a:pt x="110" y="310"/>
                  </a:lnTo>
                  <a:lnTo>
                    <a:pt x="112" y="310"/>
                  </a:lnTo>
                  <a:lnTo>
                    <a:pt x="114" y="310"/>
                  </a:lnTo>
                  <a:lnTo>
                    <a:pt x="116" y="310"/>
                  </a:lnTo>
                  <a:lnTo>
                    <a:pt x="118" y="310"/>
                  </a:lnTo>
                  <a:lnTo>
                    <a:pt x="120" y="310"/>
                  </a:lnTo>
                  <a:lnTo>
                    <a:pt x="122" y="310"/>
                  </a:lnTo>
                  <a:lnTo>
                    <a:pt x="124" y="310"/>
                  </a:lnTo>
                  <a:lnTo>
                    <a:pt x="126" y="310"/>
                  </a:lnTo>
                  <a:lnTo>
                    <a:pt x="128" y="310"/>
                  </a:lnTo>
                  <a:lnTo>
                    <a:pt x="131" y="309"/>
                  </a:lnTo>
                  <a:lnTo>
                    <a:pt x="133" y="310"/>
                  </a:lnTo>
                  <a:lnTo>
                    <a:pt x="135" y="310"/>
                  </a:lnTo>
                  <a:lnTo>
                    <a:pt x="136" y="309"/>
                  </a:lnTo>
                  <a:lnTo>
                    <a:pt x="138" y="309"/>
                  </a:lnTo>
                  <a:lnTo>
                    <a:pt x="141" y="309"/>
                  </a:lnTo>
                  <a:lnTo>
                    <a:pt x="143" y="309"/>
                  </a:lnTo>
                  <a:lnTo>
                    <a:pt x="145" y="309"/>
                  </a:lnTo>
                  <a:lnTo>
                    <a:pt x="147" y="309"/>
                  </a:lnTo>
                  <a:lnTo>
                    <a:pt x="149" y="309"/>
                  </a:lnTo>
                  <a:lnTo>
                    <a:pt x="151" y="309"/>
                  </a:lnTo>
                  <a:lnTo>
                    <a:pt x="153" y="309"/>
                  </a:lnTo>
                  <a:lnTo>
                    <a:pt x="155" y="309"/>
                  </a:lnTo>
                  <a:lnTo>
                    <a:pt x="157" y="309"/>
                  </a:lnTo>
                  <a:lnTo>
                    <a:pt x="159" y="309"/>
                  </a:lnTo>
                  <a:lnTo>
                    <a:pt x="161" y="309"/>
                  </a:lnTo>
                  <a:lnTo>
                    <a:pt x="163" y="310"/>
                  </a:lnTo>
                  <a:lnTo>
                    <a:pt x="165" y="314"/>
                  </a:lnTo>
                  <a:lnTo>
                    <a:pt x="167" y="320"/>
                  </a:lnTo>
                  <a:lnTo>
                    <a:pt x="169" y="322"/>
                  </a:lnTo>
                  <a:lnTo>
                    <a:pt x="171" y="321"/>
                  </a:lnTo>
                  <a:lnTo>
                    <a:pt x="173" y="320"/>
                  </a:lnTo>
                  <a:lnTo>
                    <a:pt x="175" y="317"/>
                  </a:lnTo>
                  <a:lnTo>
                    <a:pt x="177" y="314"/>
                  </a:lnTo>
                  <a:lnTo>
                    <a:pt x="179" y="312"/>
                  </a:lnTo>
                  <a:lnTo>
                    <a:pt x="181" y="311"/>
                  </a:lnTo>
                  <a:lnTo>
                    <a:pt x="183" y="310"/>
                  </a:lnTo>
                  <a:lnTo>
                    <a:pt x="185" y="308"/>
                  </a:lnTo>
                  <a:lnTo>
                    <a:pt x="187" y="307"/>
                  </a:lnTo>
                  <a:lnTo>
                    <a:pt x="189" y="306"/>
                  </a:lnTo>
                  <a:lnTo>
                    <a:pt x="191" y="307"/>
                  </a:lnTo>
                  <a:lnTo>
                    <a:pt x="193" y="306"/>
                  </a:lnTo>
                  <a:lnTo>
                    <a:pt x="195" y="301"/>
                  </a:lnTo>
                  <a:lnTo>
                    <a:pt x="197" y="287"/>
                  </a:lnTo>
                  <a:lnTo>
                    <a:pt x="199" y="267"/>
                  </a:lnTo>
                  <a:lnTo>
                    <a:pt x="201" y="246"/>
                  </a:lnTo>
                  <a:lnTo>
                    <a:pt x="203" y="236"/>
                  </a:lnTo>
                  <a:lnTo>
                    <a:pt x="205" y="240"/>
                  </a:lnTo>
                  <a:lnTo>
                    <a:pt x="207" y="251"/>
                  </a:lnTo>
                  <a:lnTo>
                    <a:pt x="209" y="264"/>
                  </a:lnTo>
                  <a:lnTo>
                    <a:pt x="211" y="276"/>
                  </a:lnTo>
                  <a:lnTo>
                    <a:pt x="213" y="288"/>
                  </a:lnTo>
                  <a:lnTo>
                    <a:pt x="215" y="296"/>
                  </a:lnTo>
                  <a:lnTo>
                    <a:pt x="217" y="301"/>
                  </a:lnTo>
                  <a:lnTo>
                    <a:pt x="219" y="303"/>
                  </a:lnTo>
                  <a:lnTo>
                    <a:pt x="221" y="304"/>
                  </a:lnTo>
                  <a:lnTo>
                    <a:pt x="223" y="305"/>
                  </a:lnTo>
                  <a:lnTo>
                    <a:pt x="225" y="305"/>
                  </a:lnTo>
                  <a:lnTo>
                    <a:pt x="227" y="305"/>
                  </a:lnTo>
                  <a:lnTo>
                    <a:pt x="229" y="305"/>
                  </a:lnTo>
                  <a:lnTo>
                    <a:pt x="231" y="304"/>
                  </a:lnTo>
                  <a:lnTo>
                    <a:pt x="233" y="303"/>
                  </a:lnTo>
                  <a:lnTo>
                    <a:pt x="235" y="302"/>
                  </a:lnTo>
                  <a:lnTo>
                    <a:pt x="237" y="301"/>
                  </a:lnTo>
                  <a:lnTo>
                    <a:pt x="239" y="301"/>
                  </a:lnTo>
                  <a:lnTo>
                    <a:pt x="241" y="301"/>
                  </a:lnTo>
                  <a:lnTo>
                    <a:pt x="243" y="301"/>
                  </a:lnTo>
                  <a:lnTo>
                    <a:pt x="245" y="302"/>
                  </a:lnTo>
                  <a:lnTo>
                    <a:pt x="247" y="303"/>
                  </a:lnTo>
                  <a:lnTo>
                    <a:pt x="249" y="304"/>
                  </a:lnTo>
                  <a:lnTo>
                    <a:pt x="251" y="304"/>
                  </a:lnTo>
                  <a:lnTo>
                    <a:pt x="253" y="305"/>
                  </a:lnTo>
                  <a:lnTo>
                    <a:pt x="255" y="305"/>
                  </a:lnTo>
                  <a:lnTo>
                    <a:pt x="257" y="305"/>
                  </a:lnTo>
                  <a:lnTo>
                    <a:pt x="259" y="305"/>
                  </a:lnTo>
                  <a:lnTo>
                    <a:pt x="261" y="305"/>
                  </a:lnTo>
                  <a:lnTo>
                    <a:pt x="263" y="305"/>
                  </a:lnTo>
                  <a:lnTo>
                    <a:pt x="265" y="304"/>
                  </a:lnTo>
                  <a:lnTo>
                    <a:pt x="267" y="303"/>
                  </a:lnTo>
                  <a:lnTo>
                    <a:pt x="269" y="301"/>
                  </a:lnTo>
                  <a:lnTo>
                    <a:pt x="271" y="299"/>
                  </a:lnTo>
                  <a:lnTo>
                    <a:pt x="273" y="298"/>
                  </a:lnTo>
                  <a:lnTo>
                    <a:pt x="275" y="298"/>
                  </a:lnTo>
                  <a:lnTo>
                    <a:pt x="277" y="299"/>
                  </a:lnTo>
                  <a:lnTo>
                    <a:pt x="279" y="300"/>
                  </a:lnTo>
                  <a:lnTo>
                    <a:pt x="281" y="301"/>
                  </a:lnTo>
                  <a:lnTo>
                    <a:pt x="284" y="302"/>
                  </a:lnTo>
                  <a:lnTo>
                    <a:pt x="286" y="303"/>
                  </a:lnTo>
                  <a:lnTo>
                    <a:pt x="288" y="303"/>
                  </a:lnTo>
                  <a:lnTo>
                    <a:pt x="290" y="304"/>
                  </a:lnTo>
                  <a:lnTo>
                    <a:pt x="291" y="304"/>
                  </a:lnTo>
                  <a:lnTo>
                    <a:pt x="294" y="304"/>
                  </a:lnTo>
                  <a:lnTo>
                    <a:pt x="296" y="304"/>
                  </a:lnTo>
                  <a:lnTo>
                    <a:pt x="298" y="304"/>
                  </a:lnTo>
                  <a:lnTo>
                    <a:pt x="300" y="304"/>
                  </a:lnTo>
                  <a:lnTo>
                    <a:pt x="302" y="304"/>
                  </a:lnTo>
                  <a:lnTo>
                    <a:pt x="304" y="304"/>
                  </a:lnTo>
                  <a:lnTo>
                    <a:pt x="306" y="304"/>
                  </a:lnTo>
                  <a:lnTo>
                    <a:pt x="308" y="304"/>
                  </a:lnTo>
                  <a:lnTo>
                    <a:pt x="310" y="304"/>
                  </a:lnTo>
                  <a:lnTo>
                    <a:pt x="312" y="304"/>
                  </a:lnTo>
                  <a:lnTo>
                    <a:pt x="314" y="304"/>
                  </a:lnTo>
                  <a:lnTo>
                    <a:pt x="316" y="303"/>
                  </a:lnTo>
                  <a:lnTo>
                    <a:pt x="318" y="303"/>
                  </a:lnTo>
                  <a:lnTo>
                    <a:pt x="320" y="303"/>
                  </a:lnTo>
                  <a:lnTo>
                    <a:pt x="322" y="303"/>
                  </a:lnTo>
                  <a:lnTo>
                    <a:pt x="324" y="302"/>
                  </a:lnTo>
                  <a:lnTo>
                    <a:pt x="326" y="299"/>
                  </a:lnTo>
                  <a:lnTo>
                    <a:pt x="328" y="295"/>
                  </a:lnTo>
                  <a:lnTo>
                    <a:pt x="330" y="291"/>
                  </a:lnTo>
                  <a:lnTo>
                    <a:pt x="332" y="288"/>
                  </a:lnTo>
                  <a:lnTo>
                    <a:pt x="334" y="286"/>
                  </a:lnTo>
                  <a:lnTo>
                    <a:pt x="336" y="286"/>
                  </a:lnTo>
                  <a:lnTo>
                    <a:pt x="338" y="287"/>
                  </a:lnTo>
                  <a:lnTo>
                    <a:pt x="340" y="288"/>
                  </a:lnTo>
                  <a:lnTo>
                    <a:pt x="342" y="290"/>
                  </a:lnTo>
                  <a:lnTo>
                    <a:pt x="344" y="292"/>
                  </a:lnTo>
                  <a:lnTo>
                    <a:pt x="346" y="294"/>
                  </a:lnTo>
                  <a:lnTo>
                    <a:pt x="348" y="296"/>
                  </a:lnTo>
                  <a:lnTo>
                    <a:pt x="350" y="297"/>
                  </a:lnTo>
                  <a:lnTo>
                    <a:pt x="352" y="298"/>
                  </a:lnTo>
                  <a:lnTo>
                    <a:pt x="354" y="299"/>
                  </a:lnTo>
                  <a:lnTo>
                    <a:pt x="356" y="300"/>
                  </a:lnTo>
                  <a:lnTo>
                    <a:pt x="358" y="300"/>
                  </a:lnTo>
                  <a:lnTo>
                    <a:pt x="360" y="300"/>
                  </a:lnTo>
                  <a:lnTo>
                    <a:pt x="362" y="300"/>
                  </a:lnTo>
                  <a:lnTo>
                    <a:pt x="364" y="300"/>
                  </a:lnTo>
                  <a:lnTo>
                    <a:pt x="366" y="300"/>
                  </a:lnTo>
                  <a:lnTo>
                    <a:pt x="368" y="299"/>
                  </a:lnTo>
                  <a:lnTo>
                    <a:pt x="370" y="299"/>
                  </a:lnTo>
                  <a:lnTo>
                    <a:pt x="372" y="298"/>
                  </a:lnTo>
                  <a:lnTo>
                    <a:pt x="374" y="299"/>
                  </a:lnTo>
                  <a:lnTo>
                    <a:pt x="376" y="299"/>
                  </a:lnTo>
                  <a:lnTo>
                    <a:pt x="378" y="299"/>
                  </a:lnTo>
                  <a:lnTo>
                    <a:pt x="380" y="299"/>
                  </a:lnTo>
                  <a:lnTo>
                    <a:pt x="382" y="299"/>
                  </a:lnTo>
                  <a:lnTo>
                    <a:pt x="384" y="299"/>
                  </a:lnTo>
                  <a:lnTo>
                    <a:pt x="386" y="299"/>
                  </a:lnTo>
                  <a:lnTo>
                    <a:pt x="388" y="299"/>
                  </a:lnTo>
                  <a:lnTo>
                    <a:pt x="390" y="299"/>
                  </a:lnTo>
                  <a:lnTo>
                    <a:pt x="392" y="300"/>
                  </a:lnTo>
                  <a:lnTo>
                    <a:pt x="394" y="300"/>
                  </a:lnTo>
                  <a:lnTo>
                    <a:pt x="396" y="300"/>
                  </a:lnTo>
                  <a:lnTo>
                    <a:pt x="398" y="300"/>
                  </a:lnTo>
                  <a:lnTo>
                    <a:pt x="400" y="300"/>
                  </a:lnTo>
                  <a:lnTo>
                    <a:pt x="402" y="300"/>
                  </a:lnTo>
                  <a:lnTo>
                    <a:pt x="404" y="300"/>
                  </a:lnTo>
                  <a:lnTo>
                    <a:pt x="406" y="300"/>
                  </a:lnTo>
                  <a:lnTo>
                    <a:pt x="408" y="299"/>
                  </a:lnTo>
                  <a:lnTo>
                    <a:pt x="410" y="299"/>
                  </a:lnTo>
                  <a:lnTo>
                    <a:pt x="412" y="300"/>
                  </a:lnTo>
                  <a:lnTo>
                    <a:pt x="414" y="299"/>
                  </a:lnTo>
                  <a:lnTo>
                    <a:pt x="416" y="299"/>
                  </a:lnTo>
                  <a:lnTo>
                    <a:pt x="418" y="299"/>
                  </a:lnTo>
                  <a:lnTo>
                    <a:pt x="420" y="299"/>
                  </a:lnTo>
                  <a:lnTo>
                    <a:pt x="422" y="299"/>
                  </a:lnTo>
                  <a:lnTo>
                    <a:pt x="424" y="299"/>
                  </a:lnTo>
                  <a:lnTo>
                    <a:pt x="426" y="299"/>
                  </a:lnTo>
                  <a:lnTo>
                    <a:pt x="428" y="299"/>
                  </a:lnTo>
                  <a:lnTo>
                    <a:pt x="430" y="299"/>
                  </a:lnTo>
                  <a:lnTo>
                    <a:pt x="432" y="299"/>
                  </a:lnTo>
                  <a:lnTo>
                    <a:pt x="434" y="299"/>
                  </a:lnTo>
                  <a:lnTo>
                    <a:pt x="437" y="299"/>
                  </a:lnTo>
                  <a:lnTo>
                    <a:pt x="439" y="299"/>
                  </a:lnTo>
                  <a:lnTo>
                    <a:pt x="441" y="299"/>
                  </a:lnTo>
                  <a:lnTo>
                    <a:pt x="443" y="299"/>
                  </a:lnTo>
                  <a:lnTo>
                    <a:pt x="445" y="299"/>
                  </a:lnTo>
                  <a:lnTo>
                    <a:pt x="447" y="298"/>
                  </a:lnTo>
                  <a:lnTo>
                    <a:pt x="449" y="298"/>
                  </a:lnTo>
                  <a:lnTo>
                    <a:pt x="451" y="298"/>
                  </a:lnTo>
                  <a:lnTo>
                    <a:pt x="453" y="298"/>
                  </a:lnTo>
                  <a:lnTo>
                    <a:pt x="455" y="298"/>
                  </a:lnTo>
                  <a:lnTo>
                    <a:pt x="457" y="298"/>
                  </a:lnTo>
                  <a:lnTo>
                    <a:pt x="459" y="298"/>
                  </a:lnTo>
                  <a:lnTo>
                    <a:pt x="461" y="298"/>
                  </a:lnTo>
                  <a:lnTo>
                    <a:pt x="463" y="298"/>
                  </a:lnTo>
                  <a:lnTo>
                    <a:pt x="465" y="298"/>
                  </a:lnTo>
                  <a:lnTo>
                    <a:pt x="467" y="298"/>
                  </a:lnTo>
                  <a:lnTo>
                    <a:pt x="469" y="298"/>
                  </a:lnTo>
                  <a:lnTo>
                    <a:pt x="471" y="298"/>
                  </a:lnTo>
                  <a:lnTo>
                    <a:pt x="473" y="298"/>
                  </a:lnTo>
                  <a:lnTo>
                    <a:pt x="475" y="298"/>
                  </a:lnTo>
                  <a:lnTo>
                    <a:pt x="477" y="298"/>
                  </a:lnTo>
                  <a:lnTo>
                    <a:pt x="479" y="298"/>
                  </a:lnTo>
                  <a:lnTo>
                    <a:pt x="481" y="298"/>
                  </a:lnTo>
                  <a:lnTo>
                    <a:pt x="483" y="298"/>
                  </a:lnTo>
                  <a:lnTo>
                    <a:pt x="485" y="298"/>
                  </a:lnTo>
                  <a:lnTo>
                    <a:pt x="487" y="298"/>
                  </a:lnTo>
                  <a:lnTo>
                    <a:pt x="489" y="298"/>
                  </a:lnTo>
                  <a:lnTo>
                    <a:pt x="491" y="298"/>
                  </a:lnTo>
                  <a:lnTo>
                    <a:pt x="493" y="298"/>
                  </a:lnTo>
                  <a:lnTo>
                    <a:pt x="495" y="299"/>
                  </a:lnTo>
                  <a:lnTo>
                    <a:pt x="497" y="299"/>
                  </a:lnTo>
                  <a:lnTo>
                    <a:pt x="499" y="299"/>
                  </a:lnTo>
                  <a:lnTo>
                    <a:pt x="501" y="299"/>
                  </a:lnTo>
                  <a:lnTo>
                    <a:pt x="503" y="299"/>
                  </a:lnTo>
                  <a:lnTo>
                    <a:pt x="505" y="299"/>
                  </a:lnTo>
                  <a:lnTo>
                    <a:pt x="507" y="298"/>
                  </a:lnTo>
                  <a:lnTo>
                    <a:pt x="509" y="298"/>
                  </a:lnTo>
                  <a:lnTo>
                    <a:pt x="511" y="297"/>
                  </a:lnTo>
                  <a:lnTo>
                    <a:pt x="513" y="296"/>
                  </a:lnTo>
                  <a:lnTo>
                    <a:pt x="515" y="294"/>
                  </a:lnTo>
                  <a:lnTo>
                    <a:pt x="517" y="293"/>
                  </a:lnTo>
                  <a:lnTo>
                    <a:pt x="519" y="291"/>
                  </a:lnTo>
                  <a:lnTo>
                    <a:pt x="521" y="291"/>
                  </a:lnTo>
                  <a:lnTo>
                    <a:pt x="523" y="291"/>
                  </a:lnTo>
                  <a:lnTo>
                    <a:pt x="525" y="291"/>
                  </a:lnTo>
                  <a:lnTo>
                    <a:pt x="527" y="291"/>
                  </a:lnTo>
                  <a:lnTo>
                    <a:pt x="529" y="291"/>
                  </a:lnTo>
                  <a:lnTo>
                    <a:pt x="531" y="292"/>
                  </a:lnTo>
                  <a:lnTo>
                    <a:pt x="533" y="292"/>
                  </a:lnTo>
                  <a:lnTo>
                    <a:pt x="535" y="293"/>
                  </a:lnTo>
                  <a:lnTo>
                    <a:pt x="537" y="293"/>
                  </a:lnTo>
                  <a:lnTo>
                    <a:pt x="539" y="294"/>
                  </a:lnTo>
                  <a:lnTo>
                    <a:pt x="541" y="295"/>
                  </a:lnTo>
                  <a:lnTo>
                    <a:pt x="543" y="295"/>
                  </a:lnTo>
                  <a:lnTo>
                    <a:pt x="545" y="295"/>
                  </a:lnTo>
                  <a:lnTo>
                    <a:pt x="547" y="295"/>
                  </a:lnTo>
                  <a:lnTo>
                    <a:pt x="549" y="295"/>
                  </a:lnTo>
                  <a:lnTo>
                    <a:pt x="551" y="296"/>
                  </a:lnTo>
                  <a:lnTo>
                    <a:pt x="553" y="295"/>
                  </a:lnTo>
                  <a:lnTo>
                    <a:pt x="555" y="295"/>
                  </a:lnTo>
                  <a:lnTo>
                    <a:pt x="557" y="295"/>
                  </a:lnTo>
                  <a:lnTo>
                    <a:pt x="559" y="296"/>
                  </a:lnTo>
                  <a:lnTo>
                    <a:pt x="561" y="296"/>
                  </a:lnTo>
                  <a:lnTo>
                    <a:pt x="563" y="296"/>
                  </a:lnTo>
                  <a:lnTo>
                    <a:pt x="565" y="295"/>
                  </a:lnTo>
                  <a:lnTo>
                    <a:pt x="567" y="296"/>
                  </a:lnTo>
                  <a:lnTo>
                    <a:pt x="569" y="296"/>
                  </a:lnTo>
                  <a:lnTo>
                    <a:pt x="571" y="296"/>
                  </a:lnTo>
                  <a:lnTo>
                    <a:pt x="573" y="295"/>
                  </a:lnTo>
                  <a:lnTo>
                    <a:pt x="575" y="296"/>
                  </a:lnTo>
                  <a:lnTo>
                    <a:pt x="577" y="296"/>
                  </a:lnTo>
                  <a:lnTo>
                    <a:pt x="579" y="296"/>
                  </a:lnTo>
                  <a:lnTo>
                    <a:pt x="581" y="296"/>
                  </a:lnTo>
                  <a:lnTo>
                    <a:pt x="583" y="296"/>
                  </a:lnTo>
                  <a:lnTo>
                    <a:pt x="585" y="297"/>
                  </a:lnTo>
                  <a:lnTo>
                    <a:pt x="587" y="297"/>
                  </a:lnTo>
                  <a:lnTo>
                    <a:pt x="590" y="298"/>
                  </a:lnTo>
                  <a:lnTo>
                    <a:pt x="592" y="298"/>
                  </a:lnTo>
                  <a:lnTo>
                    <a:pt x="594" y="299"/>
                  </a:lnTo>
                  <a:lnTo>
                    <a:pt x="596" y="299"/>
                  </a:lnTo>
                  <a:lnTo>
                    <a:pt x="598" y="300"/>
                  </a:lnTo>
                  <a:lnTo>
                    <a:pt x="600" y="300"/>
                  </a:lnTo>
                  <a:lnTo>
                    <a:pt x="602" y="301"/>
                  </a:lnTo>
                  <a:lnTo>
                    <a:pt x="604" y="301"/>
                  </a:lnTo>
                  <a:lnTo>
                    <a:pt x="606" y="301"/>
                  </a:lnTo>
                  <a:lnTo>
                    <a:pt x="608" y="302"/>
                  </a:lnTo>
                  <a:lnTo>
                    <a:pt x="610" y="302"/>
                  </a:lnTo>
                  <a:lnTo>
                    <a:pt x="612" y="302"/>
                  </a:lnTo>
                  <a:lnTo>
                    <a:pt x="614" y="303"/>
                  </a:lnTo>
                  <a:lnTo>
                    <a:pt x="616" y="303"/>
                  </a:lnTo>
                  <a:lnTo>
                    <a:pt x="618" y="303"/>
                  </a:lnTo>
                  <a:lnTo>
                    <a:pt x="620" y="303"/>
                  </a:lnTo>
                  <a:lnTo>
                    <a:pt x="622" y="303"/>
                  </a:lnTo>
                  <a:lnTo>
                    <a:pt x="624" y="303"/>
                  </a:lnTo>
                  <a:lnTo>
                    <a:pt x="626" y="303"/>
                  </a:lnTo>
                  <a:lnTo>
                    <a:pt x="628" y="303"/>
                  </a:lnTo>
                  <a:lnTo>
                    <a:pt x="630" y="302"/>
                  </a:lnTo>
                  <a:lnTo>
                    <a:pt x="632" y="302"/>
                  </a:lnTo>
                  <a:lnTo>
                    <a:pt x="634" y="302"/>
                  </a:lnTo>
                  <a:lnTo>
                    <a:pt x="636" y="302"/>
                  </a:lnTo>
                  <a:lnTo>
                    <a:pt x="638" y="302"/>
                  </a:lnTo>
                  <a:lnTo>
                    <a:pt x="640" y="302"/>
                  </a:lnTo>
                  <a:lnTo>
                    <a:pt x="642" y="301"/>
                  </a:lnTo>
                  <a:lnTo>
                    <a:pt x="644" y="301"/>
                  </a:lnTo>
                  <a:lnTo>
                    <a:pt x="646" y="301"/>
                  </a:lnTo>
                  <a:lnTo>
                    <a:pt x="648" y="301"/>
                  </a:lnTo>
                  <a:lnTo>
                    <a:pt x="650" y="301"/>
                  </a:lnTo>
                  <a:lnTo>
                    <a:pt x="652" y="301"/>
                  </a:lnTo>
                  <a:lnTo>
                    <a:pt x="654" y="301"/>
                  </a:lnTo>
                  <a:lnTo>
                    <a:pt x="656" y="300"/>
                  </a:lnTo>
                  <a:lnTo>
                    <a:pt x="658" y="300"/>
                  </a:lnTo>
                  <a:lnTo>
                    <a:pt x="660" y="300"/>
                  </a:lnTo>
                  <a:lnTo>
                    <a:pt x="662" y="300"/>
                  </a:lnTo>
                  <a:lnTo>
                    <a:pt x="664" y="300"/>
                  </a:lnTo>
                  <a:lnTo>
                    <a:pt x="666" y="299"/>
                  </a:lnTo>
                  <a:lnTo>
                    <a:pt x="668" y="299"/>
                  </a:lnTo>
                  <a:lnTo>
                    <a:pt x="670" y="299"/>
                  </a:lnTo>
                  <a:lnTo>
                    <a:pt x="672" y="299"/>
                  </a:lnTo>
                  <a:lnTo>
                    <a:pt x="674" y="299"/>
                  </a:lnTo>
                  <a:lnTo>
                    <a:pt x="676" y="299"/>
                  </a:lnTo>
                  <a:lnTo>
                    <a:pt x="678" y="299"/>
                  </a:lnTo>
                  <a:lnTo>
                    <a:pt x="680" y="299"/>
                  </a:lnTo>
                  <a:lnTo>
                    <a:pt x="682" y="299"/>
                  </a:lnTo>
                  <a:lnTo>
                    <a:pt x="684" y="299"/>
                  </a:lnTo>
                  <a:lnTo>
                    <a:pt x="686" y="299"/>
                  </a:lnTo>
                  <a:lnTo>
                    <a:pt x="688" y="299"/>
                  </a:lnTo>
                  <a:lnTo>
                    <a:pt x="690" y="299"/>
                  </a:lnTo>
                  <a:lnTo>
                    <a:pt x="692" y="300"/>
                  </a:lnTo>
                  <a:lnTo>
                    <a:pt x="694" y="300"/>
                  </a:lnTo>
                  <a:lnTo>
                    <a:pt x="696" y="300"/>
                  </a:lnTo>
                  <a:lnTo>
                    <a:pt x="698" y="300"/>
                  </a:lnTo>
                  <a:lnTo>
                    <a:pt x="700" y="300"/>
                  </a:lnTo>
                  <a:lnTo>
                    <a:pt x="702" y="299"/>
                  </a:lnTo>
                  <a:lnTo>
                    <a:pt x="704" y="299"/>
                  </a:lnTo>
                  <a:lnTo>
                    <a:pt x="706" y="299"/>
                  </a:lnTo>
                  <a:lnTo>
                    <a:pt x="708" y="299"/>
                  </a:lnTo>
                  <a:lnTo>
                    <a:pt x="710" y="298"/>
                  </a:lnTo>
                  <a:lnTo>
                    <a:pt x="712" y="298"/>
                  </a:lnTo>
                  <a:lnTo>
                    <a:pt x="714" y="298"/>
                  </a:lnTo>
                  <a:lnTo>
                    <a:pt x="716" y="298"/>
                  </a:lnTo>
                  <a:lnTo>
                    <a:pt x="718" y="297"/>
                  </a:lnTo>
                  <a:lnTo>
                    <a:pt x="720" y="297"/>
                  </a:lnTo>
                  <a:lnTo>
                    <a:pt x="722" y="297"/>
                  </a:lnTo>
                  <a:lnTo>
                    <a:pt x="724" y="296"/>
                  </a:lnTo>
                  <a:lnTo>
                    <a:pt x="726" y="296"/>
                  </a:lnTo>
                  <a:lnTo>
                    <a:pt x="728" y="296"/>
                  </a:lnTo>
                  <a:lnTo>
                    <a:pt x="730" y="296"/>
                  </a:lnTo>
                  <a:lnTo>
                    <a:pt x="732" y="296"/>
                  </a:lnTo>
                  <a:lnTo>
                    <a:pt x="734" y="295"/>
                  </a:lnTo>
                  <a:lnTo>
                    <a:pt x="736" y="295"/>
                  </a:lnTo>
                  <a:lnTo>
                    <a:pt x="738" y="295"/>
                  </a:lnTo>
                  <a:lnTo>
                    <a:pt x="740" y="295"/>
                  </a:lnTo>
                  <a:lnTo>
                    <a:pt x="742" y="295"/>
                  </a:lnTo>
                  <a:lnTo>
                    <a:pt x="745" y="295"/>
                  </a:lnTo>
                  <a:lnTo>
                    <a:pt x="747" y="295"/>
                  </a:lnTo>
                  <a:lnTo>
                    <a:pt x="749" y="294"/>
                  </a:lnTo>
                  <a:lnTo>
                    <a:pt x="751" y="294"/>
                  </a:lnTo>
                  <a:lnTo>
                    <a:pt x="753" y="294"/>
                  </a:lnTo>
                  <a:lnTo>
                    <a:pt x="755" y="294"/>
                  </a:lnTo>
                  <a:lnTo>
                    <a:pt x="757" y="294"/>
                  </a:lnTo>
                  <a:lnTo>
                    <a:pt x="759" y="294"/>
                  </a:lnTo>
                  <a:lnTo>
                    <a:pt x="761" y="294"/>
                  </a:lnTo>
                  <a:lnTo>
                    <a:pt x="763" y="294"/>
                  </a:lnTo>
                  <a:lnTo>
                    <a:pt x="765" y="294"/>
                  </a:lnTo>
                  <a:lnTo>
                    <a:pt x="767" y="294"/>
                  </a:lnTo>
                  <a:lnTo>
                    <a:pt x="769" y="294"/>
                  </a:lnTo>
                  <a:lnTo>
                    <a:pt x="771" y="294"/>
                  </a:lnTo>
                  <a:lnTo>
                    <a:pt x="773" y="294"/>
                  </a:lnTo>
                  <a:lnTo>
                    <a:pt x="775" y="294"/>
                  </a:lnTo>
                  <a:lnTo>
                    <a:pt x="777" y="293"/>
                  </a:lnTo>
                  <a:lnTo>
                    <a:pt x="779" y="293"/>
                  </a:lnTo>
                  <a:lnTo>
                    <a:pt x="781" y="292"/>
                  </a:lnTo>
                  <a:lnTo>
                    <a:pt x="783" y="292"/>
                  </a:lnTo>
                  <a:lnTo>
                    <a:pt x="785" y="291"/>
                  </a:lnTo>
                  <a:lnTo>
                    <a:pt x="787" y="290"/>
                  </a:lnTo>
                  <a:lnTo>
                    <a:pt x="789" y="289"/>
                  </a:lnTo>
                  <a:lnTo>
                    <a:pt x="791" y="289"/>
                  </a:lnTo>
                  <a:lnTo>
                    <a:pt x="793" y="288"/>
                  </a:lnTo>
                  <a:lnTo>
                    <a:pt x="795" y="287"/>
                  </a:lnTo>
                  <a:lnTo>
                    <a:pt x="797" y="287"/>
                  </a:lnTo>
                  <a:lnTo>
                    <a:pt x="799" y="287"/>
                  </a:lnTo>
                  <a:lnTo>
                    <a:pt x="801" y="287"/>
                  </a:lnTo>
                  <a:lnTo>
                    <a:pt x="803" y="287"/>
                  </a:lnTo>
                  <a:lnTo>
                    <a:pt x="805" y="287"/>
                  </a:lnTo>
                  <a:lnTo>
                    <a:pt x="807" y="287"/>
                  </a:lnTo>
                  <a:lnTo>
                    <a:pt x="809" y="288"/>
                  </a:lnTo>
                  <a:lnTo>
                    <a:pt x="811" y="288"/>
                  </a:lnTo>
                  <a:lnTo>
                    <a:pt x="813" y="288"/>
                  </a:lnTo>
                  <a:lnTo>
                    <a:pt x="815" y="289"/>
                  </a:lnTo>
                  <a:lnTo>
                    <a:pt x="817" y="289"/>
                  </a:lnTo>
                  <a:lnTo>
                    <a:pt x="819" y="289"/>
                  </a:lnTo>
                  <a:lnTo>
                    <a:pt x="821" y="290"/>
                  </a:lnTo>
                  <a:lnTo>
                    <a:pt x="823" y="290"/>
                  </a:lnTo>
                  <a:lnTo>
                    <a:pt x="825" y="290"/>
                  </a:lnTo>
                  <a:lnTo>
                    <a:pt x="827" y="290"/>
                  </a:lnTo>
                  <a:lnTo>
                    <a:pt x="829" y="290"/>
                  </a:lnTo>
                  <a:lnTo>
                    <a:pt x="831" y="290"/>
                  </a:lnTo>
                  <a:lnTo>
                    <a:pt x="833" y="290"/>
                  </a:lnTo>
                  <a:lnTo>
                    <a:pt x="835" y="290"/>
                  </a:lnTo>
                  <a:lnTo>
                    <a:pt x="837" y="290"/>
                  </a:lnTo>
                  <a:lnTo>
                    <a:pt x="839" y="290"/>
                  </a:lnTo>
                  <a:lnTo>
                    <a:pt x="841" y="290"/>
                  </a:lnTo>
                  <a:lnTo>
                    <a:pt x="843" y="290"/>
                  </a:lnTo>
                  <a:lnTo>
                    <a:pt x="845" y="290"/>
                  </a:lnTo>
                  <a:lnTo>
                    <a:pt x="847" y="290"/>
                  </a:lnTo>
                  <a:lnTo>
                    <a:pt x="849" y="290"/>
                  </a:lnTo>
                  <a:lnTo>
                    <a:pt x="851" y="290"/>
                  </a:lnTo>
                  <a:lnTo>
                    <a:pt x="853" y="289"/>
                  </a:lnTo>
                  <a:lnTo>
                    <a:pt x="855" y="289"/>
                  </a:lnTo>
                  <a:lnTo>
                    <a:pt x="857" y="289"/>
                  </a:lnTo>
                  <a:lnTo>
                    <a:pt x="859" y="289"/>
                  </a:lnTo>
                  <a:lnTo>
                    <a:pt x="861" y="289"/>
                  </a:lnTo>
                  <a:lnTo>
                    <a:pt x="863" y="289"/>
                  </a:lnTo>
                  <a:lnTo>
                    <a:pt x="865" y="288"/>
                  </a:lnTo>
                  <a:lnTo>
                    <a:pt x="867" y="288"/>
                  </a:lnTo>
                  <a:lnTo>
                    <a:pt x="869" y="286"/>
                  </a:lnTo>
                  <a:lnTo>
                    <a:pt x="871" y="284"/>
                  </a:lnTo>
                  <a:lnTo>
                    <a:pt x="873" y="281"/>
                  </a:lnTo>
                  <a:lnTo>
                    <a:pt x="875" y="275"/>
                  </a:lnTo>
                  <a:lnTo>
                    <a:pt x="877" y="267"/>
                  </a:lnTo>
                  <a:lnTo>
                    <a:pt x="879" y="255"/>
                  </a:lnTo>
                  <a:lnTo>
                    <a:pt x="881" y="240"/>
                  </a:lnTo>
                  <a:lnTo>
                    <a:pt x="883" y="220"/>
                  </a:lnTo>
                  <a:lnTo>
                    <a:pt x="885" y="195"/>
                  </a:lnTo>
                  <a:lnTo>
                    <a:pt x="887" y="168"/>
                  </a:lnTo>
                  <a:lnTo>
                    <a:pt x="889" y="138"/>
                  </a:lnTo>
                  <a:lnTo>
                    <a:pt x="891" y="108"/>
                  </a:lnTo>
                  <a:lnTo>
                    <a:pt x="893" y="79"/>
                  </a:lnTo>
                  <a:lnTo>
                    <a:pt x="895" y="53"/>
                  </a:lnTo>
                  <a:lnTo>
                    <a:pt x="898" y="32"/>
                  </a:lnTo>
                  <a:lnTo>
                    <a:pt x="900" y="15"/>
                  </a:lnTo>
                  <a:lnTo>
                    <a:pt x="902" y="5"/>
                  </a:lnTo>
                  <a:lnTo>
                    <a:pt x="904" y="0"/>
                  </a:lnTo>
                  <a:lnTo>
                    <a:pt x="906" y="0"/>
                  </a:lnTo>
                  <a:lnTo>
                    <a:pt x="908" y="4"/>
                  </a:lnTo>
                  <a:lnTo>
                    <a:pt x="910" y="12"/>
                  </a:lnTo>
                  <a:lnTo>
                    <a:pt x="912" y="22"/>
                  </a:lnTo>
                  <a:lnTo>
                    <a:pt x="914" y="33"/>
                  </a:lnTo>
                  <a:lnTo>
                    <a:pt x="916" y="46"/>
                  </a:lnTo>
                  <a:lnTo>
                    <a:pt x="918" y="60"/>
                  </a:lnTo>
                  <a:lnTo>
                    <a:pt x="920" y="75"/>
                  </a:lnTo>
                  <a:lnTo>
                    <a:pt x="922" y="92"/>
                  </a:lnTo>
                  <a:lnTo>
                    <a:pt x="924" y="108"/>
                  </a:lnTo>
                  <a:lnTo>
                    <a:pt x="926" y="125"/>
                  </a:lnTo>
                  <a:lnTo>
                    <a:pt x="928" y="142"/>
                  </a:lnTo>
                  <a:lnTo>
                    <a:pt x="930" y="159"/>
                  </a:lnTo>
                  <a:lnTo>
                    <a:pt x="932" y="176"/>
                  </a:lnTo>
                  <a:lnTo>
                    <a:pt x="934" y="191"/>
                  </a:lnTo>
                  <a:lnTo>
                    <a:pt x="936" y="204"/>
                  </a:lnTo>
                  <a:lnTo>
                    <a:pt x="938" y="217"/>
                  </a:lnTo>
                  <a:lnTo>
                    <a:pt x="940" y="228"/>
                  </a:lnTo>
                  <a:lnTo>
                    <a:pt x="942" y="237"/>
                  </a:lnTo>
                  <a:lnTo>
                    <a:pt x="944" y="244"/>
                  </a:lnTo>
                  <a:lnTo>
                    <a:pt x="946" y="250"/>
                  </a:lnTo>
                  <a:lnTo>
                    <a:pt x="948" y="256"/>
                  </a:lnTo>
                  <a:lnTo>
                    <a:pt x="950" y="260"/>
                  </a:lnTo>
                  <a:lnTo>
                    <a:pt x="952" y="263"/>
                  </a:lnTo>
                  <a:lnTo>
                    <a:pt x="954" y="266"/>
                  </a:lnTo>
                  <a:lnTo>
                    <a:pt x="956" y="268"/>
                  </a:lnTo>
                  <a:lnTo>
                    <a:pt x="958" y="269"/>
                  </a:lnTo>
                  <a:lnTo>
                    <a:pt x="960" y="270"/>
                  </a:lnTo>
                  <a:lnTo>
                    <a:pt x="962" y="270"/>
                  </a:lnTo>
                  <a:lnTo>
                    <a:pt x="964" y="270"/>
                  </a:lnTo>
                  <a:lnTo>
                    <a:pt x="966" y="269"/>
                  </a:lnTo>
                  <a:lnTo>
                    <a:pt x="968" y="268"/>
                  </a:lnTo>
                  <a:lnTo>
                    <a:pt x="970" y="265"/>
                  </a:lnTo>
                  <a:lnTo>
                    <a:pt x="972" y="261"/>
                  </a:lnTo>
                  <a:lnTo>
                    <a:pt x="974" y="257"/>
                  </a:lnTo>
                  <a:lnTo>
                    <a:pt x="976" y="251"/>
                  </a:lnTo>
                  <a:lnTo>
                    <a:pt x="978" y="246"/>
                  </a:lnTo>
                  <a:lnTo>
                    <a:pt x="980" y="239"/>
                  </a:lnTo>
                  <a:lnTo>
                    <a:pt x="982" y="233"/>
                  </a:lnTo>
                  <a:lnTo>
                    <a:pt x="984" y="227"/>
                  </a:lnTo>
                  <a:lnTo>
                    <a:pt x="986" y="221"/>
                  </a:lnTo>
                  <a:lnTo>
                    <a:pt x="988" y="217"/>
                  </a:lnTo>
                  <a:lnTo>
                    <a:pt x="990" y="213"/>
                  </a:lnTo>
                  <a:lnTo>
                    <a:pt x="992" y="210"/>
                  </a:lnTo>
                  <a:lnTo>
                    <a:pt x="994" y="208"/>
                  </a:lnTo>
                  <a:lnTo>
                    <a:pt x="996" y="206"/>
                  </a:lnTo>
                  <a:lnTo>
                    <a:pt x="998" y="205"/>
                  </a:lnTo>
                  <a:lnTo>
                    <a:pt x="1000" y="204"/>
                  </a:lnTo>
                  <a:lnTo>
                    <a:pt x="1002" y="204"/>
                  </a:lnTo>
                  <a:lnTo>
                    <a:pt x="1004" y="203"/>
                  </a:lnTo>
                  <a:lnTo>
                    <a:pt x="1006" y="202"/>
                  </a:lnTo>
                  <a:lnTo>
                    <a:pt x="1008" y="200"/>
                  </a:lnTo>
                  <a:lnTo>
                    <a:pt x="1010" y="198"/>
                  </a:lnTo>
                  <a:lnTo>
                    <a:pt x="1012" y="195"/>
                  </a:lnTo>
                  <a:lnTo>
                    <a:pt x="1014" y="191"/>
                  </a:lnTo>
                  <a:lnTo>
                    <a:pt x="1016" y="186"/>
                  </a:lnTo>
                  <a:lnTo>
                    <a:pt x="1018" y="181"/>
                  </a:lnTo>
                  <a:lnTo>
                    <a:pt x="1020" y="175"/>
                  </a:lnTo>
                  <a:lnTo>
                    <a:pt x="1022" y="168"/>
                  </a:lnTo>
                  <a:lnTo>
                    <a:pt x="1024" y="162"/>
                  </a:lnTo>
                  <a:lnTo>
                    <a:pt x="1026" y="157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598" name="Freeform 594"/>
            <p:cNvSpPr>
              <a:spLocks/>
            </p:cNvSpPr>
            <p:nvPr/>
          </p:nvSpPr>
          <p:spPr bwMode="auto">
            <a:xfrm>
              <a:off x="5370513" y="3708400"/>
              <a:ext cx="1247775" cy="1720850"/>
            </a:xfrm>
            <a:custGeom>
              <a:avLst/>
              <a:gdLst>
                <a:gd name="T0" fmla="*/ 12 w 786"/>
                <a:gd name="T1" fmla="*/ 974 h 1084"/>
                <a:gd name="T2" fmla="*/ 27 w 786"/>
                <a:gd name="T3" fmla="*/ 1023 h 1084"/>
                <a:gd name="T4" fmla="*/ 41 w 786"/>
                <a:gd name="T5" fmla="*/ 1065 h 1084"/>
                <a:gd name="T6" fmla="*/ 55 w 786"/>
                <a:gd name="T7" fmla="*/ 1079 h 1084"/>
                <a:gd name="T8" fmla="*/ 69 w 786"/>
                <a:gd name="T9" fmla="*/ 1082 h 1084"/>
                <a:gd name="T10" fmla="*/ 83 w 786"/>
                <a:gd name="T11" fmla="*/ 1083 h 1084"/>
                <a:gd name="T12" fmla="*/ 97 w 786"/>
                <a:gd name="T13" fmla="*/ 1082 h 1084"/>
                <a:gd name="T14" fmla="*/ 111 w 786"/>
                <a:gd name="T15" fmla="*/ 1050 h 1084"/>
                <a:gd name="T16" fmla="*/ 125 w 786"/>
                <a:gd name="T17" fmla="*/ 859 h 1084"/>
                <a:gd name="T18" fmla="*/ 139 w 786"/>
                <a:gd name="T19" fmla="*/ 530 h 1084"/>
                <a:gd name="T20" fmla="*/ 153 w 786"/>
                <a:gd name="T21" fmla="*/ 379 h 1084"/>
                <a:gd name="T22" fmla="*/ 168 w 786"/>
                <a:gd name="T23" fmla="*/ 450 h 1084"/>
                <a:gd name="T24" fmla="*/ 182 w 786"/>
                <a:gd name="T25" fmla="*/ 633 h 1084"/>
                <a:gd name="T26" fmla="*/ 196 w 786"/>
                <a:gd name="T27" fmla="*/ 845 h 1084"/>
                <a:gd name="T28" fmla="*/ 210 w 786"/>
                <a:gd name="T29" fmla="*/ 994 h 1084"/>
                <a:gd name="T30" fmla="*/ 224 w 786"/>
                <a:gd name="T31" fmla="*/ 1054 h 1084"/>
                <a:gd name="T32" fmla="*/ 238 w 786"/>
                <a:gd name="T33" fmla="*/ 1072 h 1084"/>
                <a:gd name="T34" fmla="*/ 252 w 786"/>
                <a:gd name="T35" fmla="*/ 1076 h 1084"/>
                <a:gd name="T36" fmla="*/ 266 w 786"/>
                <a:gd name="T37" fmla="*/ 1077 h 1084"/>
                <a:gd name="T38" fmla="*/ 280 w 786"/>
                <a:gd name="T39" fmla="*/ 1077 h 1084"/>
                <a:gd name="T40" fmla="*/ 294 w 786"/>
                <a:gd name="T41" fmla="*/ 1078 h 1084"/>
                <a:gd name="T42" fmla="*/ 308 w 786"/>
                <a:gd name="T43" fmla="*/ 1078 h 1084"/>
                <a:gd name="T44" fmla="*/ 323 w 786"/>
                <a:gd name="T45" fmla="*/ 1077 h 1084"/>
                <a:gd name="T46" fmla="*/ 337 w 786"/>
                <a:gd name="T47" fmla="*/ 1075 h 1084"/>
                <a:gd name="T48" fmla="*/ 351 w 786"/>
                <a:gd name="T49" fmla="*/ 1074 h 1084"/>
                <a:gd name="T50" fmla="*/ 365 w 786"/>
                <a:gd name="T51" fmla="*/ 1073 h 1084"/>
                <a:gd name="T52" fmla="*/ 379 w 786"/>
                <a:gd name="T53" fmla="*/ 1052 h 1084"/>
                <a:gd name="T54" fmla="*/ 393 w 786"/>
                <a:gd name="T55" fmla="*/ 911 h 1084"/>
                <a:gd name="T56" fmla="*/ 407 w 786"/>
                <a:gd name="T57" fmla="*/ 528 h 1084"/>
                <a:gd name="T58" fmla="*/ 421 w 786"/>
                <a:gd name="T59" fmla="*/ 117 h 1084"/>
                <a:gd name="T60" fmla="*/ 435 w 786"/>
                <a:gd name="T61" fmla="*/ 4 h 1084"/>
                <a:gd name="T62" fmla="*/ 449 w 786"/>
                <a:gd name="T63" fmla="*/ 148 h 1084"/>
                <a:gd name="T64" fmla="*/ 463 w 786"/>
                <a:gd name="T65" fmla="*/ 392 h 1084"/>
                <a:gd name="T66" fmla="*/ 478 w 786"/>
                <a:gd name="T67" fmla="*/ 653 h 1084"/>
                <a:gd name="T68" fmla="*/ 492 w 786"/>
                <a:gd name="T69" fmla="*/ 858 h 1084"/>
                <a:gd name="T70" fmla="*/ 506 w 786"/>
                <a:gd name="T71" fmla="*/ 971 h 1084"/>
                <a:gd name="T72" fmla="*/ 520 w 786"/>
                <a:gd name="T73" fmla="*/ 1016 h 1084"/>
                <a:gd name="T74" fmla="*/ 534 w 786"/>
                <a:gd name="T75" fmla="*/ 1033 h 1084"/>
                <a:gd name="T76" fmla="*/ 548 w 786"/>
                <a:gd name="T77" fmla="*/ 1040 h 1084"/>
                <a:gd name="T78" fmla="*/ 562 w 786"/>
                <a:gd name="T79" fmla="*/ 1046 h 1084"/>
                <a:gd name="T80" fmla="*/ 576 w 786"/>
                <a:gd name="T81" fmla="*/ 1050 h 1084"/>
                <a:gd name="T82" fmla="*/ 590 w 786"/>
                <a:gd name="T83" fmla="*/ 1055 h 1084"/>
                <a:gd name="T84" fmla="*/ 604 w 786"/>
                <a:gd name="T85" fmla="*/ 1058 h 1084"/>
                <a:gd name="T86" fmla="*/ 618 w 786"/>
                <a:gd name="T87" fmla="*/ 1062 h 1084"/>
                <a:gd name="T88" fmla="*/ 633 w 786"/>
                <a:gd name="T89" fmla="*/ 1065 h 1084"/>
                <a:gd name="T90" fmla="*/ 647 w 786"/>
                <a:gd name="T91" fmla="*/ 1068 h 1084"/>
                <a:gd name="T92" fmla="*/ 661 w 786"/>
                <a:gd name="T93" fmla="*/ 1072 h 1084"/>
                <a:gd name="T94" fmla="*/ 675 w 786"/>
                <a:gd name="T95" fmla="*/ 1075 h 1084"/>
                <a:gd name="T96" fmla="*/ 689 w 786"/>
                <a:gd name="T97" fmla="*/ 1077 h 1084"/>
                <a:gd name="T98" fmla="*/ 703 w 786"/>
                <a:gd name="T99" fmla="*/ 1078 h 1084"/>
                <a:gd name="T100" fmla="*/ 717 w 786"/>
                <a:gd name="T101" fmla="*/ 1078 h 1084"/>
                <a:gd name="T102" fmla="*/ 731 w 786"/>
                <a:gd name="T103" fmla="*/ 1078 h 1084"/>
                <a:gd name="T104" fmla="*/ 745 w 786"/>
                <a:gd name="T105" fmla="*/ 1077 h 1084"/>
                <a:gd name="T106" fmla="*/ 759 w 786"/>
                <a:gd name="T107" fmla="*/ 1076 h 1084"/>
                <a:gd name="T108" fmla="*/ 773 w 786"/>
                <a:gd name="T109" fmla="*/ 1075 h 10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786" h="1084">
                  <a:moveTo>
                    <a:pt x="0" y="964"/>
                  </a:moveTo>
                  <a:lnTo>
                    <a:pt x="2" y="960"/>
                  </a:lnTo>
                  <a:lnTo>
                    <a:pt x="4" y="958"/>
                  </a:lnTo>
                  <a:lnTo>
                    <a:pt x="6" y="959"/>
                  </a:lnTo>
                  <a:lnTo>
                    <a:pt x="8" y="962"/>
                  </a:lnTo>
                  <a:lnTo>
                    <a:pt x="10" y="967"/>
                  </a:lnTo>
                  <a:lnTo>
                    <a:pt x="12" y="974"/>
                  </a:lnTo>
                  <a:lnTo>
                    <a:pt x="15" y="982"/>
                  </a:lnTo>
                  <a:lnTo>
                    <a:pt x="16" y="990"/>
                  </a:lnTo>
                  <a:lnTo>
                    <a:pt x="18" y="998"/>
                  </a:lnTo>
                  <a:lnTo>
                    <a:pt x="20" y="1005"/>
                  </a:lnTo>
                  <a:lnTo>
                    <a:pt x="22" y="1011"/>
                  </a:lnTo>
                  <a:lnTo>
                    <a:pt x="25" y="1017"/>
                  </a:lnTo>
                  <a:lnTo>
                    <a:pt x="27" y="1023"/>
                  </a:lnTo>
                  <a:lnTo>
                    <a:pt x="29" y="1029"/>
                  </a:lnTo>
                  <a:lnTo>
                    <a:pt x="31" y="1035"/>
                  </a:lnTo>
                  <a:lnTo>
                    <a:pt x="33" y="1042"/>
                  </a:lnTo>
                  <a:lnTo>
                    <a:pt x="35" y="1048"/>
                  </a:lnTo>
                  <a:lnTo>
                    <a:pt x="37" y="1054"/>
                  </a:lnTo>
                  <a:lnTo>
                    <a:pt x="39" y="1060"/>
                  </a:lnTo>
                  <a:lnTo>
                    <a:pt x="41" y="1065"/>
                  </a:lnTo>
                  <a:lnTo>
                    <a:pt x="43" y="1069"/>
                  </a:lnTo>
                  <a:lnTo>
                    <a:pt x="45" y="1072"/>
                  </a:lnTo>
                  <a:lnTo>
                    <a:pt x="47" y="1074"/>
                  </a:lnTo>
                  <a:lnTo>
                    <a:pt x="49" y="1076"/>
                  </a:lnTo>
                  <a:lnTo>
                    <a:pt x="51" y="1077"/>
                  </a:lnTo>
                  <a:lnTo>
                    <a:pt x="53" y="1078"/>
                  </a:lnTo>
                  <a:lnTo>
                    <a:pt x="55" y="1079"/>
                  </a:lnTo>
                  <a:lnTo>
                    <a:pt x="57" y="1080"/>
                  </a:lnTo>
                  <a:lnTo>
                    <a:pt x="59" y="1080"/>
                  </a:lnTo>
                  <a:lnTo>
                    <a:pt x="61" y="1081"/>
                  </a:lnTo>
                  <a:lnTo>
                    <a:pt x="63" y="1081"/>
                  </a:lnTo>
                  <a:lnTo>
                    <a:pt x="65" y="1081"/>
                  </a:lnTo>
                  <a:lnTo>
                    <a:pt x="67" y="1081"/>
                  </a:lnTo>
                  <a:lnTo>
                    <a:pt x="69" y="1082"/>
                  </a:lnTo>
                  <a:lnTo>
                    <a:pt x="71" y="1082"/>
                  </a:lnTo>
                  <a:lnTo>
                    <a:pt x="73" y="1082"/>
                  </a:lnTo>
                  <a:lnTo>
                    <a:pt x="75" y="1083"/>
                  </a:lnTo>
                  <a:lnTo>
                    <a:pt x="77" y="1083"/>
                  </a:lnTo>
                  <a:lnTo>
                    <a:pt x="79" y="1083"/>
                  </a:lnTo>
                  <a:lnTo>
                    <a:pt x="81" y="1083"/>
                  </a:lnTo>
                  <a:lnTo>
                    <a:pt x="83" y="1083"/>
                  </a:lnTo>
                  <a:lnTo>
                    <a:pt x="85" y="1083"/>
                  </a:lnTo>
                  <a:lnTo>
                    <a:pt x="87" y="1083"/>
                  </a:lnTo>
                  <a:lnTo>
                    <a:pt x="89" y="1084"/>
                  </a:lnTo>
                  <a:lnTo>
                    <a:pt x="91" y="1083"/>
                  </a:lnTo>
                  <a:lnTo>
                    <a:pt x="93" y="1083"/>
                  </a:lnTo>
                  <a:lnTo>
                    <a:pt x="95" y="1083"/>
                  </a:lnTo>
                  <a:lnTo>
                    <a:pt x="97" y="1082"/>
                  </a:lnTo>
                  <a:lnTo>
                    <a:pt x="99" y="1081"/>
                  </a:lnTo>
                  <a:lnTo>
                    <a:pt x="101" y="1079"/>
                  </a:lnTo>
                  <a:lnTo>
                    <a:pt x="103" y="1076"/>
                  </a:lnTo>
                  <a:lnTo>
                    <a:pt x="105" y="1073"/>
                  </a:lnTo>
                  <a:lnTo>
                    <a:pt x="107" y="1067"/>
                  </a:lnTo>
                  <a:lnTo>
                    <a:pt x="109" y="1060"/>
                  </a:lnTo>
                  <a:lnTo>
                    <a:pt x="111" y="1050"/>
                  </a:lnTo>
                  <a:lnTo>
                    <a:pt x="113" y="1037"/>
                  </a:lnTo>
                  <a:lnTo>
                    <a:pt x="115" y="1019"/>
                  </a:lnTo>
                  <a:lnTo>
                    <a:pt x="117" y="997"/>
                  </a:lnTo>
                  <a:lnTo>
                    <a:pt x="119" y="970"/>
                  </a:lnTo>
                  <a:lnTo>
                    <a:pt x="121" y="938"/>
                  </a:lnTo>
                  <a:lnTo>
                    <a:pt x="123" y="901"/>
                  </a:lnTo>
                  <a:lnTo>
                    <a:pt x="125" y="859"/>
                  </a:lnTo>
                  <a:lnTo>
                    <a:pt x="127" y="813"/>
                  </a:lnTo>
                  <a:lnTo>
                    <a:pt x="129" y="765"/>
                  </a:lnTo>
                  <a:lnTo>
                    <a:pt x="131" y="716"/>
                  </a:lnTo>
                  <a:lnTo>
                    <a:pt x="133" y="666"/>
                  </a:lnTo>
                  <a:lnTo>
                    <a:pt x="135" y="617"/>
                  </a:lnTo>
                  <a:lnTo>
                    <a:pt x="137" y="572"/>
                  </a:lnTo>
                  <a:lnTo>
                    <a:pt x="139" y="530"/>
                  </a:lnTo>
                  <a:lnTo>
                    <a:pt x="141" y="493"/>
                  </a:lnTo>
                  <a:lnTo>
                    <a:pt x="143" y="460"/>
                  </a:lnTo>
                  <a:lnTo>
                    <a:pt x="145" y="433"/>
                  </a:lnTo>
                  <a:lnTo>
                    <a:pt x="147" y="412"/>
                  </a:lnTo>
                  <a:lnTo>
                    <a:pt x="149" y="396"/>
                  </a:lnTo>
                  <a:lnTo>
                    <a:pt x="151" y="385"/>
                  </a:lnTo>
                  <a:lnTo>
                    <a:pt x="153" y="379"/>
                  </a:lnTo>
                  <a:lnTo>
                    <a:pt x="155" y="378"/>
                  </a:lnTo>
                  <a:lnTo>
                    <a:pt x="157" y="382"/>
                  </a:lnTo>
                  <a:lnTo>
                    <a:pt x="159" y="389"/>
                  </a:lnTo>
                  <a:lnTo>
                    <a:pt x="161" y="399"/>
                  </a:lnTo>
                  <a:lnTo>
                    <a:pt x="163" y="414"/>
                  </a:lnTo>
                  <a:lnTo>
                    <a:pt x="165" y="431"/>
                  </a:lnTo>
                  <a:lnTo>
                    <a:pt x="168" y="450"/>
                  </a:lnTo>
                  <a:lnTo>
                    <a:pt x="170" y="472"/>
                  </a:lnTo>
                  <a:lnTo>
                    <a:pt x="171" y="495"/>
                  </a:lnTo>
                  <a:lnTo>
                    <a:pt x="173" y="521"/>
                  </a:lnTo>
                  <a:lnTo>
                    <a:pt x="175" y="547"/>
                  </a:lnTo>
                  <a:lnTo>
                    <a:pt x="177" y="574"/>
                  </a:lnTo>
                  <a:lnTo>
                    <a:pt x="180" y="603"/>
                  </a:lnTo>
                  <a:lnTo>
                    <a:pt x="182" y="633"/>
                  </a:lnTo>
                  <a:lnTo>
                    <a:pt x="184" y="664"/>
                  </a:lnTo>
                  <a:lnTo>
                    <a:pt x="186" y="695"/>
                  </a:lnTo>
                  <a:lnTo>
                    <a:pt x="188" y="726"/>
                  </a:lnTo>
                  <a:lnTo>
                    <a:pt x="190" y="757"/>
                  </a:lnTo>
                  <a:lnTo>
                    <a:pt x="192" y="787"/>
                  </a:lnTo>
                  <a:lnTo>
                    <a:pt x="194" y="817"/>
                  </a:lnTo>
                  <a:lnTo>
                    <a:pt x="196" y="845"/>
                  </a:lnTo>
                  <a:lnTo>
                    <a:pt x="198" y="872"/>
                  </a:lnTo>
                  <a:lnTo>
                    <a:pt x="200" y="898"/>
                  </a:lnTo>
                  <a:lnTo>
                    <a:pt x="202" y="921"/>
                  </a:lnTo>
                  <a:lnTo>
                    <a:pt x="204" y="942"/>
                  </a:lnTo>
                  <a:lnTo>
                    <a:pt x="206" y="961"/>
                  </a:lnTo>
                  <a:lnTo>
                    <a:pt x="208" y="979"/>
                  </a:lnTo>
                  <a:lnTo>
                    <a:pt x="210" y="994"/>
                  </a:lnTo>
                  <a:lnTo>
                    <a:pt x="212" y="1007"/>
                  </a:lnTo>
                  <a:lnTo>
                    <a:pt x="214" y="1018"/>
                  </a:lnTo>
                  <a:lnTo>
                    <a:pt x="216" y="1028"/>
                  </a:lnTo>
                  <a:lnTo>
                    <a:pt x="218" y="1037"/>
                  </a:lnTo>
                  <a:lnTo>
                    <a:pt x="220" y="1044"/>
                  </a:lnTo>
                  <a:lnTo>
                    <a:pt x="222" y="1049"/>
                  </a:lnTo>
                  <a:lnTo>
                    <a:pt x="224" y="1054"/>
                  </a:lnTo>
                  <a:lnTo>
                    <a:pt x="226" y="1058"/>
                  </a:lnTo>
                  <a:lnTo>
                    <a:pt x="228" y="1062"/>
                  </a:lnTo>
                  <a:lnTo>
                    <a:pt x="230" y="1065"/>
                  </a:lnTo>
                  <a:lnTo>
                    <a:pt x="232" y="1067"/>
                  </a:lnTo>
                  <a:lnTo>
                    <a:pt x="234" y="1069"/>
                  </a:lnTo>
                  <a:lnTo>
                    <a:pt x="236" y="1070"/>
                  </a:lnTo>
                  <a:lnTo>
                    <a:pt x="238" y="1072"/>
                  </a:lnTo>
                  <a:lnTo>
                    <a:pt x="240" y="1073"/>
                  </a:lnTo>
                  <a:lnTo>
                    <a:pt x="242" y="1073"/>
                  </a:lnTo>
                  <a:lnTo>
                    <a:pt x="244" y="1074"/>
                  </a:lnTo>
                  <a:lnTo>
                    <a:pt x="246" y="1075"/>
                  </a:lnTo>
                  <a:lnTo>
                    <a:pt x="248" y="1075"/>
                  </a:lnTo>
                  <a:lnTo>
                    <a:pt x="250" y="1075"/>
                  </a:lnTo>
                  <a:lnTo>
                    <a:pt x="252" y="1076"/>
                  </a:lnTo>
                  <a:lnTo>
                    <a:pt x="254" y="1076"/>
                  </a:lnTo>
                  <a:lnTo>
                    <a:pt x="256" y="1076"/>
                  </a:lnTo>
                  <a:lnTo>
                    <a:pt x="258" y="1076"/>
                  </a:lnTo>
                  <a:lnTo>
                    <a:pt x="260" y="1076"/>
                  </a:lnTo>
                  <a:lnTo>
                    <a:pt x="262" y="1077"/>
                  </a:lnTo>
                  <a:lnTo>
                    <a:pt x="264" y="1077"/>
                  </a:lnTo>
                  <a:lnTo>
                    <a:pt x="266" y="1077"/>
                  </a:lnTo>
                  <a:lnTo>
                    <a:pt x="268" y="1077"/>
                  </a:lnTo>
                  <a:lnTo>
                    <a:pt x="270" y="1077"/>
                  </a:lnTo>
                  <a:lnTo>
                    <a:pt x="272" y="1077"/>
                  </a:lnTo>
                  <a:lnTo>
                    <a:pt x="274" y="1077"/>
                  </a:lnTo>
                  <a:lnTo>
                    <a:pt x="276" y="1077"/>
                  </a:lnTo>
                  <a:lnTo>
                    <a:pt x="278" y="1077"/>
                  </a:lnTo>
                  <a:lnTo>
                    <a:pt x="280" y="1077"/>
                  </a:lnTo>
                  <a:lnTo>
                    <a:pt x="282" y="1078"/>
                  </a:lnTo>
                  <a:lnTo>
                    <a:pt x="284" y="1078"/>
                  </a:lnTo>
                  <a:lnTo>
                    <a:pt x="286" y="1078"/>
                  </a:lnTo>
                  <a:lnTo>
                    <a:pt x="288" y="1078"/>
                  </a:lnTo>
                  <a:lnTo>
                    <a:pt x="290" y="1078"/>
                  </a:lnTo>
                  <a:lnTo>
                    <a:pt x="292" y="1078"/>
                  </a:lnTo>
                  <a:lnTo>
                    <a:pt x="294" y="1078"/>
                  </a:lnTo>
                  <a:lnTo>
                    <a:pt x="296" y="1078"/>
                  </a:lnTo>
                  <a:lnTo>
                    <a:pt x="298" y="1078"/>
                  </a:lnTo>
                  <a:lnTo>
                    <a:pt x="300" y="1078"/>
                  </a:lnTo>
                  <a:lnTo>
                    <a:pt x="302" y="1078"/>
                  </a:lnTo>
                  <a:lnTo>
                    <a:pt x="304" y="1078"/>
                  </a:lnTo>
                  <a:lnTo>
                    <a:pt x="306" y="1078"/>
                  </a:lnTo>
                  <a:lnTo>
                    <a:pt x="308" y="1078"/>
                  </a:lnTo>
                  <a:lnTo>
                    <a:pt x="310" y="1078"/>
                  </a:lnTo>
                  <a:lnTo>
                    <a:pt x="312" y="1078"/>
                  </a:lnTo>
                  <a:lnTo>
                    <a:pt x="314" y="1078"/>
                  </a:lnTo>
                  <a:lnTo>
                    <a:pt x="316" y="1077"/>
                  </a:lnTo>
                  <a:lnTo>
                    <a:pt x="318" y="1077"/>
                  </a:lnTo>
                  <a:lnTo>
                    <a:pt x="320" y="1077"/>
                  </a:lnTo>
                  <a:lnTo>
                    <a:pt x="323" y="1077"/>
                  </a:lnTo>
                  <a:lnTo>
                    <a:pt x="325" y="1077"/>
                  </a:lnTo>
                  <a:lnTo>
                    <a:pt x="327" y="1076"/>
                  </a:lnTo>
                  <a:lnTo>
                    <a:pt x="328" y="1076"/>
                  </a:lnTo>
                  <a:lnTo>
                    <a:pt x="330" y="1076"/>
                  </a:lnTo>
                  <a:lnTo>
                    <a:pt x="333" y="1076"/>
                  </a:lnTo>
                  <a:lnTo>
                    <a:pt x="335" y="1075"/>
                  </a:lnTo>
                  <a:lnTo>
                    <a:pt x="337" y="1075"/>
                  </a:lnTo>
                  <a:lnTo>
                    <a:pt x="339" y="1075"/>
                  </a:lnTo>
                  <a:lnTo>
                    <a:pt x="341" y="1075"/>
                  </a:lnTo>
                  <a:lnTo>
                    <a:pt x="343" y="1074"/>
                  </a:lnTo>
                  <a:lnTo>
                    <a:pt x="345" y="1074"/>
                  </a:lnTo>
                  <a:lnTo>
                    <a:pt x="347" y="1074"/>
                  </a:lnTo>
                  <a:lnTo>
                    <a:pt x="349" y="1074"/>
                  </a:lnTo>
                  <a:lnTo>
                    <a:pt x="351" y="1074"/>
                  </a:lnTo>
                  <a:lnTo>
                    <a:pt x="353" y="1074"/>
                  </a:lnTo>
                  <a:lnTo>
                    <a:pt x="355" y="1074"/>
                  </a:lnTo>
                  <a:lnTo>
                    <a:pt x="357" y="1074"/>
                  </a:lnTo>
                  <a:lnTo>
                    <a:pt x="359" y="1074"/>
                  </a:lnTo>
                  <a:lnTo>
                    <a:pt x="361" y="1074"/>
                  </a:lnTo>
                  <a:lnTo>
                    <a:pt x="363" y="1073"/>
                  </a:lnTo>
                  <a:lnTo>
                    <a:pt x="365" y="1073"/>
                  </a:lnTo>
                  <a:lnTo>
                    <a:pt x="367" y="1072"/>
                  </a:lnTo>
                  <a:lnTo>
                    <a:pt x="369" y="1071"/>
                  </a:lnTo>
                  <a:lnTo>
                    <a:pt x="371" y="1069"/>
                  </a:lnTo>
                  <a:lnTo>
                    <a:pt x="373" y="1067"/>
                  </a:lnTo>
                  <a:lnTo>
                    <a:pt x="375" y="1063"/>
                  </a:lnTo>
                  <a:lnTo>
                    <a:pt x="377" y="1058"/>
                  </a:lnTo>
                  <a:lnTo>
                    <a:pt x="379" y="1052"/>
                  </a:lnTo>
                  <a:lnTo>
                    <a:pt x="381" y="1043"/>
                  </a:lnTo>
                  <a:lnTo>
                    <a:pt x="383" y="1031"/>
                  </a:lnTo>
                  <a:lnTo>
                    <a:pt x="385" y="1016"/>
                  </a:lnTo>
                  <a:lnTo>
                    <a:pt x="387" y="998"/>
                  </a:lnTo>
                  <a:lnTo>
                    <a:pt x="389" y="974"/>
                  </a:lnTo>
                  <a:lnTo>
                    <a:pt x="391" y="946"/>
                  </a:lnTo>
                  <a:lnTo>
                    <a:pt x="393" y="911"/>
                  </a:lnTo>
                  <a:lnTo>
                    <a:pt x="395" y="871"/>
                  </a:lnTo>
                  <a:lnTo>
                    <a:pt x="397" y="826"/>
                  </a:lnTo>
                  <a:lnTo>
                    <a:pt x="399" y="775"/>
                  </a:lnTo>
                  <a:lnTo>
                    <a:pt x="401" y="718"/>
                  </a:lnTo>
                  <a:lnTo>
                    <a:pt x="403" y="656"/>
                  </a:lnTo>
                  <a:lnTo>
                    <a:pt x="405" y="593"/>
                  </a:lnTo>
                  <a:lnTo>
                    <a:pt x="407" y="528"/>
                  </a:lnTo>
                  <a:lnTo>
                    <a:pt x="409" y="461"/>
                  </a:lnTo>
                  <a:lnTo>
                    <a:pt x="411" y="394"/>
                  </a:lnTo>
                  <a:lnTo>
                    <a:pt x="413" y="329"/>
                  </a:lnTo>
                  <a:lnTo>
                    <a:pt x="415" y="270"/>
                  </a:lnTo>
                  <a:lnTo>
                    <a:pt x="417" y="214"/>
                  </a:lnTo>
                  <a:lnTo>
                    <a:pt x="419" y="163"/>
                  </a:lnTo>
                  <a:lnTo>
                    <a:pt x="421" y="117"/>
                  </a:lnTo>
                  <a:lnTo>
                    <a:pt x="423" y="81"/>
                  </a:lnTo>
                  <a:lnTo>
                    <a:pt x="425" y="51"/>
                  </a:lnTo>
                  <a:lnTo>
                    <a:pt x="427" y="28"/>
                  </a:lnTo>
                  <a:lnTo>
                    <a:pt x="429" y="11"/>
                  </a:lnTo>
                  <a:lnTo>
                    <a:pt x="431" y="2"/>
                  </a:lnTo>
                  <a:lnTo>
                    <a:pt x="433" y="0"/>
                  </a:lnTo>
                  <a:lnTo>
                    <a:pt x="435" y="4"/>
                  </a:lnTo>
                  <a:lnTo>
                    <a:pt x="437" y="12"/>
                  </a:lnTo>
                  <a:lnTo>
                    <a:pt x="439" y="25"/>
                  </a:lnTo>
                  <a:lnTo>
                    <a:pt x="441" y="44"/>
                  </a:lnTo>
                  <a:lnTo>
                    <a:pt x="443" y="66"/>
                  </a:lnTo>
                  <a:lnTo>
                    <a:pt x="445" y="91"/>
                  </a:lnTo>
                  <a:lnTo>
                    <a:pt x="447" y="118"/>
                  </a:lnTo>
                  <a:lnTo>
                    <a:pt x="449" y="148"/>
                  </a:lnTo>
                  <a:lnTo>
                    <a:pt x="451" y="180"/>
                  </a:lnTo>
                  <a:lnTo>
                    <a:pt x="453" y="213"/>
                  </a:lnTo>
                  <a:lnTo>
                    <a:pt x="455" y="247"/>
                  </a:lnTo>
                  <a:lnTo>
                    <a:pt x="457" y="282"/>
                  </a:lnTo>
                  <a:lnTo>
                    <a:pt x="459" y="318"/>
                  </a:lnTo>
                  <a:lnTo>
                    <a:pt x="461" y="355"/>
                  </a:lnTo>
                  <a:lnTo>
                    <a:pt x="463" y="392"/>
                  </a:lnTo>
                  <a:lnTo>
                    <a:pt x="465" y="430"/>
                  </a:lnTo>
                  <a:lnTo>
                    <a:pt x="467" y="468"/>
                  </a:lnTo>
                  <a:lnTo>
                    <a:pt x="469" y="506"/>
                  </a:lnTo>
                  <a:lnTo>
                    <a:pt x="471" y="543"/>
                  </a:lnTo>
                  <a:lnTo>
                    <a:pt x="473" y="580"/>
                  </a:lnTo>
                  <a:lnTo>
                    <a:pt x="476" y="617"/>
                  </a:lnTo>
                  <a:lnTo>
                    <a:pt x="478" y="653"/>
                  </a:lnTo>
                  <a:lnTo>
                    <a:pt x="480" y="687"/>
                  </a:lnTo>
                  <a:lnTo>
                    <a:pt x="482" y="719"/>
                  </a:lnTo>
                  <a:lnTo>
                    <a:pt x="483" y="751"/>
                  </a:lnTo>
                  <a:lnTo>
                    <a:pt x="486" y="781"/>
                  </a:lnTo>
                  <a:lnTo>
                    <a:pt x="488" y="809"/>
                  </a:lnTo>
                  <a:lnTo>
                    <a:pt x="490" y="834"/>
                  </a:lnTo>
                  <a:lnTo>
                    <a:pt x="492" y="858"/>
                  </a:lnTo>
                  <a:lnTo>
                    <a:pt x="494" y="880"/>
                  </a:lnTo>
                  <a:lnTo>
                    <a:pt x="496" y="899"/>
                  </a:lnTo>
                  <a:lnTo>
                    <a:pt x="498" y="917"/>
                  </a:lnTo>
                  <a:lnTo>
                    <a:pt x="500" y="933"/>
                  </a:lnTo>
                  <a:lnTo>
                    <a:pt x="502" y="947"/>
                  </a:lnTo>
                  <a:lnTo>
                    <a:pt x="504" y="959"/>
                  </a:lnTo>
                  <a:lnTo>
                    <a:pt x="506" y="971"/>
                  </a:lnTo>
                  <a:lnTo>
                    <a:pt x="508" y="980"/>
                  </a:lnTo>
                  <a:lnTo>
                    <a:pt x="510" y="988"/>
                  </a:lnTo>
                  <a:lnTo>
                    <a:pt x="512" y="996"/>
                  </a:lnTo>
                  <a:lnTo>
                    <a:pt x="514" y="1002"/>
                  </a:lnTo>
                  <a:lnTo>
                    <a:pt x="516" y="1007"/>
                  </a:lnTo>
                  <a:lnTo>
                    <a:pt x="518" y="1012"/>
                  </a:lnTo>
                  <a:lnTo>
                    <a:pt x="520" y="1016"/>
                  </a:lnTo>
                  <a:lnTo>
                    <a:pt x="522" y="1019"/>
                  </a:lnTo>
                  <a:lnTo>
                    <a:pt x="524" y="1023"/>
                  </a:lnTo>
                  <a:lnTo>
                    <a:pt x="526" y="1025"/>
                  </a:lnTo>
                  <a:lnTo>
                    <a:pt x="528" y="1027"/>
                  </a:lnTo>
                  <a:lnTo>
                    <a:pt x="530" y="1029"/>
                  </a:lnTo>
                  <a:lnTo>
                    <a:pt x="532" y="1031"/>
                  </a:lnTo>
                  <a:lnTo>
                    <a:pt x="534" y="1033"/>
                  </a:lnTo>
                  <a:lnTo>
                    <a:pt x="536" y="1034"/>
                  </a:lnTo>
                  <a:lnTo>
                    <a:pt x="538" y="1035"/>
                  </a:lnTo>
                  <a:lnTo>
                    <a:pt x="540" y="1037"/>
                  </a:lnTo>
                  <a:lnTo>
                    <a:pt x="542" y="1038"/>
                  </a:lnTo>
                  <a:lnTo>
                    <a:pt x="544" y="1039"/>
                  </a:lnTo>
                  <a:lnTo>
                    <a:pt x="546" y="1040"/>
                  </a:lnTo>
                  <a:lnTo>
                    <a:pt x="548" y="1040"/>
                  </a:lnTo>
                  <a:lnTo>
                    <a:pt x="550" y="1041"/>
                  </a:lnTo>
                  <a:lnTo>
                    <a:pt x="552" y="1042"/>
                  </a:lnTo>
                  <a:lnTo>
                    <a:pt x="554" y="1043"/>
                  </a:lnTo>
                  <a:lnTo>
                    <a:pt x="556" y="1044"/>
                  </a:lnTo>
                  <a:lnTo>
                    <a:pt x="558" y="1045"/>
                  </a:lnTo>
                  <a:lnTo>
                    <a:pt x="560" y="1045"/>
                  </a:lnTo>
                  <a:lnTo>
                    <a:pt x="562" y="1046"/>
                  </a:lnTo>
                  <a:lnTo>
                    <a:pt x="564" y="1047"/>
                  </a:lnTo>
                  <a:lnTo>
                    <a:pt x="566" y="1047"/>
                  </a:lnTo>
                  <a:lnTo>
                    <a:pt x="568" y="1048"/>
                  </a:lnTo>
                  <a:lnTo>
                    <a:pt x="570" y="1049"/>
                  </a:lnTo>
                  <a:lnTo>
                    <a:pt x="572" y="1049"/>
                  </a:lnTo>
                  <a:lnTo>
                    <a:pt x="574" y="1050"/>
                  </a:lnTo>
                  <a:lnTo>
                    <a:pt x="576" y="1050"/>
                  </a:lnTo>
                  <a:lnTo>
                    <a:pt x="578" y="1051"/>
                  </a:lnTo>
                  <a:lnTo>
                    <a:pt x="580" y="1052"/>
                  </a:lnTo>
                  <a:lnTo>
                    <a:pt x="582" y="1052"/>
                  </a:lnTo>
                  <a:lnTo>
                    <a:pt x="584" y="1053"/>
                  </a:lnTo>
                  <a:lnTo>
                    <a:pt x="586" y="1053"/>
                  </a:lnTo>
                  <a:lnTo>
                    <a:pt x="588" y="1054"/>
                  </a:lnTo>
                  <a:lnTo>
                    <a:pt x="590" y="1055"/>
                  </a:lnTo>
                  <a:lnTo>
                    <a:pt x="592" y="1055"/>
                  </a:lnTo>
                  <a:lnTo>
                    <a:pt x="594" y="1056"/>
                  </a:lnTo>
                  <a:lnTo>
                    <a:pt x="596" y="1056"/>
                  </a:lnTo>
                  <a:lnTo>
                    <a:pt x="598" y="1057"/>
                  </a:lnTo>
                  <a:lnTo>
                    <a:pt x="600" y="1057"/>
                  </a:lnTo>
                  <a:lnTo>
                    <a:pt x="602" y="1058"/>
                  </a:lnTo>
                  <a:lnTo>
                    <a:pt x="604" y="1058"/>
                  </a:lnTo>
                  <a:lnTo>
                    <a:pt x="606" y="1059"/>
                  </a:lnTo>
                  <a:lnTo>
                    <a:pt x="608" y="1059"/>
                  </a:lnTo>
                  <a:lnTo>
                    <a:pt x="610" y="1060"/>
                  </a:lnTo>
                  <a:lnTo>
                    <a:pt x="612" y="1060"/>
                  </a:lnTo>
                  <a:lnTo>
                    <a:pt x="614" y="1061"/>
                  </a:lnTo>
                  <a:lnTo>
                    <a:pt x="616" y="1061"/>
                  </a:lnTo>
                  <a:lnTo>
                    <a:pt x="618" y="1062"/>
                  </a:lnTo>
                  <a:lnTo>
                    <a:pt x="620" y="1062"/>
                  </a:lnTo>
                  <a:lnTo>
                    <a:pt x="622" y="1063"/>
                  </a:lnTo>
                  <a:lnTo>
                    <a:pt x="624" y="1063"/>
                  </a:lnTo>
                  <a:lnTo>
                    <a:pt x="626" y="1064"/>
                  </a:lnTo>
                  <a:lnTo>
                    <a:pt x="629" y="1064"/>
                  </a:lnTo>
                  <a:lnTo>
                    <a:pt x="631" y="1064"/>
                  </a:lnTo>
                  <a:lnTo>
                    <a:pt x="633" y="1065"/>
                  </a:lnTo>
                  <a:lnTo>
                    <a:pt x="635" y="1066"/>
                  </a:lnTo>
                  <a:lnTo>
                    <a:pt x="637" y="1066"/>
                  </a:lnTo>
                  <a:lnTo>
                    <a:pt x="639" y="1066"/>
                  </a:lnTo>
                  <a:lnTo>
                    <a:pt x="641" y="1067"/>
                  </a:lnTo>
                  <a:lnTo>
                    <a:pt x="643" y="1067"/>
                  </a:lnTo>
                  <a:lnTo>
                    <a:pt x="645" y="1068"/>
                  </a:lnTo>
                  <a:lnTo>
                    <a:pt x="647" y="1068"/>
                  </a:lnTo>
                  <a:lnTo>
                    <a:pt x="649" y="1069"/>
                  </a:lnTo>
                  <a:lnTo>
                    <a:pt x="651" y="1069"/>
                  </a:lnTo>
                  <a:lnTo>
                    <a:pt x="653" y="1070"/>
                  </a:lnTo>
                  <a:lnTo>
                    <a:pt x="655" y="1070"/>
                  </a:lnTo>
                  <a:lnTo>
                    <a:pt x="657" y="1071"/>
                  </a:lnTo>
                  <a:lnTo>
                    <a:pt x="659" y="1071"/>
                  </a:lnTo>
                  <a:lnTo>
                    <a:pt x="661" y="1072"/>
                  </a:lnTo>
                  <a:lnTo>
                    <a:pt x="663" y="1072"/>
                  </a:lnTo>
                  <a:lnTo>
                    <a:pt x="665" y="1073"/>
                  </a:lnTo>
                  <a:lnTo>
                    <a:pt x="667" y="1073"/>
                  </a:lnTo>
                  <a:lnTo>
                    <a:pt x="669" y="1073"/>
                  </a:lnTo>
                  <a:lnTo>
                    <a:pt x="671" y="1074"/>
                  </a:lnTo>
                  <a:lnTo>
                    <a:pt x="673" y="1074"/>
                  </a:lnTo>
                  <a:lnTo>
                    <a:pt x="675" y="1075"/>
                  </a:lnTo>
                  <a:lnTo>
                    <a:pt x="677" y="1075"/>
                  </a:lnTo>
                  <a:lnTo>
                    <a:pt x="679" y="1075"/>
                  </a:lnTo>
                  <a:lnTo>
                    <a:pt x="681" y="1076"/>
                  </a:lnTo>
                  <a:lnTo>
                    <a:pt x="683" y="1076"/>
                  </a:lnTo>
                  <a:lnTo>
                    <a:pt x="685" y="1076"/>
                  </a:lnTo>
                  <a:lnTo>
                    <a:pt x="687" y="1076"/>
                  </a:lnTo>
                  <a:lnTo>
                    <a:pt x="689" y="1077"/>
                  </a:lnTo>
                  <a:lnTo>
                    <a:pt x="691" y="1077"/>
                  </a:lnTo>
                  <a:lnTo>
                    <a:pt x="693" y="1077"/>
                  </a:lnTo>
                  <a:lnTo>
                    <a:pt x="695" y="1077"/>
                  </a:lnTo>
                  <a:lnTo>
                    <a:pt x="697" y="1077"/>
                  </a:lnTo>
                  <a:lnTo>
                    <a:pt x="699" y="1078"/>
                  </a:lnTo>
                  <a:lnTo>
                    <a:pt x="701" y="1078"/>
                  </a:lnTo>
                  <a:lnTo>
                    <a:pt x="703" y="1078"/>
                  </a:lnTo>
                  <a:lnTo>
                    <a:pt x="705" y="1078"/>
                  </a:lnTo>
                  <a:lnTo>
                    <a:pt x="707" y="1078"/>
                  </a:lnTo>
                  <a:lnTo>
                    <a:pt x="709" y="1078"/>
                  </a:lnTo>
                  <a:lnTo>
                    <a:pt x="711" y="1078"/>
                  </a:lnTo>
                  <a:lnTo>
                    <a:pt x="713" y="1078"/>
                  </a:lnTo>
                  <a:lnTo>
                    <a:pt x="715" y="1078"/>
                  </a:lnTo>
                  <a:lnTo>
                    <a:pt x="717" y="1078"/>
                  </a:lnTo>
                  <a:lnTo>
                    <a:pt x="719" y="1078"/>
                  </a:lnTo>
                  <a:lnTo>
                    <a:pt x="721" y="1078"/>
                  </a:lnTo>
                  <a:lnTo>
                    <a:pt x="723" y="1078"/>
                  </a:lnTo>
                  <a:lnTo>
                    <a:pt x="725" y="1078"/>
                  </a:lnTo>
                  <a:lnTo>
                    <a:pt x="727" y="1078"/>
                  </a:lnTo>
                  <a:lnTo>
                    <a:pt x="729" y="1078"/>
                  </a:lnTo>
                  <a:lnTo>
                    <a:pt x="731" y="1078"/>
                  </a:lnTo>
                  <a:lnTo>
                    <a:pt x="733" y="1078"/>
                  </a:lnTo>
                  <a:lnTo>
                    <a:pt x="735" y="1078"/>
                  </a:lnTo>
                  <a:lnTo>
                    <a:pt x="737" y="1078"/>
                  </a:lnTo>
                  <a:lnTo>
                    <a:pt x="739" y="1078"/>
                  </a:lnTo>
                  <a:lnTo>
                    <a:pt x="741" y="1077"/>
                  </a:lnTo>
                  <a:lnTo>
                    <a:pt x="743" y="1077"/>
                  </a:lnTo>
                  <a:lnTo>
                    <a:pt x="745" y="1077"/>
                  </a:lnTo>
                  <a:lnTo>
                    <a:pt x="747" y="1077"/>
                  </a:lnTo>
                  <a:lnTo>
                    <a:pt x="749" y="1077"/>
                  </a:lnTo>
                  <a:lnTo>
                    <a:pt x="751" y="1077"/>
                  </a:lnTo>
                  <a:lnTo>
                    <a:pt x="753" y="1077"/>
                  </a:lnTo>
                  <a:lnTo>
                    <a:pt x="755" y="1077"/>
                  </a:lnTo>
                  <a:lnTo>
                    <a:pt x="757" y="1077"/>
                  </a:lnTo>
                  <a:lnTo>
                    <a:pt x="759" y="1076"/>
                  </a:lnTo>
                  <a:lnTo>
                    <a:pt x="761" y="1076"/>
                  </a:lnTo>
                  <a:lnTo>
                    <a:pt x="763" y="1076"/>
                  </a:lnTo>
                  <a:lnTo>
                    <a:pt x="765" y="1076"/>
                  </a:lnTo>
                  <a:lnTo>
                    <a:pt x="767" y="1076"/>
                  </a:lnTo>
                  <a:lnTo>
                    <a:pt x="769" y="1076"/>
                  </a:lnTo>
                  <a:lnTo>
                    <a:pt x="771" y="1075"/>
                  </a:lnTo>
                  <a:lnTo>
                    <a:pt x="773" y="1075"/>
                  </a:lnTo>
                  <a:lnTo>
                    <a:pt x="775" y="1075"/>
                  </a:lnTo>
                  <a:lnTo>
                    <a:pt x="777" y="1075"/>
                  </a:lnTo>
                  <a:lnTo>
                    <a:pt x="779" y="1075"/>
                  </a:lnTo>
                  <a:lnTo>
                    <a:pt x="781" y="1075"/>
                  </a:lnTo>
                  <a:lnTo>
                    <a:pt x="784" y="1075"/>
                  </a:lnTo>
                  <a:lnTo>
                    <a:pt x="786" y="1074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1600" name="ZoneTexte 1599"/>
          <p:cNvSpPr txBox="1"/>
          <p:nvPr/>
        </p:nvSpPr>
        <p:spPr>
          <a:xfrm>
            <a:off x="3717032" y="3395274"/>
            <a:ext cx="217925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OPDV_11715::Tn2.13</a:t>
            </a:r>
            <a:endParaRPr lang="fr-FR" i="1" dirty="0"/>
          </a:p>
        </p:txBody>
      </p:sp>
      <p:grpSp>
        <p:nvGrpSpPr>
          <p:cNvPr id="1715" name="Groupe 1714"/>
          <p:cNvGrpSpPr/>
          <p:nvPr/>
        </p:nvGrpSpPr>
        <p:grpSpPr>
          <a:xfrm>
            <a:off x="3686006" y="5251499"/>
            <a:ext cx="2876550" cy="2011363"/>
            <a:chOff x="3741738" y="6269038"/>
            <a:chExt cx="2876550" cy="2011363"/>
          </a:xfrm>
        </p:grpSpPr>
        <p:sp>
          <p:nvSpPr>
            <p:cNvPr id="1713" name="Freeform 708"/>
            <p:cNvSpPr>
              <a:spLocks/>
            </p:cNvSpPr>
            <p:nvPr/>
          </p:nvSpPr>
          <p:spPr bwMode="auto">
            <a:xfrm>
              <a:off x="3741738" y="7707313"/>
              <a:ext cx="1628775" cy="573088"/>
            </a:xfrm>
            <a:custGeom>
              <a:avLst/>
              <a:gdLst>
                <a:gd name="T0" fmla="*/ 14 w 1026"/>
                <a:gd name="T1" fmla="*/ 352 h 361"/>
                <a:gd name="T2" fmla="*/ 30 w 1026"/>
                <a:gd name="T3" fmla="*/ 351 h 361"/>
                <a:gd name="T4" fmla="*/ 46 w 1026"/>
                <a:gd name="T5" fmla="*/ 351 h 361"/>
                <a:gd name="T6" fmla="*/ 62 w 1026"/>
                <a:gd name="T7" fmla="*/ 350 h 361"/>
                <a:gd name="T8" fmla="*/ 78 w 1026"/>
                <a:gd name="T9" fmla="*/ 349 h 361"/>
                <a:gd name="T10" fmla="*/ 94 w 1026"/>
                <a:gd name="T11" fmla="*/ 349 h 361"/>
                <a:gd name="T12" fmla="*/ 110 w 1026"/>
                <a:gd name="T13" fmla="*/ 348 h 361"/>
                <a:gd name="T14" fmla="*/ 126 w 1026"/>
                <a:gd name="T15" fmla="*/ 348 h 361"/>
                <a:gd name="T16" fmla="*/ 142 w 1026"/>
                <a:gd name="T17" fmla="*/ 347 h 361"/>
                <a:gd name="T18" fmla="*/ 159 w 1026"/>
                <a:gd name="T19" fmla="*/ 347 h 361"/>
                <a:gd name="T20" fmla="*/ 175 w 1026"/>
                <a:gd name="T21" fmla="*/ 357 h 361"/>
                <a:gd name="T22" fmla="*/ 191 w 1026"/>
                <a:gd name="T23" fmla="*/ 345 h 361"/>
                <a:gd name="T24" fmla="*/ 207 w 1026"/>
                <a:gd name="T25" fmla="*/ 222 h 361"/>
                <a:gd name="T26" fmla="*/ 223 w 1026"/>
                <a:gd name="T27" fmla="*/ 341 h 361"/>
                <a:gd name="T28" fmla="*/ 239 w 1026"/>
                <a:gd name="T29" fmla="*/ 336 h 361"/>
                <a:gd name="T30" fmla="*/ 255 w 1026"/>
                <a:gd name="T31" fmla="*/ 341 h 361"/>
                <a:gd name="T32" fmla="*/ 271 w 1026"/>
                <a:gd name="T33" fmla="*/ 336 h 361"/>
                <a:gd name="T34" fmla="*/ 288 w 1026"/>
                <a:gd name="T35" fmla="*/ 339 h 361"/>
                <a:gd name="T36" fmla="*/ 304 w 1026"/>
                <a:gd name="T37" fmla="*/ 340 h 361"/>
                <a:gd name="T38" fmla="*/ 320 w 1026"/>
                <a:gd name="T39" fmla="*/ 339 h 361"/>
                <a:gd name="T40" fmla="*/ 336 w 1026"/>
                <a:gd name="T41" fmla="*/ 332 h 361"/>
                <a:gd name="T42" fmla="*/ 352 w 1026"/>
                <a:gd name="T43" fmla="*/ 339 h 361"/>
                <a:gd name="T44" fmla="*/ 368 w 1026"/>
                <a:gd name="T45" fmla="*/ 339 h 361"/>
                <a:gd name="T46" fmla="*/ 384 w 1026"/>
                <a:gd name="T47" fmla="*/ 338 h 361"/>
                <a:gd name="T48" fmla="*/ 400 w 1026"/>
                <a:gd name="T49" fmla="*/ 337 h 361"/>
                <a:gd name="T50" fmla="*/ 416 w 1026"/>
                <a:gd name="T51" fmla="*/ 337 h 361"/>
                <a:gd name="T52" fmla="*/ 432 w 1026"/>
                <a:gd name="T53" fmla="*/ 337 h 361"/>
                <a:gd name="T54" fmla="*/ 448 w 1026"/>
                <a:gd name="T55" fmla="*/ 336 h 361"/>
                <a:gd name="T56" fmla="*/ 465 w 1026"/>
                <a:gd name="T57" fmla="*/ 335 h 361"/>
                <a:gd name="T58" fmla="*/ 481 w 1026"/>
                <a:gd name="T59" fmla="*/ 335 h 361"/>
                <a:gd name="T60" fmla="*/ 497 w 1026"/>
                <a:gd name="T61" fmla="*/ 336 h 361"/>
                <a:gd name="T62" fmla="*/ 513 w 1026"/>
                <a:gd name="T63" fmla="*/ 333 h 361"/>
                <a:gd name="T64" fmla="*/ 529 w 1026"/>
                <a:gd name="T65" fmla="*/ 325 h 361"/>
                <a:gd name="T66" fmla="*/ 545 w 1026"/>
                <a:gd name="T67" fmla="*/ 331 h 361"/>
                <a:gd name="T68" fmla="*/ 561 w 1026"/>
                <a:gd name="T69" fmla="*/ 333 h 361"/>
                <a:gd name="T70" fmla="*/ 577 w 1026"/>
                <a:gd name="T71" fmla="*/ 333 h 361"/>
                <a:gd name="T72" fmla="*/ 594 w 1026"/>
                <a:gd name="T73" fmla="*/ 337 h 361"/>
                <a:gd name="T74" fmla="*/ 610 w 1026"/>
                <a:gd name="T75" fmla="*/ 342 h 361"/>
                <a:gd name="T76" fmla="*/ 626 w 1026"/>
                <a:gd name="T77" fmla="*/ 343 h 361"/>
                <a:gd name="T78" fmla="*/ 642 w 1026"/>
                <a:gd name="T79" fmla="*/ 341 h 361"/>
                <a:gd name="T80" fmla="*/ 658 w 1026"/>
                <a:gd name="T81" fmla="*/ 340 h 361"/>
                <a:gd name="T82" fmla="*/ 674 w 1026"/>
                <a:gd name="T83" fmla="*/ 338 h 361"/>
                <a:gd name="T84" fmla="*/ 690 w 1026"/>
                <a:gd name="T85" fmla="*/ 338 h 361"/>
                <a:gd name="T86" fmla="*/ 706 w 1026"/>
                <a:gd name="T87" fmla="*/ 338 h 361"/>
                <a:gd name="T88" fmla="*/ 722 w 1026"/>
                <a:gd name="T89" fmla="*/ 335 h 361"/>
                <a:gd name="T90" fmla="*/ 738 w 1026"/>
                <a:gd name="T91" fmla="*/ 333 h 361"/>
                <a:gd name="T92" fmla="*/ 755 w 1026"/>
                <a:gd name="T93" fmla="*/ 332 h 361"/>
                <a:gd name="T94" fmla="*/ 771 w 1026"/>
                <a:gd name="T95" fmla="*/ 332 h 361"/>
                <a:gd name="T96" fmla="*/ 787 w 1026"/>
                <a:gd name="T97" fmla="*/ 328 h 361"/>
                <a:gd name="T98" fmla="*/ 803 w 1026"/>
                <a:gd name="T99" fmla="*/ 324 h 361"/>
                <a:gd name="T100" fmla="*/ 819 w 1026"/>
                <a:gd name="T101" fmla="*/ 326 h 361"/>
                <a:gd name="T102" fmla="*/ 835 w 1026"/>
                <a:gd name="T103" fmla="*/ 327 h 361"/>
                <a:gd name="T104" fmla="*/ 851 w 1026"/>
                <a:gd name="T105" fmla="*/ 326 h 361"/>
                <a:gd name="T106" fmla="*/ 867 w 1026"/>
                <a:gd name="T107" fmla="*/ 325 h 361"/>
                <a:gd name="T108" fmla="*/ 883 w 1026"/>
                <a:gd name="T109" fmla="*/ 261 h 361"/>
                <a:gd name="T110" fmla="*/ 900 w 1026"/>
                <a:gd name="T111" fmla="*/ 27 h 361"/>
                <a:gd name="T112" fmla="*/ 916 w 1026"/>
                <a:gd name="T113" fmla="*/ 45 h 361"/>
                <a:gd name="T114" fmla="*/ 932 w 1026"/>
                <a:gd name="T115" fmla="*/ 189 h 361"/>
                <a:gd name="T116" fmla="*/ 948 w 1026"/>
                <a:gd name="T117" fmla="*/ 284 h 361"/>
                <a:gd name="T118" fmla="*/ 964 w 1026"/>
                <a:gd name="T119" fmla="*/ 303 h 361"/>
                <a:gd name="T120" fmla="*/ 980 w 1026"/>
                <a:gd name="T121" fmla="*/ 263 h 361"/>
                <a:gd name="T122" fmla="*/ 996 w 1026"/>
                <a:gd name="T123" fmla="*/ 212 h 361"/>
                <a:gd name="T124" fmla="*/ 1012 w 1026"/>
                <a:gd name="T125" fmla="*/ 196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1026" h="361">
                  <a:moveTo>
                    <a:pt x="0" y="353"/>
                  </a:moveTo>
                  <a:lnTo>
                    <a:pt x="2" y="352"/>
                  </a:lnTo>
                  <a:lnTo>
                    <a:pt x="4" y="352"/>
                  </a:lnTo>
                  <a:lnTo>
                    <a:pt x="6" y="352"/>
                  </a:lnTo>
                  <a:lnTo>
                    <a:pt x="8" y="352"/>
                  </a:lnTo>
                  <a:lnTo>
                    <a:pt x="10" y="352"/>
                  </a:lnTo>
                  <a:lnTo>
                    <a:pt x="12" y="352"/>
                  </a:lnTo>
                  <a:lnTo>
                    <a:pt x="14" y="352"/>
                  </a:lnTo>
                  <a:lnTo>
                    <a:pt x="16" y="352"/>
                  </a:lnTo>
                  <a:lnTo>
                    <a:pt x="18" y="352"/>
                  </a:lnTo>
                  <a:lnTo>
                    <a:pt x="20" y="351"/>
                  </a:lnTo>
                  <a:lnTo>
                    <a:pt x="22" y="351"/>
                  </a:lnTo>
                  <a:lnTo>
                    <a:pt x="24" y="351"/>
                  </a:lnTo>
                  <a:lnTo>
                    <a:pt x="26" y="351"/>
                  </a:lnTo>
                  <a:lnTo>
                    <a:pt x="28" y="351"/>
                  </a:lnTo>
                  <a:lnTo>
                    <a:pt x="30" y="351"/>
                  </a:lnTo>
                  <a:lnTo>
                    <a:pt x="32" y="351"/>
                  </a:lnTo>
                  <a:lnTo>
                    <a:pt x="34" y="351"/>
                  </a:lnTo>
                  <a:lnTo>
                    <a:pt x="36" y="351"/>
                  </a:lnTo>
                  <a:lnTo>
                    <a:pt x="38" y="351"/>
                  </a:lnTo>
                  <a:lnTo>
                    <a:pt x="40" y="351"/>
                  </a:lnTo>
                  <a:lnTo>
                    <a:pt x="42" y="351"/>
                  </a:lnTo>
                  <a:lnTo>
                    <a:pt x="44" y="351"/>
                  </a:lnTo>
                  <a:lnTo>
                    <a:pt x="46" y="351"/>
                  </a:lnTo>
                  <a:lnTo>
                    <a:pt x="48" y="350"/>
                  </a:lnTo>
                  <a:lnTo>
                    <a:pt x="50" y="350"/>
                  </a:lnTo>
                  <a:lnTo>
                    <a:pt x="52" y="350"/>
                  </a:lnTo>
                  <a:lnTo>
                    <a:pt x="54" y="350"/>
                  </a:lnTo>
                  <a:lnTo>
                    <a:pt x="56" y="350"/>
                  </a:lnTo>
                  <a:lnTo>
                    <a:pt x="58" y="350"/>
                  </a:lnTo>
                  <a:lnTo>
                    <a:pt x="60" y="350"/>
                  </a:lnTo>
                  <a:lnTo>
                    <a:pt x="62" y="350"/>
                  </a:lnTo>
                  <a:lnTo>
                    <a:pt x="64" y="350"/>
                  </a:lnTo>
                  <a:lnTo>
                    <a:pt x="66" y="350"/>
                  </a:lnTo>
                  <a:lnTo>
                    <a:pt x="68" y="350"/>
                  </a:lnTo>
                  <a:lnTo>
                    <a:pt x="70" y="350"/>
                  </a:lnTo>
                  <a:lnTo>
                    <a:pt x="72" y="350"/>
                  </a:lnTo>
                  <a:lnTo>
                    <a:pt x="74" y="350"/>
                  </a:lnTo>
                  <a:lnTo>
                    <a:pt x="76" y="349"/>
                  </a:lnTo>
                  <a:lnTo>
                    <a:pt x="78" y="349"/>
                  </a:lnTo>
                  <a:lnTo>
                    <a:pt x="80" y="349"/>
                  </a:lnTo>
                  <a:lnTo>
                    <a:pt x="82" y="349"/>
                  </a:lnTo>
                  <a:lnTo>
                    <a:pt x="84" y="349"/>
                  </a:lnTo>
                  <a:lnTo>
                    <a:pt x="86" y="349"/>
                  </a:lnTo>
                  <a:lnTo>
                    <a:pt x="88" y="349"/>
                  </a:lnTo>
                  <a:lnTo>
                    <a:pt x="90" y="349"/>
                  </a:lnTo>
                  <a:lnTo>
                    <a:pt x="92" y="349"/>
                  </a:lnTo>
                  <a:lnTo>
                    <a:pt x="94" y="349"/>
                  </a:lnTo>
                  <a:lnTo>
                    <a:pt x="96" y="349"/>
                  </a:lnTo>
                  <a:lnTo>
                    <a:pt x="98" y="349"/>
                  </a:lnTo>
                  <a:lnTo>
                    <a:pt x="100" y="349"/>
                  </a:lnTo>
                  <a:lnTo>
                    <a:pt x="102" y="349"/>
                  </a:lnTo>
                  <a:lnTo>
                    <a:pt x="104" y="348"/>
                  </a:lnTo>
                  <a:lnTo>
                    <a:pt x="106" y="348"/>
                  </a:lnTo>
                  <a:lnTo>
                    <a:pt x="108" y="348"/>
                  </a:lnTo>
                  <a:lnTo>
                    <a:pt x="110" y="348"/>
                  </a:lnTo>
                  <a:lnTo>
                    <a:pt x="112" y="348"/>
                  </a:lnTo>
                  <a:lnTo>
                    <a:pt x="114" y="348"/>
                  </a:lnTo>
                  <a:lnTo>
                    <a:pt x="116" y="348"/>
                  </a:lnTo>
                  <a:lnTo>
                    <a:pt x="118" y="348"/>
                  </a:lnTo>
                  <a:lnTo>
                    <a:pt x="120" y="348"/>
                  </a:lnTo>
                  <a:lnTo>
                    <a:pt x="122" y="348"/>
                  </a:lnTo>
                  <a:lnTo>
                    <a:pt x="124" y="348"/>
                  </a:lnTo>
                  <a:lnTo>
                    <a:pt x="126" y="348"/>
                  </a:lnTo>
                  <a:lnTo>
                    <a:pt x="128" y="348"/>
                  </a:lnTo>
                  <a:lnTo>
                    <a:pt x="130" y="347"/>
                  </a:lnTo>
                  <a:lnTo>
                    <a:pt x="132" y="347"/>
                  </a:lnTo>
                  <a:lnTo>
                    <a:pt x="135" y="347"/>
                  </a:lnTo>
                  <a:lnTo>
                    <a:pt x="136" y="347"/>
                  </a:lnTo>
                  <a:lnTo>
                    <a:pt x="138" y="347"/>
                  </a:lnTo>
                  <a:lnTo>
                    <a:pt x="140" y="347"/>
                  </a:lnTo>
                  <a:lnTo>
                    <a:pt x="142" y="347"/>
                  </a:lnTo>
                  <a:lnTo>
                    <a:pt x="145" y="347"/>
                  </a:lnTo>
                  <a:lnTo>
                    <a:pt x="147" y="347"/>
                  </a:lnTo>
                  <a:lnTo>
                    <a:pt x="149" y="347"/>
                  </a:lnTo>
                  <a:lnTo>
                    <a:pt x="151" y="347"/>
                  </a:lnTo>
                  <a:lnTo>
                    <a:pt x="153" y="347"/>
                  </a:lnTo>
                  <a:lnTo>
                    <a:pt x="155" y="347"/>
                  </a:lnTo>
                  <a:lnTo>
                    <a:pt x="157" y="347"/>
                  </a:lnTo>
                  <a:lnTo>
                    <a:pt x="159" y="347"/>
                  </a:lnTo>
                  <a:lnTo>
                    <a:pt x="161" y="346"/>
                  </a:lnTo>
                  <a:lnTo>
                    <a:pt x="163" y="347"/>
                  </a:lnTo>
                  <a:lnTo>
                    <a:pt x="165" y="349"/>
                  </a:lnTo>
                  <a:lnTo>
                    <a:pt x="167" y="356"/>
                  </a:lnTo>
                  <a:lnTo>
                    <a:pt x="169" y="360"/>
                  </a:lnTo>
                  <a:lnTo>
                    <a:pt x="171" y="361"/>
                  </a:lnTo>
                  <a:lnTo>
                    <a:pt x="173" y="359"/>
                  </a:lnTo>
                  <a:lnTo>
                    <a:pt x="175" y="357"/>
                  </a:lnTo>
                  <a:lnTo>
                    <a:pt x="177" y="354"/>
                  </a:lnTo>
                  <a:lnTo>
                    <a:pt x="179" y="351"/>
                  </a:lnTo>
                  <a:lnTo>
                    <a:pt x="181" y="349"/>
                  </a:lnTo>
                  <a:lnTo>
                    <a:pt x="183" y="348"/>
                  </a:lnTo>
                  <a:lnTo>
                    <a:pt x="185" y="347"/>
                  </a:lnTo>
                  <a:lnTo>
                    <a:pt x="187" y="346"/>
                  </a:lnTo>
                  <a:lnTo>
                    <a:pt x="189" y="345"/>
                  </a:lnTo>
                  <a:lnTo>
                    <a:pt x="191" y="345"/>
                  </a:lnTo>
                  <a:lnTo>
                    <a:pt x="193" y="345"/>
                  </a:lnTo>
                  <a:lnTo>
                    <a:pt x="195" y="339"/>
                  </a:lnTo>
                  <a:lnTo>
                    <a:pt x="197" y="312"/>
                  </a:lnTo>
                  <a:lnTo>
                    <a:pt x="199" y="259"/>
                  </a:lnTo>
                  <a:lnTo>
                    <a:pt x="201" y="214"/>
                  </a:lnTo>
                  <a:lnTo>
                    <a:pt x="203" y="196"/>
                  </a:lnTo>
                  <a:lnTo>
                    <a:pt x="205" y="202"/>
                  </a:lnTo>
                  <a:lnTo>
                    <a:pt x="207" y="222"/>
                  </a:lnTo>
                  <a:lnTo>
                    <a:pt x="209" y="249"/>
                  </a:lnTo>
                  <a:lnTo>
                    <a:pt x="211" y="277"/>
                  </a:lnTo>
                  <a:lnTo>
                    <a:pt x="213" y="302"/>
                  </a:lnTo>
                  <a:lnTo>
                    <a:pt x="215" y="321"/>
                  </a:lnTo>
                  <a:lnTo>
                    <a:pt x="217" y="332"/>
                  </a:lnTo>
                  <a:lnTo>
                    <a:pt x="219" y="337"/>
                  </a:lnTo>
                  <a:lnTo>
                    <a:pt x="221" y="340"/>
                  </a:lnTo>
                  <a:lnTo>
                    <a:pt x="223" y="341"/>
                  </a:lnTo>
                  <a:lnTo>
                    <a:pt x="225" y="342"/>
                  </a:lnTo>
                  <a:lnTo>
                    <a:pt x="227" y="342"/>
                  </a:lnTo>
                  <a:lnTo>
                    <a:pt x="229" y="342"/>
                  </a:lnTo>
                  <a:lnTo>
                    <a:pt x="231" y="342"/>
                  </a:lnTo>
                  <a:lnTo>
                    <a:pt x="233" y="340"/>
                  </a:lnTo>
                  <a:lnTo>
                    <a:pt x="235" y="338"/>
                  </a:lnTo>
                  <a:lnTo>
                    <a:pt x="237" y="337"/>
                  </a:lnTo>
                  <a:lnTo>
                    <a:pt x="239" y="336"/>
                  </a:lnTo>
                  <a:lnTo>
                    <a:pt x="241" y="336"/>
                  </a:lnTo>
                  <a:lnTo>
                    <a:pt x="243" y="336"/>
                  </a:lnTo>
                  <a:lnTo>
                    <a:pt x="245" y="337"/>
                  </a:lnTo>
                  <a:lnTo>
                    <a:pt x="247" y="338"/>
                  </a:lnTo>
                  <a:lnTo>
                    <a:pt x="249" y="339"/>
                  </a:lnTo>
                  <a:lnTo>
                    <a:pt x="251" y="339"/>
                  </a:lnTo>
                  <a:lnTo>
                    <a:pt x="253" y="340"/>
                  </a:lnTo>
                  <a:lnTo>
                    <a:pt x="255" y="341"/>
                  </a:lnTo>
                  <a:lnTo>
                    <a:pt x="257" y="341"/>
                  </a:lnTo>
                  <a:lnTo>
                    <a:pt x="259" y="341"/>
                  </a:lnTo>
                  <a:lnTo>
                    <a:pt x="261" y="341"/>
                  </a:lnTo>
                  <a:lnTo>
                    <a:pt x="263" y="341"/>
                  </a:lnTo>
                  <a:lnTo>
                    <a:pt x="265" y="341"/>
                  </a:lnTo>
                  <a:lnTo>
                    <a:pt x="267" y="340"/>
                  </a:lnTo>
                  <a:lnTo>
                    <a:pt x="269" y="339"/>
                  </a:lnTo>
                  <a:lnTo>
                    <a:pt x="271" y="336"/>
                  </a:lnTo>
                  <a:lnTo>
                    <a:pt x="273" y="334"/>
                  </a:lnTo>
                  <a:lnTo>
                    <a:pt x="275" y="334"/>
                  </a:lnTo>
                  <a:lnTo>
                    <a:pt x="277" y="334"/>
                  </a:lnTo>
                  <a:lnTo>
                    <a:pt x="279" y="335"/>
                  </a:lnTo>
                  <a:lnTo>
                    <a:pt x="281" y="336"/>
                  </a:lnTo>
                  <a:lnTo>
                    <a:pt x="283" y="337"/>
                  </a:lnTo>
                  <a:lnTo>
                    <a:pt x="285" y="338"/>
                  </a:lnTo>
                  <a:lnTo>
                    <a:pt x="288" y="339"/>
                  </a:lnTo>
                  <a:lnTo>
                    <a:pt x="290" y="340"/>
                  </a:lnTo>
                  <a:lnTo>
                    <a:pt x="291" y="340"/>
                  </a:lnTo>
                  <a:lnTo>
                    <a:pt x="293" y="341"/>
                  </a:lnTo>
                  <a:lnTo>
                    <a:pt x="295" y="341"/>
                  </a:lnTo>
                  <a:lnTo>
                    <a:pt x="298" y="341"/>
                  </a:lnTo>
                  <a:lnTo>
                    <a:pt x="300" y="340"/>
                  </a:lnTo>
                  <a:lnTo>
                    <a:pt x="302" y="341"/>
                  </a:lnTo>
                  <a:lnTo>
                    <a:pt x="304" y="340"/>
                  </a:lnTo>
                  <a:lnTo>
                    <a:pt x="306" y="340"/>
                  </a:lnTo>
                  <a:lnTo>
                    <a:pt x="308" y="340"/>
                  </a:lnTo>
                  <a:lnTo>
                    <a:pt x="310" y="340"/>
                  </a:lnTo>
                  <a:lnTo>
                    <a:pt x="312" y="340"/>
                  </a:lnTo>
                  <a:lnTo>
                    <a:pt x="314" y="340"/>
                  </a:lnTo>
                  <a:lnTo>
                    <a:pt x="316" y="339"/>
                  </a:lnTo>
                  <a:lnTo>
                    <a:pt x="318" y="339"/>
                  </a:lnTo>
                  <a:lnTo>
                    <a:pt x="320" y="339"/>
                  </a:lnTo>
                  <a:lnTo>
                    <a:pt x="322" y="339"/>
                  </a:lnTo>
                  <a:lnTo>
                    <a:pt x="324" y="339"/>
                  </a:lnTo>
                  <a:lnTo>
                    <a:pt x="326" y="338"/>
                  </a:lnTo>
                  <a:lnTo>
                    <a:pt x="328" y="336"/>
                  </a:lnTo>
                  <a:lnTo>
                    <a:pt x="330" y="335"/>
                  </a:lnTo>
                  <a:lnTo>
                    <a:pt x="332" y="333"/>
                  </a:lnTo>
                  <a:lnTo>
                    <a:pt x="334" y="332"/>
                  </a:lnTo>
                  <a:lnTo>
                    <a:pt x="336" y="332"/>
                  </a:lnTo>
                  <a:lnTo>
                    <a:pt x="338" y="332"/>
                  </a:lnTo>
                  <a:lnTo>
                    <a:pt x="340" y="333"/>
                  </a:lnTo>
                  <a:lnTo>
                    <a:pt x="342" y="334"/>
                  </a:lnTo>
                  <a:lnTo>
                    <a:pt x="344" y="335"/>
                  </a:lnTo>
                  <a:lnTo>
                    <a:pt x="346" y="336"/>
                  </a:lnTo>
                  <a:lnTo>
                    <a:pt x="348" y="337"/>
                  </a:lnTo>
                  <a:lnTo>
                    <a:pt x="350" y="338"/>
                  </a:lnTo>
                  <a:lnTo>
                    <a:pt x="352" y="339"/>
                  </a:lnTo>
                  <a:lnTo>
                    <a:pt x="354" y="339"/>
                  </a:lnTo>
                  <a:lnTo>
                    <a:pt x="356" y="340"/>
                  </a:lnTo>
                  <a:lnTo>
                    <a:pt x="358" y="340"/>
                  </a:lnTo>
                  <a:lnTo>
                    <a:pt x="360" y="340"/>
                  </a:lnTo>
                  <a:lnTo>
                    <a:pt x="362" y="339"/>
                  </a:lnTo>
                  <a:lnTo>
                    <a:pt x="364" y="339"/>
                  </a:lnTo>
                  <a:lnTo>
                    <a:pt x="366" y="339"/>
                  </a:lnTo>
                  <a:lnTo>
                    <a:pt x="368" y="339"/>
                  </a:lnTo>
                  <a:lnTo>
                    <a:pt x="370" y="338"/>
                  </a:lnTo>
                  <a:lnTo>
                    <a:pt x="372" y="338"/>
                  </a:lnTo>
                  <a:lnTo>
                    <a:pt x="374" y="338"/>
                  </a:lnTo>
                  <a:lnTo>
                    <a:pt x="376" y="338"/>
                  </a:lnTo>
                  <a:lnTo>
                    <a:pt x="378" y="338"/>
                  </a:lnTo>
                  <a:lnTo>
                    <a:pt x="380" y="338"/>
                  </a:lnTo>
                  <a:lnTo>
                    <a:pt x="382" y="338"/>
                  </a:lnTo>
                  <a:lnTo>
                    <a:pt x="384" y="338"/>
                  </a:lnTo>
                  <a:lnTo>
                    <a:pt x="386" y="338"/>
                  </a:lnTo>
                  <a:lnTo>
                    <a:pt x="388" y="338"/>
                  </a:lnTo>
                  <a:lnTo>
                    <a:pt x="390" y="338"/>
                  </a:lnTo>
                  <a:lnTo>
                    <a:pt x="392" y="338"/>
                  </a:lnTo>
                  <a:lnTo>
                    <a:pt x="394" y="338"/>
                  </a:lnTo>
                  <a:lnTo>
                    <a:pt x="396" y="338"/>
                  </a:lnTo>
                  <a:lnTo>
                    <a:pt x="398" y="338"/>
                  </a:lnTo>
                  <a:lnTo>
                    <a:pt x="400" y="337"/>
                  </a:lnTo>
                  <a:lnTo>
                    <a:pt x="402" y="337"/>
                  </a:lnTo>
                  <a:lnTo>
                    <a:pt x="404" y="338"/>
                  </a:lnTo>
                  <a:lnTo>
                    <a:pt x="406" y="337"/>
                  </a:lnTo>
                  <a:lnTo>
                    <a:pt x="408" y="337"/>
                  </a:lnTo>
                  <a:lnTo>
                    <a:pt x="410" y="337"/>
                  </a:lnTo>
                  <a:lnTo>
                    <a:pt x="412" y="337"/>
                  </a:lnTo>
                  <a:lnTo>
                    <a:pt x="414" y="337"/>
                  </a:lnTo>
                  <a:lnTo>
                    <a:pt x="416" y="337"/>
                  </a:lnTo>
                  <a:lnTo>
                    <a:pt x="418" y="337"/>
                  </a:lnTo>
                  <a:lnTo>
                    <a:pt x="420" y="337"/>
                  </a:lnTo>
                  <a:lnTo>
                    <a:pt x="422" y="337"/>
                  </a:lnTo>
                  <a:lnTo>
                    <a:pt x="424" y="337"/>
                  </a:lnTo>
                  <a:lnTo>
                    <a:pt x="426" y="337"/>
                  </a:lnTo>
                  <a:lnTo>
                    <a:pt x="428" y="337"/>
                  </a:lnTo>
                  <a:lnTo>
                    <a:pt x="430" y="337"/>
                  </a:lnTo>
                  <a:lnTo>
                    <a:pt x="432" y="337"/>
                  </a:lnTo>
                  <a:lnTo>
                    <a:pt x="434" y="337"/>
                  </a:lnTo>
                  <a:lnTo>
                    <a:pt x="436" y="337"/>
                  </a:lnTo>
                  <a:lnTo>
                    <a:pt x="438" y="337"/>
                  </a:lnTo>
                  <a:lnTo>
                    <a:pt x="441" y="337"/>
                  </a:lnTo>
                  <a:lnTo>
                    <a:pt x="443" y="337"/>
                  </a:lnTo>
                  <a:lnTo>
                    <a:pt x="445" y="336"/>
                  </a:lnTo>
                  <a:lnTo>
                    <a:pt x="446" y="336"/>
                  </a:lnTo>
                  <a:lnTo>
                    <a:pt x="448" y="336"/>
                  </a:lnTo>
                  <a:lnTo>
                    <a:pt x="451" y="336"/>
                  </a:lnTo>
                  <a:lnTo>
                    <a:pt x="453" y="336"/>
                  </a:lnTo>
                  <a:lnTo>
                    <a:pt x="455" y="335"/>
                  </a:lnTo>
                  <a:lnTo>
                    <a:pt x="457" y="335"/>
                  </a:lnTo>
                  <a:lnTo>
                    <a:pt x="459" y="335"/>
                  </a:lnTo>
                  <a:lnTo>
                    <a:pt x="461" y="335"/>
                  </a:lnTo>
                  <a:lnTo>
                    <a:pt x="463" y="335"/>
                  </a:lnTo>
                  <a:lnTo>
                    <a:pt x="465" y="335"/>
                  </a:lnTo>
                  <a:lnTo>
                    <a:pt x="467" y="335"/>
                  </a:lnTo>
                  <a:lnTo>
                    <a:pt x="469" y="335"/>
                  </a:lnTo>
                  <a:lnTo>
                    <a:pt x="471" y="335"/>
                  </a:lnTo>
                  <a:lnTo>
                    <a:pt x="473" y="335"/>
                  </a:lnTo>
                  <a:lnTo>
                    <a:pt x="475" y="335"/>
                  </a:lnTo>
                  <a:lnTo>
                    <a:pt x="477" y="335"/>
                  </a:lnTo>
                  <a:lnTo>
                    <a:pt x="479" y="335"/>
                  </a:lnTo>
                  <a:lnTo>
                    <a:pt x="481" y="335"/>
                  </a:lnTo>
                  <a:lnTo>
                    <a:pt x="483" y="335"/>
                  </a:lnTo>
                  <a:lnTo>
                    <a:pt x="485" y="335"/>
                  </a:lnTo>
                  <a:lnTo>
                    <a:pt x="487" y="336"/>
                  </a:lnTo>
                  <a:lnTo>
                    <a:pt x="489" y="335"/>
                  </a:lnTo>
                  <a:lnTo>
                    <a:pt x="491" y="335"/>
                  </a:lnTo>
                  <a:lnTo>
                    <a:pt x="493" y="336"/>
                  </a:lnTo>
                  <a:lnTo>
                    <a:pt x="495" y="336"/>
                  </a:lnTo>
                  <a:lnTo>
                    <a:pt x="497" y="336"/>
                  </a:lnTo>
                  <a:lnTo>
                    <a:pt x="499" y="336"/>
                  </a:lnTo>
                  <a:lnTo>
                    <a:pt x="501" y="336"/>
                  </a:lnTo>
                  <a:lnTo>
                    <a:pt x="503" y="336"/>
                  </a:lnTo>
                  <a:lnTo>
                    <a:pt x="505" y="336"/>
                  </a:lnTo>
                  <a:lnTo>
                    <a:pt x="507" y="336"/>
                  </a:lnTo>
                  <a:lnTo>
                    <a:pt x="509" y="335"/>
                  </a:lnTo>
                  <a:lnTo>
                    <a:pt x="511" y="334"/>
                  </a:lnTo>
                  <a:lnTo>
                    <a:pt x="513" y="333"/>
                  </a:lnTo>
                  <a:lnTo>
                    <a:pt x="515" y="331"/>
                  </a:lnTo>
                  <a:lnTo>
                    <a:pt x="517" y="329"/>
                  </a:lnTo>
                  <a:lnTo>
                    <a:pt x="519" y="326"/>
                  </a:lnTo>
                  <a:lnTo>
                    <a:pt x="521" y="325"/>
                  </a:lnTo>
                  <a:lnTo>
                    <a:pt x="523" y="324"/>
                  </a:lnTo>
                  <a:lnTo>
                    <a:pt x="525" y="324"/>
                  </a:lnTo>
                  <a:lnTo>
                    <a:pt x="527" y="324"/>
                  </a:lnTo>
                  <a:lnTo>
                    <a:pt x="529" y="325"/>
                  </a:lnTo>
                  <a:lnTo>
                    <a:pt x="531" y="326"/>
                  </a:lnTo>
                  <a:lnTo>
                    <a:pt x="533" y="327"/>
                  </a:lnTo>
                  <a:lnTo>
                    <a:pt x="535" y="327"/>
                  </a:lnTo>
                  <a:lnTo>
                    <a:pt x="537" y="328"/>
                  </a:lnTo>
                  <a:lnTo>
                    <a:pt x="539" y="329"/>
                  </a:lnTo>
                  <a:lnTo>
                    <a:pt x="541" y="330"/>
                  </a:lnTo>
                  <a:lnTo>
                    <a:pt x="543" y="331"/>
                  </a:lnTo>
                  <a:lnTo>
                    <a:pt x="545" y="331"/>
                  </a:lnTo>
                  <a:lnTo>
                    <a:pt x="547" y="332"/>
                  </a:lnTo>
                  <a:lnTo>
                    <a:pt x="549" y="332"/>
                  </a:lnTo>
                  <a:lnTo>
                    <a:pt x="551" y="332"/>
                  </a:lnTo>
                  <a:lnTo>
                    <a:pt x="553" y="333"/>
                  </a:lnTo>
                  <a:lnTo>
                    <a:pt x="555" y="333"/>
                  </a:lnTo>
                  <a:lnTo>
                    <a:pt x="557" y="333"/>
                  </a:lnTo>
                  <a:lnTo>
                    <a:pt x="559" y="333"/>
                  </a:lnTo>
                  <a:lnTo>
                    <a:pt x="561" y="333"/>
                  </a:lnTo>
                  <a:lnTo>
                    <a:pt x="563" y="333"/>
                  </a:lnTo>
                  <a:lnTo>
                    <a:pt x="565" y="333"/>
                  </a:lnTo>
                  <a:lnTo>
                    <a:pt x="567" y="333"/>
                  </a:lnTo>
                  <a:lnTo>
                    <a:pt x="569" y="333"/>
                  </a:lnTo>
                  <a:lnTo>
                    <a:pt x="571" y="333"/>
                  </a:lnTo>
                  <a:lnTo>
                    <a:pt x="573" y="333"/>
                  </a:lnTo>
                  <a:lnTo>
                    <a:pt x="575" y="333"/>
                  </a:lnTo>
                  <a:lnTo>
                    <a:pt x="577" y="333"/>
                  </a:lnTo>
                  <a:lnTo>
                    <a:pt x="579" y="333"/>
                  </a:lnTo>
                  <a:lnTo>
                    <a:pt x="581" y="334"/>
                  </a:lnTo>
                  <a:lnTo>
                    <a:pt x="583" y="334"/>
                  </a:lnTo>
                  <a:lnTo>
                    <a:pt x="585" y="334"/>
                  </a:lnTo>
                  <a:lnTo>
                    <a:pt x="587" y="335"/>
                  </a:lnTo>
                  <a:lnTo>
                    <a:pt x="589" y="336"/>
                  </a:lnTo>
                  <a:lnTo>
                    <a:pt x="591" y="336"/>
                  </a:lnTo>
                  <a:lnTo>
                    <a:pt x="594" y="337"/>
                  </a:lnTo>
                  <a:lnTo>
                    <a:pt x="596" y="338"/>
                  </a:lnTo>
                  <a:lnTo>
                    <a:pt x="598" y="339"/>
                  </a:lnTo>
                  <a:lnTo>
                    <a:pt x="600" y="340"/>
                  </a:lnTo>
                  <a:lnTo>
                    <a:pt x="602" y="340"/>
                  </a:lnTo>
                  <a:lnTo>
                    <a:pt x="604" y="341"/>
                  </a:lnTo>
                  <a:lnTo>
                    <a:pt x="606" y="341"/>
                  </a:lnTo>
                  <a:lnTo>
                    <a:pt x="608" y="342"/>
                  </a:lnTo>
                  <a:lnTo>
                    <a:pt x="610" y="342"/>
                  </a:lnTo>
                  <a:lnTo>
                    <a:pt x="612" y="342"/>
                  </a:lnTo>
                  <a:lnTo>
                    <a:pt x="614" y="343"/>
                  </a:lnTo>
                  <a:lnTo>
                    <a:pt x="616" y="343"/>
                  </a:lnTo>
                  <a:lnTo>
                    <a:pt x="618" y="343"/>
                  </a:lnTo>
                  <a:lnTo>
                    <a:pt x="620" y="343"/>
                  </a:lnTo>
                  <a:lnTo>
                    <a:pt x="622" y="343"/>
                  </a:lnTo>
                  <a:lnTo>
                    <a:pt x="624" y="343"/>
                  </a:lnTo>
                  <a:lnTo>
                    <a:pt x="626" y="343"/>
                  </a:lnTo>
                  <a:lnTo>
                    <a:pt x="628" y="343"/>
                  </a:lnTo>
                  <a:lnTo>
                    <a:pt x="630" y="343"/>
                  </a:lnTo>
                  <a:lnTo>
                    <a:pt x="632" y="342"/>
                  </a:lnTo>
                  <a:lnTo>
                    <a:pt x="634" y="342"/>
                  </a:lnTo>
                  <a:lnTo>
                    <a:pt x="636" y="342"/>
                  </a:lnTo>
                  <a:lnTo>
                    <a:pt x="638" y="342"/>
                  </a:lnTo>
                  <a:lnTo>
                    <a:pt x="640" y="341"/>
                  </a:lnTo>
                  <a:lnTo>
                    <a:pt x="642" y="341"/>
                  </a:lnTo>
                  <a:lnTo>
                    <a:pt x="644" y="341"/>
                  </a:lnTo>
                  <a:lnTo>
                    <a:pt x="646" y="341"/>
                  </a:lnTo>
                  <a:lnTo>
                    <a:pt x="648" y="341"/>
                  </a:lnTo>
                  <a:lnTo>
                    <a:pt x="650" y="340"/>
                  </a:lnTo>
                  <a:lnTo>
                    <a:pt x="652" y="340"/>
                  </a:lnTo>
                  <a:lnTo>
                    <a:pt x="654" y="340"/>
                  </a:lnTo>
                  <a:lnTo>
                    <a:pt x="656" y="340"/>
                  </a:lnTo>
                  <a:lnTo>
                    <a:pt x="658" y="340"/>
                  </a:lnTo>
                  <a:lnTo>
                    <a:pt x="660" y="339"/>
                  </a:lnTo>
                  <a:lnTo>
                    <a:pt x="662" y="339"/>
                  </a:lnTo>
                  <a:lnTo>
                    <a:pt x="664" y="339"/>
                  </a:lnTo>
                  <a:lnTo>
                    <a:pt x="666" y="339"/>
                  </a:lnTo>
                  <a:lnTo>
                    <a:pt x="668" y="339"/>
                  </a:lnTo>
                  <a:lnTo>
                    <a:pt x="670" y="338"/>
                  </a:lnTo>
                  <a:lnTo>
                    <a:pt x="672" y="338"/>
                  </a:lnTo>
                  <a:lnTo>
                    <a:pt x="674" y="338"/>
                  </a:lnTo>
                  <a:lnTo>
                    <a:pt x="676" y="338"/>
                  </a:lnTo>
                  <a:lnTo>
                    <a:pt x="678" y="338"/>
                  </a:lnTo>
                  <a:lnTo>
                    <a:pt x="680" y="338"/>
                  </a:lnTo>
                  <a:lnTo>
                    <a:pt x="682" y="338"/>
                  </a:lnTo>
                  <a:lnTo>
                    <a:pt x="684" y="338"/>
                  </a:lnTo>
                  <a:lnTo>
                    <a:pt x="686" y="338"/>
                  </a:lnTo>
                  <a:lnTo>
                    <a:pt x="688" y="338"/>
                  </a:lnTo>
                  <a:lnTo>
                    <a:pt x="690" y="338"/>
                  </a:lnTo>
                  <a:lnTo>
                    <a:pt x="692" y="339"/>
                  </a:lnTo>
                  <a:lnTo>
                    <a:pt x="694" y="339"/>
                  </a:lnTo>
                  <a:lnTo>
                    <a:pt x="696" y="339"/>
                  </a:lnTo>
                  <a:lnTo>
                    <a:pt x="698" y="339"/>
                  </a:lnTo>
                  <a:lnTo>
                    <a:pt x="700" y="339"/>
                  </a:lnTo>
                  <a:lnTo>
                    <a:pt x="702" y="338"/>
                  </a:lnTo>
                  <a:lnTo>
                    <a:pt x="704" y="338"/>
                  </a:lnTo>
                  <a:lnTo>
                    <a:pt x="706" y="338"/>
                  </a:lnTo>
                  <a:lnTo>
                    <a:pt x="708" y="337"/>
                  </a:lnTo>
                  <a:lnTo>
                    <a:pt x="710" y="337"/>
                  </a:lnTo>
                  <a:lnTo>
                    <a:pt x="712" y="337"/>
                  </a:lnTo>
                  <a:lnTo>
                    <a:pt x="714" y="336"/>
                  </a:lnTo>
                  <a:lnTo>
                    <a:pt x="716" y="336"/>
                  </a:lnTo>
                  <a:lnTo>
                    <a:pt x="718" y="336"/>
                  </a:lnTo>
                  <a:lnTo>
                    <a:pt x="720" y="335"/>
                  </a:lnTo>
                  <a:lnTo>
                    <a:pt x="722" y="335"/>
                  </a:lnTo>
                  <a:lnTo>
                    <a:pt x="724" y="335"/>
                  </a:lnTo>
                  <a:lnTo>
                    <a:pt x="726" y="334"/>
                  </a:lnTo>
                  <a:lnTo>
                    <a:pt x="728" y="334"/>
                  </a:lnTo>
                  <a:lnTo>
                    <a:pt x="730" y="334"/>
                  </a:lnTo>
                  <a:lnTo>
                    <a:pt x="732" y="333"/>
                  </a:lnTo>
                  <a:lnTo>
                    <a:pt x="734" y="333"/>
                  </a:lnTo>
                  <a:lnTo>
                    <a:pt x="736" y="333"/>
                  </a:lnTo>
                  <a:lnTo>
                    <a:pt x="738" y="333"/>
                  </a:lnTo>
                  <a:lnTo>
                    <a:pt x="740" y="333"/>
                  </a:lnTo>
                  <a:lnTo>
                    <a:pt x="742" y="333"/>
                  </a:lnTo>
                  <a:lnTo>
                    <a:pt x="744" y="332"/>
                  </a:lnTo>
                  <a:lnTo>
                    <a:pt x="747" y="332"/>
                  </a:lnTo>
                  <a:lnTo>
                    <a:pt x="749" y="332"/>
                  </a:lnTo>
                  <a:lnTo>
                    <a:pt x="751" y="332"/>
                  </a:lnTo>
                  <a:lnTo>
                    <a:pt x="753" y="332"/>
                  </a:lnTo>
                  <a:lnTo>
                    <a:pt x="755" y="332"/>
                  </a:lnTo>
                  <a:lnTo>
                    <a:pt x="757" y="332"/>
                  </a:lnTo>
                  <a:lnTo>
                    <a:pt x="759" y="332"/>
                  </a:lnTo>
                  <a:lnTo>
                    <a:pt x="761" y="332"/>
                  </a:lnTo>
                  <a:lnTo>
                    <a:pt x="763" y="332"/>
                  </a:lnTo>
                  <a:lnTo>
                    <a:pt x="765" y="332"/>
                  </a:lnTo>
                  <a:lnTo>
                    <a:pt x="767" y="332"/>
                  </a:lnTo>
                  <a:lnTo>
                    <a:pt x="769" y="332"/>
                  </a:lnTo>
                  <a:lnTo>
                    <a:pt x="771" y="332"/>
                  </a:lnTo>
                  <a:lnTo>
                    <a:pt x="773" y="332"/>
                  </a:lnTo>
                  <a:lnTo>
                    <a:pt x="775" y="332"/>
                  </a:lnTo>
                  <a:lnTo>
                    <a:pt x="777" y="331"/>
                  </a:lnTo>
                  <a:lnTo>
                    <a:pt x="779" y="331"/>
                  </a:lnTo>
                  <a:lnTo>
                    <a:pt x="781" y="330"/>
                  </a:lnTo>
                  <a:lnTo>
                    <a:pt x="783" y="330"/>
                  </a:lnTo>
                  <a:lnTo>
                    <a:pt x="785" y="329"/>
                  </a:lnTo>
                  <a:lnTo>
                    <a:pt x="787" y="328"/>
                  </a:lnTo>
                  <a:lnTo>
                    <a:pt x="789" y="327"/>
                  </a:lnTo>
                  <a:lnTo>
                    <a:pt x="791" y="326"/>
                  </a:lnTo>
                  <a:lnTo>
                    <a:pt x="793" y="325"/>
                  </a:lnTo>
                  <a:lnTo>
                    <a:pt x="795" y="324"/>
                  </a:lnTo>
                  <a:lnTo>
                    <a:pt x="797" y="324"/>
                  </a:lnTo>
                  <a:lnTo>
                    <a:pt x="799" y="323"/>
                  </a:lnTo>
                  <a:lnTo>
                    <a:pt x="801" y="323"/>
                  </a:lnTo>
                  <a:lnTo>
                    <a:pt x="803" y="324"/>
                  </a:lnTo>
                  <a:lnTo>
                    <a:pt x="805" y="324"/>
                  </a:lnTo>
                  <a:lnTo>
                    <a:pt x="807" y="324"/>
                  </a:lnTo>
                  <a:lnTo>
                    <a:pt x="809" y="324"/>
                  </a:lnTo>
                  <a:lnTo>
                    <a:pt x="811" y="325"/>
                  </a:lnTo>
                  <a:lnTo>
                    <a:pt x="813" y="325"/>
                  </a:lnTo>
                  <a:lnTo>
                    <a:pt x="815" y="325"/>
                  </a:lnTo>
                  <a:lnTo>
                    <a:pt x="817" y="326"/>
                  </a:lnTo>
                  <a:lnTo>
                    <a:pt x="819" y="326"/>
                  </a:lnTo>
                  <a:lnTo>
                    <a:pt x="821" y="327"/>
                  </a:lnTo>
                  <a:lnTo>
                    <a:pt x="823" y="327"/>
                  </a:lnTo>
                  <a:lnTo>
                    <a:pt x="825" y="327"/>
                  </a:lnTo>
                  <a:lnTo>
                    <a:pt x="827" y="327"/>
                  </a:lnTo>
                  <a:lnTo>
                    <a:pt x="829" y="327"/>
                  </a:lnTo>
                  <a:lnTo>
                    <a:pt x="831" y="327"/>
                  </a:lnTo>
                  <a:lnTo>
                    <a:pt x="833" y="327"/>
                  </a:lnTo>
                  <a:lnTo>
                    <a:pt x="835" y="327"/>
                  </a:lnTo>
                  <a:lnTo>
                    <a:pt x="837" y="327"/>
                  </a:lnTo>
                  <a:lnTo>
                    <a:pt x="839" y="327"/>
                  </a:lnTo>
                  <a:lnTo>
                    <a:pt x="841" y="327"/>
                  </a:lnTo>
                  <a:lnTo>
                    <a:pt x="843" y="327"/>
                  </a:lnTo>
                  <a:lnTo>
                    <a:pt x="845" y="327"/>
                  </a:lnTo>
                  <a:lnTo>
                    <a:pt x="847" y="327"/>
                  </a:lnTo>
                  <a:lnTo>
                    <a:pt x="849" y="327"/>
                  </a:lnTo>
                  <a:lnTo>
                    <a:pt x="851" y="326"/>
                  </a:lnTo>
                  <a:lnTo>
                    <a:pt x="853" y="326"/>
                  </a:lnTo>
                  <a:lnTo>
                    <a:pt x="855" y="326"/>
                  </a:lnTo>
                  <a:lnTo>
                    <a:pt x="857" y="326"/>
                  </a:lnTo>
                  <a:lnTo>
                    <a:pt x="859" y="326"/>
                  </a:lnTo>
                  <a:lnTo>
                    <a:pt x="861" y="326"/>
                  </a:lnTo>
                  <a:lnTo>
                    <a:pt x="863" y="326"/>
                  </a:lnTo>
                  <a:lnTo>
                    <a:pt x="865" y="325"/>
                  </a:lnTo>
                  <a:lnTo>
                    <a:pt x="867" y="325"/>
                  </a:lnTo>
                  <a:lnTo>
                    <a:pt x="869" y="324"/>
                  </a:lnTo>
                  <a:lnTo>
                    <a:pt x="871" y="322"/>
                  </a:lnTo>
                  <a:lnTo>
                    <a:pt x="873" y="319"/>
                  </a:lnTo>
                  <a:lnTo>
                    <a:pt x="875" y="314"/>
                  </a:lnTo>
                  <a:lnTo>
                    <a:pt x="877" y="306"/>
                  </a:lnTo>
                  <a:lnTo>
                    <a:pt x="879" y="295"/>
                  </a:lnTo>
                  <a:lnTo>
                    <a:pt x="881" y="280"/>
                  </a:lnTo>
                  <a:lnTo>
                    <a:pt x="883" y="261"/>
                  </a:lnTo>
                  <a:lnTo>
                    <a:pt x="885" y="236"/>
                  </a:lnTo>
                  <a:lnTo>
                    <a:pt x="887" y="207"/>
                  </a:lnTo>
                  <a:lnTo>
                    <a:pt x="889" y="175"/>
                  </a:lnTo>
                  <a:lnTo>
                    <a:pt x="891" y="140"/>
                  </a:lnTo>
                  <a:lnTo>
                    <a:pt x="893" y="106"/>
                  </a:lnTo>
                  <a:lnTo>
                    <a:pt x="895" y="75"/>
                  </a:lnTo>
                  <a:lnTo>
                    <a:pt x="897" y="48"/>
                  </a:lnTo>
                  <a:lnTo>
                    <a:pt x="900" y="27"/>
                  </a:lnTo>
                  <a:lnTo>
                    <a:pt x="902" y="12"/>
                  </a:lnTo>
                  <a:lnTo>
                    <a:pt x="904" y="3"/>
                  </a:lnTo>
                  <a:lnTo>
                    <a:pt x="906" y="0"/>
                  </a:lnTo>
                  <a:lnTo>
                    <a:pt x="908" y="2"/>
                  </a:lnTo>
                  <a:lnTo>
                    <a:pt x="910" y="9"/>
                  </a:lnTo>
                  <a:lnTo>
                    <a:pt x="912" y="19"/>
                  </a:lnTo>
                  <a:lnTo>
                    <a:pt x="914" y="31"/>
                  </a:lnTo>
                  <a:lnTo>
                    <a:pt x="916" y="45"/>
                  </a:lnTo>
                  <a:lnTo>
                    <a:pt x="918" y="60"/>
                  </a:lnTo>
                  <a:lnTo>
                    <a:pt x="920" y="76"/>
                  </a:lnTo>
                  <a:lnTo>
                    <a:pt x="922" y="94"/>
                  </a:lnTo>
                  <a:lnTo>
                    <a:pt x="924" y="113"/>
                  </a:lnTo>
                  <a:lnTo>
                    <a:pt x="926" y="131"/>
                  </a:lnTo>
                  <a:lnTo>
                    <a:pt x="928" y="149"/>
                  </a:lnTo>
                  <a:lnTo>
                    <a:pt x="930" y="168"/>
                  </a:lnTo>
                  <a:lnTo>
                    <a:pt x="932" y="189"/>
                  </a:lnTo>
                  <a:lnTo>
                    <a:pt x="934" y="207"/>
                  </a:lnTo>
                  <a:lnTo>
                    <a:pt x="936" y="223"/>
                  </a:lnTo>
                  <a:lnTo>
                    <a:pt x="938" y="237"/>
                  </a:lnTo>
                  <a:lnTo>
                    <a:pt x="940" y="250"/>
                  </a:lnTo>
                  <a:lnTo>
                    <a:pt x="942" y="261"/>
                  </a:lnTo>
                  <a:lnTo>
                    <a:pt x="944" y="270"/>
                  </a:lnTo>
                  <a:lnTo>
                    <a:pt x="946" y="277"/>
                  </a:lnTo>
                  <a:lnTo>
                    <a:pt x="948" y="284"/>
                  </a:lnTo>
                  <a:lnTo>
                    <a:pt x="950" y="289"/>
                  </a:lnTo>
                  <a:lnTo>
                    <a:pt x="952" y="293"/>
                  </a:lnTo>
                  <a:lnTo>
                    <a:pt x="954" y="296"/>
                  </a:lnTo>
                  <a:lnTo>
                    <a:pt x="956" y="299"/>
                  </a:lnTo>
                  <a:lnTo>
                    <a:pt x="958" y="301"/>
                  </a:lnTo>
                  <a:lnTo>
                    <a:pt x="960" y="302"/>
                  </a:lnTo>
                  <a:lnTo>
                    <a:pt x="962" y="303"/>
                  </a:lnTo>
                  <a:lnTo>
                    <a:pt x="964" y="303"/>
                  </a:lnTo>
                  <a:lnTo>
                    <a:pt x="966" y="302"/>
                  </a:lnTo>
                  <a:lnTo>
                    <a:pt x="968" y="300"/>
                  </a:lnTo>
                  <a:lnTo>
                    <a:pt x="970" y="297"/>
                  </a:lnTo>
                  <a:lnTo>
                    <a:pt x="972" y="292"/>
                  </a:lnTo>
                  <a:lnTo>
                    <a:pt x="974" y="287"/>
                  </a:lnTo>
                  <a:lnTo>
                    <a:pt x="976" y="280"/>
                  </a:lnTo>
                  <a:lnTo>
                    <a:pt x="978" y="272"/>
                  </a:lnTo>
                  <a:lnTo>
                    <a:pt x="980" y="263"/>
                  </a:lnTo>
                  <a:lnTo>
                    <a:pt x="982" y="254"/>
                  </a:lnTo>
                  <a:lnTo>
                    <a:pt x="984" y="245"/>
                  </a:lnTo>
                  <a:lnTo>
                    <a:pt x="986" y="237"/>
                  </a:lnTo>
                  <a:lnTo>
                    <a:pt x="988" y="229"/>
                  </a:lnTo>
                  <a:lnTo>
                    <a:pt x="990" y="223"/>
                  </a:lnTo>
                  <a:lnTo>
                    <a:pt x="992" y="218"/>
                  </a:lnTo>
                  <a:lnTo>
                    <a:pt x="994" y="214"/>
                  </a:lnTo>
                  <a:lnTo>
                    <a:pt x="996" y="212"/>
                  </a:lnTo>
                  <a:lnTo>
                    <a:pt x="998" y="210"/>
                  </a:lnTo>
                  <a:lnTo>
                    <a:pt x="1000" y="208"/>
                  </a:lnTo>
                  <a:lnTo>
                    <a:pt x="1002" y="207"/>
                  </a:lnTo>
                  <a:lnTo>
                    <a:pt x="1004" y="206"/>
                  </a:lnTo>
                  <a:lnTo>
                    <a:pt x="1006" y="204"/>
                  </a:lnTo>
                  <a:lnTo>
                    <a:pt x="1008" y="202"/>
                  </a:lnTo>
                  <a:lnTo>
                    <a:pt x="1010" y="200"/>
                  </a:lnTo>
                  <a:lnTo>
                    <a:pt x="1012" y="196"/>
                  </a:lnTo>
                  <a:lnTo>
                    <a:pt x="1014" y="191"/>
                  </a:lnTo>
                  <a:lnTo>
                    <a:pt x="1016" y="185"/>
                  </a:lnTo>
                  <a:lnTo>
                    <a:pt x="1018" y="178"/>
                  </a:lnTo>
                  <a:lnTo>
                    <a:pt x="1020" y="171"/>
                  </a:lnTo>
                  <a:lnTo>
                    <a:pt x="1022" y="163"/>
                  </a:lnTo>
                  <a:lnTo>
                    <a:pt x="1024" y="155"/>
                  </a:lnTo>
                  <a:lnTo>
                    <a:pt x="1026" y="148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714" name="Freeform 709"/>
            <p:cNvSpPr>
              <a:spLocks/>
            </p:cNvSpPr>
            <p:nvPr/>
          </p:nvSpPr>
          <p:spPr bwMode="auto">
            <a:xfrm>
              <a:off x="5370513" y="6269038"/>
              <a:ext cx="1247775" cy="1930400"/>
            </a:xfrm>
            <a:custGeom>
              <a:avLst/>
              <a:gdLst>
                <a:gd name="T0" fmla="*/ 12 w 786"/>
                <a:gd name="T1" fmla="*/ 1062 h 1216"/>
                <a:gd name="T2" fmla="*/ 26 w 786"/>
                <a:gd name="T3" fmla="*/ 1128 h 1216"/>
                <a:gd name="T4" fmla="*/ 41 w 786"/>
                <a:gd name="T5" fmla="*/ 1186 h 1216"/>
                <a:gd name="T6" fmla="*/ 55 w 786"/>
                <a:gd name="T7" fmla="*/ 1208 h 1216"/>
                <a:gd name="T8" fmla="*/ 69 w 786"/>
                <a:gd name="T9" fmla="*/ 1213 h 1216"/>
                <a:gd name="T10" fmla="*/ 83 w 786"/>
                <a:gd name="T11" fmla="*/ 1215 h 1216"/>
                <a:gd name="T12" fmla="*/ 97 w 786"/>
                <a:gd name="T13" fmla="*/ 1214 h 1216"/>
                <a:gd name="T14" fmla="*/ 111 w 786"/>
                <a:gd name="T15" fmla="*/ 1178 h 1216"/>
                <a:gd name="T16" fmla="*/ 125 w 786"/>
                <a:gd name="T17" fmla="*/ 943 h 1216"/>
                <a:gd name="T18" fmla="*/ 139 w 786"/>
                <a:gd name="T19" fmla="*/ 537 h 1216"/>
                <a:gd name="T20" fmla="*/ 153 w 786"/>
                <a:gd name="T21" fmla="*/ 339 h 1216"/>
                <a:gd name="T22" fmla="*/ 167 w 786"/>
                <a:gd name="T23" fmla="*/ 390 h 1216"/>
                <a:gd name="T24" fmla="*/ 182 w 786"/>
                <a:gd name="T25" fmla="*/ 588 h 1216"/>
                <a:gd name="T26" fmla="*/ 196 w 786"/>
                <a:gd name="T27" fmla="*/ 856 h 1216"/>
                <a:gd name="T28" fmla="*/ 210 w 786"/>
                <a:gd name="T29" fmla="*/ 1072 h 1216"/>
                <a:gd name="T30" fmla="*/ 224 w 786"/>
                <a:gd name="T31" fmla="*/ 1168 h 1216"/>
                <a:gd name="T32" fmla="*/ 238 w 786"/>
                <a:gd name="T33" fmla="*/ 1197 h 1216"/>
                <a:gd name="T34" fmla="*/ 252 w 786"/>
                <a:gd name="T35" fmla="*/ 1204 h 1216"/>
                <a:gd name="T36" fmla="*/ 266 w 786"/>
                <a:gd name="T37" fmla="*/ 1206 h 1216"/>
                <a:gd name="T38" fmla="*/ 280 w 786"/>
                <a:gd name="T39" fmla="*/ 1207 h 1216"/>
                <a:gd name="T40" fmla="*/ 294 w 786"/>
                <a:gd name="T41" fmla="*/ 1207 h 1216"/>
                <a:gd name="T42" fmla="*/ 308 w 786"/>
                <a:gd name="T43" fmla="*/ 1204 h 1216"/>
                <a:gd name="T44" fmla="*/ 322 w 786"/>
                <a:gd name="T45" fmla="*/ 1189 h 1216"/>
                <a:gd name="T46" fmla="*/ 337 w 786"/>
                <a:gd name="T47" fmla="*/ 1160 h 1216"/>
                <a:gd name="T48" fmla="*/ 351 w 786"/>
                <a:gd name="T49" fmla="*/ 1144 h 1216"/>
                <a:gd name="T50" fmla="*/ 365 w 786"/>
                <a:gd name="T51" fmla="*/ 1150 h 1216"/>
                <a:gd name="T52" fmla="*/ 379 w 786"/>
                <a:gd name="T53" fmla="*/ 1147 h 1216"/>
                <a:gd name="T54" fmla="*/ 393 w 786"/>
                <a:gd name="T55" fmla="*/ 1023 h 1216"/>
                <a:gd name="T56" fmla="*/ 407 w 786"/>
                <a:gd name="T57" fmla="*/ 622 h 1216"/>
                <a:gd name="T58" fmla="*/ 421 w 786"/>
                <a:gd name="T59" fmla="*/ 157 h 1216"/>
                <a:gd name="T60" fmla="*/ 435 w 786"/>
                <a:gd name="T61" fmla="*/ 0 h 1216"/>
                <a:gd name="T62" fmla="*/ 449 w 786"/>
                <a:gd name="T63" fmla="*/ 139 h 1216"/>
                <a:gd name="T64" fmla="*/ 463 w 786"/>
                <a:gd name="T65" fmla="*/ 405 h 1216"/>
                <a:gd name="T66" fmla="*/ 478 w 786"/>
                <a:gd name="T67" fmla="*/ 698 h 1216"/>
                <a:gd name="T68" fmla="*/ 492 w 786"/>
                <a:gd name="T69" fmla="*/ 936 h 1216"/>
                <a:gd name="T70" fmla="*/ 506 w 786"/>
                <a:gd name="T71" fmla="*/ 1071 h 1216"/>
                <a:gd name="T72" fmla="*/ 520 w 786"/>
                <a:gd name="T73" fmla="*/ 1129 h 1216"/>
                <a:gd name="T74" fmla="*/ 534 w 786"/>
                <a:gd name="T75" fmla="*/ 1153 h 1216"/>
                <a:gd name="T76" fmla="*/ 548 w 786"/>
                <a:gd name="T77" fmla="*/ 1164 h 1216"/>
                <a:gd name="T78" fmla="*/ 562 w 786"/>
                <a:gd name="T79" fmla="*/ 1172 h 1216"/>
                <a:gd name="T80" fmla="*/ 576 w 786"/>
                <a:gd name="T81" fmla="*/ 1177 h 1216"/>
                <a:gd name="T82" fmla="*/ 590 w 786"/>
                <a:gd name="T83" fmla="*/ 1182 h 1216"/>
                <a:gd name="T84" fmla="*/ 604 w 786"/>
                <a:gd name="T85" fmla="*/ 1186 h 1216"/>
                <a:gd name="T86" fmla="*/ 618 w 786"/>
                <a:gd name="T87" fmla="*/ 1190 h 1216"/>
                <a:gd name="T88" fmla="*/ 633 w 786"/>
                <a:gd name="T89" fmla="*/ 1194 h 1216"/>
                <a:gd name="T90" fmla="*/ 647 w 786"/>
                <a:gd name="T91" fmla="*/ 1198 h 1216"/>
                <a:gd name="T92" fmla="*/ 661 w 786"/>
                <a:gd name="T93" fmla="*/ 1201 h 1216"/>
                <a:gd name="T94" fmla="*/ 675 w 786"/>
                <a:gd name="T95" fmla="*/ 1205 h 1216"/>
                <a:gd name="T96" fmla="*/ 689 w 786"/>
                <a:gd name="T97" fmla="*/ 1207 h 1216"/>
                <a:gd name="T98" fmla="*/ 703 w 786"/>
                <a:gd name="T99" fmla="*/ 1208 h 1216"/>
                <a:gd name="T100" fmla="*/ 717 w 786"/>
                <a:gd name="T101" fmla="*/ 1209 h 1216"/>
                <a:gd name="T102" fmla="*/ 731 w 786"/>
                <a:gd name="T103" fmla="*/ 1209 h 1216"/>
                <a:gd name="T104" fmla="*/ 745 w 786"/>
                <a:gd name="T105" fmla="*/ 1208 h 1216"/>
                <a:gd name="T106" fmla="*/ 759 w 786"/>
                <a:gd name="T107" fmla="*/ 1207 h 1216"/>
                <a:gd name="T108" fmla="*/ 773 w 786"/>
                <a:gd name="T109" fmla="*/ 1206 h 1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</a:cxnLst>
              <a:rect l="0" t="0" r="r" b="b"/>
              <a:pathLst>
                <a:path w="786" h="1216">
                  <a:moveTo>
                    <a:pt x="0" y="1054"/>
                  </a:moveTo>
                  <a:lnTo>
                    <a:pt x="2" y="1048"/>
                  </a:lnTo>
                  <a:lnTo>
                    <a:pt x="4" y="1045"/>
                  </a:lnTo>
                  <a:lnTo>
                    <a:pt x="6" y="1044"/>
                  </a:lnTo>
                  <a:lnTo>
                    <a:pt x="8" y="1047"/>
                  </a:lnTo>
                  <a:lnTo>
                    <a:pt x="10" y="1053"/>
                  </a:lnTo>
                  <a:lnTo>
                    <a:pt x="12" y="1062"/>
                  </a:lnTo>
                  <a:lnTo>
                    <a:pt x="14" y="1072"/>
                  </a:lnTo>
                  <a:lnTo>
                    <a:pt x="16" y="1083"/>
                  </a:lnTo>
                  <a:lnTo>
                    <a:pt x="18" y="1093"/>
                  </a:lnTo>
                  <a:lnTo>
                    <a:pt x="20" y="1103"/>
                  </a:lnTo>
                  <a:lnTo>
                    <a:pt x="22" y="1112"/>
                  </a:lnTo>
                  <a:lnTo>
                    <a:pt x="24" y="1120"/>
                  </a:lnTo>
                  <a:lnTo>
                    <a:pt x="26" y="1128"/>
                  </a:lnTo>
                  <a:lnTo>
                    <a:pt x="29" y="1136"/>
                  </a:lnTo>
                  <a:lnTo>
                    <a:pt x="31" y="1144"/>
                  </a:lnTo>
                  <a:lnTo>
                    <a:pt x="33" y="1153"/>
                  </a:lnTo>
                  <a:lnTo>
                    <a:pt x="35" y="1162"/>
                  </a:lnTo>
                  <a:lnTo>
                    <a:pt x="37" y="1171"/>
                  </a:lnTo>
                  <a:lnTo>
                    <a:pt x="39" y="1179"/>
                  </a:lnTo>
                  <a:lnTo>
                    <a:pt x="41" y="1186"/>
                  </a:lnTo>
                  <a:lnTo>
                    <a:pt x="43" y="1192"/>
                  </a:lnTo>
                  <a:lnTo>
                    <a:pt x="45" y="1197"/>
                  </a:lnTo>
                  <a:lnTo>
                    <a:pt x="47" y="1201"/>
                  </a:lnTo>
                  <a:lnTo>
                    <a:pt x="49" y="1203"/>
                  </a:lnTo>
                  <a:lnTo>
                    <a:pt x="51" y="1205"/>
                  </a:lnTo>
                  <a:lnTo>
                    <a:pt x="53" y="1207"/>
                  </a:lnTo>
                  <a:lnTo>
                    <a:pt x="55" y="1208"/>
                  </a:lnTo>
                  <a:lnTo>
                    <a:pt x="57" y="1209"/>
                  </a:lnTo>
                  <a:lnTo>
                    <a:pt x="59" y="1210"/>
                  </a:lnTo>
                  <a:lnTo>
                    <a:pt x="61" y="1211"/>
                  </a:lnTo>
                  <a:lnTo>
                    <a:pt x="63" y="1211"/>
                  </a:lnTo>
                  <a:lnTo>
                    <a:pt x="65" y="1212"/>
                  </a:lnTo>
                  <a:lnTo>
                    <a:pt x="67" y="1212"/>
                  </a:lnTo>
                  <a:lnTo>
                    <a:pt x="69" y="1213"/>
                  </a:lnTo>
                  <a:lnTo>
                    <a:pt x="71" y="1213"/>
                  </a:lnTo>
                  <a:lnTo>
                    <a:pt x="73" y="1214"/>
                  </a:lnTo>
                  <a:lnTo>
                    <a:pt x="75" y="1214"/>
                  </a:lnTo>
                  <a:lnTo>
                    <a:pt x="77" y="1214"/>
                  </a:lnTo>
                  <a:lnTo>
                    <a:pt x="79" y="1215"/>
                  </a:lnTo>
                  <a:lnTo>
                    <a:pt x="81" y="1215"/>
                  </a:lnTo>
                  <a:lnTo>
                    <a:pt x="83" y="1215"/>
                  </a:lnTo>
                  <a:lnTo>
                    <a:pt x="85" y="1216"/>
                  </a:lnTo>
                  <a:lnTo>
                    <a:pt x="87" y="1216"/>
                  </a:lnTo>
                  <a:lnTo>
                    <a:pt x="89" y="1216"/>
                  </a:lnTo>
                  <a:lnTo>
                    <a:pt x="91" y="1216"/>
                  </a:lnTo>
                  <a:lnTo>
                    <a:pt x="93" y="1216"/>
                  </a:lnTo>
                  <a:lnTo>
                    <a:pt x="95" y="1215"/>
                  </a:lnTo>
                  <a:lnTo>
                    <a:pt x="97" y="1214"/>
                  </a:lnTo>
                  <a:lnTo>
                    <a:pt x="99" y="1213"/>
                  </a:lnTo>
                  <a:lnTo>
                    <a:pt x="101" y="1212"/>
                  </a:lnTo>
                  <a:lnTo>
                    <a:pt x="103" y="1209"/>
                  </a:lnTo>
                  <a:lnTo>
                    <a:pt x="105" y="1204"/>
                  </a:lnTo>
                  <a:lnTo>
                    <a:pt x="107" y="1198"/>
                  </a:lnTo>
                  <a:lnTo>
                    <a:pt x="109" y="1190"/>
                  </a:lnTo>
                  <a:lnTo>
                    <a:pt x="111" y="1178"/>
                  </a:lnTo>
                  <a:lnTo>
                    <a:pt x="113" y="1162"/>
                  </a:lnTo>
                  <a:lnTo>
                    <a:pt x="115" y="1141"/>
                  </a:lnTo>
                  <a:lnTo>
                    <a:pt x="117" y="1114"/>
                  </a:lnTo>
                  <a:lnTo>
                    <a:pt x="119" y="1081"/>
                  </a:lnTo>
                  <a:lnTo>
                    <a:pt x="121" y="1042"/>
                  </a:lnTo>
                  <a:lnTo>
                    <a:pt x="123" y="995"/>
                  </a:lnTo>
                  <a:lnTo>
                    <a:pt x="125" y="943"/>
                  </a:lnTo>
                  <a:lnTo>
                    <a:pt x="127" y="886"/>
                  </a:lnTo>
                  <a:lnTo>
                    <a:pt x="129" y="826"/>
                  </a:lnTo>
                  <a:lnTo>
                    <a:pt x="131" y="765"/>
                  </a:lnTo>
                  <a:lnTo>
                    <a:pt x="133" y="703"/>
                  </a:lnTo>
                  <a:lnTo>
                    <a:pt x="135" y="643"/>
                  </a:lnTo>
                  <a:lnTo>
                    <a:pt x="137" y="588"/>
                  </a:lnTo>
                  <a:lnTo>
                    <a:pt x="139" y="537"/>
                  </a:lnTo>
                  <a:lnTo>
                    <a:pt x="141" y="491"/>
                  </a:lnTo>
                  <a:lnTo>
                    <a:pt x="143" y="451"/>
                  </a:lnTo>
                  <a:lnTo>
                    <a:pt x="145" y="417"/>
                  </a:lnTo>
                  <a:lnTo>
                    <a:pt x="147" y="389"/>
                  </a:lnTo>
                  <a:lnTo>
                    <a:pt x="149" y="367"/>
                  </a:lnTo>
                  <a:lnTo>
                    <a:pt x="151" y="351"/>
                  </a:lnTo>
                  <a:lnTo>
                    <a:pt x="153" y="339"/>
                  </a:lnTo>
                  <a:lnTo>
                    <a:pt x="155" y="334"/>
                  </a:lnTo>
                  <a:lnTo>
                    <a:pt x="157" y="334"/>
                  </a:lnTo>
                  <a:lnTo>
                    <a:pt x="159" y="337"/>
                  </a:lnTo>
                  <a:lnTo>
                    <a:pt x="161" y="345"/>
                  </a:lnTo>
                  <a:lnTo>
                    <a:pt x="163" y="357"/>
                  </a:lnTo>
                  <a:lnTo>
                    <a:pt x="165" y="372"/>
                  </a:lnTo>
                  <a:lnTo>
                    <a:pt x="167" y="390"/>
                  </a:lnTo>
                  <a:lnTo>
                    <a:pt x="169" y="411"/>
                  </a:lnTo>
                  <a:lnTo>
                    <a:pt x="171" y="435"/>
                  </a:lnTo>
                  <a:lnTo>
                    <a:pt x="173" y="462"/>
                  </a:lnTo>
                  <a:lnTo>
                    <a:pt x="175" y="490"/>
                  </a:lnTo>
                  <a:lnTo>
                    <a:pt x="177" y="521"/>
                  </a:lnTo>
                  <a:lnTo>
                    <a:pt x="179" y="553"/>
                  </a:lnTo>
                  <a:lnTo>
                    <a:pt x="182" y="588"/>
                  </a:lnTo>
                  <a:lnTo>
                    <a:pt x="184" y="624"/>
                  </a:lnTo>
                  <a:lnTo>
                    <a:pt x="186" y="661"/>
                  </a:lnTo>
                  <a:lnTo>
                    <a:pt x="188" y="699"/>
                  </a:lnTo>
                  <a:lnTo>
                    <a:pt x="190" y="739"/>
                  </a:lnTo>
                  <a:lnTo>
                    <a:pt x="192" y="779"/>
                  </a:lnTo>
                  <a:lnTo>
                    <a:pt x="194" y="818"/>
                  </a:lnTo>
                  <a:lnTo>
                    <a:pt x="196" y="856"/>
                  </a:lnTo>
                  <a:lnTo>
                    <a:pt x="198" y="893"/>
                  </a:lnTo>
                  <a:lnTo>
                    <a:pt x="200" y="929"/>
                  </a:lnTo>
                  <a:lnTo>
                    <a:pt x="202" y="963"/>
                  </a:lnTo>
                  <a:lnTo>
                    <a:pt x="204" y="994"/>
                  </a:lnTo>
                  <a:lnTo>
                    <a:pt x="206" y="1023"/>
                  </a:lnTo>
                  <a:lnTo>
                    <a:pt x="208" y="1048"/>
                  </a:lnTo>
                  <a:lnTo>
                    <a:pt x="210" y="1072"/>
                  </a:lnTo>
                  <a:lnTo>
                    <a:pt x="212" y="1092"/>
                  </a:lnTo>
                  <a:lnTo>
                    <a:pt x="214" y="1110"/>
                  </a:lnTo>
                  <a:lnTo>
                    <a:pt x="216" y="1126"/>
                  </a:lnTo>
                  <a:lnTo>
                    <a:pt x="218" y="1139"/>
                  </a:lnTo>
                  <a:lnTo>
                    <a:pt x="220" y="1151"/>
                  </a:lnTo>
                  <a:lnTo>
                    <a:pt x="222" y="1160"/>
                  </a:lnTo>
                  <a:lnTo>
                    <a:pt x="224" y="1168"/>
                  </a:lnTo>
                  <a:lnTo>
                    <a:pt x="226" y="1175"/>
                  </a:lnTo>
                  <a:lnTo>
                    <a:pt x="228" y="1181"/>
                  </a:lnTo>
                  <a:lnTo>
                    <a:pt x="230" y="1185"/>
                  </a:lnTo>
                  <a:lnTo>
                    <a:pt x="232" y="1189"/>
                  </a:lnTo>
                  <a:lnTo>
                    <a:pt x="234" y="1192"/>
                  </a:lnTo>
                  <a:lnTo>
                    <a:pt x="236" y="1195"/>
                  </a:lnTo>
                  <a:lnTo>
                    <a:pt x="238" y="1197"/>
                  </a:lnTo>
                  <a:lnTo>
                    <a:pt x="240" y="1199"/>
                  </a:lnTo>
                  <a:lnTo>
                    <a:pt x="242" y="1200"/>
                  </a:lnTo>
                  <a:lnTo>
                    <a:pt x="244" y="1201"/>
                  </a:lnTo>
                  <a:lnTo>
                    <a:pt x="246" y="1202"/>
                  </a:lnTo>
                  <a:lnTo>
                    <a:pt x="248" y="1203"/>
                  </a:lnTo>
                  <a:lnTo>
                    <a:pt x="250" y="1203"/>
                  </a:lnTo>
                  <a:lnTo>
                    <a:pt x="252" y="1204"/>
                  </a:lnTo>
                  <a:lnTo>
                    <a:pt x="254" y="1204"/>
                  </a:lnTo>
                  <a:lnTo>
                    <a:pt x="256" y="1205"/>
                  </a:lnTo>
                  <a:lnTo>
                    <a:pt x="258" y="1205"/>
                  </a:lnTo>
                  <a:lnTo>
                    <a:pt x="260" y="1205"/>
                  </a:lnTo>
                  <a:lnTo>
                    <a:pt x="262" y="1205"/>
                  </a:lnTo>
                  <a:lnTo>
                    <a:pt x="264" y="1206"/>
                  </a:lnTo>
                  <a:lnTo>
                    <a:pt x="266" y="1206"/>
                  </a:lnTo>
                  <a:lnTo>
                    <a:pt x="268" y="1206"/>
                  </a:lnTo>
                  <a:lnTo>
                    <a:pt x="270" y="1206"/>
                  </a:lnTo>
                  <a:lnTo>
                    <a:pt x="272" y="1206"/>
                  </a:lnTo>
                  <a:lnTo>
                    <a:pt x="274" y="1207"/>
                  </a:lnTo>
                  <a:lnTo>
                    <a:pt x="276" y="1207"/>
                  </a:lnTo>
                  <a:lnTo>
                    <a:pt x="278" y="1207"/>
                  </a:lnTo>
                  <a:lnTo>
                    <a:pt x="280" y="1207"/>
                  </a:lnTo>
                  <a:lnTo>
                    <a:pt x="282" y="1207"/>
                  </a:lnTo>
                  <a:lnTo>
                    <a:pt x="284" y="1207"/>
                  </a:lnTo>
                  <a:lnTo>
                    <a:pt x="286" y="1207"/>
                  </a:lnTo>
                  <a:lnTo>
                    <a:pt x="288" y="1207"/>
                  </a:lnTo>
                  <a:lnTo>
                    <a:pt x="290" y="1207"/>
                  </a:lnTo>
                  <a:lnTo>
                    <a:pt x="292" y="1207"/>
                  </a:lnTo>
                  <a:lnTo>
                    <a:pt x="294" y="1207"/>
                  </a:lnTo>
                  <a:lnTo>
                    <a:pt x="296" y="1207"/>
                  </a:lnTo>
                  <a:lnTo>
                    <a:pt x="298" y="1207"/>
                  </a:lnTo>
                  <a:lnTo>
                    <a:pt x="300" y="1207"/>
                  </a:lnTo>
                  <a:lnTo>
                    <a:pt x="302" y="1206"/>
                  </a:lnTo>
                  <a:lnTo>
                    <a:pt x="304" y="1206"/>
                  </a:lnTo>
                  <a:lnTo>
                    <a:pt x="306" y="1205"/>
                  </a:lnTo>
                  <a:lnTo>
                    <a:pt x="308" y="1204"/>
                  </a:lnTo>
                  <a:lnTo>
                    <a:pt x="310" y="1203"/>
                  </a:lnTo>
                  <a:lnTo>
                    <a:pt x="312" y="1201"/>
                  </a:lnTo>
                  <a:lnTo>
                    <a:pt x="314" y="1199"/>
                  </a:lnTo>
                  <a:lnTo>
                    <a:pt x="316" y="1197"/>
                  </a:lnTo>
                  <a:lnTo>
                    <a:pt x="318" y="1195"/>
                  </a:lnTo>
                  <a:lnTo>
                    <a:pt x="320" y="1192"/>
                  </a:lnTo>
                  <a:lnTo>
                    <a:pt x="322" y="1189"/>
                  </a:lnTo>
                  <a:lnTo>
                    <a:pt x="325" y="1185"/>
                  </a:lnTo>
                  <a:lnTo>
                    <a:pt x="327" y="1181"/>
                  </a:lnTo>
                  <a:lnTo>
                    <a:pt x="328" y="1177"/>
                  </a:lnTo>
                  <a:lnTo>
                    <a:pt x="330" y="1173"/>
                  </a:lnTo>
                  <a:lnTo>
                    <a:pt x="332" y="1168"/>
                  </a:lnTo>
                  <a:lnTo>
                    <a:pt x="335" y="1164"/>
                  </a:lnTo>
                  <a:lnTo>
                    <a:pt x="337" y="1160"/>
                  </a:lnTo>
                  <a:lnTo>
                    <a:pt x="339" y="1156"/>
                  </a:lnTo>
                  <a:lnTo>
                    <a:pt x="341" y="1153"/>
                  </a:lnTo>
                  <a:lnTo>
                    <a:pt x="343" y="1150"/>
                  </a:lnTo>
                  <a:lnTo>
                    <a:pt x="345" y="1148"/>
                  </a:lnTo>
                  <a:lnTo>
                    <a:pt x="347" y="1146"/>
                  </a:lnTo>
                  <a:lnTo>
                    <a:pt x="349" y="1145"/>
                  </a:lnTo>
                  <a:lnTo>
                    <a:pt x="351" y="1144"/>
                  </a:lnTo>
                  <a:lnTo>
                    <a:pt x="353" y="1144"/>
                  </a:lnTo>
                  <a:lnTo>
                    <a:pt x="355" y="1144"/>
                  </a:lnTo>
                  <a:lnTo>
                    <a:pt x="357" y="1145"/>
                  </a:lnTo>
                  <a:lnTo>
                    <a:pt x="359" y="1146"/>
                  </a:lnTo>
                  <a:lnTo>
                    <a:pt x="361" y="1147"/>
                  </a:lnTo>
                  <a:lnTo>
                    <a:pt x="363" y="1149"/>
                  </a:lnTo>
                  <a:lnTo>
                    <a:pt x="365" y="1150"/>
                  </a:lnTo>
                  <a:lnTo>
                    <a:pt x="367" y="1152"/>
                  </a:lnTo>
                  <a:lnTo>
                    <a:pt x="369" y="1153"/>
                  </a:lnTo>
                  <a:lnTo>
                    <a:pt x="371" y="1153"/>
                  </a:lnTo>
                  <a:lnTo>
                    <a:pt x="373" y="1154"/>
                  </a:lnTo>
                  <a:lnTo>
                    <a:pt x="375" y="1153"/>
                  </a:lnTo>
                  <a:lnTo>
                    <a:pt x="377" y="1150"/>
                  </a:lnTo>
                  <a:lnTo>
                    <a:pt x="379" y="1147"/>
                  </a:lnTo>
                  <a:lnTo>
                    <a:pt x="381" y="1141"/>
                  </a:lnTo>
                  <a:lnTo>
                    <a:pt x="383" y="1132"/>
                  </a:lnTo>
                  <a:lnTo>
                    <a:pt x="385" y="1119"/>
                  </a:lnTo>
                  <a:lnTo>
                    <a:pt x="387" y="1103"/>
                  </a:lnTo>
                  <a:lnTo>
                    <a:pt x="389" y="1082"/>
                  </a:lnTo>
                  <a:lnTo>
                    <a:pt x="391" y="1056"/>
                  </a:lnTo>
                  <a:lnTo>
                    <a:pt x="393" y="1023"/>
                  </a:lnTo>
                  <a:lnTo>
                    <a:pt x="395" y="983"/>
                  </a:lnTo>
                  <a:lnTo>
                    <a:pt x="397" y="938"/>
                  </a:lnTo>
                  <a:lnTo>
                    <a:pt x="399" y="886"/>
                  </a:lnTo>
                  <a:lnTo>
                    <a:pt x="401" y="827"/>
                  </a:lnTo>
                  <a:lnTo>
                    <a:pt x="403" y="762"/>
                  </a:lnTo>
                  <a:lnTo>
                    <a:pt x="405" y="693"/>
                  </a:lnTo>
                  <a:lnTo>
                    <a:pt x="407" y="622"/>
                  </a:lnTo>
                  <a:lnTo>
                    <a:pt x="409" y="550"/>
                  </a:lnTo>
                  <a:lnTo>
                    <a:pt x="411" y="475"/>
                  </a:lnTo>
                  <a:lnTo>
                    <a:pt x="413" y="402"/>
                  </a:lnTo>
                  <a:lnTo>
                    <a:pt x="415" y="334"/>
                  </a:lnTo>
                  <a:lnTo>
                    <a:pt x="417" y="271"/>
                  </a:lnTo>
                  <a:lnTo>
                    <a:pt x="419" y="211"/>
                  </a:lnTo>
                  <a:lnTo>
                    <a:pt x="421" y="157"/>
                  </a:lnTo>
                  <a:lnTo>
                    <a:pt x="423" y="111"/>
                  </a:lnTo>
                  <a:lnTo>
                    <a:pt x="425" y="74"/>
                  </a:lnTo>
                  <a:lnTo>
                    <a:pt x="427" y="45"/>
                  </a:lnTo>
                  <a:lnTo>
                    <a:pt x="429" y="22"/>
                  </a:lnTo>
                  <a:lnTo>
                    <a:pt x="431" y="6"/>
                  </a:lnTo>
                  <a:lnTo>
                    <a:pt x="433" y="0"/>
                  </a:lnTo>
                  <a:lnTo>
                    <a:pt x="435" y="0"/>
                  </a:lnTo>
                  <a:lnTo>
                    <a:pt x="437" y="5"/>
                  </a:lnTo>
                  <a:lnTo>
                    <a:pt x="439" y="16"/>
                  </a:lnTo>
                  <a:lnTo>
                    <a:pt x="441" y="33"/>
                  </a:lnTo>
                  <a:lnTo>
                    <a:pt x="443" y="55"/>
                  </a:lnTo>
                  <a:lnTo>
                    <a:pt x="445" y="80"/>
                  </a:lnTo>
                  <a:lnTo>
                    <a:pt x="447" y="108"/>
                  </a:lnTo>
                  <a:lnTo>
                    <a:pt x="449" y="139"/>
                  </a:lnTo>
                  <a:lnTo>
                    <a:pt x="451" y="173"/>
                  </a:lnTo>
                  <a:lnTo>
                    <a:pt x="453" y="208"/>
                  </a:lnTo>
                  <a:lnTo>
                    <a:pt x="455" y="245"/>
                  </a:lnTo>
                  <a:lnTo>
                    <a:pt x="457" y="283"/>
                  </a:lnTo>
                  <a:lnTo>
                    <a:pt x="459" y="323"/>
                  </a:lnTo>
                  <a:lnTo>
                    <a:pt x="461" y="364"/>
                  </a:lnTo>
                  <a:lnTo>
                    <a:pt x="463" y="405"/>
                  </a:lnTo>
                  <a:lnTo>
                    <a:pt x="465" y="447"/>
                  </a:lnTo>
                  <a:lnTo>
                    <a:pt x="467" y="489"/>
                  </a:lnTo>
                  <a:lnTo>
                    <a:pt x="469" y="532"/>
                  </a:lnTo>
                  <a:lnTo>
                    <a:pt x="471" y="574"/>
                  </a:lnTo>
                  <a:lnTo>
                    <a:pt x="473" y="616"/>
                  </a:lnTo>
                  <a:lnTo>
                    <a:pt x="475" y="657"/>
                  </a:lnTo>
                  <a:lnTo>
                    <a:pt x="478" y="698"/>
                  </a:lnTo>
                  <a:lnTo>
                    <a:pt x="480" y="738"/>
                  </a:lnTo>
                  <a:lnTo>
                    <a:pt x="482" y="775"/>
                  </a:lnTo>
                  <a:lnTo>
                    <a:pt x="483" y="811"/>
                  </a:lnTo>
                  <a:lnTo>
                    <a:pt x="485" y="846"/>
                  </a:lnTo>
                  <a:lnTo>
                    <a:pt x="488" y="878"/>
                  </a:lnTo>
                  <a:lnTo>
                    <a:pt x="490" y="908"/>
                  </a:lnTo>
                  <a:lnTo>
                    <a:pt x="492" y="936"/>
                  </a:lnTo>
                  <a:lnTo>
                    <a:pt x="494" y="962"/>
                  </a:lnTo>
                  <a:lnTo>
                    <a:pt x="496" y="985"/>
                  </a:lnTo>
                  <a:lnTo>
                    <a:pt x="498" y="1006"/>
                  </a:lnTo>
                  <a:lnTo>
                    <a:pt x="500" y="1025"/>
                  </a:lnTo>
                  <a:lnTo>
                    <a:pt x="502" y="1042"/>
                  </a:lnTo>
                  <a:lnTo>
                    <a:pt x="504" y="1057"/>
                  </a:lnTo>
                  <a:lnTo>
                    <a:pt x="506" y="1071"/>
                  </a:lnTo>
                  <a:lnTo>
                    <a:pt x="508" y="1083"/>
                  </a:lnTo>
                  <a:lnTo>
                    <a:pt x="510" y="1094"/>
                  </a:lnTo>
                  <a:lnTo>
                    <a:pt x="512" y="1103"/>
                  </a:lnTo>
                  <a:lnTo>
                    <a:pt x="514" y="1111"/>
                  </a:lnTo>
                  <a:lnTo>
                    <a:pt x="516" y="1118"/>
                  </a:lnTo>
                  <a:lnTo>
                    <a:pt x="518" y="1124"/>
                  </a:lnTo>
                  <a:lnTo>
                    <a:pt x="520" y="1129"/>
                  </a:lnTo>
                  <a:lnTo>
                    <a:pt x="522" y="1134"/>
                  </a:lnTo>
                  <a:lnTo>
                    <a:pt x="524" y="1138"/>
                  </a:lnTo>
                  <a:lnTo>
                    <a:pt x="526" y="1142"/>
                  </a:lnTo>
                  <a:lnTo>
                    <a:pt x="528" y="1145"/>
                  </a:lnTo>
                  <a:lnTo>
                    <a:pt x="530" y="1148"/>
                  </a:lnTo>
                  <a:lnTo>
                    <a:pt x="532" y="1150"/>
                  </a:lnTo>
                  <a:lnTo>
                    <a:pt x="534" y="1153"/>
                  </a:lnTo>
                  <a:lnTo>
                    <a:pt x="536" y="1155"/>
                  </a:lnTo>
                  <a:lnTo>
                    <a:pt x="538" y="1156"/>
                  </a:lnTo>
                  <a:lnTo>
                    <a:pt x="540" y="1158"/>
                  </a:lnTo>
                  <a:lnTo>
                    <a:pt x="542" y="1160"/>
                  </a:lnTo>
                  <a:lnTo>
                    <a:pt x="544" y="1162"/>
                  </a:lnTo>
                  <a:lnTo>
                    <a:pt x="546" y="1163"/>
                  </a:lnTo>
                  <a:lnTo>
                    <a:pt x="548" y="1164"/>
                  </a:lnTo>
                  <a:lnTo>
                    <a:pt x="550" y="1165"/>
                  </a:lnTo>
                  <a:lnTo>
                    <a:pt x="552" y="1166"/>
                  </a:lnTo>
                  <a:lnTo>
                    <a:pt x="554" y="1168"/>
                  </a:lnTo>
                  <a:lnTo>
                    <a:pt x="556" y="1169"/>
                  </a:lnTo>
                  <a:lnTo>
                    <a:pt x="558" y="1170"/>
                  </a:lnTo>
                  <a:lnTo>
                    <a:pt x="560" y="1171"/>
                  </a:lnTo>
                  <a:lnTo>
                    <a:pt x="562" y="1172"/>
                  </a:lnTo>
                  <a:lnTo>
                    <a:pt x="564" y="1173"/>
                  </a:lnTo>
                  <a:lnTo>
                    <a:pt x="566" y="1173"/>
                  </a:lnTo>
                  <a:lnTo>
                    <a:pt x="568" y="1174"/>
                  </a:lnTo>
                  <a:lnTo>
                    <a:pt x="570" y="1175"/>
                  </a:lnTo>
                  <a:lnTo>
                    <a:pt x="572" y="1176"/>
                  </a:lnTo>
                  <a:lnTo>
                    <a:pt x="574" y="1177"/>
                  </a:lnTo>
                  <a:lnTo>
                    <a:pt x="576" y="1177"/>
                  </a:lnTo>
                  <a:lnTo>
                    <a:pt x="578" y="1178"/>
                  </a:lnTo>
                  <a:lnTo>
                    <a:pt x="580" y="1179"/>
                  </a:lnTo>
                  <a:lnTo>
                    <a:pt x="582" y="1179"/>
                  </a:lnTo>
                  <a:lnTo>
                    <a:pt x="584" y="1180"/>
                  </a:lnTo>
                  <a:lnTo>
                    <a:pt x="586" y="1181"/>
                  </a:lnTo>
                  <a:lnTo>
                    <a:pt x="588" y="1181"/>
                  </a:lnTo>
                  <a:lnTo>
                    <a:pt x="590" y="1182"/>
                  </a:lnTo>
                  <a:lnTo>
                    <a:pt x="592" y="1182"/>
                  </a:lnTo>
                  <a:lnTo>
                    <a:pt x="594" y="1183"/>
                  </a:lnTo>
                  <a:lnTo>
                    <a:pt x="596" y="1184"/>
                  </a:lnTo>
                  <a:lnTo>
                    <a:pt x="598" y="1184"/>
                  </a:lnTo>
                  <a:lnTo>
                    <a:pt x="600" y="1185"/>
                  </a:lnTo>
                  <a:lnTo>
                    <a:pt x="602" y="1185"/>
                  </a:lnTo>
                  <a:lnTo>
                    <a:pt x="604" y="1186"/>
                  </a:lnTo>
                  <a:lnTo>
                    <a:pt x="606" y="1186"/>
                  </a:lnTo>
                  <a:lnTo>
                    <a:pt x="608" y="1187"/>
                  </a:lnTo>
                  <a:lnTo>
                    <a:pt x="610" y="1188"/>
                  </a:lnTo>
                  <a:lnTo>
                    <a:pt x="612" y="1188"/>
                  </a:lnTo>
                  <a:lnTo>
                    <a:pt x="614" y="1189"/>
                  </a:lnTo>
                  <a:lnTo>
                    <a:pt x="616" y="1190"/>
                  </a:lnTo>
                  <a:lnTo>
                    <a:pt x="618" y="1190"/>
                  </a:lnTo>
                  <a:lnTo>
                    <a:pt x="620" y="1191"/>
                  </a:lnTo>
                  <a:lnTo>
                    <a:pt x="622" y="1191"/>
                  </a:lnTo>
                  <a:lnTo>
                    <a:pt x="624" y="1192"/>
                  </a:lnTo>
                  <a:lnTo>
                    <a:pt x="626" y="1192"/>
                  </a:lnTo>
                  <a:lnTo>
                    <a:pt x="628" y="1193"/>
                  </a:lnTo>
                  <a:lnTo>
                    <a:pt x="631" y="1193"/>
                  </a:lnTo>
                  <a:lnTo>
                    <a:pt x="633" y="1194"/>
                  </a:lnTo>
                  <a:lnTo>
                    <a:pt x="635" y="1194"/>
                  </a:lnTo>
                  <a:lnTo>
                    <a:pt x="637" y="1195"/>
                  </a:lnTo>
                  <a:lnTo>
                    <a:pt x="639" y="1195"/>
                  </a:lnTo>
                  <a:lnTo>
                    <a:pt x="641" y="1196"/>
                  </a:lnTo>
                  <a:lnTo>
                    <a:pt x="643" y="1196"/>
                  </a:lnTo>
                  <a:lnTo>
                    <a:pt x="645" y="1197"/>
                  </a:lnTo>
                  <a:lnTo>
                    <a:pt x="647" y="1198"/>
                  </a:lnTo>
                  <a:lnTo>
                    <a:pt x="649" y="1198"/>
                  </a:lnTo>
                  <a:lnTo>
                    <a:pt x="651" y="1199"/>
                  </a:lnTo>
                  <a:lnTo>
                    <a:pt x="653" y="1199"/>
                  </a:lnTo>
                  <a:lnTo>
                    <a:pt x="655" y="1200"/>
                  </a:lnTo>
                  <a:lnTo>
                    <a:pt x="657" y="1200"/>
                  </a:lnTo>
                  <a:lnTo>
                    <a:pt x="659" y="1201"/>
                  </a:lnTo>
                  <a:lnTo>
                    <a:pt x="661" y="1201"/>
                  </a:lnTo>
                  <a:lnTo>
                    <a:pt x="663" y="1202"/>
                  </a:lnTo>
                  <a:lnTo>
                    <a:pt x="665" y="1202"/>
                  </a:lnTo>
                  <a:lnTo>
                    <a:pt x="667" y="1203"/>
                  </a:lnTo>
                  <a:lnTo>
                    <a:pt x="669" y="1203"/>
                  </a:lnTo>
                  <a:lnTo>
                    <a:pt x="671" y="1204"/>
                  </a:lnTo>
                  <a:lnTo>
                    <a:pt x="673" y="1204"/>
                  </a:lnTo>
                  <a:lnTo>
                    <a:pt x="675" y="1205"/>
                  </a:lnTo>
                  <a:lnTo>
                    <a:pt x="677" y="1205"/>
                  </a:lnTo>
                  <a:lnTo>
                    <a:pt x="679" y="1205"/>
                  </a:lnTo>
                  <a:lnTo>
                    <a:pt x="681" y="1206"/>
                  </a:lnTo>
                  <a:lnTo>
                    <a:pt x="683" y="1206"/>
                  </a:lnTo>
                  <a:lnTo>
                    <a:pt x="685" y="1206"/>
                  </a:lnTo>
                  <a:lnTo>
                    <a:pt x="687" y="1207"/>
                  </a:lnTo>
                  <a:lnTo>
                    <a:pt x="689" y="1207"/>
                  </a:lnTo>
                  <a:lnTo>
                    <a:pt x="691" y="1207"/>
                  </a:lnTo>
                  <a:lnTo>
                    <a:pt x="693" y="1208"/>
                  </a:lnTo>
                  <a:lnTo>
                    <a:pt x="695" y="1208"/>
                  </a:lnTo>
                  <a:lnTo>
                    <a:pt x="697" y="1208"/>
                  </a:lnTo>
                  <a:lnTo>
                    <a:pt x="699" y="1208"/>
                  </a:lnTo>
                  <a:lnTo>
                    <a:pt x="701" y="1208"/>
                  </a:lnTo>
                  <a:lnTo>
                    <a:pt x="703" y="1208"/>
                  </a:lnTo>
                  <a:lnTo>
                    <a:pt x="705" y="1208"/>
                  </a:lnTo>
                  <a:lnTo>
                    <a:pt x="707" y="1209"/>
                  </a:lnTo>
                  <a:lnTo>
                    <a:pt x="709" y="1209"/>
                  </a:lnTo>
                  <a:lnTo>
                    <a:pt x="711" y="1209"/>
                  </a:lnTo>
                  <a:lnTo>
                    <a:pt x="713" y="1209"/>
                  </a:lnTo>
                  <a:lnTo>
                    <a:pt x="715" y="1209"/>
                  </a:lnTo>
                  <a:lnTo>
                    <a:pt x="717" y="1209"/>
                  </a:lnTo>
                  <a:lnTo>
                    <a:pt x="719" y="1209"/>
                  </a:lnTo>
                  <a:lnTo>
                    <a:pt x="721" y="1209"/>
                  </a:lnTo>
                  <a:lnTo>
                    <a:pt x="723" y="1209"/>
                  </a:lnTo>
                  <a:lnTo>
                    <a:pt x="725" y="1209"/>
                  </a:lnTo>
                  <a:lnTo>
                    <a:pt x="727" y="1209"/>
                  </a:lnTo>
                  <a:lnTo>
                    <a:pt x="729" y="1209"/>
                  </a:lnTo>
                  <a:lnTo>
                    <a:pt x="731" y="1209"/>
                  </a:lnTo>
                  <a:lnTo>
                    <a:pt x="733" y="1209"/>
                  </a:lnTo>
                  <a:lnTo>
                    <a:pt x="735" y="1209"/>
                  </a:lnTo>
                  <a:lnTo>
                    <a:pt x="737" y="1209"/>
                  </a:lnTo>
                  <a:lnTo>
                    <a:pt x="739" y="1209"/>
                  </a:lnTo>
                  <a:lnTo>
                    <a:pt x="741" y="1208"/>
                  </a:lnTo>
                  <a:lnTo>
                    <a:pt x="743" y="1208"/>
                  </a:lnTo>
                  <a:lnTo>
                    <a:pt x="745" y="1208"/>
                  </a:lnTo>
                  <a:lnTo>
                    <a:pt x="747" y="1208"/>
                  </a:lnTo>
                  <a:lnTo>
                    <a:pt x="749" y="1208"/>
                  </a:lnTo>
                  <a:lnTo>
                    <a:pt x="751" y="1208"/>
                  </a:lnTo>
                  <a:lnTo>
                    <a:pt x="753" y="1208"/>
                  </a:lnTo>
                  <a:lnTo>
                    <a:pt x="755" y="1208"/>
                  </a:lnTo>
                  <a:lnTo>
                    <a:pt x="757" y="1207"/>
                  </a:lnTo>
                  <a:lnTo>
                    <a:pt x="759" y="1207"/>
                  </a:lnTo>
                  <a:lnTo>
                    <a:pt x="761" y="1207"/>
                  </a:lnTo>
                  <a:lnTo>
                    <a:pt x="763" y="1207"/>
                  </a:lnTo>
                  <a:lnTo>
                    <a:pt x="765" y="1207"/>
                  </a:lnTo>
                  <a:lnTo>
                    <a:pt x="767" y="1207"/>
                  </a:lnTo>
                  <a:lnTo>
                    <a:pt x="769" y="1206"/>
                  </a:lnTo>
                  <a:lnTo>
                    <a:pt x="771" y="1206"/>
                  </a:lnTo>
                  <a:lnTo>
                    <a:pt x="773" y="1206"/>
                  </a:lnTo>
                  <a:lnTo>
                    <a:pt x="775" y="1206"/>
                  </a:lnTo>
                  <a:lnTo>
                    <a:pt x="777" y="1206"/>
                  </a:lnTo>
                  <a:lnTo>
                    <a:pt x="779" y="1206"/>
                  </a:lnTo>
                  <a:lnTo>
                    <a:pt x="781" y="1206"/>
                  </a:lnTo>
                  <a:lnTo>
                    <a:pt x="783" y="1205"/>
                  </a:lnTo>
                  <a:lnTo>
                    <a:pt x="786" y="1205"/>
                  </a:lnTo>
                </a:path>
              </a:pathLst>
            </a:cu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1716" name="ZoneTexte 1715"/>
          <p:cNvSpPr txBox="1"/>
          <p:nvPr/>
        </p:nvSpPr>
        <p:spPr>
          <a:xfrm>
            <a:off x="3717032" y="5402841"/>
            <a:ext cx="2179251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fr-FR" i="1" dirty="0" smtClean="0"/>
              <a:t>OPDV_11714::Tn2.14</a:t>
            </a:r>
            <a:endParaRPr lang="fr-FR" i="1" dirty="0"/>
          </a:p>
        </p:txBody>
      </p:sp>
      <p:grpSp>
        <p:nvGrpSpPr>
          <p:cNvPr id="729" name="Groupe 728"/>
          <p:cNvGrpSpPr/>
          <p:nvPr/>
        </p:nvGrpSpPr>
        <p:grpSpPr>
          <a:xfrm>
            <a:off x="575513" y="7277887"/>
            <a:ext cx="3045624" cy="237221"/>
            <a:chOff x="355283" y="2671763"/>
            <a:chExt cx="3045624" cy="237221"/>
          </a:xfrm>
        </p:grpSpPr>
        <p:sp>
          <p:nvSpPr>
            <p:cNvPr id="730" name="Rectangle 18"/>
            <p:cNvSpPr>
              <a:spLocks noChangeArrowheads="1"/>
            </p:cNvSpPr>
            <p:nvPr/>
          </p:nvSpPr>
          <p:spPr bwMode="auto">
            <a:xfrm>
              <a:off x="355283" y="2755096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1" name="Line 19"/>
            <p:cNvSpPr>
              <a:spLocks noChangeShapeType="1"/>
            </p:cNvSpPr>
            <p:nvPr/>
          </p:nvSpPr>
          <p:spPr bwMode="auto">
            <a:xfrm>
              <a:off x="398463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2" name="Line 25"/>
            <p:cNvSpPr>
              <a:spLocks noChangeShapeType="1"/>
            </p:cNvSpPr>
            <p:nvPr/>
          </p:nvSpPr>
          <p:spPr bwMode="auto">
            <a:xfrm>
              <a:off x="638175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3" name="Rectangle 30"/>
            <p:cNvSpPr>
              <a:spLocks noChangeArrowheads="1"/>
            </p:cNvSpPr>
            <p:nvPr/>
          </p:nvSpPr>
          <p:spPr bwMode="auto">
            <a:xfrm>
              <a:off x="792798" y="2755096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.5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4" name="Line 31"/>
            <p:cNvSpPr>
              <a:spLocks noChangeShapeType="1"/>
            </p:cNvSpPr>
            <p:nvPr/>
          </p:nvSpPr>
          <p:spPr bwMode="auto">
            <a:xfrm>
              <a:off x="877888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5" name="Line 37"/>
            <p:cNvSpPr>
              <a:spLocks noChangeShapeType="1"/>
            </p:cNvSpPr>
            <p:nvPr/>
          </p:nvSpPr>
          <p:spPr bwMode="auto">
            <a:xfrm>
              <a:off x="1117600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6" name="Rectangle 42"/>
            <p:cNvSpPr>
              <a:spLocks noChangeArrowheads="1"/>
            </p:cNvSpPr>
            <p:nvPr/>
          </p:nvSpPr>
          <p:spPr bwMode="auto">
            <a:xfrm>
              <a:off x="1272223" y="2755096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.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7" name="Line 43"/>
            <p:cNvSpPr>
              <a:spLocks noChangeShapeType="1"/>
            </p:cNvSpPr>
            <p:nvPr/>
          </p:nvSpPr>
          <p:spPr bwMode="auto">
            <a:xfrm>
              <a:off x="1357313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8" name="Line 49"/>
            <p:cNvSpPr>
              <a:spLocks noChangeShapeType="1"/>
            </p:cNvSpPr>
            <p:nvPr/>
          </p:nvSpPr>
          <p:spPr bwMode="auto">
            <a:xfrm>
              <a:off x="1597025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39" name="Rectangle 54"/>
            <p:cNvSpPr>
              <a:spLocks noChangeArrowheads="1"/>
            </p:cNvSpPr>
            <p:nvPr/>
          </p:nvSpPr>
          <p:spPr bwMode="auto">
            <a:xfrm>
              <a:off x="1751648" y="2755096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.5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0" name="Line 55"/>
            <p:cNvSpPr>
              <a:spLocks noChangeShapeType="1"/>
            </p:cNvSpPr>
            <p:nvPr/>
          </p:nvSpPr>
          <p:spPr bwMode="auto">
            <a:xfrm>
              <a:off x="1836738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1" name="Line 61"/>
            <p:cNvSpPr>
              <a:spLocks noChangeShapeType="1"/>
            </p:cNvSpPr>
            <p:nvPr/>
          </p:nvSpPr>
          <p:spPr bwMode="auto">
            <a:xfrm>
              <a:off x="2076450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2" name="Rectangle 66"/>
            <p:cNvSpPr>
              <a:spLocks noChangeArrowheads="1"/>
            </p:cNvSpPr>
            <p:nvPr/>
          </p:nvSpPr>
          <p:spPr bwMode="auto">
            <a:xfrm>
              <a:off x="2195513" y="275509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.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3" name="Line 67"/>
            <p:cNvSpPr>
              <a:spLocks noChangeShapeType="1"/>
            </p:cNvSpPr>
            <p:nvPr/>
          </p:nvSpPr>
          <p:spPr bwMode="auto">
            <a:xfrm>
              <a:off x="2316163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4" name="Line 73"/>
            <p:cNvSpPr>
              <a:spLocks noChangeShapeType="1"/>
            </p:cNvSpPr>
            <p:nvPr/>
          </p:nvSpPr>
          <p:spPr bwMode="auto">
            <a:xfrm>
              <a:off x="2555875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5" name="Rectangle 78"/>
            <p:cNvSpPr>
              <a:spLocks noChangeArrowheads="1"/>
            </p:cNvSpPr>
            <p:nvPr/>
          </p:nvSpPr>
          <p:spPr bwMode="auto">
            <a:xfrm>
              <a:off x="2674938" y="275509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.5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6" name="Line 79"/>
            <p:cNvSpPr>
              <a:spLocks noChangeShapeType="1"/>
            </p:cNvSpPr>
            <p:nvPr/>
          </p:nvSpPr>
          <p:spPr bwMode="auto">
            <a:xfrm>
              <a:off x="2795588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7" name="Line 85"/>
            <p:cNvSpPr>
              <a:spLocks noChangeShapeType="1"/>
            </p:cNvSpPr>
            <p:nvPr/>
          </p:nvSpPr>
          <p:spPr bwMode="auto">
            <a:xfrm>
              <a:off x="3035300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48" name="Rectangle 90"/>
            <p:cNvSpPr>
              <a:spLocks noChangeArrowheads="1"/>
            </p:cNvSpPr>
            <p:nvPr/>
          </p:nvSpPr>
          <p:spPr bwMode="auto">
            <a:xfrm>
              <a:off x="3154045" y="2755096"/>
              <a:ext cx="2468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.0</a:t>
              </a:r>
              <a:endParaRPr kumimoji="0" lang="fr-FR" alt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9" name="Line 91"/>
            <p:cNvSpPr>
              <a:spLocks noChangeShapeType="1"/>
            </p:cNvSpPr>
            <p:nvPr/>
          </p:nvSpPr>
          <p:spPr bwMode="auto">
            <a:xfrm>
              <a:off x="3276600" y="2671763"/>
              <a:ext cx="0" cy="460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cxnSp>
          <p:nvCxnSpPr>
            <p:cNvPr id="750" name="Connecteur droit 749"/>
            <p:cNvCxnSpPr>
              <a:endCxn id="749" idx="0"/>
            </p:cNvCxnSpPr>
            <p:nvPr/>
          </p:nvCxnSpPr>
          <p:spPr>
            <a:xfrm flipV="1">
              <a:off x="369888" y="2671763"/>
              <a:ext cx="2906712" cy="396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21" name="ZoneTexte 1720"/>
          <p:cNvSpPr txBox="1"/>
          <p:nvPr/>
        </p:nvSpPr>
        <p:spPr>
          <a:xfrm>
            <a:off x="2519420" y="7659052"/>
            <a:ext cx="18806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Elution time (min)</a:t>
            </a:r>
            <a:endParaRPr lang="fr-FR" dirty="0"/>
          </a:p>
        </p:txBody>
      </p:sp>
      <p:sp>
        <p:nvSpPr>
          <p:cNvPr id="1722" name="ZoneTexte 1721"/>
          <p:cNvSpPr txBox="1"/>
          <p:nvPr/>
        </p:nvSpPr>
        <p:spPr>
          <a:xfrm rot="16200000">
            <a:off x="-389217" y="4036585"/>
            <a:ext cx="1464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PED </a:t>
            </a:r>
            <a:r>
              <a:rPr lang="fr-FR" dirty="0" err="1" smtClean="0"/>
              <a:t>response</a:t>
            </a:r>
            <a:endParaRPr lang="fr-FR" dirty="0"/>
          </a:p>
        </p:txBody>
      </p:sp>
      <p:sp>
        <p:nvSpPr>
          <p:cNvPr id="79" name="ZoneTexte 1720"/>
          <p:cNvSpPr txBox="1"/>
          <p:nvPr/>
        </p:nvSpPr>
        <p:spPr>
          <a:xfrm>
            <a:off x="3070522" y="8316416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/>
              <a:t>S3 Figure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11849162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046</TotalTime>
  <Words>43</Words>
  <Application>Microsoft Office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Institut Pasteu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spergillus</dc:creator>
  <cp:lastModifiedBy>steph</cp:lastModifiedBy>
  <cp:revision>13</cp:revision>
  <cp:lastPrinted>2018-11-19T14:18:27Z</cp:lastPrinted>
  <dcterms:created xsi:type="dcterms:W3CDTF">2018-10-19T09:16:29Z</dcterms:created>
  <dcterms:modified xsi:type="dcterms:W3CDTF">2018-11-27T17:02:44Z</dcterms:modified>
</cp:coreProperties>
</file>